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2" d="100"/>
          <a:sy n="82" d="100"/>
        </p:scale>
        <p:origin x="67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6B3D7-EB14-4C0C-9B73-6998AF0F2053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A6EB1-4A80-421C-AFB5-A6C8FA5E1FD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275217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6B3D7-EB14-4C0C-9B73-6998AF0F2053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A6EB1-4A80-421C-AFB5-A6C8FA5E1FD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987317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6B3D7-EB14-4C0C-9B73-6998AF0F2053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A6EB1-4A80-421C-AFB5-A6C8FA5E1FD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1603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6B3D7-EB14-4C0C-9B73-6998AF0F2053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A6EB1-4A80-421C-AFB5-A6C8FA5E1FD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8932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6B3D7-EB14-4C0C-9B73-6998AF0F2053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A6EB1-4A80-421C-AFB5-A6C8FA5E1FD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794251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6B3D7-EB14-4C0C-9B73-6998AF0F2053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A6EB1-4A80-421C-AFB5-A6C8FA5E1FD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830552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6B3D7-EB14-4C0C-9B73-6998AF0F2053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A6EB1-4A80-421C-AFB5-A6C8FA5E1FD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273000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6B3D7-EB14-4C0C-9B73-6998AF0F2053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A6EB1-4A80-421C-AFB5-A6C8FA5E1FD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12225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6B3D7-EB14-4C0C-9B73-6998AF0F2053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A6EB1-4A80-421C-AFB5-A6C8FA5E1FD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65343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6B3D7-EB14-4C0C-9B73-6998AF0F2053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A6EB1-4A80-421C-AFB5-A6C8FA5E1FD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913834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6B3D7-EB14-4C0C-9B73-6998AF0F2053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A6EB1-4A80-421C-AFB5-A6C8FA5E1FD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89327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D6B3D7-EB14-4C0C-9B73-6998AF0F2053}" type="datetimeFigureOut">
              <a:rPr lang="en-IN" smtClean="0"/>
              <a:t>30-10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AA6EB1-4A80-421C-AFB5-A6C8FA5E1FD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4753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0EF0516-460C-1305-4454-571D9B6EBE3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7" name="Group 66">
            <a:extLst>
              <a:ext uri="{FF2B5EF4-FFF2-40B4-BE49-F238E27FC236}">
                <a16:creationId xmlns:a16="http://schemas.microsoft.com/office/drawing/2014/main" id="{55E66556-379F-A0D3-4555-6042A68D56E9}"/>
              </a:ext>
            </a:extLst>
          </p:cNvPr>
          <p:cNvGrpSpPr/>
          <p:nvPr/>
        </p:nvGrpSpPr>
        <p:grpSpPr>
          <a:xfrm>
            <a:off x="2284000" y="-831032"/>
            <a:ext cx="7696421" cy="8388158"/>
            <a:chOff x="2284000" y="-831032"/>
            <a:chExt cx="7696421" cy="8388158"/>
          </a:xfrm>
        </p:grpSpPr>
        <p:grpSp>
          <p:nvGrpSpPr>
            <p:cNvPr id="66" name="Group 65">
              <a:extLst>
                <a:ext uri="{FF2B5EF4-FFF2-40B4-BE49-F238E27FC236}">
                  <a16:creationId xmlns:a16="http://schemas.microsoft.com/office/drawing/2014/main" id="{FAFB18DD-E51A-E66F-8EE0-429D9BBE34F9}"/>
                </a:ext>
              </a:extLst>
            </p:cNvPr>
            <p:cNvGrpSpPr/>
            <p:nvPr/>
          </p:nvGrpSpPr>
          <p:grpSpPr>
            <a:xfrm>
              <a:off x="2284000" y="-831032"/>
              <a:ext cx="7696421" cy="8388158"/>
              <a:chOff x="2284000" y="-831032"/>
              <a:chExt cx="7696421" cy="8388158"/>
            </a:xfrm>
          </p:grpSpPr>
          <p:sp>
            <p:nvSpPr>
              <p:cNvPr id="50" name="Arc 49">
                <a:extLst>
                  <a:ext uri="{FF2B5EF4-FFF2-40B4-BE49-F238E27FC236}">
                    <a16:creationId xmlns:a16="http://schemas.microsoft.com/office/drawing/2014/main" id="{86FCD297-332B-0F86-75B8-F849608D83A3}"/>
                  </a:ext>
                </a:extLst>
              </p:cNvPr>
              <p:cNvSpPr/>
              <p:nvPr/>
            </p:nvSpPr>
            <p:spPr>
              <a:xfrm>
                <a:off x="2895600" y="228600"/>
                <a:ext cx="6400800" cy="6400800"/>
              </a:xfrm>
              <a:prstGeom prst="arc">
                <a:avLst>
                  <a:gd name="adj1" fmla="val 16200000"/>
                  <a:gd name="adj2" fmla="val 16163462"/>
                </a:avLst>
              </a:prstGeom>
              <a:ln w="317500">
                <a:solidFill>
                  <a:schemeClr val="accent5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" name="TextBox 1"/>
              <p:cNvSpPr txBox="1"/>
              <p:nvPr/>
            </p:nvSpPr>
            <p:spPr>
              <a:xfrm>
                <a:off x="5496423" y="-831032"/>
                <a:ext cx="6703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HSP1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6967395" y="-262225"/>
                <a:ext cx="43313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O</a:t>
                </a:r>
                <a:r>
                  <a:rPr lang="en-US" baseline="-25000" dirty="0"/>
                  <a:t>H</a:t>
                </a:r>
                <a:endParaRPr lang="en-IN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5642202" y="-256776"/>
                <a:ext cx="81624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dirty="0"/>
                  <a:t>D-loop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6875743" y="-94202"/>
                <a:ext cx="2968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T</a:t>
                </a: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5203198" y="-141372"/>
                <a:ext cx="2968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F</a:t>
                </a: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7743376" y="290869"/>
                <a:ext cx="66511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 err="1"/>
                  <a:t>Cyt</a:t>
                </a:r>
                <a:r>
                  <a:rPr lang="en-IN" dirty="0"/>
                  <a:t> b</a:t>
                </a: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 rot="20275485">
                <a:off x="4204446" y="24002"/>
                <a:ext cx="104868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12s </a:t>
                </a:r>
                <a:r>
                  <a:rPr lang="en-IN" dirty="0" err="1"/>
                  <a:t>rRNA</a:t>
                </a:r>
                <a:endParaRPr lang="en-IN" dirty="0"/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4005913" y="346421"/>
                <a:ext cx="31611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V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2753348" y="1855619"/>
                <a:ext cx="28244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L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6399138" y="-435302"/>
                <a:ext cx="140756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Heavy strand</a:t>
                </a: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9224277" y="1898921"/>
                <a:ext cx="59343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ND5</a:t>
                </a: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9365606" y="2988911"/>
                <a:ext cx="29046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S</a:t>
                </a: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9364227" y="2831061"/>
                <a:ext cx="28244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L</a:t>
                </a: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9374251" y="3159052"/>
                <a:ext cx="32893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H</a:t>
                </a: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9386989" y="3680331"/>
                <a:ext cx="59343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ND4</a:t>
                </a: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9105447" y="4677855"/>
                <a:ext cx="6912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ND4L</a:t>
                </a: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8670478" y="5387434"/>
                <a:ext cx="59343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ND3</a:t>
                </a: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8447393" y="5634660"/>
                <a:ext cx="33054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G</a:t>
                </a: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8865764" y="5091036"/>
                <a:ext cx="30970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R</a:t>
                </a: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8004010" y="6054978"/>
                <a:ext cx="63145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COIII</a:t>
                </a: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6623719" y="6654135"/>
                <a:ext cx="9584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ATPase6</a:t>
                </a: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5831611" y="7187794"/>
                <a:ext cx="9584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ATPase8</a:t>
                </a: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5970100" y="6721685"/>
                <a:ext cx="30489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K</a:t>
                </a: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5044600" y="6720241"/>
                <a:ext cx="57374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COII</a:t>
                </a: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4643468" y="6485918"/>
                <a:ext cx="32733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D</a:t>
                </a: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2846216" y="4931367"/>
                <a:ext cx="38985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W</a:t>
                </a: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2373544" y="4230084"/>
                <a:ext cx="59343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ND2</a:t>
                </a: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2567443" y="3141954"/>
                <a:ext cx="24237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I</a:t>
                </a: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2464059" y="3495665"/>
                <a:ext cx="3818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M</a:t>
                </a: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2284000" y="2572954"/>
                <a:ext cx="59343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ND1</a:t>
                </a: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7308035" y="-37275"/>
                <a:ext cx="128772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Light strand</a:t>
                </a: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2917084" y="808804"/>
                <a:ext cx="671979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16s</a:t>
                </a:r>
              </a:p>
              <a:p>
                <a:pPr algn="ctr"/>
                <a:r>
                  <a:rPr lang="en-IN" dirty="0" err="1"/>
                  <a:t>rRNA</a:t>
                </a:r>
                <a:endParaRPr lang="en-IN" dirty="0"/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4343906" y="1051417"/>
                <a:ext cx="67999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5-mC</a:t>
                </a: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8468825" y="939019"/>
                <a:ext cx="59343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ND6</a:t>
                </a: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2930044" y="5366296"/>
                <a:ext cx="40107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O</a:t>
                </a:r>
                <a:r>
                  <a:rPr lang="en-US" baseline="-25000" dirty="0"/>
                  <a:t>L</a:t>
                </a:r>
                <a:endParaRPr lang="en-IN" dirty="0"/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3438580" y="4776335"/>
                <a:ext cx="317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A</a:t>
                </a: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3011183" y="5097833"/>
                <a:ext cx="33374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N</a:t>
                </a: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3574481" y="4990139"/>
                <a:ext cx="308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</a:t>
                </a: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3225369" y="5409405"/>
                <a:ext cx="308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Y</a:t>
                </a:r>
              </a:p>
            </p:txBody>
          </p:sp>
          <p:sp>
            <p:nvSpPr>
              <p:cNvPr id="62" name="Arc 61">
                <a:extLst>
                  <a:ext uri="{FF2B5EF4-FFF2-40B4-BE49-F238E27FC236}">
                    <a16:creationId xmlns:a16="http://schemas.microsoft.com/office/drawing/2014/main" id="{0B12573B-E6C9-D530-52B8-70EA96EBE404}"/>
                  </a:ext>
                </a:extLst>
              </p:cNvPr>
              <p:cNvSpPr/>
              <p:nvPr/>
            </p:nvSpPr>
            <p:spPr>
              <a:xfrm rot="19498733">
                <a:off x="5519526" y="-112111"/>
                <a:ext cx="1252532" cy="1254867"/>
              </a:xfrm>
              <a:custGeom>
                <a:avLst/>
                <a:gdLst>
                  <a:gd name="connsiteX0" fmla="*/ 1522872 w 3045745"/>
                  <a:gd name="connsiteY0" fmla="*/ 0 h 3231900"/>
                  <a:gd name="connsiteX1" fmla="*/ 2839898 w 3045745"/>
                  <a:gd name="connsiteY1" fmla="*/ 804638 h 3231900"/>
                  <a:gd name="connsiteX2" fmla="*/ 1522873 w 3045745"/>
                  <a:gd name="connsiteY2" fmla="*/ 1615950 h 3231900"/>
                  <a:gd name="connsiteX3" fmla="*/ 1522872 w 3045745"/>
                  <a:gd name="connsiteY3" fmla="*/ 0 h 3231900"/>
                  <a:gd name="connsiteX0" fmla="*/ 1522872 w 3045745"/>
                  <a:gd name="connsiteY0" fmla="*/ 0 h 3231900"/>
                  <a:gd name="connsiteX1" fmla="*/ 2839898 w 3045745"/>
                  <a:gd name="connsiteY1" fmla="*/ 804638 h 3231900"/>
                  <a:gd name="connsiteX0" fmla="*/ 0 w 1499212"/>
                  <a:gd name="connsiteY0" fmla="*/ 0 h 1615950"/>
                  <a:gd name="connsiteX1" fmla="*/ 1317026 w 1499212"/>
                  <a:gd name="connsiteY1" fmla="*/ 804638 h 1615950"/>
                  <a:gd name="connsiteX2" fmla="*/ 1 w 1499212"/>
                  <a:gd name="connsiteY2" fmla="*/ 1615950 h 1615950"/>
                  <a:gd name="connsiteX3" fmla="*/ 0 w 1499212"/>
                  <a:gd name="connsiteY3" fmla="*/ 0 h 1615950"/>
                  <a:gd name="connsiteX0" fmla="*/ 0 w 1499212"/>
                  <a:gd name="connsiteY0" fmla="*/ 0 h 1615950"/>
                  <a:gd name="connsiteX1" fmla="*/ 1499212 w 1499212"/>
                  <a:gd name="connsiteY1" fmla="*/ 615307 h 1615950"/>
                  <a:gd name="connsiteX0" fmla="*/ 9012 w 1508224"/>
                  <a:gd name="connsiteY0" fmla="*/ 202703 h 1818653"/>
                  <a:gd name="connsiteX1" fmla="*/ 1326038 w 1508224"/>
                  <a:gd name="connsiteY1" fmla="*/ 1007341 h 1818653"/>
                  <a:gd name="connsiteX2" fmla="*/ 9013 w 1508224"/>
                  <a:gd name="connsiteY2" fmla="*/ 1818653 h 1818653"/>
                  <a:gd name="connsiteX3" fmla="*/ 9012 w 1508224"/>
                  <a:gd name="connsiteY3" fmla="*/ 202703 h 1818653"/>
                  <a:gd name="connsiteX0" fmla="*/ 0 w 1508224"/>
                  <a:gd name="connsiteY0" fmla="*/ 0 h 1818653"/>
                  <a:gd name="connsiteX1" fmla="*/ 1508224 w 1508224"/>
                  <a:gd name="connsiteY1" fmla="*/ 818010 h 1818653"/>
                  <a:gd name="connsiteX0" fmla="*/ 9012 w 1754657"/>
                  <a:gd name="connsiteY0" fmla="*/ 202703 h 1818653"/>
                  <a:gd name="connsiteX1" fmla="*/ 1326038 w 1754657"/>
                  <a:gd name="connsiteY1" fmla="*/ 1007341 h 1818653"/>
                  <a:gd name="connsiteX2" fmla="*/ 9013 w 1754657"/>
                  <a:gd name="connsiteY2" fmla="*/ 1818653 h 1818653"/>
                  <a:gd name="connsiteX3" fmla="*/ 9012 w 1754657"/>
                  <a:gd name="connsiteY3" fmla="*/ 202703 h 1818653"/>
                  <a:gd name="connsiteX0" fmla="*/ 0 w 1754657"/>
                  <a:gd name="connsiteY0" fmla="*/ 0 h 1818653"/>
                  <a:gd name="connsiteX1" fmla="*/ 1754657 w 1754657"/>
                  <a:gd name="connsiteY1" fmla="*/ 925792 h 1818653"/>
                  <a:gd name="connsiteX0" fmla="*/ 82588 w 1828233"/>
                  <a:gd name="connsiteY0" fmla="*/ 334834 h 1950784"/>
                  <a:gd name="connsiteX1" fmla="*/ 1399614 w 1828233"/>
                  <a:gd name="connsiteY1" fmla="*/ 1139472 h 1950784"/>
                  <a:gd name="connsiteX2" fmla="*/ 82589 w 1828233"/>
                  <a:gd name="connsiteY2" fmla="*/ 1950784 h 1950784"/>
                  <a:gd name="connsiteX3" fmla="*/ 82588 w 1828233"/>
                  <a:gd name="connsiteY3" fmla="*/ 334834 h 1950784"/>
                  <a:gd name="connsiteX0" fmla="*/ 0 w 1828233"/>
                  <a:gd name="connsiteY0" fmla="*/ 0 h 1950784"/>
                  <a:gd name="connsiteX1" fmla="*/ 1828233 w 1828233"/>
                  <a:gd name="connsiteY1" fmla="*/ 1057923 h 1950784"/>
                  <a:gd name="connsiteX0" fmla="*/ 82588 w 1806935"/>
                  <a:gd name="connsiteY0" fmla="*/ 334834 h 1950784"/>
                  <a:gd name="connsiteX1" fmla="*/ 1399614 w 1806935"/>
                  <a:gd name="connsiteY1" fmla="*/ 1139472 h 1950784"/>
                  <a:gd name="connsiteX2" fmla="*/ 82589 w 1806935"/>
                  <a:gd name="connsiteY2" fmla="*/ 1950784 h 1950784"/>
                  <a:gd name="connsiteX3" fmla="*/ 82588 w 1806935"/>
                  <a:gd name="connsiteY3" fmla="*/ 334834 h 1950784"/>
                  <a:gd name="connsiteX0" fmla="*/ 0 w 1806935"/>
                  <a:gd name="connsiteY0" fmla="*/ 0 h 1950784"/>
                  <a:gd name="connsiteX1" fmla="*/ 1806935 w 1806935"/>
                  <a:gd name="connsiteY1" fmla="*/ 942130 h 1950784"/>
                  <a:gd name="connsiteX0" fmla="*/ 76578 w 1800925"/>
                  <a:gd name="connsiteY0" fmla="*/ 385715 h 2001665"/>
                  <a:gd name="connsiteX1" fmla="*/ 1393604 w 1800925"/>
                  <a:gd name="connsiteY1" fmla="*/ 1190353 h 2001665"/>
                  <a:gd name="connsiteX2" fmla="*/ 76579 w 1800925"/>
                  <a:gd name="connsiteY2" fmla="*/ 2001665 h 2001665"/>
                  <a:gd name="connsiteX3" fmla="*/ 76578 w 1800925"/>
                  <a:gd name="connsiteY3" fmla="*/ 385715 h 2001665"/>
                  <a:gd name="connsiteX0" fmla="*/ -1 w 1800925"/>
                  <a:gd name="connsiteY0" fmla="*/ 0 h 2001665"/>
                  <a:gd name="connsiteX1" fmla="*/ 1800925 w 1800925"/>
                  <a:gd name="connsiteY1" fmla="*/ 993011 h 2001665"/>
                  <a:gd name="connsiteX0" fmla="*/ 76579 w 1800926"/>
                  <a:gd name="connsiteY0" fmla="*/ 385715 h 2001665"/>
                  <a:gd name="connsiteX1" fmla="*/ 1527326 w 1800926"/>
                  <a:gd name="connsiteY1" fmla="*/ 1159779 h 2001665"/>
                  <a:gd name="connsiteX2" fmla="*/ 76580 w 1800926"/>
                  <a:gd name="connsiteY2" fmla="*/ 2001665 h 2001665"/>
                  <a:gd name="connsiteX3" fmla="*/ 76579 w 1800926"/>
                  <a:gd name="connsiteY3" fmla="*/ 385715 h 2001665"/>
                  <a:gd name="connsiteX0" fmla="*/ 0 w 1800926"/>
                  <a:gd name="connsiteY0" fmla="*/ 0 h 2001665"/>
                  <a:gd name="connsiteX1" fmla="*/ 1800926 w 1800926"/>
                  <a:gd name="connsiteY1" fmla="*/ 993011 h 2001665"/>
                  <a:gd name="connsiteX0" fmla="*/ 76579 w 1800926"/>
                  <a:gd name="connsiteY0" fmla="*/ 385715 h 2001665"/>
                  <a:gd name="connsiteX1" fmla="*/ 1595713 w 1800926"/>
                  <a:gd name="connsiteY1" fmla="*/ 1113801 h 2001665"/>
                  <a:gd name="connsiteX2" fmla="*/ 76580 w 1800926"/>
                  <a:gd name="connsiteY2" fmla="*/ 2001665 h 2001665"/>
                  <a:gd name="connsiteX3" fmla="*/ 76579 w 1800926"/>
                  <a:gd name="connsiteY3" fmla="*/ 385715 h 2001665"/>
                  <a:gd name="connsiteX0" fmla="*/ 0 w 1800926"/>
                  <a:gd name="connsiteY0" fmla="*/ 0 h 2001665"/>
                  <a:gd name="connsiteX1" fmla="*/ 1800926 w 1800926"/>
                  <a:gd name="connsiteY1" fmla="*/ 993011 h 2001665"/>
                  <a:gd name="connsiteX0" fmla="*/ 13442 w 1800926"/>
                  <a:gd name="connsiteY0" fmla="*/ 209577 h 2001665"/>
                  <a:gd name="connsiteX1" fmla="*/ 1595713 w 1800926"/>
                  <a:gd name="connsiteY1" fmla="*/ 1113801 h 2001665"/>
                  <a:gd name="connsiteX2" fmla="*/ 76580 w 1800926"/>
                  <a:gd name="connsiteY2" fmla="*/ 2001665 h 2001665"/>
                  <a:gd name="connsiteX3" fmla="*/ 13442 w 1800926"/>
                  <a:gd name="connsiteY3" fmla="*/ 209577 h 2001665"/>
                  <a:gd name="connsiteX0" fmla="*/ 0 w 1800926"/>
                  <a:gd name="connsiteY0" fmla="*/ 0 h 2001665"/>
                  <a:gd name="connsiteX1" fmla="*/ 1800926 w 1800926"/>
                  <a:gd name="connsiteY1" fmla="*/ 993011 h 2001665"/>
                  <a:gd name="connsiteX0" fmla="*/ 13442 w 1888100"/>
                  <a:gd name="connsiteY0" fmla="*/ 209577 h 2001665"/>
                  <a:gd name="connsiteX1" fmla="*/ 1595713 w 1888100"/>
                  <a:gd name="connsiteY1" fmla="*/ 1113801 h 2001665"/>
                  <a:gd name="connsiteX2" fmla="*/ 76580 w 1888100"/>
                  <a:gd name="connsiteY2" fmla="*/ 2001665 h 2001665"/>
                  <a:gd name="connsiteX3" fmla="*/ 13442 w 1888100"/>
                  <a:gd name="connsiteY3" fmla="*/ 209577 h 2001665"/>
                  <a:gd name="connsiteX0" fmla="*/ 0 w 1888100"/>
                  <a:gd name="connsiteY0" fmla="*/ 0 h 2001665"/>
                  <a:gd name="connsiteX1" fmla="*/ 1888101 w 1888100"/>
                  <a:gd name="connsiteY1" fmla="*/ 965627 h 2001665"/>
                  <a:gd name="connsiteX0" fmla="*/ 39099 w 1913758"/>
                  <a:gd name="connsiteY0" fmla="*/ 276641 h 2068729"/>
                  <a:gd name="connsiteX1" fmla="*/ 1621370 w 1913758"/>
                  <a:gd name="connsiteY1" fmla="*/ 1180865 h 2068729"/>
                  <a:gd name="connsiteX2" fmla="*/ 102237 w 1913758"/>
                  <a:gd name="connsiteY2" fmla="*/ 2068729 h 2068729"/>
                  <a:gd name="connsiteX3" fmla="*/ 39099 w 1913758"/>
                  <a:gd name="connsiteY3" fmla="*/ 276641 h 2068729"/>
                  <a:gd name="connsiteX0" fmla="*/ 1 w 1913758"/>
                  <a:gd name="connsiteY0" fmla="*/ 0 h 2068729"/>
                  <a:gd name="connsiteX1" fmla="*/ 1913758 w 1913758"/>
                  <a:gd name="connsiteY1" fmla="*/ 1032691 h 2068729"/>
                  <a:gd name="connsiteX0" fmla="*/ 39098 w 1995424"/>
                  <a:gd name="connsiteY0" fmla="*/ 276641 h 2068729"/>
                  <a:gd name="connsiteX1" fmla="*/ 1621369 w 1995424"/>
                  <a:gd name="connsiteY1" fmla="*/ 1180865 h 2068729"/>
                  <a:gd name="connsiteX2" fmla="*/ 102236 w 1995424"/>
                  <a:gd name="connsiteY2" fmla="*/ 2068729 h 2068729"/>
                  <a:gd name="connsiteX3" fmla="*/ 39098 w 1995424"/>
                  <a:gd name="connsiteY3" fmla="*/ 276641 h 2068729"/>
                  <a:gd name="connsiteX0" fmla="*/ 0 w 1995424"/>
                  <a:gd name="connsiteY0" fmla="*/ 0 h 2068729"/>
                  <a:gd name="connsiteX1" fmla="*/ 1995425 w 1995424"/>
                  <a:gd name="connsiteY1" fmla="*/ 1051949 h 2068729"/>
                  <a:gd name="connsiteX0" fmla="*/ 14895 w 1971223"/>
                  <a:gd name="connsiteY0" fmla="*/ 326091 h 2118179"/>
                  <a:gd name="connsiteX1" fmla="*/ 1597166 w 1971223"/>
                  <a:gd name="connsiteY1" fmla="*/ 1230315 h 2118179"/>
                  <a:gd name="connsiteX2" fmla="*/ 78033 w 1971223"/>
                  <a:gd name="connsiteY2" fmla="*/ 2118179 h 2118179"/>
                  <a:gd name="connsiteX3" fmla="*/ 14895 w 1971223"/>
                  <a:gd name="connsiteY3" fmla="*/ 326091 h 2118179"/>
                  <a:gd name="connsiteX0" fmla="*/ -1 w 1971223"/>
                  <a:gd name="connsiteY0" fmla="*/ 0 h 2118179"/>
                  <a:gd name="connsiteX1" fmla="*/ 1971222 w 1971223"/>
                  <a:gd name="connsiteY1" fmla="*/ 1101399 h 2118179"/>
                  <a:gd name="connsiteX0" fmla="*/ 14896 w 2060311"/>
                  <a:gd name="connsiteY0" fmla="*/ 326091 h 2118179"/>
                  <a:gd name="connsiteX1" fmla="*/ 1597167 w 2060311"/>
                  <a:gd name="connsiteY1" fmla="*/ 1230315 h 2118179"/>
                  <a:gd name="connsiteX2" fmla="*/ 78034 w 2060311"/>
                  <a:gd name="connsiteY2" fmla="*/ 2118179 h 2118179"/>
                  <a:gd name="connsiteX3" fmla="*/ 14896 w 2060311"/>
                  <a:gd name="connsiteY3" fmla="*/ 326091 h 2118179"/>
                  <a:gd name="connsiteX0" fmla="*/ 0 w 2060311"/>
                  <a:gd name="connsiteY0" fmla="*/ 0 h 2118179"/>
                  <a:gd name="connsiteX1" fmla="*/ 2060311 w 2060311"/>
                  <a:gd name="connsiteY1" fmla="*/ 1124449 h 2118179"/>
                  <a:gd name="connsiteX0" fmla="*/ 68037 w 2113452"/>
                  <a:gd name="connsiteY0" fmla="*/ 386970 h 2179058"/>
                  <a:gd name="connsiteX1" fmla="*/ 1650308 w 2113452"/>
                  <a:gd name="connsiteY1" fmla="*/ 1291194 h 2179058"/>
                  <a:gd name="connsiteX2" fmla="*/ 131175 w 2113452"/>
                  <a:gd name="connsiteY2" fmla="*/ 2179058 h 2179058"/>
                  <a:gd name="connsiteX3" fmla="*/ 68037 w 2113452"/>
                  <a:gd name="connsiteY3" fmla="*/ 386970 h 2179058"/>
                  <a:gd name="connsiteX0" fmla="*/ 0 w 2113452"/>
                  <a:gd name="connsiteY0" fmla="*/ 0 h 2179058"/>
                  <a:gd name="connsiteX1" fmla="*/ 2113452 w 2113452"/>
                  <a:gd name="connsiteY1" fmla="*/ 1185328 h 2179058"/>
                  <a:gd name="connsiteX0" fmla="*/ 68037 w 2202540"/>
                  <a:gd name="connsiteY0" fmla="*/ 386970 h 2179058"/>
                  <a:gd name="connsiteX1" fmla="*/ 1650308 w 2202540"/>
                  <a:gd name="connsiteY1" fmla="*/ 1291194 h 2179058"/>
                  <a:gd name="connsiteX2" fmla="*/ 131175 w 2202540"/>
                  <a:gd name="connsiteY2" fmla="*/ 2179058 h 2179058"/>
                  <a:gd name="connsiteX3" fmla="*/ 68037 w 2202540"/>
                  <a:gd name="connsiteY3" fmla="*/ 386970 h 2179058"/>
                  <a:gd name="connsiteX0" fmla="*/ 0 w 2202540"/>
                  <a:gd name="connsiteY0" fmla="*/ 0 h 2179058"/>
                  <a:gd name="connsiteX1" fmla="*/ 2202540 w 2202540"/>
                  <a:gd name="connsiteY1" fmla="*/ 1208377 h 2179058"/>
                  <a:gd name="connsiteX0" fmla="*/ 108184 w 2242687"/>
                  <a:gd name="connsiteY0" fmla="*/ 446827 h 2238915"/>
                  <a:gd name="connsiteX1" fmla="*/ 1690455 w 2242687"/>
                  <a:gd name="connsiteY1" fmla="*/ 1351051 h 2238915"/>
                  <a:gd name="connsiteX2" fmla="*/ 171322 w 2242687"/>
                  <a:gd name="connsiteY2" fmla="*/ 2238915 h 2238915"/>
                  <a:gd name="connsiteX3" fmla="*/ 108184 w 2242687"/>
                  <a:gd name="connsiteY3" fmla="*/ 446827 h 2238915"/>
                  <a:gd name="connsiteX0" fmla="*/ 0 w 2242687"/>
                  <a:gd name="connsiteY0" fmla="*/ 0 h 2238915"/>
                  <a:gd name="connsiteX1" fmla="*/ 2242687 w 2242687"/>
                  <a:gd name="connsiteY1" fmla="*/ 1268234 h 2238915"/>
                  <a:gd name="connsiteX0" fmla="*/ 108184 w 2242687"/>
                  <a:gd name="connsiteY0" fmla="*/ 446827 h 2238915"/>
                  <a:gd name="connsiteX1" fmla="*/ 1690455 w 2242687"/>
                  <a:gd name="connsiteY1" fmla="*/ 1351051 h 2238915"/>
                  <a:gd name="connsiteX2" fmla="*/ 171322 w 2242687"/>
                  <a:gd name="connsiteY2" fmla="*/ 2238915 h 2238915"/>
                  <a:gd name="connsiteX3" fmla="*/ 108184 w 2242687"/>
                  <a:gd name="connsiteY3" fmla="*/ 446827 h 2238915"/>
                  <a:gd name="connsiteX0" fmla="*/ 0 w 2242687"/>
                  <a:gd name="connsiteY0" fmla="*/ 0 h 2238915"/>
                  <a:gd name="connsiteX1" fmla="*/ 2242687 w 2242687"/>
                  <a:gd name="connsiteY1" fmla="*/ 1268234 h 2238915"/>
                  <a:gd name="connsiteX0" fmla="*/ 108184 w 2242687"/>
                  <a:gd name="connsiteY0" fmla="*/ 446827 h 2238915"/>
                  <a:gd name="connsiteX1" fmla="*/ 1690455 w 2242687"/>
                  <a:gd name="connsiteY1" fmla="*/ 1351051 h 2238915"/>
                  <a:gd name="connsiteX2" fmla="*/ 171322 w 2242687"/>
                  <a:gd name="connsiteY2" fmla="*/ 2238915 h 2238915"/>
                  <a:gd name="connsiteX3" fmla="*/ 108184 w 2242687"/>
                  <a:gd name="connsiteY3" fmla="*/ 446827 h 2238915"/>
                  <a:gd name="connsiteX0" fmla="*/ 0 w 2242687"/>
                  <a:gd name="connsiteY0" fmla="*/ 0 h 2238915"/>
                  <a:gd name="connsiteX1" fmla="*/ 2242687 w 2242687"/>
                  <a:gd name="connsiteY1" fmla="*/ 1268234 h 2238915"/>
                  <a:gd name="connsiteX0" fmla="*/ 108184 w 2324441"/>
                  <a:gd name="connsiteY0" fmla="*/ 446827 h 2238915"/>
                  <a:gd name="connsiteX1" fmla="*/ 1690455 w 2324441"/>
                  <a:gd name="connsiteY1" fmla="*/ 1351051 h 2238915"/>
                  <a:gd name="connsiteX2" fmla="*/ 171322 w 2324441"/>
                  <a:gd name="connsiteY2" fmla="*/ 2238915 h 2238915"/>
                  <a:gd name="connsiteX3" fmla="*/ 108184 w 2324441"/>
                  <a:gd name="connsiteY3" fmla="*/ 446827 h 2238915"/>
                  <a:gd name="connsiteX0" fmla="*/ 0 w 2324441"/>
                  <a:gd name="connsiteY0" fmla="*/ 0 h 2238915"/>
                  <a:gd name="connsiteX1" fmla="*/ 2324441 w 2324441"/>
                  <a:gd name="connsiteY1" fmla="*/ 1326596 h 2238915"/>
                  <a:gd name="connsiteX0" fmla="*/ 78208 w 2294465"/>
                  <a:gd name="connsiteY0" fmla="*/ 734167 h 2526255"/>
                  <a:gd name="connsiteX1" fmla="*/ 1660479 w 2294465"/>
                  <a:gd name="connsiteY1" fmla="*/ 1638391 h 2526255"/>
                  <a:gd name="connsiteX2" fmla="*/ 141346 w 2294465"/>
                  <a:gd name="connsiteY2" fmla="*/ 2526255 h 2526255"/>
                  <a:gd name="connsiteX3" fmla="*/ 78208 w 2294465"/>
                  <a:gd name="connsiteY3" fmla="*/ 734167 h 2526255"/>
                  <a:gd name="connsiteX0" fmla="*/ 0 w 2294465"/>
                  <a:gd name="connsiteY0" fmla="*/ 0 h 2526255"/>
                  <a:gd name="connsiteX1" fmla="*/ 2294465 w 2294465"/>
                  <a:gd name="connsiteY1" fmla="*/ 1613936 h 2526255"/>
                  <a:gd name="connsiteX0" fmla="*/ 73930 w 2290187"/>
                  <a:gd name="connsiteY0" fmla="*/ 766672 h 2558760"/>
                  <a:gd name="connsiteX1" fmla="*/ 1656201 w 2290187"/>
                  <a:gd name="connsiteY1" fmla="*/ 1670896 h 2558760"/>
                  <a:gd name="connsiteX2" fmla="*/ 137068 w 2290187"/>
                  <a:gd name="connsiteY2" fmla="*/ 2558760 h 2558760"/>
                  <a:gd name="connsiteX3" fmla="*/ 73930 w 2290187"/>
                  <a:gd name="connsiteY3" fmla="*/ 766672 h 2558760"/>
                  <a:gd name="connsiteX0" fmla="*/ 1 w 2290187"/>
                  <a:gd name="connsiteY0" fmla="*/ 0 h 2558760"/>
                  <a:gd name="connsiteX1" fmla="*/ 2290187 w 2290187"/>
                  <a:gd name="connsiteY1" fmla="*/ 1646441 h 2558760"/>
                  <a:gd name="connsiteX0" fmla="*/ 73928 w 2290185"/>
                  <a:gd name="connsiteY0" fmla="*/ 766672 h 2558760"/>
                  <a:gd name="connsiteX1" fmla="*/ 1656199 w 2290185"/>
                  <a:gd name="connsiteY1" fmla="*/ 1670896 h 2558760"/>
                  <a:gd name="connsiteX2" fmla="*/ 137066 w 2290185"/>
                  <a:gd name="connsiteY2" fmla="*/ 2558760 h 2558760"/>
                  <a:gd name="connsiteX3" fmla="*/ 73928 w 2290185"/>
                  <a:gd name="connsiteY3" fmla="*/ 766672 h 2558760"/>
                  <a:gd name="connsiteX0" fmla="*/ -1 w 2290185"/>
                  <a:gd name="connsiteY0" fmla="*/ 0 h 2558760"/>
                  <a:gd name="connsiteX1" fmla="*/ 2290185 w 2290185"/>
                  <a:gd name="connsiteY1" fmla="*/ 1646441 h 2558760"/>
                  <a:gd name="connsiteX0" fmla="*/ 65036 w 2281293"/>
                  <a:gd name="connsiteY0" fmla="*/ 789543 h 2581631"/>
                  <a:gd name="connsiteX1" fmla="*/ 1647307 w 2281293"/>
                  <a:gd name="connsiteY1" fmla="*/ 1693767 h 2581631"/>
                  <a:gd name="connsiteX2" fmla="*/ 128174 w 2281293"/>
                  <a:gd name="connsiteY2" fmla="*/ 2581631 h 2581631"/>
                  <a:gd name="connsiteX3" fmla="*/ 65036 w 2281293"/>
                  <a:gd name="connsiteY3" fmla="*/ 789543 h 2581631"/>
                  <a:gd name="connsiteX0" fmla="*/ 0 w 2281293"/>
                  <a:gd name="connsiteY0" fmla="*/ 0 h 2581631"/>
                  <a:gd name="connsiteX1" fmla="*/ 2281293 w 2281293"/>
                  <a:gd name="connsiteY1" fmla="*/ 1669312 h 2581631"/>
                  <a:gd name="connsiteX0" fmla="*/ 65036 w 2281293"/>
                  <a:gd name="connsiteY0" fmla="*/ 789543 h 2581631"/>
                  <a:gd name="connsiteX1" fmla="*/ 1647307 w 2281293"/>
                  <a:gd name="connsiteY1" fmla="*/ 1693767 h 2581631"/>
                  <a:gd name="connsiteX2" fmla="*/ 128174 w 2281293"/>
                  <a:gd name="connsiteY2" fmla="*/ 2581631 h 2581631"/>
                  <a:gd name="connsiteX3" fmla="*/ 65036 w 2281293"/>
                  <a:gd name="connsiteY3" fmla="*/ 789543 h 2581631"/>
                  <a:gd name="connsiteX0" fmla="*/ 0 w 2281293"/>
                  <a:gd name="connsiteY0" fmla="*/ 0 h 2581631"/>
                  <a:gd name="connsiteX1" fmla="*/ 2281293 w 2281293"/>
                  <a:gd name="connsiteY1" fmla="*/ 1669312 h 25816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281293" h="2581631" stroke="0" extrusionOk="0">
                    <a:moveTo>
                      <a:pt x="65036" y="789543"/>
                    </a:moveTo>
                    <a:cubicBezTo>
                      <a:pt x="607808" y="789543"/>
                      <a:pt x="1374800" y="1195672"/>
                      <a:pt x="1647307" y="1693767"/>
                    </a:cubicBezTo>
                    <a:lnTo>
                      <a:pt x="128174" y="2581631"/>
                    </a:lnTo>
                    <a:cubicBezTo>
                      <a:pt x="128174" y="2042981"/>
                      <a:pt x="65036" y="1328193"/>
                      <a:pt x="65036" y="789543"/>
                    </a:cubicBezTo>
                    <a:close/>
                  </a:path>
                  <a:path w="2281293" h="2581631" fill="none">
                    <a:moveTo>
                      <a:pt x="0" y="0"/>
                    </a:moveTo>
                    <a:cubicBezTo>
                      <a:pt x="521075" y="60587"/>
                      <a:pt x="1831458" y="970992"/>
                      <a:pt x="2281293" y="1669312"/>
                    </a:cubicBezTo>
                  </a:path>
                </a:pathLst>
              </a:custGeom>
              <a:ln w="31750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3" name="Arc 62">
                <a:extLst>
                  <a:ext uri="{FF2B5EF4-FFF2-40B4-BE49-F238E27FC236}">
                    <a16:creationId xmlns:a16="http://schemas.microsoft.com/office/drawing/2014/main" id="{0B12573B-E6C9-D530-52B8-70EA96EBE404}"/>
                  </a:ext>
                </a:extLst>
              </p:cNvPr>
              <p:cNvSpPr/>
              <p:nvPr/>
            </p:nvSpPr>
            <p:spPr>
              <a:xfrm rot="16200000">
                <a:off x="3426063" y="532236"/>
                <a:ext cx="1351952" cy="1942972"/>
              </a:xfrm>
              <a:custGeom>
                <a:avLst/>
                <a:gdLst>
                  <a:gd name="connsiteX0" fmla="*/ 1522872 w 3045745"/>
                  <a:gd name="connsiteY0" fmla="*/ 0 h 3231900"/>
                  <a:gd name="connsiteX1" fmla="*/ 2839898 w 3045745"/>
                  <a:gd name="connsiteY1" fmla="*/ 804638 h 3231900"/>
                  <a:gd name="connsiteX2" fmla="*/ 1522873 w 3045745"/>
                  <a:gd name="connsiteY2" fmla="*/ 1615950 h 3231900"/>
                  <a:gd name="connsiteX3" fmla="*/ 1522872 w 3045745"/>
                  <a:gd name="connsiteY3" fmla="*/ 0 h 3231900"/>
                  <a:gd name="connsiteX0" fmla="*/ 1522872 w 3045745"/>
                  <a:gd name="connsiteY0" fmla="*/ 0 h 3231900"/>
                  <a:gd name="connsiteX1" fmla="*/ 2839898 w 3045745"/>
                  <a:gd name="connsiteY1" fmla="*/ 804638 h 3231900"/>
                  <a:gd name="connsiteX0" fmla="*/ 0 w 1317026"/>
                  <a:gd name="connsiteY0" fmla="*/ 238126 h 1854076"/>
                  <a:gd name="connsiteX1" fmla="*/ 1317026 w 1317026"/>
                  <a:gd name="connsiteY1" fmla="*/ 1042764 h 1854076"/>
                  <a:gd name="connsiteX2" fmla="*/ 1 w 1317026"/>
                  <a:gd name="connsiteY2" fmla="*/ 1854076 h 1854076"/>
                  <a:gd name="connsiteX3" fmla="*/ 0 w 1317026"/>
                  <a:gd name="connsiteY3" fmla="*/ 238126 h 1854076"/>
                  <a:gd name="connsiteX0" fmla="*/ 95250 w 1317026"/>
                  <a:gd name="connsiteY0" fmla="*/ 0 h 1854076"/>
                  <a:gd name="connsiteX1" fmla="*/ 1317026 w 1317026"/>
                  <a:gd name="connsiteY1" fmla="*/ 1042764 h 1854076"/>
                  <a:gd name="connsiteX0" fmla="*/ 0 w 1317026"/>
                  <a:gd name="connsiteY0" fmla="*/ 76201 h 1692151"/>
                  <a:gd name="connsiteX1" fmla="*/ 1317026 w 1317026"/>
                  <a:gd name="connsiteY1" fmla="*/ 880839 h 1692151"/>
                  <a:gd name="connsiteX2" fmla="*/ 1 w 1317026"/>
                  <a:gd name="connsiteY2" fmla="*/ 1692151 h 1692151"/>
                  <a:gd name="connsiteX3" fmla="*/ 0 w 1317026"/>
                  <a:gd name="connsiteY3" fmla="*/ 76201 h 1692151"/>
                  <a:gd name="connsiteX0" fmla="*/ 38100 w 1317026"/>
                  <a:gd name="connsiteY0" fmla="*/ 0 h 1692151"/>
                  <a:gd name="connsiteX1" fmla="*/ 1317026 w 1317026"/>
                  <a:gd name="connsiteY1" fmla="*/ 880839 h 1692151"/>
                  <a:gd name="connsiteX0" fmla="*/ 0 w 1317026"/>
                  <a:gd name="connsiteY0" fmla="*/ 209549 h 1825499"/>
                  <a:gd name="connsiteX1" fmla="*/ 1317026 w 1317026"/>
                  <a:gd name="connsiteY1" fmla="*/ 1014187 h 1825499"/>
                  <a:gd name="connsiteX2" fmla="*/ 1 w 1317026"/>
                  <a:gd name="connsiteY2" fmla="*/ 1825499 h 1825499"/>
                  <a:gd name="connsiteX3" fmla="*/ 0 w 1317026"/>
                  <a:gd name="connsiteY3" fmla="*/ 209549 h 1825499"/>
                  <a:gd name="connsiteX0" fmla="*/ 47625 w 1317026"/>
                  <a:gd name="connsiteY0" fmla="*/ 0 h 1825499"/>
                  <a:gd name="connsiteX1" fmla="*/ 1317026 w 1317026"/>
                  <a:gd name="connsiteY1" fmla="*/ 1014187 h 1825499"/>
                  <a:gd name="connsiteX0" fmla="*/ 85726 w 1402752"/>
                  <a:gd name="connsiteY0" fmla="*/ 219072 h 1835022"/>
                  <a:gd name="connsiteX1" fmla="*/ 1402752 w 1402752"/>
                  <a:gd name="connsiteY1" fmla="*/ 1023710 h 1835022"/>
                  <a:gd name="connsiteX2" fmla="*/ 85727 w 1402752"/>
                  <a:gd name="connsiteY2" fmla="*/ 1835022 h 1835022"/>
                  <a:gd name="connsiteX3" fmla="*/ 85726 w 1402752"/>
                  <a:gd name="connsiteY3" fmla="*/ 219072 h 1835022"/>
                  <a:gd name="connsiteX0" fmla="*/ 0 w 1402752"/>
                  <a:gd name="connsiteY0" fmla="*/ 0 h 1835022"/>
                  <a:gd name="connsiteX1" fmla="*/ 1402752 w 1402752"/>
                  <a:gd name="connsiteY1" fmla="*/ 1023710 h 1835022"/>
                  <a:gd name="connsiteX0" fmla="*/ 85726 w 1402752"/>
                  <a:gd name="connsiteY0" fmla="*/ 219072 h 1835022"/>
                  <a:gd name="connsiteX1" fmla="*/ 1402752 w 1402752"/>
                  <a:gd name="connsiteY1" fmla="*/ 1023710 h 1835022"/>
                  <a:gd name="connsiteX2" fmla="*/ 85727 w 1402752"/>
                  <a:gd name="connsiteY2" fmla="*/ 1835022 h 1835022"/>
                  <a:gd name="connsiteX3" fmla="*/ 85726 w 1402752"/>
                  <a:gd name="connsiteY3" fmla="*/ 219072 h 1835022"/>
                  <a:gd name="connsiteX0" fmla="*/ 0 w 1402752"/>
                  <a:gd name="connsiteY0" fmla="*/ 0 h 1835022"/>
                  <a:gd name="connsiteX1" fmla="*/ 1402752 w 1402752"/>
                  <a:gd name="connsiteY1" fmla="*/ 1023710 h 1835022"/>
                  <a:gd name="connsiteX0" fmla="*/ 85726 w 1402752"/>
                  <a:gd name="connsiteY0" fmla="*/ 219072 h 1835022"/>
                  <a:gd name="connsiteX1" fmla="*/ 1402752 w 1402752"/>
                  <a:gd name="connsiteY1" fmla="*/ 1023710 h 1835022"/>
                  <a:gd name="connsiteX2" fmla="*/ 85727 w 1402752"/>
                  <a:gd name="connsiteY2" fmla="*/ 1835022 h 1835022"/>
                  <a:gd name="connsiteX3" fmla="*/ 85726 w 1402752"/>
                  <a:gd name="connsiteY3" fmla="*/ 219072 h 1835022"/>
                  <a:gd name="connsiteX0" fmla="*/ 0 w 1402752"/>
                  <a:gd name="connsiteY0" fmla="*/ 0 h 1835022"/>
                  <a:gd name="connsiteX1" fmla="*/ 1402752 w 1402752"/>
                  <a:gd name="connsiteY1" fmla="*/ 1023710 h 1835022"/>
                  <a:gd name="connsiteX0" fmla="*/ 57151 w 1374177"/>
                  <a:gd name="connsiteY0" fmla="*/ 285747 h 1901697"/>
                  <a:gd name="connsiteX1" fmla="*/ 1374177 w 1374177"/>
                  <a:gd name="connsiteY1" fmla="*/ 1090385 h 1901697"/>
                  <a:gd name="connsiteX2" fmla="*/ 57152 w 1374177"/>
                  <a:gd name="connsiteY2" fmla="*/ 1901697 h 1901697"/>
                  <a:gd name="connsiteX3" fmla="*/ 57151 w 1374177"/>
                  <a:gd name="connsiteY3" fmla="*/ 285747 h 1901697"/>
                  <a:gd name="connsiteX0" fmla="*/ 0 w 1374177"/>
                  <a:gd name="connsiteY0" fmla="*/ 0 h 1901697"/>
                  <a:gd name="connsiteX1" fmla="*/ 1374177 w 1374177"/>
                  <a:gd name="connsiteY1" fmla="*/ 1090385 h 1901697"/>
                  <a:gd name="connsiteX0" fmla="*/ 57151 w 1374177"/>
                  <a:gd name="connsiteY0" fmla="*/ 285747 h 1901697"/>
                  <a:gd name="connsiteX1" fmla="*/ 1374177 w 1374177"/>
                  <a:gd name="connsiteY1" fmla="*/ 1090385 h 1901697"/>
                  <a:gd name="connsiteX2" fmla="*/ 57152 w 1374177"/>
                  <a:gd name="connsiteY2" fmla="*/ 1901697 h 1901697"/>
                  <a:gd name="connsiteX3" fmla="*/ 57151 w 1374177"/>
                  <a:gd name="connsiteY3" fmla="*/ 285747 h 1901697"/>
                  <a:gd name="connsiteX0" fmla="*/ 0 w 1374177"/>
                  <a:gd name="connsiteY0" fmla="*/ 0 h 1901697"/>
                  <a:gd name="connsiteX1" fmla="*/ 1374177 w 1374177"/>
                  <a:gd name="connsiteY1" fmla="*/ 1090385 h 1901697"/>
                  <a:gd name="connsiteX0" fmla="*/ 66676 w 1383702"/>
                  <a:gd name="connsiteY0" fmla="*/ 257172 h 1873122"/>
                  <a:gd name="connsiteX1" fmla="*/ 1383702 w 1383702"/>
                  <a:gd name="connsiteY1" fmla="*/ 1061810 h 1873122"/>
                  <a:gd name="connsiteX2" fmla="*/ 66677 w 1383702"/>
                  <a:gd name="connsiteY2" fmla="*/ 1873122 h 1873122"/>
                  <a:gd name="connsiteX3" fmla="*/ 66676 w 1383702"/>
                  <a:gd name="connsiteY3" fmla="*/ 257172 h 1873122"/>
                  <a:gd name="connsiteX0" fmla="*/ 0 w 1383702"/>
                  <a:gd name="connsiteY0" fmla="*/ 0 h 1873122"/>
                  <a:gd name="connsiteX1" fmla="*/ 1383702 w 1383702"/>
                  <a:gd name="connsiteY1" fmla="*/ 1061810 h 1873122"/>
                  <a:gd name="connsiteX0" fmla="*/ 28576 w 1345602"/>
                  <a:gd name="connsiteY0" fmla="*/ 327022 h 1942972"/>
                  <a:gd name="connsiteX1" fmla="*/ 1345602 w 1345602"/>
                  <a:gd name="connsiteY1" fmla="*/ 1131660 h 1942972"/>
                  <a:gd name="connsiteX2" fmla="*/ 28577 w 1345602"/>
                  <a:gd name="connsiteY2" fmla="*/ 1942972 h 1942972"/>
                  <a:gd name="connsiteX3" fmla="*/ 28576 w 1345602"/>
                  <a:gd name="connsiteY3" fmla="*/ 327022 h 1942972"/>
                  <a:gd name="connsiteX0" fmla="*/ 0 w 1345602"/>
                  <a:gd name="connsiteY0" fmla="*/ 0 h 1942972"/>
                  <a:gd name="connsiteX1" fmla="*/ 1345602 w 1345602"/>
                  <a:gd name="connsiteY1" fmla="*/ 1131660 h 1942972"/>
                  <a:gd name="connsiteX0" fmla="*/ 28576 w 1345602"/>
                  <a:gd name="connsiteY0" fmla="*/ 327022 h 1942972"/>
                  <a:gd name="connsiteX1" fmla="*/ 1345602 w 1345602"/>
                  <a:gd name="connsiteY1" fmla="*/ 1131660 h 1942972"/>
                  <a:gd name="connsiteX2" fmla="*/ 28577 w 1345602"/>
                  <a:gd name="connsiteY2" fmla="*/ 1942972 h 1942972"/>
                  <a:gd name="connsiteX3" fmla="*/ 28576 w 1345602"/>
                  <a:gd name="connsiteY3" fmla="*/ 327022 h 1942972"/>
                  <a:gd name="connsiteX0" fmla="*/ 0 w 1345602"/>
                  <a:gd name="connsiteY0" fmla="*/ 0 h 1942972"/>
                  <a:gd name="connsiteX1" fmla="*/ 1345602 w 1345602"/>
                  <a:gd name="connsiteY1" fmla="*/ 1131660 h 1942972"/>
                  <a:gd name="connsiteX0" fmla="*/ 28576 w 1351952"/>
                  <a:gd name="connsiteY0" fmla="*/ 327022 h 1942972"/>
                  <a:gd name="connsiteX1" fmla="*/ 1345602 w 1351952"/>
                  <a:gd name="connsiteY1" fmla="*/ 1131660 h 1942972"/>
                  <a:gd name="connsiteX2" fmla="*/ 28577 w 1351952"/>
                  <a:gd name="connsiteY2" fmla="*/ 1942972 h 1942972"/>
                  <a:gd name="connsiteX3" fmla="*/ 28576 w 1351952"/>
                  <a:gd name="connsiteY3" fmla="*/ 327022 h 1942972"/>
                  <a:gd name="connsiteX0" fmla="*/ 0 w 1351952"/>
                  <a:gd name="connsiteY0" fmla="*/ 0 h 1942972"/>
                  <a:gd name="connsiteX1" fmla="*/ 1351952 w 1351952"/>
                  <a:gd name="connsiteY1" fmla="*/ 1138010 h 1942972"/>
                  <a:gd name="connsiteX0" fmla="*/ 28576 w 1351952"/>
                  <a:gd name="connsiteY0" fmla="*/ 327022 h 1942972"/>
                  <a:gd name="connsiteX1" fmla="*/ 1345602 w 1351952"/>
                  <a:gd name="connsiteY1" fmla="*/ 1131660 h 1942972"/>
                  <a:gd name="connsiteX2" fmla="*/ 28577 w 1351952"/>
                  <a:gd name="connsiteY2" fmla="*/ 1942972 h 1942972"/>
                  <a:gd name="connsiteX3" fmla="*/ 28576 w 1351952"/>
                  <a:gd name="connsiteY3" fmla="*/ 327022 h 1942972"/>
                  <a:gd name="connsiteX0" fmla="*/ 0 w 1351952"/>
                  <a:gd name="connsiteY0" fmla="*/ 0 h 1942972"/>
                  <a:gd name="connsiteX1" fmla="*/ 1351952 w 1351952"/>
                  <a:gd name="connsiteY1" fmla="*/ 1138010 h 194297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351952" h="1942972" stroke="0" extrusionOk="0">
                    <a:moveTo>
                      <a:pt x="28576" y="327022"/>
                    </a:moveTo>
                    <a:cubicBezTo>
                      <a:pt x="571348" y="327022"/>
                      <a:pt x="1073095" y="633565"/>
                      <a:pt x="1345602" y="1131660"/>
                    </a:cubicBezTo>
                    <a:lnTo>
                      <a:pt x="28577" y="1942972"/>
                    </a:lnTo>
                    <a:cubicBezTo>
                      <a:pt x="28577" y="1404322"/>
                      <a:pt x="28576" y="865672"/>
                      <a:pt x="28576" y="327022"/>
                    </a:cubicBezTo>
                    <a:close/>
                  </a:path>
                  <a:path w="1351952" h="1942972" fill="none">
                    <a:moveTo>
                      <a:pt x="0" y="0"/>
                    </a:moveTo>
                    <a:cubicBezTo>
                      <a:pt x="437997" y="206375"/>
                      <a:pt x="1073095" y="658965"/>
                      <a:pt x="1351952" y="1138010"/>
                    </a:cubicBezTo>
                  </a:path>
                </a:pathLst>
              </a:custGeom>
              <a:ln w="3175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4" name="Arc 61">
                <a:extLst>
                  <a:ext uri="{FF2B5EF4-FFF2-40B4-BE49-F238E27FC236}">
                    <a16:creationId xmlns:a16="http://schemas.microsoft.com/office/drawing/2014/main" id="{0B12573B-E6C9-D530-52B8-70EA96EBE404}"/>
                  </a:ext>
                </a:extLst>
              </p:cNvPr>
              <p:cNvSpPr/>
              <p:nvPr/>
            </p:nvSpPr>
            <p:spPr>
              <a:xfrm rot="21219792">
                <a:off x="6940030" y="258812"/>
                <a:ext cx="1246880" cy="1280282"/>
              </a:xfrm>
              <a:custGeom>
                <a:avLst/>
                <a:gdLst>
                  <a:gd name="connsiteX0" fmla="*/ 1522872 w 3045745"/>
                  <a:gd name="connsiteY0" fmla="*/ 0 h 3231900"/>
                  <a:gd name="connsiteX1" fmla="*/ 2839898 w 3045745"/>
                  <a:gd name="connsiteY1" fmla="*/ 804638 h 3231900"/>
                  <a:gd name="connsiteX2" fmla="*/ 1522873 w 3045745"/>
                  <a:gd name="connsiteY2" fmla="*/ 1615950 h 3231900"/>
                  <a:gd name="connsiteX3" fmla="*/ 1522872 w 3045745"/>
                  <a:gd name="connsiteY3" fmla="*/ 0 h 3231900"/>
                  <a:gd name="connsiteX0" fmla="*/ 1522872 w 3045745"/>
                  <a:gd name="connsiteY0" fmla="*/ 0 h 3231900"/>
                  <a:gd name="connsiteX1" fmla="*/ 2839898 w 3045745"/>
                  <a:gd name="connsiteY1" fmla="*/ 804638 h 3231900"/>
                  <a:gd name="connsiteX0" fmla="*/ 0 w 1499212"/>
                  <a:gd name="connsiteY0" fmla="*/ 0 h 1615950"/>
                  <a:gd name="connsiteX1" fmla="*/ 1317026 w 1499212"/>
                  <a:gd name="connsiteY1" fmla="*/ 804638 h 1615950"/>
                  <a:gd name="connsiteX2" fmla="*/ 1 w 1499212"/>
                  <a:gd name="connsiteY2" fmla="*/ 1615950 h 1615950"/>
                  <a:gd name="connsiteX3" fmla="*/ 0 w 1499212"/>
                  <a:gd name="connsiteY3" fmla="*/ 0 h 1615950"/>
                  <a:gd name="connsiteX0" fmla="*/ 0 w 1499212"/>
                  <a:gd name="connsiteY0" fmla="*/ 0 h 1615950"/>
                  <a:gd name="connsiteX1" fmla="*/ 1499212 w 1499212"/>
                  <a:gd name="connsiteY1" fmla="*/ 615307 h 1615950"/>
                  <a:gd name="connsiteX0" fmla="*/ 9012 w 1508224"/>
                  <a:gd name="connsiteY0" fmla="*/ 202703 h 1818653"/>
                  <a:gd name="connsiteX1" fmla="*/ 1326038 w 1508224"/>
                  <a:gd name="connsiteY1" fmla="*/ 1007341 h 1818653"/>
                  <a:gd name="connsiteX2" fmla="*/ 9013 w 1508224"/>
                  <a:gd name="connsiteY2" fmla="*/ 1818653 h 1818653"/>
                  <a:gd name="connsiteX3" fmla="*/ 9012 w 1508224"/>
                  <a:gd name="connsiteY3" fmla="*/ 202703 h 1818653"/>
                  <a:gd name="connsiteX0" fmla="*/ 0 w 1508224"/>
                  <a:gd name="connsiteY0" fmla="*/ 0 h 1818653"/>
                  <a:gd name="connsiteX1" fmla="*/ 1508224 w 1508224"/>
                  <a:gd name="connsiteY1" fmla="*/ 818010 h 1818653"/>
                  <a:gd name="connsiteX0" fmla="*/ 9012 w 1754657"/>
                  <a:gd name="connsiteY0" fmla="*/ 202703 h 1818653"/>
                  <a:gd name="connsiteX1" fmla="*/ 1326038 w 1754657"/>
                  <a:gd name="connsiteY1" fmla="*/ 1007341 h 1818653"/>
                  <a:gd name="connsiteX2" fmla="*/ 9013 w 1754657"/>
                  <a:gd name="connsiteY2" fmla="*/ 1818653 h 1818653"/>
                  <a:gd name="connsiteX3" fmla="*/ 9012 w 1754657"/>
                  <a:gd name="connsiteY3" fmla="*/ 202703 h 1818653"/>
                  <a:gd name="connsiteX0" fmla="*/ 0 w 1754657"/>
                  <a:gd name="connsiteY0" fmla="*/ 0 h 1818653"/>
                  <a:gd name="connsiteX1" fmla="*/ 1754657 w 1754657"/>
                  <a:gd name="connsiteY1" fmla="*/ 925792 h 1818653"/>
                  <a:gd name="connsiteX0" fmla="*/ 82588 w 1828233"/>
                  <a:gd name="connsiteY0" fmla="*/ 334834 h 1950784"/>
                  <a:gd name="connsiteX1" fmla="*/ 1399614 w 1828233"/>
                  <a:gd name="connsiteY1" fmla="*/ 1139472 h 1950784"/>
                  <a:gd name="connsiteX2" fmla="*/ 82589 w 1828233"/>
                  <a:gd name="connsiteY2" fmla="*/ 1950784 h 1950784"/>
                  <a:gd name="connsiteX3" fmla="*/ 82588 w 1828233"/>
                  <a:gd name="connsiteY3" fmla="*/ 334834 h 1950784"/>
                  <a:gd name="connsiteX0" fmla="*/ 0 w 1828233"/>
                  <a:gd name="connsiteY0" fmla="*/ 0 h 1950784"/>
                  <a:gd name="connsiteX1" fmla="*/ 1828233 w 1828233"/>
                  <a:gd name="connsiteY1" fmla="*/ 1057923 h 1950784"/>
                  <a:gd name="connsiteX0" fmla="*/ 82588 w 1806935"/>
                  <a:gd name="connsiteY0" fmla="*/ 334834 h 1950784"/>
                  <a:gd name="connsiteX1" fmla="*/ 1399614 w 1806935"/>
                  <a:gd name="connsiteY1" fmla="*/ 1139472 h 1950784"/>
                  <a:gd name="connsiteX2" fmla="*/ 82589 w 1806935"/>
                  <a:gd name="connsiteY2" fmla="*/ 1950784 h 1950784"/>
                  <a:gd name="connsiteX3" fmla="*/ 82588 w 1806935"/>
                  <a:gd name="connsiteY3" fmla="*/ 334834 h 1950784"/>
                  <a:gd name="connsiteX0" fmla="*/ 0 w 1806935"/>
                  <a:gd name="connsiteY0" fmla="*/ 0 h 1950784"/>
                  <a:gd name="connsiteX1" fmla="*/ 1806935 w 1806935"/>
                  <a:gd name="connsiteY1" fmla="*/ 942130 h 1950784"/>
                  <a:gd name="connsiteX0" fmla="*/ 76578 w 1800925"/>
                  <a:gd name="connsiteY0" fmla="*/ 385715 h 2001665"/>
                  <a:gd name="connsiteX1" fmla="*/ 1393604 w 1800925"/>
                  <a:gd name="connsiteY1" fmla="*/ 1190353 h 2001665"/>
                  <a:gd name="connsiteX2" fmla="*/ 76579 w 1800925"/>
                  <a:gd name="connsiteY2" fmla="*/ 2001665 h 2001665"/>
                  <a:gd name="connsiteX3" fmla="*/ 76578 w 1800925"/>
                  <a:gd name="connsiteY3" fmla="*/ 385715 h 2001665"/>
                  <a:gd name="connsiteX0" fmla="*/ -1 w 1800925"/>
                  <a:gd name="connsiteY0" fmla="*/ 0 h 2001665"/>
                  <a:gd name="connsiteX1" fmla="*/ 1800925 w 1800925"/>
                  <a:gd name="connsiteY1" fmla="*/ 993011 h 2001665"/>
                  <a:gd name="connsiteX0" fmla="*/ 76579 w 1800926"/>
                  <a:gd name="connsiteY0" fmla="*/ 385715 h 2001665"/>
                  <a:gd name="connsiteX1" fmla="*/ 1527326 w 1800926"/>
                  <a:gd name="connsiteY1" fmla="*/ 1159779 h 2001665"/>
                  <a:gd name="connsiteX2" fmla="*/ 76580 w 1800926"/>
                  <a:gd name="connsiteY2" fmla="*/ 2001665 h 2001665"/>
                  <a:gd name="connsiteX3" fmla="*/ 76579 w 1800926"/>
                  <a:gd name="connsiteY3" fmla="*/ 385715 h 2001665"/>
                  <a:gd name="connsiteX0" fmla="*/ 0 w 1800926"/>
                  <a:gd name="connsiteY0" fmla="*/ 0 h 2001665"/>
                  <a:gd name="connsiteX1" fmla="*/ 1800926 w 1800926"/>
                  <a:gd name="connsiteY1" fmla="*/ 993011 h 2001665"/>
                  <a:gd name="connsiteX0" fmla="*/ 76579 w 1800926"/>
                  <a:gd name="connsiteY0" fmla="*/ 385715 h 2001665"/>
                  <a:gd name="connsiteX1" fmla="*/ 1595713 w 1800926"/>
                  <a:gd name="connsiteY1" fmla="*/ 1113801 h 2001665"/>
                  <a:gd name="connsiteX2" fmla="*/ 76580 w 1800926"/>
                  <a:gd name="connsiteY2" fmla="*/ 2001665 h 2001665"/>
                  <a:gd name="connsiteX3" fmla="*/ 76579 w 1800926"/>
                  <a:gd name="connsiteY3" fmla="*/ 385715 h 2001665"/>
                  <a:gd name="connsiteX0" fmla="*/ 0 w 1800926"/>
                  <a:gd name="connsiteY0" fmla="*/ 0 h 2001665"/>
                  <a:gd name="connsiteX1" fmla="*/ 1800926 w 1800926"/>
                  <a:gd name="connsiteY1" fmla="*/ 993011 h 2001665"/>
                  <a:gd name="connsiteX0" fmla="*/ 13442 w 1800926"/>
                  <a:gd name="connsiteY0" fmla="*/ 209577 h 2001665"/>
                  <a:gd name="connsiteX1" fmla="*/ 1595713 w 1800926"/>
                  <a:gd name="connsiteY1" fmla="*/ 1113801 h 2001665"/>
                  <a:gd name="connsiteX2" fmla="*/ 76580 w 1800926"/>
                  <a:gd name="connsiteY2" fmla="*/ 2001665 h 2001665"/>
                  <a:gd name="connsiteX3" fmla="*/ 13442 w 1800926"/>
                  <a:gd name="connsiteY3" fmla="*/ 209577 h 2001665"/>
                  <a:gd name="connsiteX0" fmla="*/ 0 w 1800926"/>
                  <a:gd name="connsiteY0" fmla="*/ 0 h 2001665"/>
                  <a:gd name="connsiteX1" fmla="*/ 1800926 w 1800926"/>
                  <a:gd name="connsiteY1" fmla="*/ 993011 h 2001665"/>
                  <a:gd name="connsiteX0" fmla="*/ 13442 w 1888100"/>
                  <a:gd name="connsiteY0" fmla="*/ 209577 h 2001665"/>
                  <a:gd name="connsiteX1" fmla="*/ 1595713 w 1888100"/>
                  <a:gd name="connsiteY1" fmla="*/ 1113801 h 2001665"/>
                  <a:gd name="connsiteX2" fmla="*/ 76580 w 1888100"/>
                  <a:gd name="connsiteY2" fmla="*/ 2001665 h 2001665"/>
                  <a:gd name="connsiteX3" fmla="*/ 13442 w 1888100"/>
                  <a:gd name="connsiteY3" fmla="*/ 209577 h 2001665"/>
                  <a:gd name="connsiteX0" fmla="*/ 0 w 1888100"/>
                  <a:gd name="connsiteY0" fmla="*/ 0 h 2001665"/>
                  <a:gd name="connsiteX1" fmla="*/ 1888101 w 1888100"/>
                  <a:gd name="connsiteY1" fmla="*/ 965627 h 2001665"/>
                  <a:gd name="connsiteX0" fmla="*/ 39099 w 1913758"/>
                  <a:gd name="connsiteY0" fmla="*/ 276641 h 2068729"/>
                  <a:gd name="connsiteX1" fmla="*/ 1621370 w 1913758"/>
                  <a:gd name="connsiteY1" fmla="*/ 1180865 h 2068729"/>
                  <a:gd name="connsiteX2" fmla="*/ 102237 w 1913758"/>
                  <a:gd name="connsiteY2" fmla="*/ 2068729 h 2068729"/>
                  <a:gd name="connsiteX3" fmla="*/ 39099 w 1913758"/>
                  <a:gd name="connsiteY3" fmla="*/ 276641 h 2068729"/>
                  <a:gd name="connsiteX0" fmla="*/ 1 w 1913758"/>
                  <a:gd name="connsiteY0" fmla="*/ 0 h 2068729"/>
                  <a:gd name="connsiteX1" fmla="*/ 1913758 w 1913758"/>
                  <a:gd name="connsiteY1" fmla="*/ 1032691 h 2068729"/>
                  <a:gd name="connsiteX0" fmla="*/ 39098 w 1995424"/>
                  <a:gd name="connsiteY0" fmla="*/ 276641 h 2068729"/>
                  <a:gd name="connsiteX1" fmla="*/ 1621369 w 1995424"/>
                  <a:gd name="connsiteY1" fmla="*/ 1180865 h 2068729"/>
                  <a:gd name="connsiteX2" fmla="*/ 102236 w 1995424"/>
                  <a:gd name="connsiteY2" fmla="*/ 2068729 h 2068729"/>
                  <a:gd name="connsiteX3" fmla="*/ 39098 w 1995424"/>
                  <a:gd name="connsiteY3" fmla="*/ 276641 h 2068729"/>
                  <a:gd name="connsiteX0" fmla="*/ 0 w 1995424"/>
                  <a:gd name="connsiteY0" fmla="*/ 0 h 2068729"/>
                  <a:gd name="connsiteX1" fmla="*/ 1995425 w 1995424"/>
                  <a:gd name="connsiteY1" fmla="*/ 1051949 h 2068729"/>
                  <a:gd name="connsiteX0" fmla="*/ 14895 w 1971223"/>
                  <a:gd name="connsiteY0" fmla="*/ 326091 h 2118179"/>
                  <a:gd name="connsiteX1" fmla="*/ 1597166 w 1971223"/>
                  <a:gd name="connsiteY1" fmla="*/ 1230315 h 2118179"/>
                  <a:gd name="connsiteX2" fmla="*/ 78033 w 1971223"/>
                  <a:gd name="connsiteY2" fmla="*/ 2118179 h 2118179"/>
                  <a:gd name="connsiteX3" fmla="*/ 14895 w 1971223"/>
                  <a:gd name="connsiteY3" fmla="*/ 326091 h 2118179"/>
                  <a:gd name="connsiteX0" fmla="*/ -1 w 1971223"/>
                  <a:gd name="connsiteY0" fmla="*/ 0 h 2118179"/>
                  <a:gd name="connsiteX1" fmla="*/ 1971222 w 1971223"/>
                  <a:gd name="connsiteY1" fmla="*/ 1101399 h 2118179"/>
                  <a:gd name="connsiteX0" fmla="*/ 14896 w 2060311"/>
                  <a:gd name="connsiteY0" fmla="*/ 326091 h 2118179"/>
                  <a:gd name="connsiteX1" fmla="*/ 1597167 w 2060311"/>
                  <a:gd name="connsiteY1" fmla="*/ 1230315 h 2118179"/>
                  <a:gd name="connsiteX2" fmla="*/ 78034 w 2060311"/>
                  <a:gd name="connsiteY2" fmla="*/ 2118179 h 2118179"/>
                  <a:gd name="connsiteX3" fmla="*/ 14896 w 2060311"/>
                  <a:gd name="connsiteY3" fmla="*/ 326091 h 2118179"/>
                  <a:gd name="connsiteX0" fmla="*/ 0 w 2060311"/>
                  <a:gd name="connsiteY0" fmla="*/ 0 h 2118179"/>
                  <a:gd name="connsiteX1" fmla="*/ 2060311 w 2060311"/>
                  <a:gd name="connsiteY1" fmla="*/ 1124449 h 2118179"/>
                  <a:gd name="connsiteX0" fmla="*/ 68037 w 2113452"/>
                  <a:gd name="connsiteY0" fmla="*/ 386970 h 2179058"/>
                  <a:gd name="connsiteX1" fmla="*/ 1650308 w 2113452"/>
                  <a:gd name="connsiteY1" fmla="*/ 1291194 h 2179058"/>
                  <a:gd name="connsiteX2" fmla="*/ 131175 w 2113452"/>
                  <a:gd name="connsiteY2" fmla="*/ 2179058 h 2179058"/>
                  <a:gd name="connsiteX3" fmla="*/ 68037 w 2113452"/>
                  <a:gd name="connsiteY3" fmla="*/ 386970 h 2179058"/>
                  <a:gd name="connsiteX0" fmla="*/ 0 w 2113452"/>
                  <a:gd name="connsiteY0" fmla="*/ 0 h 2179058"/>
                  <a:gd name="connsiteX1" fmla="*/ 2113452 w 2113452"/>
                  <a:gd name="connsiteY1" fmla="*/ 1185328 h 2179058"/>
                  <a:gd name="connsiteX0" fmla="*/ 68037 w 2202540"/>
                  <a:gd name="connsiteY0" fmla="*/ 386970 h 2179058"/>
                  <a:gd name="connsiteX1" fmla="*/ 1650308 w 2202540"/>
                  <a:gd name="connsiteY1" fmla="*/ 1291194 h 2179058"/>
                  <a:gd name="connsiteX2" fmla="*/ 131175 w 2202540"/>
                  <a:gd name="connsiteY2" fmla="*/ 2179058 h 2179058"/>
                  <a:gd name="connsiteX3" fmla="*/ 68037 w 2202540"/>
                  <a:gd name="connsiteY3" fmla="*/ 386970 h 2179058"/>
                  <a:gd name="connsiteX0" fmla="*/ 0 w 2202540"/>
                  <a:gd name="connsiteY0" fmla="*/ 0 h 2179058"/>
                  <a:gd name="connsiteX1" fmla="*/ 2202540 w 2202540"/>
                  <a:gd name="connsiteY1" fmla="*/ 1208377 h 2179058"/>
                  <a:gd name="connsiteX0" fmla="*/ 108184 w 2242687"/>
                  <a:gd name="connsiteY0" fmla="*/ 446827 h 2238915"/>
                  <a:gd name="connsiteX1" fmla="*/ 1690455 w 2242687"/>
                  <a:gd name="connsiteY1" fmla="*/ 1351051 h 2238915"/>
                  <a:gd name="connsiteX2" fmla="*/ 171322 w 2242687"/>
                  <a:gd name="connsiteY2" fmla="*/ 2238915 h 2238915"/>
                  <a:gd name="connsiteX3" fmla="*/ 108184 w 2242687"/>
                  <a:gd name="connsiteY3" fmla="*/ 446827 h 2238915"/>
                  <a:gd name="connsiteX0" fmla="*/ 0 w 2242687"/>
                  <a:gd name="connsiteY0" fmla="*/ 0 h 2238915"/>
                  <a:gd name="connsiteX1" fmla="*/ 2242687 w 2242687"/>
                  <a:gd name="connsiteY1" fmla="*/ 1268234 h 2238915"/>
                  <a:gd name="connsiteX0" fmla="*/ 108184 w 2242687"/>
                  <a:gd name="connsiteY0" fmla="*/ 446827 h 2238915"/>
                  <a:gd name="connsiteX1" fmla="*/ 1690455 w 2242687"/>
                  <a:gd name="connsiteY1" fmla="*/ 1351051 h 2238915"/>
                  <a:gd name="connsiteX2" fmla="*/ 171322 w 2242687"/>
                  <a:gd name="connsiteY2" fmla="*/ 2238915 h 2238915"/>
                  <a:gd name="connsiteX3" fmla="*/ 108184 w 2242687"/>
                  <a:gd name="connsiteY3" fmla="*/ 446827 h 2238915"/>
                  <a:gd name="connsiteX0" fmla="*/ 0 w 2242687"/>
                  <a:gd name="connsiteY0" fmla="*/ 0 h 2238915"/>
                  <a:gd name="connsiteX1" fmla="*/ 2242687 w 2242687"/>
                  <a:gd name="connsiteY1" fmla="*/ 1268234 h 2238915"/>
                  <a:gd name="connsiteX0" fmla="*/ 108184 w 2242687"/>
                  <a:gd name="connsiteY0" fmla="*/ 446827 h 2238915"/>
                  <a:gd name="connsiteX1" fmla="*/ 1690455 w 2242687"/>
                  <a:gd name="connsiteY1" fmla="*/ 1351051 h 2238915"/>
                  <a:gd name="connsiteX2" fmla="*/ 171322 w 2242687"/>
                  <a:gd name="connsiteY2" fmla="*/ 2238915 h 2238915"/>
                  <a:gd name="connsiteX3" fmla="*/ 108184 w 2242687"/>
                  <a:gd name="connsiteY3" fmla="*/ 446827 h 2238915"/>
                  <a:gd name="connsiteX0" fmla="*/ 0 w 2242687"/>
                  <a:gd name="connsiteY0" fmla="*/ 0 h 2238915"/>
                  <a:gd name="connsiteX1" fmla="*/ 2242687 w 2242687"/>
                  <a:gd name="connsiteY1" fmla="*/ 1268234 h 2238915"/>
                  <a:gd name="connsiteX0" fmla="*/ 108184 w 2324441"/>
                  <a:gd name="connsiteY0" fmla="*/ 446827 h 2238915"/>
                  <a:gd name="connsiteX1" fmla="*/ 1690455 w 2324441"/>
                  <a:gd name="connsiteY1" fmla="*/ 1351051 h 2238915"/>
                  <a:gd name="connsiteX2" fmla="*/ 171322 w 2324441"/>
                  <a:gd name="connsiteY2" fmla="*/ 2238915 h 2238915"/>
                  <a:gd name="connsiteX3" fmla="*/ 108184 w 2324441"/>
                  <a:gd name="connsiteY3" fmla="*/ 446827 h 2238915"/>
                  <a:gd name="connsiteX0" fmla="*/ 0 w 2324441"/>
                  <a:gd name="connsiteY0" fmla="*/ 0 h 2238915"/>
                  <a:gd name="connsiteX1" fmla="*/ 2324441 w 2324441"/>
                  <a:gd name="connsiteY1" fmla="*/ 1326596 h 2238915"/>
                  <a:gd name="connsiteX0" fmla="*/ 78208 w 2294465"/>
                  <a:gd name="connsiteY0" fmla="*/ 734167 h 2526255"/>
                  <a:gd name="connsiteX1" fmla="*/ 1660479 w 2294465"/>
                  <a:gd name="connsiteY1" fmla="*/ 1638391 h 2526255"/>
                  <a:gd name="connsiteX2" fmla="*/ 141346 w 2294465"/>
                  <a:gd name="connsiteY2" fmla="*/ 2526255 h 2526255"/>
                  <a:gd name="connsiteX3" fmla="*/ 78208 w 2294465"/>
                  <a:gd name="connsiteY3" fmla="*/ 734167 h 2526255"/>
                  <a:gd name="connsiteX0" fmla="*/ 0 w 2294465"/>
                  <a:gd name="connsiteY0" fmla="*/ 0 h 2526255"/>
                  <a:gd name="connsiteX1" fmla="*/ 2294465 w 2294465"/>
                  <a:gd name="connsiteY1" fmla="*/ 1613936 h 2526255"/>
                  <a:gd name="connsiteX0" fmla="*/ 32713 w 2248970"/>
                  <a:gd name="connsiteY0" fmla="*/ 841829 h 2633917"/>
                  <a:gd name="connsiteX1" fmla="*/ 1614984 w 2248970"/>
                  <a:gd name="connsiteY1" fmla="*/ 1746053 h 2633917"/>
                  <a:gd name="connsiteX2" fmla="*/ 95851 w 2248970"/>
                  <a:gd name="connsiteY2" fmla="*/ 2633917 h 2633917"/>
                  <a:gd name="connsiteX3" fmla="*/ 32713 w 2248970"/>
                  <a:gd name="connsiteY3" fmla="*/ 841829 h 2633917"/>
                  <a:gd name="connsiteX0" fmla="*/ 1 w 2248970"/>
                  <a:gd name="connsiteY0" fmla="*/ 0 h 2633917"/>
                  <a:gd name="connsiteX1" fmla="*/ 2248970 w 2248970"/>
                  <a:gd name="connsiteY1" fmla="*/ 1721598 h 2633917"/>
                  <a:gd name="connsiteX0" fmla="*/ 32711 w 2248968"/>
                  <a:gd name="connsiteY0" fmla="*/ 841829 h 2633917"/>
                  <a:gd name="connsiteX1" fmla="*/ 1614982 w 2248968"/>
                  <a:gd name="connsiteY1" fmla="*/ 1746053 h 2633917"/>
                  <a:gd name="connsiteX2" fmla="*/ 95849 w 2248968"/>
                  <a:gd name="connsiteY2" fmla="*/ 2633917 h 2633917"/>
                  <a:gd name="connsiteX3" fmla="*/ 32711 w 2248968"/>
                  <a:gd name="connsiteY3" fmla="*/ 841829 h 2633917"/>
                  <a:gd name="connsiteX0" fmla="*/ -1 w 2248968"/>
                  <a:gd name="connsiteY0" fmla="*/ 0 h 2633917"/>
                  <a:gd name="connsiteX1" fmla="*/ 2248968 w 2248968"/>
                  <a:gd name="connsiteY1" fmla="*/ 1721598 h 2633917"/>
                  <a:gd name="connsiteX0" fmla="*/ 32713 w 2248970"/>
                  <a:gd name="connsiteY0" fmla="*/ 841829 h 2633917"/>
                  <a:gd name="connsiteX1" fmla="*/ 1614984 w 2248970"/>
                  <a:gd name="connsiteY1" fmla="*/ 1746053 h 2633917"/>
                  <a:gd name="connsiteX2" fmla="*/ 95851 w 2248970"/>
                  <a:gd name="connsiteY2" fmla="*/ 2633917 h 2633917"/>
                  <a:gd name="connsiteX3" fmla="*/ 32713 w 2248970"/>
                  <a:gd name="connsiteY3" fmla="*/ 841829 h 2633917"/>
                  <a:gd name="connsiteX0" fmla="*/ 1 w 2248970"/>
                  <a:gd name="connsiteY0" fmla="*/ 0 h 2633917"/>
                  <a:gd name="connsiteX1" fmla="*/ 2248970 w 2248970"/>
                  <a:gd name="connsiteY1" fmla="*/ 1721598 h 2633917"/>
                  <a:gd name="connsiteX0" fmla="*/ 32711 w 2284412"/>
                  <a:gd name="connsiteY0" fmla="*/ 841829 h 2633917"/>
                  <a:gd name="connsiteX1" fmla="*/ 1614982 w 2284412"/>
                  <a:gd name="connsiteY1" fmla="*/ 1746053 h 2633917"/>
                  <a:gd name="connsiteX2" fmla="*/ 95849 w 2284412"/>
                  <a:gd name="connsiteY2" fmla="*/ 2633917 h 2633917"/>
                  <a:gd name="connsiteX3" fmla="*/ 32711 w 2284412"/>
                  <a:gd name="connsiteY3" fmla="*/ 841829 h 2633917"/>
                  <a:gd name="connsiteX0" fmla="*/ -1 w 2284412"/>
                  <a:gd name="connsiteY0" fmla="*/ 0 h 2633917"/>
                  <a:gd name="connsiteX1" fmla="*/ 2284411 w 2284412"/>
                  <a:gd name="connsiteY1" fmla="*/ 1716186 h 2633917"/>
                  <a:gd name="connsiteX0" fmla="*/ 32713 w 2284412"/>
                  <a:gd name="connsiteY0" fmla="*/ 841829 h 2633917"/>
                  <a:gd name="connsiteX1" fmla="*/ 1614984 w 2284412"/>
                  <a:gd name="connsiteY1" fmla="*/ 1746053 h 2633917"/>
                  <a:gd name="connsiteX2" fmla="*/ 95851 w 2284412"/>
                  <a:gd name="connsiteY2" fmla="*/ 2633917 h 2633917"/>
                  <a:gd name="connsiteX3" fmla="*/ 32713 w 2284412"/>
                  <a:gd name="connsiteY3" fmla="*/ 841829 h 2633917"/>
                  <a:gd name="connsiteX0" fmla="*/ 1 w 2284412"/>
                  <a:gd name="connsiteY0" fmla="*/ 0 h 2633917"/>
                  <a:gd name="connsiteX1" fmla="*/ 2284413 w 2284412"/>
                  <a:gd name="connsiteY1" fmla="*/ 1716186 h 2633917"/>
                  <a:gd name="connsiteX0" fmla="*/ 32711 w 2284412"/>
                  <a:gd name="connsiteY0" fmla="*/ 841829 h 2633917"/>
                  <a:gd name="connsiteX1" fmla="*/ 1614982 w 2284412"/>
                  <a:gd name="connsiteY1" fmla="*/ 1746053 h 2633917"/>
                  <a:gd name="connsiteX2" fmla="*/ 95849 w 2284412"/>
                  <a:gd name="connsiteY2" fmla="*/ 2633917 h 2633917"/>
                  <a:gd name="connsiteX3" fmla="*/ 32711 w 2284412"/>
                  <a:gd name="connsiteY3" fmla="*/ 841829 h 2633917"/>
                  <a:gd name="connsiteX0" fmla="*/ -1 w 2284412"/>
                  <a:gd name="connsiteY0" fmla="*/ 0 h 2633917"/>
                  <a:gd name="connsiteX1" fmla="*/ 2284411 w 2284412"/>
                  <a:gd name="connsiteY1" fmla="*/ 1716186 h 2633917"/>
                  <a:gd name="connsiteX0" fmla="*/ 32713 w 2244182"/>
                  <a:gd name="connsiteY0" fmla="*/ 841829 h 2633917"/>
                  <a:gd name="connsiteX1" fmla="*/ 1614984 w 2244182"/>
                  <a:gd name="connsiteY1" fmla="*/ 1746053 h 2633917"/>
                  <a:gd name="connsiteX2" fmla="*/ 95851 w 2244182"/>
                  <a:gd name="connsiteY2" fmla="*/ 2633917 h 2633917"/>
                  <a:gd name="connsiteX3" fmla="*/ 32713 w 2244182"/>
                  <a:gd name="connsiteY3" fmla="*/ 841829 h 2633917"/>
                  <a:gd name="connsiteX0" fmla="*/ 1 w 2244182"/>
                  <a:gd name="connsiteY0" fmla="*/ 0 h 2633917"/>
                  <a:gd name="connsiteX1" fmla="*/ 2244182 w 2244182"/>
                  <a:gd name="connsiteY1" fmla="*/ 1725925 h 2633917"/>
                  <a:gd name="connsiteX0" fmla="*/ 32711 w 2244180"/>
                  <a:gd name="connsiteY0" fmla="*/ 841829 h 2633917"/>
                  <a:gd name="connsiteX1" fmla="*/ 1614982 w 2244180"/>
                  <a:gd name="connsiteY1" fmla="*/ 1746053 h 2633917"/>
                  <a:gd name="connsiteX2" fmla="*/ 95849 w 2244180"/>
                  <a:gd name="connsiteY2" fmla="*/ 2633917 h 2633917"/>
                  <a:gd name="connsiteX3" fmla="*/ 32711 w 2244180"/>
                  <a:gd name="connsiteY3" fmla="*/ 841829 h 2633917"/>
                  <a:gd name="connsiteX0" fmla="*/ -1 w 2244180"/>
                  <a:gd name="connsiteY0" fmla="*/ 0 h 2633917"/>
                  <a:gd name="connsiteX1" fmla="*/ 2244180 w 2244180"/>
                  <a:gd name="connsiteY1" fmla="*/ 1725925 h 2633917"/>
                  <a:gd name="connsiteX0" fmla="*/ 32713 w 2244182"/>
                  <a:gd name="connsiteY0" fmla="*/ 841829 h 2633917"/>
                  <a:gd name="connsiteX1" fmla="*/ 1614984 w 2244182"/>
                  <a:gd name="connsiteY1" fmla="*/ 1746053 h 2633917"/>
                  <a:gd name="connsiteX2" fmla="*/ 95851 w 2244182"/>
                  <a:gd name="connsiteY2" fmla="*/ 2633917 h 2633917"/>
                  <a:gd name="connsiteX3" fmla="*/ 32713 w 2244182"/>
                  <a:gd name="connsiteY3" fmla="*/ 841829 h 2633917"/>
                  <a:gd name="connsiteX0" fmla="*/ 1 w 2244182"/>
                  <a:gd name="connsiteY0" fmla="*/ 0 h 2633917"/>
                  <a:gd name="connsiteX1" fmla="*/ 2244182 w 2244182"/>
                  <a:gd name="connsiteY1" fmla="*/ 1725925 h 2633917"/>
                  <a:gd name="connsiteX0" fmla="*/ 32711 w 2270999"/>
                  <a:gd name="connsiteY0" fmla="*/ 841829 h 2633917"/>
                  <a:gd name="connsiteX1" fmla="*/ 1614982 w 2270999"/>
                  <a:gd name="connsiteY1" fmla="*/ 1746053 h 2633917"/>
                  <a:gd name="connsiteX2" fmla="*/ 95849 w 2270999"/>
                  <a:gd name="connsiteY2" fmla="*/ 2633917 h 2633917"/>
                  <a:gd name="connsiteX3" fmla="*/ 32711 w 2270999"/>
                  <a:gd name="connsiteY3" fmla="*/ 841829 h 2633917"/>
                  <a:gd name="connsiteX0" fmla="*/ -1 w 2270999"/>
                  <a:gd name="connsiteY0" fmla="*/ 0 h 2633917"/>
                  <a:gd name="connsiteX1" fmla="*/ 2271000 w 2270999"/>
                  <a:gd name="connsiteY1" fmla="*/ 1719431 h 2633917"/>
                  <a:gd name="connsiteX0" fmla="*/ 32713 w 2271003"/>
                  <a:gd name="connsiteY0" fmla="*/ 841829 h 2633917"/>
                  <a:gd name="connsiteX1" fmla="*/ 1614984 w 2271003"/>
                  <a:gd name="connsiteY1" fmla="*/ 1746053 h 2633917"/>
                  <a:gd name="connsiteX2" fmla="*/ 95851 w 2271003"/>
                  <a:gd name="connsiteY2" fmla="*/ 2633917 h 2633917"/>
                  <a:gd name="connsiteX3" fmla="*/ 32713 w 2271003"/>
                  <a:gd name="connsiteY3" fmla="*/ 841829 h 2633917"/>
                  <a:gd name="connsiteX0" fmla="*/ 1 w 2271003"/>
                  <a:gd name="connsiteY0" fmla="*/ 0 h 2633917"/>
                  <a:gd name="connsiteX1" fmla="*/ 2271002 w 2271003"/>
                  <a:gd name="connsiteY1" fmla="*/ 1719431 h 2633917"/>
                  <a:gd name="connsiteX0" fmla="*/ 32711 w 2270999"/>
                  <a:gd name="connsiteY0" fmla="*/ 841829 h 2633917"/>
                  <a:gd name="connsiteX1" fmla="*/ 1614982 w 2270999"/>
                  <a:gd name="connsiteY1" fmla="*/ 1746053 h 2633917"/>
                  <a:gd name="connsiteX2" fmla="*/ 95849 w 2270999"/>
                  <a:gd name="connsiteY2" fmla="*/ 2633917 h 2633917"/>
                  <a:gd name="connsiteX3" fmla="*/ 32711 w 2270999"/>
                  <a:gd name="connsiteY3" fmla="*/ 841829 h 2633917"/>
                  <a:gd name="connsiteX0" fmla="*/ -1 w 2270999"/>
                  <a:gd name="connsiteY0" fmla="*/ 0 h 2633917"/>
                  <a:gd name="connsiteX1" fmla="*/ 2271000 w 2270999"/>
                  <a:gd name="connsiteY1" fmla="*/ 1719431 h 2633917"/>
                  <a:gd name="connsiteX0" fmla="*/ 32713 w 2271003"/>
                  <a:gd name="connsiteY0" fmla="*/ 841829 h 2633917"/>
                  <a:gd name="connsiteX1" fmla="*/ 1614984 w 2271003"/>
                  <a:gd name="connsiteY1" fmla="*/ 1746053 h 2633917"/>
                  <a:gd name="connsiteX2" fmla="*/ 95851 w 2271003"/>
                  <a:gd name="connsiteY2" fmla="*/ 2633917 h 2633917"/>
                  <a:gd name="connsiteX3" fmla="*/ 32713 w 2271003"/>
                  <a:gd name="connsiteY3" fmla="*/ 841829 h 2633917"/>
                  <a:gd name="connsiteX0" fmla="*/ 1 w 2271003"/>
                  <a:gd name="connsiteY0" fmla="*/ 0 h 2633917"/>
                  <a:gd name="connsiteX1" fmla="*/ 2271002 w 2271003"/>
                  <a:gd name="connsiteY1" fmla="*/ 1719431 h 2633917"/>
                  <a:gd name="connsiteX0" fmla="*/ 32711 w 2270999"/>
                  <a:gd name="connsiteY0" fmla="*/ 841829 h 2633917"/>
                  <a:gd name="connsiteX1" fmla="*/ 1614982 w 2270999"/>
                  <a:gd name="connsiteY1" fmla="*/ 1746053 h 2633917"/>
                  <a:gd name="connsiteX2" fmla="*/ 95849 w 2270999"/>
                  <a:gd name="connsiteY2" fmla="*/ 2633917 h 2633917"/>
                  <a:gd name="connsiteX3" fmla="*/ 32711 w 2270999"/>
                  <a:gd name="connsiteY3" fmla="*/ 841829 h 2633917"/>
                  <a:gd name="connsiteX0" fmla="*/ -1 w 2270999"/>
                  <a:gd name="connsiteY0" fmla="*/ 0 h 2633917"/>
                  <a:gd name="connsiteX1" fmla="*/ 2271000 w 2270999"/>
                  <a:gd name="connsiteY1" fmla="*/ 1719431 h 26339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270999" h="2633917" stroke="0" extrusionOk="0">
                    <a:moveTo>
                      <a:pt x="32711" y="841829"/>
                    </a:moveTo>
                    <a:cubicBezTo>
                      <a:pt x="575483" y="841829"/>
                      <a:pt x="1342475" y="1247958"/>
                      <a:pt x="1614982" y="1746053"/>
                    </a:cubicBezTo>
                    <a:lnTo>
                      <a:pt x="95849" y="2633917"/>
                    </a:lnTo>
                    <a:cubicBezTo>
                      <a:pt x="95849" y="2095267"/>
                      <a:pt x="32711" y="1380479"/>
                      <a:pt x="32711" y="841829"/>
                    </a:cubicBezTo>
                    <a:close/>
                  </a:path>
                  <a:path w="2270999" h="2633917" fill="none">
                    <a:moveTo>
                      <a:pt x="-1" y="0"/>
                    </a:moveTo>
                    <a:cubicBezTo>
                      <a:pt x="513564" y="119561"/>
                      <a:pt x="1774227" y="1010294"/>
                      <a:pt x="2271000" y="1719431"/>
                    </a:cubicBezTo>
                  </a:path>
                </a:pathLst>
              </a:custGeom>
              <a:ln w="317500">
                <a:solidFill>
                  <a:schemeClr val="accent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5" name="Arc 61">
                <a:extLst>
                  <a:ext uri="{FF2B5EF4-FFF2-40B4-BE49-F238E27FC236}">
                    <a16:creationId xmlns:a16="http://schemas.microsoft.com/office/drawing/2014/main" id="{0B12573B-E6C9-D530-52B8-70EA96EBE404}"/>
                  </a:ext>
                </a:extLst>
              </p:cNvPr>
              <p:cNvSpPr/>
              <p:nvPr/>
            </p:nvSpPr>
            <p:spPr>
              <a:xfrm rot="17300809">
                <a:off x="4625387" y="-7070"/>
                <a:ext cx="775540" cy="1303213"/>
              </a:xfrm>
              <a:custGeom>
                <a:avLst/>
                <a:gdLst>
                  <a:gd name="connsiteX0" fmla="*/ 1522872 w 3045745"/>
                  <a:gd name="connsiteY0" fmla="*/ 0 h 3231900"/>
                  <a:gd name="connsiteX1" fmla="*/ 2839898 w 3045745"/>
                  <a:gd name="connsiteY1" fmla="*/ 804638 h 3231900"/>
                  <a:gd name="connsiteX2" fmla="*/ 1522873 w 3045745"/>
                  <a:gd name="connsiteY2" fmla="*/ 1615950 h 3231900"/>
                  <a:gd name="connsiteX3" fmla="*/ 1522872 w 3045745"/>
                  <a:gd name="connsiteY3" fmla="*/ 0 h 3231900"/>
                  <a:gd name="connsiteX0" fmla="*/ 1522872 w 3045745"/>
                  <a:gd name="connsiteY0" fmla="*/ 0 h 3231900"/>
                  <a:gd name="connsiteX1" fmla="*/ 2839898 w 3045745"/>
                  <a:gd name="connsiteY1" fmla="*/ 804638 h 3231900"/>
                  <a:gd name="connsiteX0" fmla="*/ 0 w 1499212"/>
                  <a:gd name="connsiteY0" fmla="*/ 0 h 1615950"/>
                  <a:gd name="connsiteX1" fmla="*/ 1317026 w 1499212"/>
                  <a:gd name="connsiteY1" fmla="*/ 804638 h 1615950"/>
                  <a:gd name="connsiteX2" fmla="*/ 1 w 1499212"/>
                  <a:gd name="connsiteY2" fmla="*/ 1615950 h 1615950"/>
                  <a:gd name="connsiteX3" fmla="*/ 0 w 1499212"/>
                  <a:gd name="connsiteY3" fmla="*/ 0 h 1615950"/>
                  <a:gd name="connsiteX0" fmla="*/ 0 w 1499212"/>
                  <a:gd name="connsiteY0" fmla="*/ 0 h 1615950"/>
                  <a:gd name="connsiteX1" fmla="*/ 1499212 w 1499212"/>
                  <a:gd name="connsiteY1" fmla="*/ 615307 h 1615950"/>
                  <a:gd name="connsiteX0" fmla="*/ 9012 w 1508224"/>
                  <a:gd name="connsiteY0" fmla="*/ 202703 h 1818653"/>
                  <a:gd name="connsiteX1" fmla="*/ 1326038 w 1508224"/>
                  <a:gd name="connsiteY1" fmla="*/ 1007341 h 1818653"/>
                  <a:gd name="connsiteX2" fmla="*/ 9013 w 1508224"/>
                  <a:gd name="connsiteY2" fmla="*/ 1818653 h 1818653"/>
                  <a:gd name="connsiteX3" fmla="*/ 9012 w 1508224"/>
                  <a:gd name="connsiteY3" fmla="*/ 202703 h 1818653"/>
                  <a:gd name="connsiteX0" fmla="*/ 0 w 1508224"/>
                  <a:gd name="connsiteY0" fmla="*/ 0 h 1818653"/>
                  <a:gd name="connsiteX1" fmla="*/ 1508224 w 1508224"/>
                  <a:gd name="connsiteY1" fmla="*/ 818010 h 1818653"/>
                  <a:gd name="connsiteX0" fmla="*/ 9012 w 1754657"/>
                  <a:gd name="connsiteY0" fmla="*/ 202703 h 1818653"/>
                  <a:gd name="connsiteX1" fmla="*/ 1326038 w 1754657"/>
                  <a:gd name="connsiteY1" fmla="*/ 1007341 h 1818653"/>
                  <a:gd name="connsiteX2" fmla="*/ 9013 w 1754657"/>
                  <a:gd name="connsiteY2" fmla="*/ 1818653 h 1818653"/>
                  <a:gd name="connsiteX3" fmla="*/ 9012 w 1754657"/>
                  <a:gd name="connsiteY3" fmla="*/ 202703 h 1818653"/>
                  <a:gd name="connsiteX0" fmla="*/ 0 w 1754657"/>
                  <a:gd name="connsiteY0" fmla="*/ 0 h 1818653"/>
                  <a:gd name="connsiteX1" fmla="*/ 1754657 w 1754657"/>
                  <a:gd name="connsiteY1" fmla="*/ 925792 h 1818653"/>
                  <a:gd name="connsiteX0" fmla="*/ 82588 w 1828233"/>
                  <a:gd name="connsiteY0" fmla="*/ 334834 h 1950784"/>
                  <a:gd name="connsiteX1" fmla="*/ 1399614 w 1828233"/>
                  <a:gd name="connsiteY1" fmla="*/ 1139472 h 1950784"/>
                  <a:gd name="connsiteX2" fmla="*/ 82589 w 1828233"/>
                  <a:gd name="connsiteY2" fmla="*/ 1950784 h 1950784"/>
                  <a:gd name="connsiteX3" fmla="*/ 82588 w 1828233"/>
                  <a:gd name="connsiteY3" fmla="*/ 334834 h 1950784"/>
                  <a:gd name="connsiteX0" fmla="*/ 0 w 1828233"/>
                  <a:gd name="connsiteY0" fmla="*/ 0 h 1950784"/>
                  <a:gd name="connsiteX1" fmla="*/ 1828233 w 1828233"/>
                  <a:gd name="connsiteY1" fmla="*/ 1057923 h 1950784"/>
                  <a:gd name="connsiteX0" fmla="*/ 82588 w 1806935"/>
                  <a:gd name="connsiteY0" fmla="*/ 334834 h 1950784"/>
                  <a:gd name="connsiteX1" fmla="*/ 1399614 w 1806935"/>
                  <a:gd name="connsiteY1" fmla="*/ 1139472 h 1950784"/>
                  <a:gd name="connsiteX2" fmla="*/ 82589 w 1806935"/>
                  <a:gd name="connsiteY2" fmla="*/ 1950784 h 1950784"/>
                  <a:gd name="connsiteX3" fmla="*/ 82588 w 1806935"/>
                  <a:gd name="connsiteY3" fmla="*/ 334834 h 1950784"/>
                  <a:gd name="connsiteX0" fmla="*/ 0 w 1806935"/>
                  <a:gd name="connsiteY0" fmla="*/ 0 h 1950784"/>
                  <a:gd name="connsiteX1" fmla="*/ 1806935 w 1806935"/>
                  <a:gd name="connsiteY1" fmla="*/ 942130 h 1950784"/>
                  <a:gd name="connsiteX0" fmla="*/ 76578 w 1800925"/>
                  <a:gd name="connsiteY0" fmla="*/ 385715 h 2001665"/>
                  <a:gd name="connsiteX1" fmla="*/ 1393604 w 1800925"/>
                  <a:gd name="connsiteY1" fmla="*/ 1190353 h 2001665"/>
                  <a:gd name="connsiteX2" fmla="*/ 76579 w 1800925"/>
                  <a:gd name="connsiteY2" fmla="*/ 2001665 h 2001665"/>
                  <a:gd name="connsiteX3" fmla="*/ 76578 w 1800925"/>
                  <a:gd name="connsiteY3" fmla="*/ 385715 h 2001665"/>
                  <a:gd name="connsiteX0" fmla="*/ -1 w 1800925"/>
                  <a:gd name="connsiteY0" fmla="*/ 0 h 2001665"/>
                  <a:gd name="connsiteX1" fmla="*/ 1800925 w 1800925"/>
                  <a:gd name="connsiteY1" fmla="*/ 993011 h 2001665"/>
                  <a:gd name="connsiteX0" fmla="*/ 76579 w 1800926"/>
                  <a:gd name="connsiteY0" fmla="*/ 385715 h 2001665"/>
                  <a:gd name="connsiteX1" fmla="*/ 1527326 w 1800926"/>
                  <a:gd name="connsiteY1" fmla="*/ 1159779 h 2001665"/>
                  <a:gd name="connsiteX2" fmla="*/ 76580 w 1800926"/>
                  <a:gd name="connsiteY2" fmla="*/ 2001665 h 2001665"/>
                  <a:gd name="connsiteX3" fmla="*/ 76579 w 1800926"/>
                  <a:gd name="connsiteY3" fmla="*/ 385715 h 2001665"/>
                  <a:gd name="connsiteX0" fmla="*/ 0 w 1800926"/>
                  <a:gd name="connsiteY0" fmla="*/ 0 h 2001665"/>
                  <a:gd name="connsiteX1" fmla="*/ 1800926 w 1800926"/>
                  <a:gd name="connsiteY1" fmla="*/ 993011 h 2001665"/>
                  <a:gd name="connsiteX0" fmla="*/ 76579 w 1800926"/>
                  <a:gd name="connsiteY0" fmla="*/ 385715 h 2001665"/>
                  <a:gd name="connsiteX1" fmla="*/ 1595713 w 1800926"/>
                  <a:gd name="connsiteY1" fmla="*/ 1113801 h 2001665"/>
                  <a:gd name="connsiteX2" fmla="*/ 76580 w 1800926"/>
                  <a:gd name="connsiteY2" fmla="*/ 2001665 h 2001665"/>
                  <a:gd name="connsiteX3" fmla="*/ 76579 w 1800926"/>
                  <a:gd name="connsiteY3" fmla="*/ 385715 h 2001665"/>
                  <a:gd name="connsiteX0" fmla="*/ 0 w 1800926"/>
                  <a:gd name="connsiteY0" fmla="*/ 0 h 2001665"/>
                  <a:gd name="connsiteX1" fmla="*/ 1800926 w 1800926"/>
                  <a:gd name="connsiteY1" fmla="*/ 993011 h 2001665"/>
                  <a:gd name="connsiteX0" fmla="*/ 13442 w 1800926"/>
                  <a:gd name="connsiteY0" fmla="*/ 209577 h 2001665"/>
                  <a:gd name="connsiteX1" fmla="*/ 1595713 w 1800926"/>
                  <a:gd name="connsiteY1" fmla="*/ 1113801 h 2001665"/>
                  <a:gd name="connsiteX2" fmla="*/ 76580 w 1800926"/>
                  <a:gd name="connsiteY2" fmla="*/ 2001665 h 2001665"/>
                  <a:gd name="connsiteX3" fmla="*/ 13442 w 1800926"/>
                  <a:gd name="connsiteY3" fmla="*/ 209577 h 2001665"/>
                  <a:gd name="connsiteX0" fmla="*/ 0 w 1800926"/>
                  <a:gd name="connsiteY0" fmla="*/ 0 h 2001665"/>
                  <a:gd name="connsiteX1" fmla="*/ 1800926 w 1800926"/>
                  <a:gd name="connsiteY1" fmla="*/ 993011 h 2001665"/>
                  <a:gd name="connsiteX0" fmla="*/ 13442 w 1888100"/>
                  <a:gd name="connsiteY0" fmla="*/ 209577 h 2001665"/>
                  <a:gd name="connsiteX1" fmla="*/ 1595713 w 1888100"/>
                  <a:gd name="connsiteY1" fmla="*/ 1113801 h 2001665"/>
                  <a:gd name="connsiteX2" fmla="*/ 76580 w 1888100"/>
                  <a:gd name="connsiteY2" fmla="*/ 2001665 h 2001665"/>
                  <a:gd name="connsiteX3" fmla="*/ 13442 w 1888100"/>
                  <a:gd name="connsiteY3" fmla="*/ 209577 h 2001665"/>
                  <a:gd name="connsiteX0" fmla="*/ 0 w 1888100"/>
                  <a:gd name="connsiteY0" fmla="*/ 0 h 2001665"/>
                  <a:gd name="connsiteX1" fmla="*/ 1888101 w 1888100"/>
                  <a:gd name="connsiteY1" fmla="*/ 965627 h 2001665"/>
                  <a:gd name="connsiteX0" fmla="*/ 39099 w 1913758"/>
                  <a:gd name="connsiteY0" fmla="*/ 276641 h 2068729"/>
                  <a:gd name="connsiteX1" fmla="*/ 1621370 w 1913758"/>
                  <a:gd name="connsiteY1" fmla="*/ 1180865 h 2068729"/>
                  <a:gd name="connsiteX2" fmla="*/ 102237 w 1913758"/>
                  <a:gd name="connsiteY2" fmla="*/ 2068729 h 2068729"/>
                  <a:gd name="connsiteX3" fmla="*/ 39099 w 1913758"/>
                  <a:gd name="connsiteY3" fmla="*/ 276641 h 2068729"/>
                  <a:gd name="connsiteX0" fmla="*/ 1 w 1913758"/>
                  <a:gd name="connsiteY0" fmla="*/ 0 h 2068729"/>
                  <a:gd name="connsiteX1" fmla="*/ 1913758 w 1913758"/>
                  <a:gd name="connsiteY1" fmla="*/ 1032691 h 2068729"/>
                  <a:gd name="connsiteX0" fmla="*/ 39098 w 1995424"/>
                  <a:gd name="connsiteY0" fmla="*/ 276641 h 2068729"/>
                  <a:gd name="connsiteX1" fmla="*/ 1621369 w 1995424"/>
                  <a:gd name="connsiteY1" fmla="*/ 1180865 h 2068729"/>
                  <a:gd name="connsiteX2" fmla="*/ 102236 w 1995424"/>
                  <a:gd name="connsiteY2" fmla="*/ 2068729 h 2068729"/>
                  <a:gd name="connsiteX3" fmla="*/ 39098 w 1995424"/>
                  <a:gd name="connsiteY3" fmla="*/ 276641 h 2068729"/>
                  <a:gd name="connsiteX0" fmla="*/ 0 w 1995424"/>
                  <a:gd name="connsiteY0" fmla="*/ 0 h 2068729"/>
                  <a:gd name="connsiteX1" fmla="*/ 1995425 w 1995424"/>
                  <a:gd name="connsiteY1" fmla="*/ 1051949 h 2068729"/>
                  <a:gd name="connsiteX0" fmla="*/ 14895 w 1971223"/>
                  <a:gd name="connsiteY0" fmla="*/ 326091 h 2118179"/>
                  <a:gd name="connsiteX1" fmla="*/ 1597166 w 1971223"/>
                  <a:gd name="connsiteY1" fmla="*/ 1230315 h 2118179"/>
                  <a:gd name="connsiteX2" fmla="*/ 78033 w 1971223"/>
                  <a:gd name="connsiteY2" fmla="*/ 2118179 h 2118179"/>
                  <a:gd name="connsiteX3" fmla="*/ 14895 w 1971223"/>
                  <a:gd name="connsiteY3" fmla="*/ 326091 h 2118179"/>
                  <a:gd name="connsiteX0" fmla="*/ -1 w 1971223"/>
                  <a:gd name="connsiteY0" fmla="*/ 0 h 2118179"/>
                  <a:gd name="connsiteX1" fmla="*/ 1971222 w 1971223"/>
                  <a:gd name="connsiteY1" fmla="*/ 1101399 h 2118179"/>
                  <a:gd name="connsiteX0" fmla="*/ 14896 w 2060311"/>
                  <a:gd name="connsiteY0" fmla="*/ 326091 h 2118179"/>
                  <a:gd name="connsiteX1" fmla="*/ 1597167 w 2060311"/>
                  <a:gd name="connsiteY1" fmla="*/ 1230315 h 2118179"/>
                  <a:gd name="connsiteX2" fmla="*/ 78034 w 2060311"/>
                  <a:gd name="connsiteY2" fmla="*/ 2118179 h 2118179"/>
                  <a:gd name="connsiteX3" fmla="*/ 14896 w 2060311"/>
                  <a:gd name="connsiteY3" fmla="*/ 326091 h 2118179"/>
                  <a:gd name="connsiteX0" fmla="*/ 0 w 2060311"/>
                  <a:gd name="connsiteY0" fmla="*/ 0 h 2118179"/>
                  <a:gd name="connsiteX1" fmla="*/ 2060311 w 2060311"/>
                  <a:gd name="connsiteY1" fmla="*/ 1124449 h 2118179"/>
                  <a:gd name="connsiteX0" fmla="*/ 68037 w 2113452"/>
                  <a:gd name="connsiteY0" fmla="*/ 386970 h 2179058"/>
                  <a:gd name="connsiteX1" fmla="*/ 1650308 w 2113452"/>
                  <a:gd name="connsiteY1" fmla="*/ 1291194 h 2179058"/>
                  <a:gd name="connsiteX2" fmla="*/ 131175 w 2113452"/>
                  <a:gd name="connsiteY2" fmla="*/ 2179058 h 2179058"/>
                  <a:gd name="connsiteX3" fmla="*/ 68037 w 2113452"/>
                  <a:gd name="connsiteY3" fmla="*/ 386970 h 2179058"/>
                  <a:gd name="connsiteX0" fmla="*/ 0 w 2113452"/>
                  <a:gd name="connsiteY0" fmla="*/ 0 h 2179058"/>
                  <a:gd name="connsiteX1" fmla="*/ 2113452 w 2113452"/>
                  <a:gd name="connsiteY1" fmla="*/ 1185328 h 2179058"/>
                  <a:gd name="connsiteX0" fmla="*/ 68037 w 2202540"/>
                  <a:gd name="connsiteY0" fmla="*/ 386970 h 2179058"/>
                  <a:gd name="connsiteX1" fmla="*/ 1650308 w 2202540"/>
                  <a:gd name="connsiteY1" fmla="*/ 1291194 h 2179058"/>
                  <a:gd name="connsiteX2" fmla="*/ 131175 w 2202540"/>
                  <a:gd name="connsiteY2" fmla="*/ 2179058 h 2179058"/>
                  <a:gd name="connsiteX3" fmla="*/ 68037 w 2202540"/>
                  <a:gd name="connsiteY3" fmla="*/ 386970 h 2179058"/>
                  <a:gd name="connsiteX0" fmla="*/ 0 w 2202540"/>
                  <a:gd name="connsiteY0" fmla="*/ 0 h 2179058"/>
                  <a:gd name="connsiteX1" fmla="*/ 2202540 w 2202540"/>
                  <a:gd name="connsiteY1" fmla="*/ 1208377 h 2179058"/>
                  <a:gd name="connsiteX0" fmla="*/ 108184 w 2242687"/>
                  <a:gd name="connsiteY0" fmla="*/ 446827 h 2238915"/>
                  <a:gd name="connsiteX1" fmla="*/ 1690455 w 2242687"/>
                  <a:gd name="connsiteY1" fmla="*/ 1351051 h 2238915"/>
                  <a:gd name="connsiteX2" fmla="*/ 171322 w 2242687"/>
                  <a:gd name="connsiteY2" fmla="*/ 2238915 h 2238915"/>
                  <a:gd name="connsiteX3" fmla="*/ 108184 w 2242687"/>
                  <a:gd name="connsiteY3" fmla="*/ 446827 h 2238915"/>
                  <a:gd name="connsiteX0" fmla="*/ 0 w 2242687"/>
                  <a:gd name="connsiteY0" fmla="*/ 0 h 2238915"/>
                  <a:gd name="connsiteX1" fmla="*/ 2242687 w 2242687"/>
                  <a:gd name="connsiteY1" fmla="*/ 1268234 h 2238915"/>
                  <a:gd name="connsiteX0" fmla="*/ 108184 w 2242687"/>
                  <a:gd name="connsiteY0" fmla="*/ 446827 h 2238915"/>
                  <a:gd name="connsiteX1" fmla="*/ 1690455 w 2242687"/>
                  <a:gd name="connsiteY1" fmla="*/ 1351051 h 2238915"/>
                  <a:gd name="connsiteX2" fmla="*/ 171322 w 2242687"/>
                  <a:gd name="connsiteY2" fmla="*/ 2238915 h 2238915"/>
                  <a:gd name="connsiteX3" fmla="*/ 108184 w 2242687"/>
                  <a:gd name="connsiteY3" fmla="*/ 446827 h 2238915"/>
                  <a:gd name="connsiteX0" fmla="*/ 0 w 2242687"/>
                  <a:gd name="connsiteY0" fmla="*/ 0 h 2238915"/>
                  <a:gd name="connsiteX1" fmla="*/ 2242687 w 2242687"/>
                  <a:gd name="connsiteY1" fmla="*/ 1268234 h 2238915"/>
                  <a:gd name="connsiteX0" fmla="*/ 108184 w 2242687"/>
                  <a:gd name="connsiteY0" fmla="*/ 446827 h 2238915"/>
                  <a:gd name="connsiteX1" fmla="*/ 1690455 w 2242687"/>
                  <a:gd name="connsiteY1" fmla="*/ 1351051 h 2238915"/>
                  <a:gd name="connsiteX2" fmla="*/ 171322 w 2242687"/>
                  <a:gd name="connsiteY2" fmla="*/ 2238915 h 2238915"/>
                  <a:gd name="connsiteX3" fmla="*/ 108184 w 2242687"/>
                  <a:gd name="connsiteY3" fmla="*/ 446827 h 2238915"/>
                  <a:gd name="connsiteX0" fmla="*/ 0 w 2242687"/>
                  <a:gd name="connsiteY0" fmla="*/ 0 h 2238915"/>
                  <a:gd name="connsiteX1" fmla="*/ 2242687 w 2242687"/>
                  <a:gd name="connsiteY1" fmla="*/ 1268234 h 2238915"/>
                  <a:gd name="connsiteX0" fmla="*/ 108184 w 2324441"/>
                  <a:gd name="connsiteY0" fmla="*/ 446827 h 2238915"/>
                  <a:gd name="connsiteX1" fmla="*/ 1690455 w 2324441"/>
                  <a:gd name="connsiteY1" fmla="*/ 1351051 h 2238915"/>
                  <a:gd name="connsiteX2" fmla="*/ 171322 w 2324441"/>
                  <a:gd name="connsiteY2" fmla="*/ 2238915 h 2238915"/>
                  <a:gd name="connsiteX3" fmla="*/ 108184 w 2324441"/>
                  <a:gd name="connsiteY3" fmla="*/ 446827 h 2238915"/>
                  <a:gd name="connsiteX0" fmla="*/ 0 w 2324441"/>
                  <a:gd name="connsiteY0" fmla="*/ 0 h 2238915"/>
                  <a:gd name="connsiteX1" fmla="*/ 2324441 w 2324441"/>
                  <a:gd name="connsiteY1" fmla="*/ 1326596 h 2238915"/>
                  <a:gd name="connsiteX0" fmla="*/ 78208 w 2294465"/>
                  <a:gd name="connsiteY0" fmla="*/ 734167 h 2526255"/>
                  <a:gd name="connsiteX1" fmla="*/ 1660479 w 2294465"/>
                  <a:gd name="connsiteY1" fmla="*/ 1638391 h 2526255"/>
                  <a:gd name="connsiteX2" fmla="*/ 141346 w 2294465"/>
                  <a:gd name="connsiteY2" fmla="*/ 2526255 h 2526255"/>
                  <a:gd name="connsiteX3" fmla="*/ 78208 w 2294465"/>
                  <a:gd name="connsiteY3" fmla="*/ 734167 h 2526255"/>
                  <a:gd name="connsiteX0" fmla="*/ 0 w 2294465"/>
                  <a:gd name="connsiteY0" fmla="*/ 0 h 2526255"/>
                  <a:gd name="connsiteX1" fmla="*/ 2294465 w 2294465"/>
                  <a:gd name="connsiteY1" fmla="*/ 1613936 h 2526255"/>
                  <a:gd name="connsiteX0" fmla="*/ 83624 w 2299881"/>
                  <a:gd name="connsiteY0" fmla="*/ 891155 h 2683243"/>
                  <a:gd name="connsiteX1" fmla="*/ 1665895 w 2299881"/>
                  <a:gd name="connsiteY1" fmla="*/ 1795379 h 2683243"/>
                  <a:gd name="connsiteX2" fmla="*/ 146762 w 2299881"/>
                  <a:gd name="connsiteY2" fmla="*/ 2683243 h 2683243"/>
                  <a:gd name="connsiteX3" fmla="*/ 83624 w 2299881"/>
                  <a:gd name="connsiteY3" fmla="*/ 891155 h 2683243"/>
                  <a:gd name="connsiteX0" fmla="*/ 1 w 2299881"/>
                  <a:gd name="connsiteY0" fmla="*/ 0 h 2683243"/>
                  <a:gd name="connsiteX1" fmla="*/ 2299881 w 2299881"/>
                  <a:gd name="connsiteY1" fmla="*/ 1770924 h 2683243"/>
                  <a:gd name="connsiteX0" fmla="*/ 83624 w 2299881"/>
                  <a:gd name="connsiteY0" fmla="*/ 891155 h 2683243"/>
                  <a:gd name="connsiteX1" fmla="*/ 1665895 w 2299881"/>
                  <a:gd name="connsiteY1" fmla="*/ 1795379 h 2683243"/>
                  <a:gd name="connsiteX2" fmla="*/ 146762 w 2299881"/>
                  <a:gd name="connsiteY2" fmla="*/ 2683243 h 2683243"/>
                  <a:gd name="connsiteX3" fmla="*/ 83624 w 2299881"/>
                  <a:gd name="connsiteY3" fmla="*/ 891155 h 2683243"/>
                  <a:gd name="connsiteX0" fmla="*/ 1 w 2299881"/>
                  <a:gd name="connsiteY0" fmla="*/ 0 h 2683243"/>
                  <a:gd name="connsiteX1" fmla="*/ 2299881 w 2299881"/>
                  <a:gd name="connsiteY1" fmla="*/ 1770924 h 2683243"/>
                  <a:gd name="connsiteX0" fmla="*/ 83624 w 2299881"/>
                  <a:gd name="connsiteY0" fmla="*/ 891155 h 2683243"/>
                  <a:gd name="connsiteX1" fmla="*/ 1665895 w 2299881"/>
                  <a:gd name="connsiteY1" fmla="*/ 1795379 h 2683243"/>
                  <a:gd name="connsiteX2" fmla="*/ 146762 w 2299881"/>
                  <a:gd name="connsiteY2" fmla="*/ 2683243 h 2683243"/>
                  <a:gd name="connsiteX3" fmla="*/ 83624 w 2299881"/>
                  <a:gd name="connsiteY3" fmla="*/ 891155 h 2683243"/>
                  <a:gd name="connsiteX0" fmla="*/ 1 w 2299881"/>
                  <a:gd name="connsiteY0" fmla="*/ 0 h 2683243"/>
                  <a:gd name="connsiteX1" fmla="*/ 2299881 w 2299881"/>
                  <a:gd name="connsiteY1" fmla="*/ 1770924 h 2683243"/>
                  <a:gd name="connsiteX0" fmla="*/ 83624 w 2299881"/>
                  <a:gd name="connsiteY0" fmla="*/ 891155 h 2683243"/>
                  <a:gd name="connsiteX1" fmla="*/ 1665895 w 2299881"/>
                  <a:gd name="connsiteY1" fmla="*/ 1795379 h 2683243"/>
                  <a:gd name="connsiteX2" fmla="*/ 146762 w 2299881"/>
                  <a:gd name="connsiteY2" fmla="*/ 2683243 h 2683243"/>
                  <a:gd name="connsiteX3" fmla="*/ 83624 w 2299881"/>
                  <a:gd name="connsiteY3" fmla="*/ 891155 h 2683243"/>
                  <a:gd name="connsiteX0" fmla="*/ 1 w 2299881"/>
                  <a:gd name="connsiteY0" fmla="*/ 0 h 2683243"/>
                  <a:gd name="connsiteX1" fmla="*/ 2299881 w 2299881"/>
                  <a:gd name="connsiteY1" fmla="*/ 1770924 h 2683243"/>
                  <a:gd name="connsiteX0" fmla="*/ 5955 w 2222212"/>
                  <a:gd name="connsiteY0" fmla="*/ 889005 h 2681093"/>
                  <a:gd name="connsiteX1" fmla="*/ 1588226 w 2222212"/>
                  <a:gd name="connsiteY1" fmla="*/ 1793229 h 2681093"/>
                  <a:gd name="connsiteX2" fmla="*/ 69093 w 2222212"/>
                  <a:gd name="connsiteY2" fmla="*/ 2681093 h 2681093"/>
                  <a:gd name="connsiteX3" fmla="*/ 5955 w 2222212"/>
                  <a:gd name="connsiteY3" fmla="*/ 889005 h 2681093"/>
                  <a:gd name="connsiteX0" fmla="*/ 1 w 2222212"/>
                  <a:gd name="connsiteY0" fmla="*/ 0 h 2681093"/>
                  <a:gd name="connsiteX1" fmla="*/ 2222212 w 2222212"/>
                  <a:gd name="connsiteY1" fmla="*/ 1768774 h 2681093"/>
                  <a:gd name="connsiteX0" fmla="*/ 5955 w 2222212"/>
                  <a:gd name="connsiteY0" fmla="*/ 889005 h 2681093"/>
                  <a:gd name="connsiteX1" fmla="*/ 1588226 w 2222212"/>
                  <a:gd name="connsiteY1" fmla="*/ 1793229 h 2681093"/>
                  <a:gd name="connsiteX2" fmla="*/ 69093 w 2222212"/>
                  <a:gd name="connsiteY2" fmla="*/ 2681093 h 2681093"/>
                  <a:gd name="connsiteX3" fmla="*/ 5955 w 2222212"/>
                  <a:gd name="connsiteY3" fmla="*/ 889005 h 2681093"/>
                  <a:gd name="connsiteX0" fmla="*/ 1 w 2222212"/>
                  <a:gd name="connsiteY0" fmla="*/ 0 h 2681093"/>
                  <a:gd name="connsiteX1" fmla="*/ 2222212 w 2222212"/>
                  <a:gd name="connsiteY1" fmla="*/ 1768774 h 2681093"/>
                  <a:gd name="connsiteX0" fmla="*/ 5955 w 2222212"/>
                  <a:gd name="connsiteY0" fmla="*/ 889005 h 2681093"/>
                  <a:gd name="connsiteX1" fmla="*/ 1588226 w 2222212"/>
                  <a:gd name="connsiteY1" fmla="*/ 1793229 h 2681093"/>
                  <a:gd name="connsiteX2" fmla="*/ 69093 w 2222212"/>
                  <a:gd name="connsiteY2" fmla="*/ 2681093 h 2681093"/>
                  <a:gd name="connsiteX3" fmla="*/ 5955 w 2222212"/>
                  <a:gd name="connsiteY3" fmla="*/ 889005 h 2681093"/>
                  <a:gd name="connsiteX0" fmla="*/ 1 w 2222212"/>
                  <a:gd name="connsiteY0" fmla="*/ 0 h 2681093"/>
                  <a:gd name="connsiteX1" fmla="*/ 2222212 w 2222212"/>
                  <a:gd name="connsiteY1" fmla="*/ 1768774 h 268109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222212" h="2681093" stroke="0" extrusionOk="0">
                    <a:moveTo>
                      <a:pt x="5955" y="889005"/>
                    </a:moveTo>
                    <a:cubicBezTo>
                      <a:pt x="548727" y="889005"/>
                      <a:pt x="1315719" y="1295134"/>
                      <a:pt x="1588226" y="1793229"/>
                    </a:cubicBezTo>
                    <a:lnTo>
                      <a:pt x="69093" y="2681093"/>
                    </a:lnTo>
                    <a:cubicBezTo>
                      <a:pt x="69093" y="2142443"/>
                      <a:pt x="5955" y="1427655"/>
                      <a:pt x="5955" y="889005"/>
                    </a:cubicBezTo>
                    <a:close/>
                  </a:path>
                  <a:path w="2222212" h="2681093" fill="none">
                    <a:moveTo>
                      <a:pt x="1" y="0"/>
                    </a:moveTo>
                    <a:cubicBezTo>
                      <a:pt x="456067" y="185807"/>
                      <a:pt x="1772377" y="1070454"/>
                      <a:pt x="2222212" y="1768774"/>
                    </a:cubicBezTo>
                  </a:path>
                </a:pathLst>
              </a:custGeom>
              <a:ln w="3175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9" name="Arc 62">
                <a:extLst>
                  <a:ext uri="{FF2B5EF4-FFF2-40B4-BE49-F238E27FC236}">
                    <a16:creationId xmlns:a16="http://schemas.microsoft.com/office/drawing/2014/main" id="{0B12573B-E6C9-D530-52B8-70EA96EBE404}"/>
                  </a:ext>
                </a:extLst>
              </p:cNvPr>
              <p:cNvSpPr/>
              <p:nvPr/>
            </p:nvSpPr>
            <p:spPr>
              <a:xfrm rot="11001189">
                <a:off x="3424819" y="4412238"/>
                <a:ext cx="1397688" cy="1873122"/>
              </a:xfrm>
              <a:custGeom>
                <a:avLst/>
                <a:gdLst>
                  <a:gd name="connsiteX0" fmla="*/ 1522872 w 3045745"/>
                  <a:gd name="connsiteY0" fmla="*/ 0 h 3231900"/>
                  <a:gd name="connsiteX1" fmla="*/ 2839898 w 3045745"/>
                  <a:gd name="connsiteY1" fmla="*/ 804638 h 3231900"/>
                  <a:gd name="connsiteX2" fmla="*/ 1522873 w 3045745"/>
                  <a:gd name="connsiteY2" fmla="*/ 1615950 h 3231900"/>
                  <a:gd name="connsiteX3" fmla="*/ 1522872 w 3045745"/>
                  <a:gd name="connsiteY3" fmla="*/ 0 h 3231900"/>
                  <a:gd name="connsiteX0" fmla="*/ 1522872 w 3045745"/>
                  <a:gd name="connsiteY0" fmla="*/ 0 h 3231900"/>
                  <a:gd name="connsiteX1" fmla="*/ 2839898 w 3045745"/>
                  <a:gd name="connsiteY1" fmla="*/ 804638 h 3231900"/>
                  <a:gd name="connsiteX0" fmla="*/ 0 w 1317026"/>
                  <a:gd name="connsiteY0" fmla="*/ 238126 h 1854076"/>
                  <a:gd name="connsiteX1" fmla="*/ 1317026 w 1317026"/>
                  <a:gd name="connsiteY1" fmla="*/ 1042764 h 1854076"/>
                  <a:gd name="connsiteX2" fmla="*/ 1 w 1317026"/>
                  <a:gd name="connsiteY2" fmla="*/ 1854076 h 1854076"/>
                  <a:gd name="connsiteX3" fmla="*/ 0 w 1317026"/>
                  <a:gd name="connsiteY3" fmla="*/ 238126 h 1854076"/>
                  <a:gd name="connsiteX0" fmla="*/ 95250 w 1317026"/>
                  <a:gd name="connsiteY0" fmla="*/ 0 h 1854076"/>
                  <a:gd name="connsiteX1" fmla="*/ 1317026 w 1317026"/>
                  <a:gd name="connsiteY1" fmla="*/ 1042764 h 1854076"/>
                  <a:gd name="connsiteX0" fmla="*/ 0 w 1317026"/>
                  <a:gd name="connsiteY0" fmla="*/ 76201 h 1692151"/>
                  <a:gd name="connsiteX1" fmla="*/ 1317026 w 1317026"/>
                  <a:gd name="connsiteY1" fmla="*/ 880839 h 1692151"/>
                  <a:gd name="connsiteX2" fmla="*/ 1 w 1317026"/>
                  <a:gd name="connsiteY2" fmla="*/ 1692151 h 1692151"/>
                  <a:gd name="connsiteX3" fmla="*/ 0 w 1317026"/>
                  <a:gd name="connsiteY3" fmla="*/ 76201 h 1692151"/>
                  <a:gd name="connsiteX0" fmla="*/ 38100 w 1317026"/>
                  <a:gd name="connsiteY0" fmla="*/ 0 h 1692151"/>
                  <a:gd name="connsiteX1" fmla="*/ 1317026 w 1317026"/>
                  <a:gd name="connsiteY1" fmla="*/ 880839 h 1692151"/>
                  <a:gd name="connsiteX0" fmla="*/ 0 w 1317026"/>
                  <a:gd name="connsiteY0" fmla="*/ 209549 h 1825499"/>
                  <a:gd name="connsiteX1" fmla="*/ 1317026 w 1317026"/>
                  <a:gd name="connsiteY1" fmla="*/ 1014187 h 1825499"/>
                  <a:gd name="connsiteX2" fmla="*/ 1 w 1317026"/>
                  <a:gd name="connsiteY2" fmla="*/ 1825499 h 1825499"/>
                  <a:gd name="connsiteX3" fmla="*/ 0 w 1317026"/>
                  <a:gd name="connsiteY3" fmla="*/ 209549 h 1825499"/>
                  <a:gd name="connsiteX0" fmla="*/ 47625 w 1317026"/>
                  <a:gd name="connsiteY0" fmla="*/ 0 h 1825499"/>
                  <a:gd name="connsiteX1" fmla="*/ 1317026 w 1317026"/>
                  <a:gd name="connsiteY1" fmla="*/ 1014187 h 1825499"/>
                  <a:gd name="connsiteX0" fmla="*/ 85726 w 1402752"/>
                  <a:gd name="connsiteY0" fmla="*/ 219072 h 1835022"/>
                  <a:gd name="connsiteX1" fmla="*/ 1402752 w 1402752"/>
                  <a:gd name="connsiteY1" fmla="*/ 1023710 h 1835022"/>
                  <a:gd name="connsiteX2" fmla="*/ 85727 w 1402752"/>
                  <a:gd name="connsiteY2" fmla="*/ 1835022 h 1835022"/>
                  <a:gd name="connsiteX3" fmla="*/ 85726 w 1402752"/>
                  <a:gd name="connsiteY3" fmla="*/ 219072 h 1835022"/>
                  <a:gd name="connsiteX0" fmla="*/ 0 w 1402752"/>
                  <a:gd name="connsiteY0" fmla="*/ 0 h 1835022"/>
                  <a:gd name="connsiteX1" fmla="*/ 1402752 w 1402752"/>
                  <a:gd name="connsiteY1" fmla="*/ 1023710 h 1835022"/>
                  <a:gd name="connsiteX0" fmla="*/ 85726 w 1402752"/>
                  <a:gd name="connsiteY0" fmla="*/ 219072 h 1835022"/>
                  <a:gd name="connsiteX1" fmla="*/ 1402752 w 1402752"/>
                  <a:gd name="connsiteY1" fmla="*/ 1023710 h 1835022"/>
                  <a:gd name="connsiteX2" fmla="*/ 85727 w 1402752"/>
                  <a:gd name="connsiteY2" fmla="*/ 1835022 h 1835022"/>
                  <a:gd name="connsiteX3" fmla="*/ 85726 w 1402752"/>
                  <a:gd name="connsiteY3" fmla="*/ 219072 h 1835022"/>
                  <a:gd name="connsiteX0" fmla="*/ 0 w 1402752"/>
                  <a:gd name="connsiteY0" fmla="*/ 0 h 1835022"/>
                  <a:gd name="connsiteX1" fmla="*/ 1402752 w 1402752"/>
                  <a:gd name="connsiteY1" fmla="*/ 1023710 h 1835022"/>
                  <a:gd name="connsiteX0" fmla="*/ 85726 w 1402752"/>
                  <a:gd name="connsiteY0" fmla="*/ 219072 h 1835022"/>
                  <a:gd name="connsiteX1" fmla="*/ 1402752 w 1402752"/>
                  <a:gd name="connsiteY1" fmla="*/ 1023710 h 1835022"/>
                  <a:gd name="connsiteX2" fmla="*/ 85727 w 1402752"/>
                  <a:gd name="connsiteY2" fmla="*/ 1835022 h 1835022"/>
                  <a:gd name="connsiteX3" fmla="*/ 85726 w 1402752"/>
                  <a:gd name="connsiteY3" fmla="*/ 219072 h 1835022"/>
                  <a:gd name="connsiteX0" fmla="*/ 0 w 1402752"/>
                  <a:gd name="connsiteY0" fmla="*/ 0 h 1835022"/>
                  <a:gd name="connsiteX1" fmla="*/ 1402752 w 1402752"/>
                  <a:gd name="connsiteY1" fmla="*/ 1023710 h 1835022"/>
                  <a:gd name="connsiteX0" fmla="*/ 57151 w 1374177"/>
                  <a:gd name="connsiteY0" fmla="*/ 285747 h 1901697"/>
                  <a:gd name="connsiteX1" fmla="*/ 1374177 w 1374177"/>
                  <a:gd name="connsiteY1" fmla="*/ 1090385 h 1901697"/>
                  <a:gd name="connsiteX2" fmla="*/ 57152 w 1374177"/>
                  <a:gd name="connsiteY2" fmla="*/ 1901697 h 1901697"/>
                  <a:gd name="connsiteX3" fmla="*/ 57151 w 1374177"/>
                  <a:gd name="connsiteY3" fmla="*/ 285747 h 1901697"/>
                  <a:gd name="connsiteX0" fmla="*/ 0 w 1374177"/>
                  <a:gd name="connsiteY0" fmla="*/ 0 h 1901697"/>
                  <a:gd name="connsiteX1" fmla="*/ 1374177 w 1374177"/>
                  <a:gd name="connsiteY1" fmla="*/ 1090385 h 1901697"/>
                  <a:gd name="connsiteX0" fmla="*/ 57151 w 1374177"/>
                  <a:gd name="connsiteY0" fmla="*/ 285747 h 1901697"/>
                  <a:gd name="connsiteX1" fmla="*/ 1374177 w 1374177"/>
                  <a:gd name="connsiteY1" fmla="*/ 1090385 h 1901697"/>
                  <a:gd name="connsiteX2" fmla="*/ 57152 w 1374177"/>
                  <a:gd name="connsiteY2" fmla="*/ 1901697 h 1901697"/>
                  <a:gd name="connsiteX3" fmla="*/ 57151 w 1374177"/>
                  <a:gd name="connsiteY3" fmla="*/ 285747 h 1901697"/>
                  <a:gd name="connsiteX0" fmla="*/ 0 w 1374177"/>
                  <a:gd name="connsiteY0" fmla="*/ 0 h 1901697"/>
                  <a:gd name="connsiteX1" fmla="*/ 1374177 w 1374177"/>
                  <a:gd name="connsiteY1" fmla="*/ 1090385 h 1901697"/>
                  <a:gd name="connsiteX0" fmla="*/ 66676 w 1383702"/>
                  <a:gd name="connsiteY0" fmla="*/ 257172 h 1873122"/>
                  <a:gd name="connsiteX1" fmla="*/ 1383702 w 1383702"/>
                  <a:gd name="connsiteY1" fmla="*/ 1061810 h 1873122"/>
                  <a:gd name="connsiteX2" fmla="*/ 66677 w 1383702"/>
                  <a:gd name="connsiteY2" fmla="*/ 1873122 h 1873122"/>
                  <a:gd name="connsiteX3" fmla="*/ 66676 w 1383702"/>
                  <a:gd name="connsiteY3" fmla="*/ 257172 h 1873122"/>
                  <a:gd name="connsiteX0" fmla="*/ 0 w 1383702"/>
                  <a:gd name="connsiteY0" fmla="*/ 0 h 1873122"/>
                  <a:gd name="connsiteX1" fmla="*/ 1383702 w 1383702"/>
                  <a:gd name="connsiteY1" fmla="*/ 1061810 h 1873122"/>
                  <a:gd name="connsiteX0" fmla="*/ 66676 w 1425935"/>
                  <a:gd name="connsiteY0" fmla="*/ 257172 h 1873122"/>
                  <a:gd name="connsiteX1" fmla="*/ 1383702 w 1425935"/>
                  <a:gd name="connsiteY1" fmla="*/ 1061810 h 1873122"/>
                  <a:gd name="connsiteX2" fmla="*/ 66677 w 1425935"/>
                  <a:gd name="connsiteY2" fmla="*/ 1873122 h 1873122"/>
                  <a:gd name="connsiteX3" fmla="*/ 66676 w 1425935"/>
                  <a:gd name="connsiteY3" fmla="*/ 257172 h 1873122"/>
                  <a:gd name="connsiteX0" fmla="*/ 0 w 1425935"/>
                  <a:gd name="connsiteY0" fmla="*/ 0 h 1873122"/>
                  <a:gd name="connsiteX1" fmla="*/ 1425935 w 1425935"/>
                  <a:gd name="connsiteY1" fmla="*/ 1049794 h 1873122"/>
                  <a:gd name="connsiteX0" fmla="*/ 66676 w 1425935"/>
                  <a:gd name="connsiteY0" fmla="*/ 257172 h 1873122"/>
                  <a:gd name="connsiteX1" fmla="*/ 1383702 w 1425935"/>
                  <a:gd name="connsiteY1" fmla="*/ 1061810 h 1873122"/>
                  <a:gd name="connsiteX2" fmla="*/ 66677 w 1425935"/>
                  <a:gd name="connsiteY2" fmla="*/ 1873122 h 1873122"/>
                  <a:gd name="connsiteX3" fmla="*/ 66676 w 1425935"/>
                  <a:gd name="connsiteY3" fmla="*/ 257172 h 1873122"/>
                  <a:gd name="connsiteX0" fmla="*/ 0 w 1425935"/>
                  <a:gd name="connsiteY0" fmla="*/ 0 h 1873122"/>
                  <a:gd name="connsiteX1" fmla="*/ 1425935 w 1425935"/>
                  <a:gd name="connsiteY1" fmla="*/ 1049794 h 1873122"/>
                  <a:gd name="connsiteX0" fmla="*/ 66676 w 1397688"/>
                  <a:gd name="connsiteY0" fmla="*/ 257172 h 1873122"/>
                  <a:gd name="connsiteX1" fmla="*/ 1383702 w 1397688"/>
                  <a:gd name="connsiteY1" fmla="*/ 1061810 h 1873122"/>
                  <a:gd name="connsiteX2" fmla="*/ 66677 w 1397688"/>
                  <a:gd name="connsiteY2" fmla="*/ 1873122 h 1873122"/>
                  <a:gd name="connsiteX3" fmla="*/ 66676 w 1397688"/>
                  <a:gd name="connsiteY3" fmla="*/ 257172 h 1873122"/>
                  <a:gd name="connsiteX0" fmla="*/ 0 w 1397688"/>
                  <a:gd name="connsiteY0" fmla="*/ 0 h 1873122"/>
                  <a:gd name="connsiteX1" fmla="*/ 1397688 w 1397688"/>
                  <a:gd name="connsiteY1" fmla="*/ 1056220 h 187312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397688" h="1873122" stroke="0" extrusionOk="0">
                    <a:moveTo>
                      <a:pt x="66676" y="257172"/>
                    </a:moveTo>
                    <a:cubicBezTo>
                      <a:pt x="609448" y="257172"/>
                      <a:pt x="1111195" y="563715"/>
                      <a:pt x="1383702" y="1061810"/>
                    </a:cubicBezTo>
                    <a:lnTo>
                      <a:pt x="66677" y="1873122"/>
                    </a:lnTo>
                    <a:cubicBezTo>
                      <a:pt x="66677" y="1334472"/>
                      <a:pt x="66676" y="795822"/>
                      <a:pt x="66676" y="257172"/>
                    </a:cubicBezTo>
                    <a:close/>
                  </a:path>
                  <a:path w="1397688" h="1873122" fill="none">
                    <a:moveTo>
                      <a:pt x="0" y="0"/>
                    </a:moveTo>
                    <a:cubicBezTo>
                      <a:pt x="457047" y="161925"/>
                      <a:pt x="1083507" y="579649"/>
                      <a:pt x="1397688" y="1056220"/>
                    </a:cubicBezTo>
                  </a:path>
                </a:pathLst>
              </a:custGeom>
              <a:ln w="31750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0" name="Arc 62">
                <a:extLst>
                  <a:ext uri="{FF2B5EF4-FFF2-40B4-BE49-F238E27FC236}">
                    <a16:creationId xmlns:a16="http://schemas.microsoft.com/office/drawing/2014/main" id="{0B12573B-E6C9-D530-52B8-70EA96EBE404}"/>
                  </a:ext>
                </a:extLst>
              </p:cNvPr>
              <p:cNvSpPr/>
              <p:nvPr/>
            </p:nvSpPr>
            <p:spPr>
              <a:xfrm rot="9069473">
                <a:off x="4853016" y="5492507"/>
                <a:ext cx="965767" cy="1445294"/>
              </a:xfrm>
              <a:custGeom>
                <a:avLst/>
                <a:gdLst>
                  <a:gd name="connsiteX0" fmla="*/ 1522872 w 3045745"/>
                  <a:gd name="connsiteY0" fmla="*/ 0 h 3231900"/>
                  <a:gd name="connsiteX1" fmla="*/ 2839898 w 3045745"/>
                  <a:gd name="connsiteY1" fmla="*/ 804638 h 3231900"/>
                  <a:gd name="connsiteX2" fmla="*/ 1522873 w 3045745"/>
                  <a:gd name="connsiteY2" fmla="*/ 1615950 h 3231900"/>
                  <a:gd name="connsiteX3" fmla="*/ 1522872 w 3045745"/>
                  <a:gd name="connsiteY3" fmla="*/ 0 h 3231900"/>
                  <a:gd name="connsiteX0" fmla="*/ 1522872 w 3045745"/>
                  <a:gd name="connsiteY0" fmla="*/ 0 h 3231900"/>
                  <a:gd name="connsiteX1" fmla="*/ 2839898 w 3045745"/>
                  <a:gd name="connsiteY1" fmla="*/ 804638 h 3231900"/>
                  <a:gd name="connsiteX0" fmla="*/ 0 w 1317026"/>
                  <a:gd name="connsiteY0" fmla="*/ 238126 h 1854076"/>
                  <a:gd name="connsiteX1" fmla="*/ 1317026 w 1317026"/>
                  <a:gd name="connsiteY1" fmla="*/ 1042764 h 1854076"/>
                  <a:gd name="connsiteX2" fmla="*/ 1 w 1317026"/>
                  <a:gd name="connsiteY2" fmla="*/ 1854076 h 1854076"/>
                  <a:gd name="connsiteX3" fmla="*/ 0 w 1317026"/>
                  <a:gd name="connsiteY3" fmla="*/ 238126 h 1854076"/>
                  <a:gd name="connsiteX0" fmla="*/ 95250 w 1317026"/>
                  <a:gd name="connsiteY0" fmla="*/ 0 h 1854076"/>
                  <a:gd name="connsiteX1" fmla="*/ 1317026 w 1317026"/>
                  <a:gd name="connsiteY1" fmla="*/ 1042764 h 1854076"/>
                  <a:gd name="connsiteX0" fmla="*/ 0 w 1317026"/>
                  <a:gd name="connsiteY0" fmla="*/ 76201 h 1692151"/>
                  <a:gd name="connsiteX1" fmla="*/ 1317026 w 1317026"/>
                  <a:gd name="connsiteY1" fmla="*/ 880839 h 1692151"/>
                  <a:gd name="connsiteX2" fmla="*/ 1 w 1317026"/>
                  <a:gd name="connsiteY2" fmla="*/ 1692151 h 1692151"/>
                  <a:gd name="connsiteX3" fmla="*/ 0 w 1317026"/>
                  <a:gd name="connsiteY3" fmla="*/ 76201 h 1692151"/>
                  <a:gd name="connsiteX0" fmla="*/ 38100 w 1317026"/>
                  <a:gd name="connsiteY0" fmla="*/ 0 h 1692151"/>
                  <a:gd name="connsiteX1" fmla="*/ 1317026 w 1317026"/>
                  <a:gd name="connsiteY1" fmla="*/ 880839 h 1692151"/>
                  <a:gd name="connsiteX0" fmla="*/ 0 w 1317026"/>
                  <a:gd name="connsiteY0" fmla="*/ 209549 h 1825499"/>
                  <a:gd name="connsiteX1" fmla="*/ 1317026 w 1317026"/>
                  <a:gd name="connsiteY1" fmla="*/ 1014187 h 1825499"/>
                  <a:gd name="connsiteX2" fmla="*/ 1 w 1317026"/>
                  <a:gd name="connsiteY2" fmla="*/ 1825499 h 1825499"/>
                  <a:gd name="connsiteX3" fmla="*/ 0 w 1317026"/>
                  <a:gd name="connsiteY3" fmla="*/ 209549 h 1825499"/>
                  <a:gd name="connsiteX0" fmla="*/ 47625 w 1317026"/>
                  <a:gd name="connsiteY0" fmla="*/ 0 h 1825499"/>
                  <a:gd name="connsiteX1" fmla="*/ 1317026 w 1317026"/>
                  <a:gd name="connsiteY1" fmla="*/ 1014187 h 1825499"/>
                  <a:gd name="connsiteX0" fmla="*/ 85726 w 1402752"/>
                  <a:gd name="connsiteY0" fmla="*/ 219072 h 1835022"/>
                  <a:gd name="connsiteX1" fmla="*/ 1402752 w 1402752"/>
                  <a:gd name="connsiteY1" fmla="*/ 1023710 h 1835022"/>
                  <a:gd name="connsiteX2" fmla="*/ 85727 w 1402752"/>
                  <a:gd name="connsiteY2" fmla="*/ 1835022 h 1835022"/>
                  <a:gd name="connsiteX3" fmla="*/ 85726 w 1402752"/>
                  <a:gd name="connsiteY3" fmla="*/ 219072 h 1835022"/>
                  <a:gd name="connsiteX0" fmla="*/ 0 w 1402752"/>
                  <a:gd name="connsiteY0" fmla="*/ 0 h 1835022"/>
                  <a:gd name="connsiteX1" fmla="*/ 1402752 w 1402752"/>
                  <a:gd name="connsiteY1" fmla="*/ 1023710 h 1835022"/>
                  <a:gd name="connsiteX0" fmla="*/ 85726 w 1402752"/>
                  <a:gd name="connsiteY0" fmla="*/ 219072 h 1835022"/>
                  <a:gd name="connsiteX1" fmla="*/ 1402752 w 1402752"/>
                  <a:gd name="connsiteY1" fmla="*/ 1023710 h 1835022"/>
                  <a:gd name="connsiteX2" fmla="*/ 85727 w 1402752"/>
                  <a:gd name="connsiteY2" fmla="*/ 1835022 h 1835022"/>
                  <a:gd name="connsiteX3" fmla="*/ 85726 w 1402752"/>
                  <a:gd name="connsiteY3" fmla="*/ 219072 h 1835022"/>
                  <a:gd name="connsiteX0" fmla="*/ 0 w 1402752"/>
                  <a:gd name="connsiteY0" fmla="*/ 0 h 1835022"/>
                  <a:gd name="connsiteX1" fmla="*/ 1402752 w 1402752"/>
                  <a:gd name="connsiteY1" fmla="*/ 1023710 h 1835022"/>
                  <a:gd name="connsiteX0" fmla="*/ 85726 w 1402752"/>
                  <a:gd name="connsiteY0" fmla="*/ 219072 h 1835022"/>
                  <a:gd name="connsiteX1" fmla="*/ 1402752 w 1402752"/>
                  <a:gd name="connsiteY1" fmla="*/ 1023710 h 1835022"/>
                  <a:gd name="connsiteX2" fmla="*/ 85727 w 1402752"/>
                  <a:gd name="connsiteY2" fmla="*/ 1835022 h 1835022"/>
                  <a:gd name="connsiteX3" fmla="*/ 85726 w 1402752"/>
                  <a:gd name="connsiteY3" fmla="*/ 219072 h 1835022"/>
                  <a:gd name="connsiteX0" fmla="*/ 0 w 1402752"/>
                  <a:gd name="connsiteY0" fmla="*/ 0 h 1835022"/>
                  <a:gd name="connsiteX1" fmla="*/ 1402752 w 1402752"/>
                  <a:gd name="connsiteY1" fmla="*/ 1023710 h 1835022"/>
                  <a:gd name="connsiteX0" fmla="*/ 57151 w 1374177"/>
                  <a:gd name="connsiteY0" fmla="*/ 285747 h 1901697"/>
                  <a:gd name="connsiteX1" fmla="*/ 1374177 w 1374177"/>
                  <a:gd name="connsiteY1" fmla="*/ 1090385 h 1901697"/>
                  <a:gd name="connsiteX2" fmla="*/ 57152 w 1374177"/>
                  <a:gd name="connsiteY2" fmla="*/ 1901697 h 1901697"/>
                  <a:gd name="connsiteX3" fmla="*/ 57151 w 1374177"/>
                  <a:gd name="connsiteY3" fmla="*/ 285747 h 1901697"/>
                  <a:gd name="connsiteX0" fmla="*/ 0 w 1374177"/>
                  <a:gd name="connsiteY0" fmla="*/ 0 h 1901697"/>
                  <a:gd name="connsiteX1" fmla="*/ 1374177 w 1374177"/>
                  <a:gd name="connsiteY1" fmla="*/ 1090385 h 1901697"/>
                  <a:gd name="connsiteX0" fmla="*/ 57151 w 1374177"/>
                  <a:gd name="connsiteY0" fmla="*/ 285747 h 1901697"/>
                  <a:gd name="connsiteX1" fmla="*/ 1374177 w 1374177"/>
                  <a:gd name="connsiteY1" fmla="*/ 1090385 h 1901697"/>
                  <a:gd name="connsiteX2" fmla="*/ 57152 w 1374177"/>
                  <a:gd name="connsiteY2" fmla="*/ 1901697 h 1901697"/>
                  <a:gd name="connsiteX3" fmla="*/ 57151 w 1374177"/>
                  <a:gd name="connsiteY3" fmla="*/ 285747 h 1901697"/>
                  <a:gd name="connsiteX0" fmla="*/ 0 w 1374177"/>
                  <a:gd name="connsiteY0" fmla="*/ 0 h 1901697"/>
                  <a:gd name="connsiteX1" fmla="*/ 1374177 w 1374177"/>
                  <a:gd name="connsiteY1" fmla="*/ 1090385 h 1901697"/>
                  <a:gd name="connsiteX0" fmla="*/ 66676 w 1383702"/>
                  <a:gd name="connsiteY0" fmla="*/ 257172 h 1873122"/>
                  <a:gd name="connsiteX1" fmla="*/ 1383702 w 1383702"/>
                  <a:gd name="connsiteY1" fmla="*/ 1061810 h 1873122"/>
                  <a:gd name="connsiteX2" fmla="*/ 66677 w 1383702"/>
                  <a:gd name="connsiteY2" fmla="*/ 1873122 h 1873122"/>
                  <a:gd name="connsiteX3" fmla="*/ 66676 w 1383702"/>
                  <a:gd name="connsiteY3" fmla="*/ 257172 h 1873122"/>
                  <a:gd name="connsiteX0" fmla="*/ 0 w 1383702"/>
                  <a:gd name="connsiteY0" fmla="*/ 0 h 1873122"/>
                  <a:gd name="connsiteX1" fmla="*/ 1383702 w 1383702"/>
                  <a:gd name="connsiteY1" fmla="*/ 1061810 h 187312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383702" h="1873122" stroke="0" extrusionOk="0">
                    <a:moveTo>
                      <a:pt x="66676" y="257172"/>
                    </a:moveTo>
                    <a:cubicBezTo>
                      <a:pt x="609448" y="257172"/>
                      <a:pt x="1111195" y="563715"/>
                      <a:pt x="1383702" y="1061810"/>
                    </a:cubicBezTo>
                    <a:lnTo>
                      <a:pt x="66677" y="1873122"/>
                    </a:lnTo>
                    <a:cubicBezTo>
                      <a:pt x="66677" y="1334472"/>
                      <a:pt x="66676" y="795822"/>
                      <a:pt x="66676" y="257172"/>
                    </a:cubicBezTo>
                    <a:close/>
                  </a:path>
                  <a:path w="1383702" h="1873122" fill="none">
                    <a:moveTo>
                      <a:pt x="0" y="0"/>
                    </a:moveTo>
                    <a:cubicBezTo>
                      <a:pt x="457047" y="161925"/>
                      <a:pt x="1111195" y="563715"/>
                      <a:pt x="1383702" y="1061810"/>
                    </a:cubicBezTo>
                  </a:path>
                </a:pathLst>
              </a:custGeom>
              <a:ln w="31750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1" name="Arc 62">
                <a:extLst>
                  <a:ext uri="{FF2B5EF4-FFF2-40B4-BE49-F238E27FC236}">
                    <a16:creationId xmlns:a16="http://schemas.microsoft.com/office/drawing/2014/main" id="{0B12573B-E6C9-D530-52B8-70EA96EBE404}"/>
                  </a:ext>
                </a:extLst>
              </p:cNvPr>
              <p:cNvSpPr/>
              <p:nvPr/>
            </p:nvSpPr>
            <p:spPr>
              <a:xfrm rot="7801211">
                <a:off x="6008042" y="5476742"/>
                <a:ext cx="1148749" cy="1499308"/>
              </a:xfrm>
              <a:custGeom>
                <a:avLst/>
                <a:gdLst>
                  <a:gd name="connsiteX0" fmla="*/ 1522872 w 3045745"/>
                  <a:gd name="connsiteY0" fmla="*/ 0 h 3231900"/>
                  <a:gd name="connsiteX1" fmla="*/ 2839898 w 3045745"/>
                  <a:gd name="connsiteY1" fmla="*/ 804638 h 3231900"/>
                  <a:gd name="connsiteX2" fmla="*/ 1522873 w 3045745"/>
                  <a:gd name="connsiteY2" fmla="*/ 1615950 h 3231900"/>
                  <a:gd name="connsiteX3" fmla="*/ 1522872 w 3045745"/>
                  <a:gd name="connsiteY3" fmla="*/ 0 h 3231900"/>
                  <a:gd name="connsiteX0" fmla="*/ 1522872 w 3045745"/>
                  <a:gd name="connsiteY0" fmla="*/ 0 h 3231900"/>
                  <a:gd name="connsiteX1" fmla="*/ 2839898 w 3045745"/>
                  <a:gd name="connsiteY1" fmla="*/ 804638 h 3231900"/>
                  <a:gd name="connsiteX0" fmla="*/ 0 w 1317026"/>
                  <a:gd name="connsiteY0" fmla="*/ 238126 h 1854076"/>
                  <a:gd name="connsiteX1" fmla="*/ 1317026 w 1317026"/>
                  <a:gd name="connsiteY1" fmla="*/ 1042764 h 1854076"/>
                  <a:gd name="connsiteX2" fmla="*/ 1 w 1317026"/>
                  <a:gd name="connsiteY2" fmla="*/ 1854076 h 1854076"/>
                  <a:gd name="connsiteX3" fmla="*/ 0 w 1317026"/>
                  <a:gd name="connsiteY3" fmla="*/ 238126 h 1854076"/>
                  <a:gd name="connsiteX0" fmla="*/ 95250 w 1317026"/>
                  <a:gd name="connsiteY0" fmla="*/ 0 h 1854076"/>
                  <a:gd name="connsiteX1" fmla="*/ 1317026 w 1317026"/>
                  <a:gd name="connsiteY1" fmla="*/ 1042764 h 1854076"/>
                  <a:gd name="connsiteX0" fmla="*/ 0 w 1317026"/>
                  <a:gd name="connsiteY0" fmla="*/ 76201 h 1692151"/>
                  <a:gd name="connsiteX1" fmla="*/ 1317026 w 1317026"/>
                  <a:gd name="connsiteY1" fmla="*/ 880839 h 1692151"/>
                  <a:gd name="connsiteX2" fmla="*/ 1 w 1317026"/>
                  <a:gd name="connsiteY2" fmla="*/ 1692151 h 1692151"/>
                  <a:gd name="connsiteX3" fmla="*/ 0 w 1317026"/>
                  <a:gd name="connsiteY3" fmla="*/ 76201 h 1692151"/>
                  <a:gd name="connsiteX0" fmla="*/ 38100 w 1317026"/>
                  <a:gd name="connsiteY0" fmla="*/ 0 h 1692151"/>
                  <a:gd name="connsiteX1" fmla="*/ 1317026 w 1317026"/>
                  <a:gd name="connsiteY1" fmla="*/ 880839 h 1692151"/>
                  <a:gd name="connsiteX0" fmla="*/ 0 w 1317026"/>
                  <a:gd name="connsiteY0" fmla="*/ 209549 h 1825499"/>
                  <a:gd name="connsiteX1" fmla="*/ 1317026 w 1317026"/>
                  <a:gd name="connsiteY1" fmla="*/ 1014187 h 1825499"/>
                  <a:gd name="connsiteX2" fmla="*/ 1 w 1317026"/>
                  <a:gd name="connsiteY2" fmla="*/ 1825499 h 1825499"/>
                  <a:gd name="connsiteX3" fmla="*/ 0 w 1317026"/>
                  <a:gd name="connsiteY3" fmla="*/ 209549 h 1825499"/>
                  <a:gd name="connsiteX0" fmla="*/ 47625 w 1317026"/>
                  <a:gd name="connsiteY0" fmla="*/ 0 h 1825499"/>
                  <a:gd name="connsiteX1" fmla="*/ 1317026 w 1317026"/>
                  <a:gd name="connsiteY1" fmla="*/ 1014187 h 1825499"/>
                  <a:gd name="connsiteX0" fmla="*/ 85726 w 1402752"/>
                  <a:gd name="connsiteY0" fmla="*/ 219072 h 1835022"/>
                  <a:gd name="connsiteX1" fmla="*/ 1402752 w 1402752"/>
                  <a:gd name="connsiteY1" fmla="*/ 1023710 h 1835022"/>
                  <a:gd name="connsiteX2" fmla="*/ 85727 w 1402752"/>
                  <a:gd name="connsiteY2" fmla="*/ 1835022 h 1835022"/>
                  <a:gd name="connsiteX3" fmla="*/ 85726 w 1402752"/>
                  <a:gd name="connsiteY3" fmla="*/ 219072 h 1835022"/>
                  <a:gd name="connsiteX0" fmla="*/ 0 w 1402752"/>
                  <a:gd name="connsiteY0" fmla="*/ 0 h 1835022"/>
                  <a:gd name="connsiteX1" fmla="*/ 1402752 w 1402752"/>
                  <a:gd name="connsiteY1" fmla="*/ 1023710 h 1835022"/>
                  <a:gd name="connsiteX0" fmla="*/ 85726 w 1402752"/>
                  <a:gd name="connsiteY0" fmla="*/ 219072 h 1835022"/>
                  <a:gd name="connsiteX1" fmla="*/ 1402752 w 1402752"/>
                  <a:gd name="connsiteY1" fmla="*/ 1023710 h 1835022"/>
                  <a:gd name="connsiteX2" fmla="*/ 85727 w 1402752"/>
                  <a:gd name="connsiteY2" fmla="*/ 1835022 h 1835022"/>
                  <a:gd name="connsiteX3" fmla="*/ 85726 w 1402752"/>
                  <a:gd name="connsiteY3" fmla="*/ 219072 h 1835022"/>
                  <a:gd name="connsiteX0" fmla="*/ 0 w 1402752"/>
                  <a:gd name="connsiteY0" fmla="*/ 0 h 1835022"/>
                  <a:gd name="connsiteX1" fmla="*/ 1402752 w 1402752"/>
                  <a:gd name="connsiteY1" fmla="*/ 1023710 h 1835022"/>
                  <a:gd name="connsiteX0" fmla="*/ 85726 w 1402752"/>
                  <a:gd name="connsiteY0" fmla="*/ 219072 h 1835022"/>
                  <a:gd name="connsiteX1" fmla="*/ 1402752 w 1402752"/>
                  <a:gd name="connsiteY1" fmla="*/ 1023710 h 1835022"/>
                  <a:gd name="connsiteX2" fmla="*/ 85727 w 1402752"/>
                  <a:gd name="connsiteY2" fmla="*/ 1835022 h 1835022"/>
                  <a:gd name="connsiteX3" fmla="*/ 85726 w 1402752"/>
                  <a:gd name="connsiteY3" fmla="*/ 219072 h 1835022"/>
                  <a:gd name="connsiteX0" fmla="*/ 0 w 1402752"/>
                  <a:gd name="connsiteY0" fmla="*/ 0 h 1835022"/>
                  <a:gd name="connsiteX1" fmla="*/ 1402752 w 1402752"/>
                  <a:gd name="connsiteY1" fmla="*/ 1023710 h 1835022"/>
                  <a:gd name="connsiteX0" fmla="*/ 57151 w 1374177"/>
                  <a:gd name="connsiteY0" fmla="*/ 285747 h 1901697"/>
                  <a:gd name="connsiteX1" fmla="*/ 1374177 w 1374177"/>
                  <a:gd name="connsiteY1" fmla="*/ 1090385 h 1901697"/>
                  <a:gd name="connsiteX2" fmla="*/ 57152 w 1374177"/>
                  <a:gd name="connsiteY2" fmla="*/ 1901697 h 1901697"/>
                  <a:gd name="connsiteX3" fmla="*/ 57151 w 1374177"/>
                  <a:gd name="connsiteY3" fmla="*/ 285747 h 1901697"/>
                  <a:gd name="connsiteX0" fmla="*/ 0 w 1374177"/>
                  <a:gd name="connsiteY0" fmla="*/ 0 h 1901697"/>
                  <a:gd name="connsiteX1" fmla="*/ 1374177 w 1374177"/>
                  <a:gd name="connsiteY1" fmla="*/ 1090385 h 1901697"/>
                  <a:gd name="connsiteX0" fmla="*/ 57151 w 1374177"/>
                  <a:gd name="connsiteY0" fmla="*/ 285747 h 1901697"/>
                  <a:gd name="connsiteX1" fmla="*/ 1374177 w 1374177"/>
                  <a:gd name="connsiteY1" fmla="*/ 1090385 h 1901697"/>
                  <a:gd name="connsiteX2" fmla="*/ 57152 w 1374177"/>
                  <a:gd name="connsiteY2" fmla="*/ 1901697 h 1901697"/>
                  <a:gd name="connsiteX3" fmla="*/ 57151 w 1374177"/>
                  <a:gd name="connsiteY3" fmla="*/ 285747 h 1901697"/>
                  <a:gd name="connsiteX0" fmla="*/ 0 w 1374177"/>
                  <a:gd name="connsiteY0" fmla="*/ 0 h 1901697"/>
                  <a:gd name="connsiteX1" fmla="*/ 1374177 w 1374177"/>
                  <a:gd name="connsiteY1" fmla="*/ 1090385 h 1901697"/>
                  <a:gd name="connsiteX0" fmla="*/ 66676 w 1383702"/>
                  <a:gd name="connsiteY0" fmla="*/ 257172 h 1873122"/>
                  <a:gd name="connsiteX1" fmla="*/ 1383702 w 1383702"/>
                  <a:gd name="connsiteY1" fmla="*/ 1061810 h 1873122"/>
                  <a:gd name="connsiteX2" fmla="*/ 66677 w 1383702"/>
                  <a:gd name="connsiteY2" fmla="*/ 1873122 h 1873122"/>
                  <a:gd name="connsiteX3" fmla="*/ 66676 w 1383702"/>
                  <a:gd name="connsiteY3" fmla="*/ 257172 h 1873122"/>
                  <a:gd name="connsiteX0" fmla="*/ 0 w 1383702"/>
                  <a:gd name="connsiteY0" fmla="*/ 0 h 1873122"/>
                  <a:gd name="connsiteX1" fmla="*/ 1383702 w 1383702"/>
                  <a:gd name="connsiteY1" fmla="*/ 1061810 h 187312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383702" h="1873122" stroke="0" extrusionOk="0">
                    <a:moveTo>
                      <a:pt x="66676" y="257172"/>
                    </a:moveTo>
                    <a:cubicBezTo>
                      <a:pt x="609448" y="257172"/>
                      <a:pt x="1111195" y="563715"/>
                      <a:pt x="1383702" y="1061810"/>
                    </a:cubicBezTo>
                    <a:lnTo>
                      <a:pt x="66677" y="1873122"/>
                    </a:lnTo>
                    <a:cubicBezTo>
                      <a:pt x="66677" y="1334472"/>
                      <a:pt x="66676" y="795822"/>
                      <a:pt x="66676" y="257172"/>
                    </a:cubicBezTo>
                    <a:close/>
                  </a:path>
                  <a:path w="1383702" h="1873122" fill="none">
                    <a:moveTo>
                      <a:pt x="0" y="0"/>
                    </a:moveTo>
                    <a:cubicBezTo>
                      <a:pt x="457047" y="161925"/>
                      <a:pt x="1111195" y="563715"/>
                      <a:pt x="1383702" y="1061810"/>
                    </a:cubicBezTo>
                  </a:path>
                </a:pathLst>
              </a:custGeom>
              <a:ln w="31750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2" name="Arc 62">
                <a:extLst>
                  <a:ext uri="{FF2B5EF4-FFF2-40B4-BE49-F238E27FC236}">
                    <a16:creationId xmlns:a16="http://schemas.microsoft.com/office/drawing/2014/main" id="{0B12573B-E6C9-D530-52B8-70EA96EBE404}"/>
                  </a:ext>
                </a:extLst>
              </p:cNvPr>
              <p:cNvSpPr/>
              <p:nvPr/>
            </p:nvSpPr>
            <p:spPr>
              <a:xfrm rot="5992145">
                <a:off x="7336590" y="5315434"/>
                <a:ext cx="818664" cy="1196820"/>
              </a:xfrm>
              <a:custGeom>
                <a:avLst/>
                <a:gdLst>
                  <a:gd name="connsiteX0" fmla="*/ 1522872 w 3045745"/>
                  <a:gd name="connsiteY0" fmla="*/ 0 h 3231900"/>
                  <a:gd name="connsiteX1" fmla="*/ 2839898 w 3045745"/>
                  <a:gd name="connsiteY1" fmla="*/ 804638 h 3231900"/>
                  <a:gd name="connsiteX2" fmla="*/ 1522873 w 3045745"/>
                  <a:gd name="connsiteY2" fmla="*/ 1615950 h 3231900"/>
                  <a:gd name="connsiteX3" fmla="*/ 1522872 w 3045745"/>
                  <a:gd name="connsiteY3" fmla="*/ 0 h 3231900"/>
                  <a:gd name="connsiteX0" fmla="*/ 1522872 w 3045745"/>
                  <a:gd name="connsiteY0" fmla="*/ 0 h 3231900"/>
                  <a:gd name="connsiteX1" fmla="*/ 2839898 w 3045745"/>
                  <a:gd name="connsiteY1" fmla="*/ 804638 h 3231900"/>
                  <a:gd name="connsiteX0" fmla="*/ 0 w 1317026"/>
                  <a:gd name="connsiteY0" fmla="*/ 238126 h 1854076"/>
                  <a:gd name="connsiteX1" fmla="*/ 1317026 w 1317026"/>
                  <a:gd name="connsiteY1" fmla="*/ 1042764 h 1854076"/>
                  <a:gd name="connsiteX2" fmla="*/ 1 w 1317026"/>
                  <a:gd name="connsiteY2" fmla="*/ 1854076 h 1854076"/>
                  <a:gd name="connsiteX3" fmla="*/ 0 w 1317026"/>
                  <a:gd name="connsiteY3" fmla="*/ 238126 h 1854076"/>
                  <a:gd name="connsiteX0" fmla="*/ 95250 w 1317026"/>
                  <a:gd name="connsiteY0" fmla="*/ 0 h 1854076"/>
                  <a:gd name="connsiteX1" fmla="*/ 1317026 w 1317026"/>
                  <a:gd name="connsiteY1" fmla="*/ 1042764 h 1854076"/>
                  <a:gd name="connsiteX0" fmla="*/ 0 w 1317026"/>
                  <a:gd name="connsiteY0" fmla="*/ 76201 h 1692151"/>
                  <a:gd name="connsiteX1" fmla="*/ 1317026 w 1317026"/>
                  <a:gd name="connsiteY1" fmla="*/ 880839 h 1692151"/>
                  <a:gd name="connsiteX2" fmla="*/ 1 w 1317026"/>
                  <a:gd name="connsiteY2" fmla="*/ 1692151 h 1692151"/>
                  <a:gd name="connsiteX3" fmla="*/ 0 w 1317026"/>
                  <a:gd name="connsiteY3" fmla="*/ 76201 h 1692151"/>
                  <a:gd name="connsiteX0" fmla="*/ 38100 w 1317026"/>
                  <a:gd name="connsiteY0" fmla="*/ 0 h 1692151"/>
                  <a:gd name="connsiteX1" fmla="*/ 1317026 w 1317026"/>
                  <a:gd name="connsiteY1" fmla="*/ 880839 h 1692151"/>
                  <a:gd name="connsiteX0" fmla="*/ 0 w 1317026"/>
                  <a:gd name="connsiteY0" fmla="*/ 209549 h 1825499"/>
                  <a:gd name="connsiteX1" fmla="*/ 1317026 w 1317026"/>
                  <a:gd name="connsiteY1" fmla="*/ 1014187 h 1825499"/>
                  <a:gd name="connsiteX2" fmla="*/ 1 w 1317026"/>
                  <a:gd name="connsiteY2" fmla="*/ 1825499 h 1825499"/>
                  <a:gd name="connsiteX3" fmla="*/ 0 w 1317026"/>
                  <a:gd name="connsiteY3" fmla="*/ 209549 h 1825499"/>
                  <a:gd name="connsiteX0" fmla="*/ 47625 w 1317026"/>
                  <a:gd name="connsiteY0" fmla="*/ 0 h 1825499"/>
                  <a:gd name="connsiteX1" fmla="*/ 1317026 w 1317026"/>
                  <a:gd name="connsiteY1" fmla="*/ 1014187 h 1825499"/>
                  <a:gd name="connsiteX0" fmla="*/ 85726 w 1402752"/>
                  <a:gd name="connsiteY0" fmla="*/ 219072 h 1835022"/>
                  <a:gd name="connsiteX1" fmla="*/ 1402752 w 1402752"/>
                  <a:gd name="connsiteY1" fmla="*/ 1023710 h 1835022"/>
                  <a:gd name="connsiteX2" fmla="*/ 85727 w 1402752"/>
                  <a:gd name="connsiteY2" fmla="*/ 1835022 h 1835022"/>
                  <a:gd name="connsiteX3" fmla="*/ 85726 w 1402752"/>
                  <a:gd name="connsiteY3" fmla="*/ 219072 h 1835022"/>
                  <a:gd name="connsiteX0" fmla="*/ 0 w 1402752"/>
                  <a:gd name="connsiteY0" fmla="*/ 0 h 1835022"/>
                  <a:gd name="connsiteX1" fmla="*/ 1402752 w 1402752"/>
                  <a:gd name="connsiteY1" fmla="*/ 1023710 h 1835022"/>
                  <a:gd name="connsiteX0" fmla="*/ 85726 w 1402752"/>
                  <a:gd name="connsiteY0" fmla="*/ 219072 h 1835022"/>
                  <a:gd name="connsiteX1" fmla="*/ 1402752 w 1402752"/>
                  <a:gd name="connsiteY1" fmla="*/ 1023710 h 1835022"/>
                  <a:gd name="connsiteX2" fmla="*/ 85727 w 1402752"/>
                  <a:gd name="connsiteY2" fmla="*/ 1835022 h 1835022"/>
                  <a:gd name="connsiteX3" fmla="*/ 85726 w 1402752"/>
                  <a:gd name="connsiteY3" fmla="*/ 219072 h 1835022"/>
                  <a:gd name="connsiteX0" fmla="*/ 0 w 1402752"/>
                  <a:gd name="connsiteY0" fmla="*/ 0 h 1835022"/>
                  <a:gd name="connsiteX1" fmla="*/ 1402752 w 1402752"/>
                  <a:gd name="connsiteY1" fmla="*/ 1023710 h 1835022"/>
                  <a:gd name="connsiteX0" fmla="*/ 85726 w 1402752"/>
                  <a:gd name="connsiteY0" fmla="*/ 219072 h 1835022"/>
                  <a:gd name="connsiteX1" fmla="*/ 1402752 w 1402752"/>
                  <a:gd name="connsiteY1" fmla="*/ 1023710 h 1835022"/>
                  <a:gd name="connsiteX2" fmla="*/ 85727 w 1402752"/>
                  <a:gd name="connsiteY2" fmla="*/ 1835022 h 1835022"/>
                  <a:gd name="connsiteX3" fmla="*/ 85726 w 1402752"/>
                  <a:gd name="connsiteY3" fmla="*/ 219072 h 1835022"/>
                  <a:gd name="connsiteX0" fmla="*/ 0 w 1402752"/>
                  <a:gd name="connsiteY0" fmla="*/ 0 h 1835022"/>
                  <a:gd name="connsiteX1" fmla="*/ 1402752 w 1402752"/>
                  <a:gd name="connsiteY1" fmla="*/ 1023710 h 1835022"/>
                  <a:gd name="connsiteX0" fmla="*/ 57151 w 1374177"/>
                  <a:gd name="connsiteY0" fmla="*/ 285747 h 1901697"/>
                  <a:gd name="connsiteX1" fmla="*/ 1374177 w 1374177"/>
                  <a:gd name="connsiteY1" fmla="*/ 1090385 h 1901697"/>
                  <a:gd name="connsiteX2" fmla="*/ 57152 w 1374177"/>
                  <a:gd name="connsiteY2" fmla="*/ 1901697 h 1901697"/>
                  <a:gd name="connsiteX3" fmla="*/ 57151 w 1374177"/>
                  <a:gd name="connsiteY3" fmla="*/ 285747 h 1901697"/>
                  <a:gd name="connsiteX0" fmla="*/ 0 w 1374177"/>
                  <a:gd name="connsiteY0" fmla="*/ 0 h 1901697"/>
                  <a:gd name="connsiteX1" fmla="*/ 1374177 w 1374177"/>
                  <a:gd name="connsiteY1" fmla="*/ 1090385 h 1901697"/>
                  <a:gd name="connsiteX0" fmla="*/ 57151 w 1374177"/>
                  <a:gd name="connsiteY0" fmla="*/ 285747 h 1901697"/>
                  <a:gd name="connsiteX1" fmla="*/ 1374177 w 1374177"/>
                  <a:gd name="connsiteY1" fmla="*/ 1090385 h 1901697"/>
                  <a:gd name="connsiteX2" fmla="*/ 57152 w 1374177"/>
                  <a:gd name="connsiteY2" fmla="*/ 1901697 h 1901697"/>
                  <a:gd name="connsiteX3" fmla="*/ 57151 w 1374177"/>
                  <a:gd name="connsiteY3" fmla="*/ 285747 h 1901697"/>
                  <a:gd name="connsiteX0" fmla="*/ 0 w 1374177"/>
                  <a:gd name="connsiteY0" fmla="*/ 0 h 1901697"/>
                  <a:gd name="connsiteX1" fmla="*/ 1374177 w 1374177"/>
                  <a:gd name="connsiteY1" fmla="*/ 1090385 h 1901697"/>
                  <a:gd name="connsiteX0" fmla="*/ 66676 w 1383702"/>
                  <a:gd name="connsiteY0" fmla="*/ 257172 h 1873122"/>
                  <a:gd name="connsiteX1" fmla="*/ 1383702 w 1383702"/>
                  <a:gd name="connsiteY1" fmla="*/ 1061810 h 1873122"/>
                  <a:gd name="connsiteX2" fmla="*/ 66677 w 1383702"/>
                  <a:gd name="connsiteY2" fmla="*/ 1873122 h 1873122"/>
                  <a:gd name="connsiteX3" fmla="*/ 66676 w 1383702"/>
                  <a:gd name="connsiteY3" fmla="*/ 257172 h 1873122"/>
                  <a:gd name="connsiteX0" fmla="*/ 0 w 1383702"/>
                  <a:gd name="connsiteY0" fmla="*/ 0 h 1873122"/>
                  <a:gd name="connsiteX1" fmla="*/ 1383702 w 1383702"/>
                  <a:gd name="connsiteY1" fmla="*/ 1061810 h 1873122"/>
                  <a:gd name="connsiteX0" fmla="*/ 0 w 1317026"/>
                  <a:gd name="connsiteY0" fmla="*/ 421104 h 2037054"/>
                  <a:gd name="connsiteX1" fmla="*/ 1317026 w 1317026"/>
                  <a:gd name="connsiteY1" fmla="*/ 1225742 h 2037054"/>
                  <a:gd name="connsiteX2" fmla="*/ 1 w 1317026"/>
                  <a:gd name="connsiteY2" fmla="*/ 2037054 h 2037054"/>
                  <a:gd name="connsiteX3" fmla="*/ 0 w 1317026"/>
                  <a:gd name="connsiteY3" fmla="*/ 421104 h 2037054"/>
                  <a:gd name="connsiteX0" fmla="*/ 57241 w 1317026"/>
                  <a:gd name="connsiteY0" fmla="*/ 0 h 2037054"/>
                  <a:gd name="connsiteX1" fmla="*/ 1317026 w 1317026"/>
                  <a:gd name="connsiteY1" fmla="*/ 1225742 h 2037054"/>
                  <a:gd name="connsiteX0" fmla="*/ 11016 w 1317024"/>
                  <a:gd name="connsiteY0" fmla="*/ 251282 h 2037054"/>
                  <a:gd name="connsiteX1" fmla="*/ 1317024 w 1317024"/>
                  <a:gd name="connsiteY1" fmla="*/ 1225742 h 2037054"/>
                  <a:gd name="connsiteX2" fmla="*/ -1 w 1317024"/>
                  <a:gd name="connsiteY2" fmla="*/ 2037054 h 2037054"/>
                  <a:gd name="connsiteX3" fmla="*/ 11016 w 1317024"/>
                  <a:gd name="connsiteY3" fmla="*/ 251282 h 2037054"/>
                  <a:gd name="connsiteX0" fmla="*/ 57239 w 1317024"/>
                  <a:gd name="connsiteY0" fmla="*/ 0 h 2037054"/>
                  <a:gd name="connsiteX1" fmla="*/ 1317024 w 1317024"/>
                  <a:gd name="connsiteY1" fmla="*/ 1225742 h 2037054"/>
                  <a:gd name="connsiteX0" fmla="*/ 11018 w 1317026"/>
                  <a:gd name="connsiteY0" fmla="*/ 342092 h 2127864"/>
                  <a:gd name="connsiteX1" fmla="*/ 1317026 w 1317026"/>
                  <a:gd name="connsiteY1" fmla="*/ 1316552 h 2127864"/>
                  <a:gd name="connsiteX2" fmla="*/ 1 w 1317026"/>
                  <a:gd name="connsiteY2" fmla="*/ 2127864 h 2127864"/>
                  <a:gd name="connsiteX3" fmla="*/ 11018 w 1317026"/>
                  <a:gd name="connsiteY3" fmla="*/ 342092 h 2127864"/>
                  <a:gd name="connsiteX0" fmla="*/ 92944 w 1317026"/>
                  <a:gd name="connsiteY0" fmla="*/ 0 h 2127864"/>
                  <a:gd name="connsiteX1" fmla="*/ 1317026 w 1317026"/>
                  <a:gd name="connsiteY1" fmla="*/ 1316552 h 2127864"/>
                  <a:gd name="connsiteX0" fmla="*/ 11016 w 1317024"/>
                  <a:gd name="connsiteY0" fmla="*/ 342092 h 2127864"/>
                  <a:gd name="connsiteX1" fmla="*/ 1317024 w 1317024"/>
                  <a:gd name="connsiteY1" fmla="*/ 1316552 h 2127864"/>
                  <a:gd name="connsiteX2" fmla="*/ -1 w 1317024"/>
                  <a:gd name="connsiteY2" fmla="*/ 2127864 h 2127864"/>
                  <a:gd name="connsiteX3" fmla="*/ 11016 w 1317024"/>
                  <a:gd name="connsiteY3" fmla="*/ 342092 h 2127864"/>
                  <a:gd name="connsiteX0" fmla="*/ 92942 w 1317024"/>
                  <a:gd name="connsiteY0" fmla="*/ 0 h 2127864"/>
                  <a:gd name="connsiteX1" fmla="*/ 1317024 w 1317024"/>
                  <a:gd name="connsiteY1" fmla="*/ 1316552 h 2127864"/>
                  <a:gd name="connsiteX0" fmla="*/ 11018 w 1317026"/>
                  <a:gd name="connsiteY0" fmla="*/ 291969 h 2077741"/>
                  <a:gd name="connsiteX1" fmla="*/ 1317026 w 1317026"/>
                  <a:gd name="connsiteY1" fmla="*/ 1266429 h 2077741"/>
                  <a:gd name="connsiteX2" fmla="*/ 1 w 1317026"/>
                  <a:gd name="connsiteY2" fmla="*/ 2077741 h 2077741"/>
                  <a:gd name="connsiteX3" fmla="*/ 11018 w 1317026"/>
                  <a:gd name="connsiteY3" fmla="*/ 291969 h 2077741"/>
                  <a:gd name="connsiteX0" fmla="*/ 50938 w 1317026"/>
                  <a:gd name="connsiteY0" fmla="*/ 0 h 2077741"/>
                  <a:gd name="connsiteX1" fmla="*/ 1317026 w 1317026"/>
                  <a:gd name="connsiteY1" fmla="*/ 1266429 h 2077741"/>
                  <a:gd name="connsiteX0" fmla="*/ 4713 w 1317024"/>
                  <a:gd name="connsiteY0" fmla="*/ 251282 h 2077741"/>
                  <a:gd name="connsiteX1" fmla="*/ 1317024 w 1317024"/>
                  <a:gd name="connsiteY1" fmla="*/ 1266429 h 2077741"/>
                  <a:gd name="connsiteX2" fmla="*/ -1 w 1317024"/>
                  <a:gd name="connsiteY2" fmla="*/ 2077741 h 2077741"/>
                  <a:gd name="connsiteX3" fmla="*/ 4713 w 1317024"/>
                  <a:gd name="connsiteY3" fmla="*/ 251282 h 2077741"/>
                  <a:gd name="connsiteX0" fmla="*/ 50936 w 1317024"/>
                  <a:gd name="connsiteY0" fmla="*/ 0 h 2077741"/>
                  <a:gd name="connsiteX1" fmla="*/ 1317024 w 1317024"/>
                  <a:gd name="connsiteY1" fmla="*/ 1266429 h 2077741"/>
                  <a:gd name="connsiteX0" fmla="*/ 4715 w 1317026"/>
                  <a:gd name="connsiteY0" fmla="*/ 301406 h 2127865"/>
                  <a:gd name="connsiteX1" fmla="*/ 1317026 w 1317026"/>
                  <a:gd name="connsiteY1" fmla="*/ 1316553 h 2127865"/>
                  <a:gd name="connsiteX2" fmla="*/ 1 w 1317026"/>
                  <a:gd name="connsiteY2" fmla="*/ 2127865 h 2127865"/>
                  <a:gd name="connsiteX3" fmla="*/ 4715 w 1317026"/>
                  <a:gd name="connsiteY3" fmla="*/ 301406 h 2127865"/>
                  <a:gd name="connsiteX0" fmla="*/ 92942 w 1317026"/>
                  <a:gd name="connsiteY0" fmla="*/ 0 h 2127865"/>
                  <a:gd name="connsiteX1" fmla="*/ 1317026 w 1317026"/>
                  <a:gd name="connsiteY1" fmla="*/ 1316553 h 2127865"/>
                  <a:gd name="connsiteX0" fmla="*/ 18891 w 1317024"/>
                  <a:gd name="connsiteY0" fmla="*/ 312610 h 2127865"/>
                  <a:gd name="connsiteX1" fmla="*/ 1317024 w 1317024"/>
                  <a:gd name="connsiteY1" fmla="*/ 1316553 h 2127865"/>
                  <a:gd name="connsiteX2" fmla="*/ -1 w 1317024"/>
                  <a:gd name="connsiteY2" fmla="*/ 2127865 h 2127865"/>
                  <a:gd name="connsiteX3" fmla="*/ 18891 w 1317024"/>
                  <a:gd name="connsiteY3" fmla="*/ 312610 h 2127865"/>
                  <a:gd name="connsiteX0" fmla="*/ 92940 w 1317024"/>
                  <a:gd name="connsiteY0" fmla="*/ 0 h 2127865"/>
                  <a:gd name="connsiteX1" fmla="*/ 1317024 w 1317024"/>
                  <a:gd name="connsiteY1" fmla="*/ 1316553 h 2127865"/>
                  <a:gd name="connsiteX0" fmla="*/ 18893 w 1317026"/>
                  <a:gd name="connsiteY0" fmla="*/ 271926 h 2087181"/>
                  <a:gd name="connsiteX1" fmla="*/ 1317026 w 1317026"/>
                  <a:gd name="connsiteY1" fmla="*/ 1275869 h 2087181"/>
                  <a:gd name="connsiteX2" fmla="*/ 1 w 1317026"/>
                  <a:gd name="connsiteY2" fmla="*/ 2087181 h 2087181"/>
                  <a:gd name="connsiteX3" fmla="*/ 18893 w 1317026"/>
                  <a:gd name="connsiteY3" fmla="*/ 271926 h 2087181"/>
                  <a:gd name="connsiteX0" fmla="*/ 99245 w 1317026"/>
                  <a:gd name="connsiteY0" fmla="*/ 0 h 2087181"/>
                  <a:gd name="connsiteX1" fmla="*/ 1317026 w 1317026"/>
                  <a:gd name="connsiteY1" fmla="*/ 1275869 h 2087181"/>
                  <a:gd name="connsiteX0" fmla="*/ 11017 w 1317024"/>
                  <a:gd name="connsiteY0" fmla="*/ 301409 h 2087181"/>
                  <a:gd name="connsiteX1" fmla="*/ 1317024 w 1317024"/>
                  <a:gd name="connsiteY1" fmla="*/ 1275869 h 2087181"/>
                  <a:gd name="connsiteX2" fmla="*/ -1 w 1317024"/>
                  <a:gd name="connsiteY2" fmla="*/ 2087181 h 2087181"/>
                  <a:gd name="connsiteX3" fmla="*/ 11017 w 1317024"/>
                  <a:gd name="connsiteY3" fmla="*/ 301409 h 2087181"/>
                  <a:gd name="connsiteX0" fmla="*/ 99243 w 1317024"/>
                  <a:gd name="connsiteY0" fmla="*/ 0 h 2087181"/>
                  <a:gd name="connsiteX1" fmla="*/ 1317024 w 1317024"/>
                  <a:gd name="connsiteY1" fmla="*/ 1275869 h 2087181"/>
                  <a:gd name="connsiteX0" fmla="*/ 11019 w 1317026"/>
                  <a:gd name="connsiteY0" fmla="*/ 301409 h 2087181"/>
                  <a:gd name="connsiteX1" fmla="*/ 1317026 w 1317026"/>
                  <a:gd name="connsiteY1" fmla="*/ 1275869 h 2087181"/>
                  <a:gd name="connsiteX2" fmla="*/ 1 w 1317026"/>
                  <a:gd name="connsiteY2" fmla="*/ 2087181 h 2087181"/>
                  <a:gd name="connsiteX3" fmla="*/ 11019 w 1317026"/>
                  <a:gd name="connsiteY3" fmla="*/ 301409 h 2087181"/>
                  <a:gd name="connsiteX0" fmla="*/ 99245 w 1317026"/>
                  <a:gd name="connsiteY0" fmla="*/ 0 h 2087181"/>
                  <a:gd name="connsiteX1" fmla="*/ 1317026 w 1317026"/>
                  <a:gd name="connsiteY1" fmla="*/ 1275869 h 2087181"/>
                  <a:gd name="connsiteX0" fmla="*/ 11017 w 1317024"/>
                  <a:gd name="connsiteY0" fmla="*/ 301409 h 2087181"/>
                  <a:gd name="connsiteX1" fmla="*/ 1317024 w 1317024"/>
                  <a:gd name="connsiteY1" fmla="*/ 1275869 h 2087181"/>
                  <a:gd name="connsiteX2" fmla="*/ -1 w 1317024"/>
                  <a:gd name="connsiteY2" fmla="*/ 2087181 h 2087181"/>
                  <a:gd name="connsiteX3" fmla="*/ 11017 w 1317024"/>
                  <a:gd name="connsiteY3" fmla="*/ 301409 h 2087181"/>
                  <a:gd name="connsiteX0" fmla="*/ 99243 w 1317024"/>
                  <a:gd name="connsiteY0" fmla="*/ 0 h 2087181"/>
                  <a:gd name="connsiteX1" fmla="*/ 1317024 w 1317024"/>
                  <a:gd name="connsiteY1" fmla="*/ 1275869 h 2087181"/>
                  <a:gd name="connsiteX0" fmla="*/ 1 w 1318617"/>
                  <a:gd name="connsiteY0" fmla="*/ 220039 h 2087181"/>
                  <a:gd name="connsiteX1" fmla="*/ 1318617 w 1318617"/>
                  <a:gd name="connsiteY1" fmla="*/ 1275869 h 2087181"/>
                  <a:gd name="connsiteX2" fmla="*/ 1592 w 1318617"/>
                  <a:gd name="connsiteY2" fmla="*/ 2087181 h 2087181"/>
                  <a:gd name="connsiteX3" fmla="*/ 1 w 1318617"/>
                  <a:gd name="connsiteY3" fmla="*/ 220039 h 2087181"/>
                  <a:gd name="connsiteX0" fmla="*/ 100836 w 1318617"/>
                  <a:gd name="connsiteY0" fmla="*/ 0 h 2087181"/>
                  <a:gd name="connsiteX1" fmla="*/ 1318617 w 1318617"/>
                  <a:gd name="connsiteY1" fmla="*/ 1275869 h 2087181"/>
                  <a:gd name="connsiteX0" fmla="*/ -1 w 1318615"/>
                  <a:gd name="connsiteY0" fmla="*/ 233602 h 2100744"/>
                  <a:gd name="connsiteX1" fmla="*/ 1318615 w 1318615"/>
                  <a:gd name="connsiteY1" fmla="*/ 1289432 h 2100744"/>
                  <a:gd name="connsiteX2" fmla="*/ 1590 w 1318615"/>
                  <a:gd name="connsiteY2" fmla="*/ 2100744 h 2100744"/>
                  <a:gd name="connsiteX3" fmla="*/ -1 w 1318615"/>
                  <a:gd name="connsiteY3" fmla="*/ 233602 h 2100744"/>
                  <a:gd name="connsiteX0" fmla="*/ 98736 w 1318615"/>
                  <a:gd name="connsiteY0" fmla="*/ 0 h 2100744"/>
                  <a:gd name="connsiteX1" fmla="*/ 1318615 w 1318615"/>
                  <a:gd name="connsiteY1" fmla="*/ 1289432 h 2100744"/>
                  <a:gd name="connsiteX0" fmla="*/ 1 w 1318617"/>
                  <a:gd name="connsiteY0" fmla="*/ 233602 h 2100744"/>
                  <a:gd name="connsiteX1" fmla="*/ 1318617 w 1318617"/>
                  <a:gd name="connsiteY1" fmla="*/ 1289432 h 2100744"/>
                  <a:gd name="connsiteX2" fmla="*/ 1592 w 1318617"/>
                  <a:gd name="connsiteY2" fmla="*/ 2100744 h 2100744"/>
                  <a:gd name="connsiteX3" fmla="*/ 1 w 1318617"/>
                  <a:gd name="connsiteY3" fmla="*/ 233602 h 2100744"/>
                  <a:gd name="connsiteX0" fmla="*/ 98738 w 1318617"/>
                  <a:gd name="connsiteY0" fmla="*/ 0 h 2100744"/>
                  <a:gd name="connsiteX1" fmla="*/ 1318617 w 1318617"/>
                  <a:gd name="connsiteY1" fmla="*/ 1289432 h 2100744"/>
                  <a:gd name="connsiteX0" fmla="*/ -1 w 1318615"/>
                  <a:gd name="connsiteY0" fmla="*/ 294930 h 2162072"/>
                  <a:gd name="connsiteX1" fmla="*/ 1318615 w 1318615"/>
                  <a:gd name="connsiteY1" fmla="*/ 1350760 h 2162072"/>
                  <a:gd name="connsiteX2" fmla="*/ 1590 w 1318615"/>
                  <a:gd name="connsiteY2" fmla="*/ 2162072 h 2162072"/>
                  <a:gd name="connsiteX3" fmla="*/ -1 w 1318615"/>
                  <a:gd name="connsiteY3" fmla="*/ 294930 h 2162072"/>
                  <a:gd name="connsiteX0" fmla="*/ 126564 w 1318615"/>
                  <a:gd name="connsiteY0" fmla="*/ 1 h 2162072"/>
                  <a:gd name="connsiteX1" fmla="*/ 1318615 w 1318615"/>
                  <a:gd name="connsiteY1" fmla="*/ 1350760 h 2162072"/>
                  <a:gd name="connsiteX0" fmla="*/ 1 w 1318617"/>
                  <a:gd name="connsiteY0" fmla="*/ 294928 h 2162070"/>
                  <a:gd name="connsiteX1" fmla="*/ 1318617 w 1318617"/>
                  <a:gd name="connsiteY1" fmla="*/ 1350758 h 2162070"/>
                  <a:gd name="connsiteX2" fmla="*/ 1592 w 1318617"/>
                  <a:gd name="connsiteY2" fmla="*/ 2162070 h 2162070"/>
                  <a:gd name="connsiteX3" fmla="*/ 1 w 1318617"/>
                  <a:gd name="connsiteY3" fmla="*/ 294928 h 2162070"/>
                  <a:gd name="connsiteX0" fmla="*/ 126566 w 1318617"/>
                  <a:gd name="connsiteY0" fmla="*/ -1 h 2162070"/>
                  <a:gd name="connsiteX1" fmla="*/ 1318617 w 1318617"/>
                  <a:gd name="connsiteY1" fmla="*/ 1350758 h 2162070"/>
                  <a:gd name="connsiteX0" fmla="*/ 12587 w 1317024"/>
                  <a:gd name="connsiteY0" fmla="*/ 306131 h 2162072"/>
                  <a:gd name="connsiteX1" fmla="*/ 1317024 w 1317024"/>
                  <a:gd name="connsiteY1" fmla="*/ 1350760 h 2162072"/>
                  <a:gd name="connsiteX2" fmla="*/ -1 w 1317024"/>
                  <a:gd name="connsiteY2" fmla="*/ 2162072 h 2162072"/>
                  <a:gd name="connsiteX3" fmla="*/ 12587 w 1317024"/>
                  <a:gd name="connsiteY3" fmla="*/ 306131 h 2162072"/>
                  <a:gd name="connsiteX0" fmla="*/ 124973 w 1317024"/>
                  <a:gd name="connsiteY0" fmla="*/ 1 h 2162072"/>
                  <a:gd name="connsiteX1" fmla="*/ 1317024 w 1317024"/>
                  <a:gd name="connsiteY1" fmla="*/ 1350760 h 216207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317024" h="2162072" stroke="0" extrusionOk="0">
                    <a:moveTo>
                      <a:pt x="12587" y="306131"/>
                    </a:moveTo>
                    <a:cubicBezTo>
                      <a:pt x="562722" y="514278"/>
                      <a:pt x="1044517" y="852665"/>
                      <a:pt x="1317024" y="1350760"/>
                    </a:cubicBezTo>
                    <a:lnTo>
                      <a:pt x="-1" y="2162072"/>
                    </a:lnTo>
                    <a:cubicBezTo>
                      <a:pt x="-1" y="1623422"/>
                      <a:pt x="12587" y="844781"/>
                      <a:pt x="12587" y="306131"/>
                    </a:cubicBezTo>
                    <a:close/>
                  </a:path>
                  <a:path w="1317024" h="2162072" fill="none">
                    <a:moveTo>
                      <a:pt x="124973" y="1"/>
                    </a:moveTo>
                    <a:cubicBezTo>
                      <a:pt x="526898" y="368308"/>
                      <a:pt x="1044517" y="852665"/>
                      <a:pt x="1317024" y="1350760"/>
                    </a:cubicBezTo>
                  </a:path>
                </a:pathLst>
              </a:custGeom>
              <a:ln w="3175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" name="Rectangle 5"/>
              <p:cNvSpPr/>
              <p:nvPr/>
            </p:nvSpPr>
            <p:spPr>
              <a:xfrm>
                <a:off x="2744920" y="3463160"/>
                <a:ext cx="304069" cy="10395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76" name="Rectangle 75"/>
              <p:cNvSpPr/>
              <p:nvPr/>
            </p:nvSpPr>
            <p:spPr>
              <a:xfrm rot="17060416">
                <a:off x="6662156" y="264719"/>
                <a:ext cx="304069" cy="10395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77" name="Rectangle 76"/>
              <p:cNvSpPr/>
              <p:nvPr/>
            </p:nvSpPr>
            <p:spPr>
              <a:xfrm rot="17091842">
                <a:off x="6775328" y="288557"/>
                <a:ext cx="304069" cy="10395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78" name="Rectangle 77"/>
              <p:cNvSpPr/>
              <p:nvPr/>
            </p:nvSpPr>
            <p:spPr>
              <a:xfrm rot="15265534">
                <a:off x="5188492" y="274141"/>
                <a:ext cx="304069" cy="10395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79" name="Rectangle 78"/>
              <p:cNvSpPr/>
              <p:nvPr/>
            </p:nvSpPr>
            <p:spPr>
              <a:xfrm rot="14007518">
                <a:off x="4120037" y="747919"/>
                <a:ext cx="304069" cy="10395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80" name="Rectangle 79"/>
              <p:cNvSpPr/>
              <p:nvPr/>
            </p:nvSpPr>
            <p:spPr>
              <a:xfrm rot="12321870">
                <a:off x="2988438" y="2127620"/>
                <a:ext cx="304069" cy="10395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81" name="Rectangle 80"/>
              <p:cNvSpPr/>
              <p:nvPr/>
            </p:nvSpPr>
            <p:spPr>
              <a:xfrm>
                <a:off x="2749625" y="3578026"/>
                <a:ext cx="304069" cy="10395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82" name="Rectangle 81"/>
              <p:cNvSpPr/>
              <p:nvPr/>
            </p:nvSpPr>
            <p:spPr>
              <a:xfrm>
                <a:off x="2742539" y="3346641"/>
                <a:ext cx="304069" cy="10395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83" name="Rectangle 82"/>
              <p:cNvSpPr/>
              <p:nvPr/>
            </p:nvSpPr>
            <p:spPr>
              <a:xfrm rot="19791232">
                <a:off x="3172977" y="4972518"/>
                <a:ext cx="304069" cy="859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84" name="Rectangle 83"/>
              <p:cNvSpPr/>
              <p:nvPr/>
            </p:nvSpPr>
            <p:spPr>
              <a:xfrm rot="19791232">
                <a:off x="3218102" y="5059937"/>
                <a:ext cx="304069" cy="859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85" name="Rectangle 84"/>
              <p:cNvSpPr/>
              <p:nvPr/>
            </p:nvSpPr>
            <p:spPr>
              <a:xfrm rot="19791232">
                <a:off x="3266050" y="5146514"/>
                <a:ext cx="304069" cy="859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86" name="Rectangle 85"/>
              <p:cNvSpPr/>
              <p:nvPr/>
            </p:nvSpPr>
            <p:spPr>
              <a:xfrm rot="19791232">
                <a:off x="3321015" y="5230967"/>
                <a:ext cx="304069" cy="8592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87" name="Rectangle 86"/>
              <p:cNvSpPr/>
              <p:nvPr/>
            </p:nvSpPr>
            <p:spPr>
              <a:xfrm rot="19791232">
                <a:off x="3375981" y="5297723"/>
                <a:ext cx="304069" cy="859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88" name="Rectangle 87"/>
              <p:cNvSpPr/>
              <p:nvPr/>
            </p:nvSpPr>
            <p:spPr>
              <a:xfrm rot="19791232">
                <a:off x="3431671" y="5375911"/>
                <a:ext cx="304069" cy="859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89" name="Rectangle 88"/>
              <p:cNvSpPr/>
              <p:nvPr/>
            </p:nvSpPr>
            <p:spPr>
              <a:xfrm rot="17930486">
                <a:off x="4634353" y="6307841"/>
                <a:ext cx="304069" cy="859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90" name="Rectangle 89"/>
              <p:cNvSpPr/>
              <p:nvPr/>
            </p:nvSpPr>
            <p:spPr>
              <a:xfrm rot="17930486">
                <a:off x="4724186" y="6350981"/>
                <a:ext cx="304069" cy="859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91" name="Rectangle 90"/>
              <p:cNvSpPr/>
              <p:nvPr/>
            </p:nvSpPr>
            <p:spPr>
              <a:xfrm rot="16200000">
                <a:off x="5970512" y="6579964"/>
                <a:ext cx="304069" cy="859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92" name="Rectangle 91"/>
              <p:cNvSpPr/>
              <p:nvPr/>
            </p:nvSpPr>
            <p:spPr>
              <a:xfrm rot="14349756">
                <a:off x="7371945" y="6274204"/>
                <a:ext cx="304069" cy="45719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93" name="Rectangle 92"/>
              <p:cNvSpPr/>
              <p:nvPr/>
            </p:nvSpPr>
            <p:spPr>
              <a:xfrm rot="15904915" flipV="1">
                <a:off x="6282913" y="6588825"/>
                <a:ext cx="304069" cy="45719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94" name="Rectangle 93"/>
              <p:cNvSpPr/>
              <p:nvPr/>
            </p:nvSpPr>
            <p:spPr>
              <a:xfrm rot="13533234">
                <a:off x="8259101" y="5610648"/>
                <a:ext cx="304069" cy="859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95" name="Rectangle 94"/>
              <p:cNvSpPr/>
              <p:nvPr/>
            </p:nvSpPr>
            <p:spPr>
              <a:xfrm rot="13186445">
                <a:off x="8662960" y="5076717"/>
                <a:ext cx="304069" cy="859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96" name="Rectangle 95"/>
              <p:cNvSpPr/>
              <p:nvPr/>
            </p:nvSpPr>
            <p:spPr>
              <a:xfrm rot="12598698">
                <a:off x="9031367" y="4263431"/>
                <a:ext cx="304069" cy="45719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97" name="Rectangle 96"/>
              <p:cNvSpPr/>
              <p:nvPr/>
            </p:nvSpPr>
            <p:spPr>
              <a:xfrm rot="10338590">
                <a:off x="9141011" y="3276808"/>
                <a:ext cx="304069" cy="859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98" name="Rectangle 97"/>
              <p:cNvSpPr/>
              <p:nvPr/>
            </p:nvSpPr>
            <p:spPr>
              <a:xfrm rot="10338590">
                <a:off x="9133924" y="3186072"/>
                <a:ext cx="304069" cy="859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99" name="Rectangle 98"/>
              <p:cNvSpPr/>
              <p:nvPr/>
            </p:nvSpPr>
            <p:spPr>
              <a:xfrm rot="10338590">
                <a:off x="9126837" y="3087114"/>
                <a:ext cx="304069" cy="859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00" name="Rectangle 99"/>
              <p:cNvSpPr/>
              <p:nvPr/>
            </p:nvSpPr>
            <p:spPr>
              <a:xfrm rot="8121684">
                <a:off x="8088500" y="1009075"/>
                <a:ext cx="304069" cy="859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01" name="Rectangle 100"/>
              <p:cNvSpPr/>
              <p:nvPr/>
            </p:nvSpPr>
            <p:spPr>
              <a:xfrm rot="8783533">
                <a:off x="8549956" y="1558805"/>
                <a:ext cx="304069" cy="45719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cxnSp>
            <p:nvCxnSpPr>
              <p:cNvPr id="41" name="Straight Arrow Connector 40"/>
              <p:cNvCxnSpPr/>
              <p:nvPr/>
            </p:nvCxnSpPr>
            <p:spPr>
              <a:xfrm flipV="1">
                <a:off x="5638962" y="-464457"/>
                <a:ext cx="0" cy="535829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Straight Arrow Connector 101"/>
              <p:cNvCxnSpPr/>
              <p:nvPr/>
            </p:nvCxnSpPr>
            <p:spPr>
              <a:xfrm flipV="1">
                <a:off x="5249638" y="-355576"/>
                <a:ext cx="0" cy="535829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3" name="TextBox 102"/>
              <p:cNvSpPr txBox="1"/>
              <p:nvPr/>
            </p:nvSpPr>
            <p:spPr>
              <a:xfrm>
                <a:off x="4818207" y="-678648"/>
                <a:ext cx="6703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HSP2</a:t>
                </a:r>
              </a:p>
            </p:txBody>
          </p:sp>
          <p:sp>
            <p:nvSpPr>
              <p:cNvPr id="104" name="Arc 103">
                <a:extLst>
                  <a:ext uri="{FF2B5EF4-FFF2-40B4-BE49-F238E27FC236}">
                    <a16:creationId xmlns:a16="http://schemas.microsoft.com/office/drawing/2014/main" id="{86FCD297-332B-0F86-75B8-F849608D83A3}"/>
                  </a:ext>
                </a:extLst>
              </p:cNvPr>
              <p:cNvSpPr/>
              <p:nvPr/>
            </p:nvSpPr>
            <p:spPr>
              <a:xfrm>
                <a:off x="3166890" y="511691"/>
                <a:ext cx="5873394" cy="5834504"/>
              </a:xfrm>
              <a:prstGeom prst="arc">
                <a:avLst>
                  <a:gd name="adj1" fmla="val 16200000"/>
                  <a:gd name="adj2" fmla="val 16163462"/>
                </a:avLst>
              </a:prstGeom>
              <a:ln w="28575">
                <a:solidFill>
                  <a:schemeClr val="accent5">
                    <a:lumMod val="75000"/>
                  </a:schemeClr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6" name="Arc 105">
                <a:extLst>
                  <a:ext uri="{FF2B5EF4-FFF2-40B4-BE49-F238E27FC236}">
                    <a16:creationId xmlns:a16="http://schemas.microsoft.com/office/drawing/2014/main" id="{86FCD297-332B-0F86-75B8-F849608D83A3}"/>
                  </a:ext>
                </a:extLst>
              </p:cNvPr>
              <p:cNvSpPr/>
              <p:nvPr/>
            </p:nvSpPr>
            <p:spPr>
              <a:xfrm>
                <a:off x="3284729" y="609202"/>
                <a:ext cx="5638146" cy="5627992"/>
              </a:xfrm>
              <a:prstGeom prst="arc">
                <a:avLst>
                  <a:gd name="adj1" fmla="val 16200000"/>
                  <a:gd name="adj2" fmla="val 16163462"/>
                </a:avLst>
              </a:prstGeom>
              <a:ln w="28575">
                <a:solidFill>
                  <a:schemeClr val="accent2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07" name="Straight Arrow Connector 106"/>
              <p:cNvCxnSpPr/>
              <p:nvPr/>
            </p:nvCxnSpPr>
            <p:spPr>
              <a:xfrm flipH="1">
                <a:off x="5782892" y="396103"/>
                <a:ext cx="10125" cy="490203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8" name="TextBox 107"/>
              <p:cNvSpPr txBox="1"/>
              <p:nvPr/>
            </p:nvSpPr>
            <p:spPr>
              <a:xfrm>
                <a:off x="5735692" y="609875"/>
                <a:ext cx="50687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LSP</a:t>
                </a:r>
              </a:p>
            </p:txBody>
          </p:sp>
          <p:cxnSp>
            <p:nvCxnSpPr>
              <p:cNvPr id="109" name="Straight Arrow Connector 108"/>
              <p:cNvCxnSpPr/>
              <p:nvPr/>
            </p:nvCxnSpPr>
            <p:spPr>
              <a:xfrm flipH="1">
                <a:off x="6346952" y="-141372"/>
                <a:ext cx="235464" cy="213557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Straight Arrow Connector 110"/>
              <p:cNvCxnSpPr/>
              <p:nvPr/>
            </p:nvCxnSpPr>
            <p:spPr>
              <a:xfrm flipH="1">
                <a:off x="6996651" y="189332"/>
                <a:ext cx="400873" cy="341755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Straight Arrow Connector 112"/>
              <p:cNvCxnSpPr/>
              <p:nvPr/>
            </p:nvCxnSpPr>
            <p:spPr>
              <a:xfrm flipH="1">
                <a:off x="6291118" y="6797533"/>
                <a:ext cx="10125" cy="490203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4" name="TextBox 113"/>
              <p:cNvSpPr txBox="1"/>
              <p:nvPr/>
            </p:nvSpPr>
            <p:spPr>
              <a:xfrm>
                <a:off x="4719661" y="5890735"/>
                <a:ext cx="29046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S</a:t>
                </a:r>
              </a:p>
            </p:txBody>
          </p:sp>
          <p:sp>
            <p:nvSpPr>
              <p:cNvPr id="115" name="TextBox 114"/>
              <p:cNvSpPr txBox="1"/>
              <p:nvPr/>
            </p:nvSpPr>
            <p:spPr>
              <a:xfrm>
                <a:off x="3526965" y="5929299"/>
                <a:ext cx="51603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COI</a:t>
                </a:r>
              </a:p>
            </p:txBody>
          </p:sp>
          <p:cxnSp>
            <p:nvCxnSpPr>
              <p:cNvPr id="117" name="Straight Arrow Connector 116"/>
              <p:cNvCxnSpPr/>
              <p:nvPr/>
            </p:nvCxnSpPr>
            <p:spPr>
              <a:xfrm flipH="1">
                <a:off x="3197251" y="5256196"/>
                <a:ext cx="235464" cy="213557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8" name="TextBox 117"/>
              <p:cNvSpPr txBox="1"/>
              <p:nvPr/>
            </p:nvSpPr>
            <p:spPr>
              <a:xfrm>
                <a:off x="2495195" y="3310946"/>
                <a:ext cx="33695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O</a:t>
                </a:r>
              </a:p>
            </p:txBody>
          </p:sp>
          <p:sp>
            <p:nvSpPr>
              <p:cNvPr id="120" name="Rounded Rectangular Callout 119"/>
              <p:cNvSpPr/>
              <p:nvPr/>
            </p:nvSpPr>
            <p:spPr>
              <a:xfrm rot="8439582">
                <a:off x="4427876" y="1001404"/>
                <a:ext cx="498159" cy="471886"/>
              </a:xfrm>
              <a:prstGeom prst="wedgeRoundRectCallout">
                <a:avLst/>
              </a:prstGeom>
              <a:noFill/>
              <a:ln>
                <a:solidFill>
                  <a:schemeClr val="accent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grpSp>
            <p:nvGrpSpPr>
              <p:cNvPr id="123" name="Group 122"/>
              <p:cNvGrpSpPr/>
              <p:nvPr/>
            </p:nvGrpSpPr>
            <p:grpSpPr>
              <a:xfrm>
                <a:off x="3242586" y="2221018"/>
                <a:ext cx="679994" cy="471886"/>
                <a:chOff x="1741950" y="516945"/>
                <a:chExt cx="679994" cy="471886"/>
              </a:xfrm>
            </p:grpSpPr>
            <p:sp>
              <p:nvSpPr>
                <p:cNvPr id="121" name="TextBox 120"/>
                <p:cNvSpPr txBox="1"/>
                <p:nvPr/>
              </p:nvSpPr>
              <p:spPr>
                <a:xfrm>
                  <a:off x="1741950" y="566958"/>
                  <a:ext cx="67999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IN" dirty="0"/>
                    <a:t>5-mC</a:t>
                  </a:r>
                </a:p>
              </p:txBody>
            </p:sp>
            <p:sp>
              <p:nvSpPr>
                <p:cNvPr id="122" name="Rounded Rectangular Callout 121"/>
                <p:cNvSpPr/>
                <p:nvPr/>
              </p:nvSpPr>
              <p:spPr>
                <a:xfrm rot="8439582">
                  <a:off x="1825920" y="516945"/>
                  <a:ext cx="498159" cy="471886"/>
                </a:xfrm>
                <a:prstGeom prst="wedgeRoundRectCallout">
                  <a:avLst/>
                </a:prstGeom>
                <a:noFill/>
                <a:ln>
                  <a:solidFill>
                    <a:schemeClr val="accent5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</p:grpSp>
          <p:grpSp>
            <p:nvGrpSpPr>
              <p:cNvPr id="133" name="Group 132"/>
              <p:cNvGrpSpPr/>
              <p:nvPr/>
            </p:nvGrpSpPr>
            <p:grpSpPr>
              <a:xfrm rot="17600506">
                <a:off x="3537928" y="3661876"/>
                <a:ext cx="498159" cy="801823"/>
                <a:chOff x="1897931" y="418000"/>
                <a:chExt cx="498159" cy="801823"/>
              </a:xfrm>
            </p:grpSpPr>
            <p:sp>
              <p:nvSpPr>
                <p:cNvPr id="134" name="TextBox 133"/>
                <p:cNvSpPr txBox="1"/>
                <p:nvPr/>
              </p:nvSpPr>
              <p:spPr>
                <a:xfrm rot="3174124">
                  <a:off x="1760101" y="634246"/>
                  <a:ext cx="80182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IN" dirty="0"/>
                    <a:t>5-hmC</a:t>
                  </a:r>
                </a:p>
              </p:txBody>
            </p:sp>
            <p:sp>
              <p:nvSpPr>
                <p:cNvPr id="135" name="Rounded Rectangular Callout 134"/>
                <p:cNvSpPr/>
                <p:nvPr/>
              </p:nvSpPr>
              <p:spPr>
                <a:xfrm rot="8439582">
                  <a:off x="1897931" y="491202"/>
                  <a:ext cx="498159" cy="699080"/>
                </a:xfrm>
                <a:prstGeom prst="wedgeRoundRectCallout">
                  <a:avLst/>
                </a:prstGeom>
                <a:noFill/>
                <a:ln>
                  <a:solidFill>
                    <a:schemeClr val="accent2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</p:grpSp>
          <p:grpSp>
            <p:nvGrpSpPr>
              <p:cNvPr id="136" name="Group 135"/>
              <p:cNvGrpSpPr/>
              <p:nvPr/>
            </p:nvGrpSpPr>
            <p:grpSpPr>
              <a:xfrm rot="13721407">
                <a:off x="5332433" y="5517484"/>
                <a:ext cx="679994" cy="570389"/>
                <a:chOff x="1773427" y="505784"/>
                <a:chExt cx="679994" cy="570389"/>
              </a:xfrm>
            </p:grpSpPr>
            <p:sp>
              <p:nvSpPr>
                <p:cNvPr id="137" name="TextBox 136"/>
                <p:cNvSpPr txBox="1"/>
                <p:nvPr/>
              </p:nvSpPr>
              <p:spPr>
                <a:xfrm rot="8237542">
                  <a:off x="1773427" y="607895"/>
                  <a:ext cx="67999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IN" dirty="0"/>
                    <a:t>5-mC</a:t>
                  </a:r>
                </a:p>
              </p:txBody>
            </p:sp>
            <p:sp>
              <p:nvSpPr>
                <p:cNvPr id="138" name="Rounded Rectangular Callout 137"/>
                <p:cNvSpPr/>
                <p:nvPr/>
              </p:nvSpPr>
              <p:spPr>
                <a:xfrm rot="8439582">
                  <a:off x="1857142" y="505784"/>
                  <a:ext cx="498159" cy="570389"/>
                </a:xfrm>
                <a:prstGeom prst="wedgeRoundRectCallout">
                  <a:avLst/>
                </a:prstGeom>
                <a:noFill/>
                <a:ln>
                  <a:solidFill>
                    <a:schemeClr val="accent2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</p:grpSp>
          <p:grpSp>
            <p:nvGrpSpPr>
              <p:cNvPr id="139" name="Group 138"/>
              <p:cNvGrpSpPr/>
              <p:nvPr/>
            </p:nvGrpSpPr>
            <p:grpSpPr>
              <a:xfrm rot="6981496">
                <a:off x="8255775" y="3457337"/>
                <a:ext cx="498159" cy="679994"/>
                <a:chOff x="1857142" y="452564"/>
                <a:chExt cx="498159" cy="679994"/>
              </a:xfrm>
            </p:grpSpPr>
            <p:sp>
              <p:nvSpPr>
                <p:cNvPr id="140" name="TextBox 139"/>
                <p:cNvSpPr txBox="1"/>
                <p:nvPr/>
              </p:nvSpPr>
              <p:spPr>
                <a:xfrm rot="14190578">
                  <a:off x="1773427" y="607895"/>
                  <a:ext cx="67999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IN" dirty="0"/>
                    <a:t>5-mC</a:t>
                  </a:r>
                </a:p>
              </p:txBody>
            </p:sp>
            <p:sp>
              <p:nvSpPr>
                <p:cNvPr id="141" name="Rounded Rectangular Callout 140"/>
                <p:cNvSpPr/>
                <p:nvPr/>
              </p:nvSpPr>
              <p:spPr>
                <a:xfrm rot="8439582">
                  <a:off x="1857142" y="505784"/>
                  <a:ext cx="498159" cy="570389"/>
                </a:xfrm>
                <a:prstGeom prst="wedgeRoundRectCallout">
                  <a:avLst/>
                </a:prstGeom>
                <a:noFill/>
                <a:ln>
                  <a:solidFill>
                    <a:schemeClr val="accent2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</p:grpSp>
          <p:grpSp>
            <p:nvGrpSpPr>
              <p:cNvPr id="142" name="Group 141"/>
              <p:cNvGrpSpPr/>
              <p:nvPr/>
            </p:nvGrpSpPr>
            <p:grpSpPr>
              <a:xfrm rot="7626131">
                <a:off x="8173916" y="4163005"/>
                <a:ext cx="498159" cy="679994"/>
                <a:chOff x="1857142" y="452564"/>
                <a:chExt cx="498159" cy="679994"/>
              </a:xfrm>
            </p:grpSpPr>
            <p:sp>
              <p:nvSpPr>
                <p:cNvPr id="143" name="TextBox 142"/>
                <p:cNvSpPr txBox="1"/>
                <p:nvPr/>
              </p:nvSpPr>
              <p:spPr>
                <a:xfrm rot="14190578">
                  <a:off x="1773427" y="607895"/>
                  <a:ext cx="67999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IN" dirty="0"/>
                    <a:t>5-mC</a:t>
                  </a:r>
                </a:p>
              </p:txBody>
            </p:sp>
            <p:sp>
              <p:nvSpPr>
                <p:cNvPr id="144" name="Rounded Rectangular Callout 143"/>
                <p:cNvSpPr/>
                <p:nvPr/>
              </p:nvSpPr>
              <p:spPr>
                <a:xfrm rot="8439582">
                  <a:off x="1857142" y="505784"/>
                  <a:ext cx="498159" cy="570389"/>
                </a:xfrm>
                <a:prstGeom prst="wedgeRoundRectCallout">
                  <a:avLst/>
                </a:prstGeom>
                <a:noFill/>
                <a:ln>
                  <a:solidFill>
                    <a:schemeClr val="accent5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</p:grpSp>
          <p:cxnSp>
            <p:nvCxnSpPr>
              <p:cNvPr id="148" name="Straight Connector 147"/>
              <p:cNvCxnSpPr>
                <a:cxnSpLocks/>
                <a:stCxn id="138" idx="0"/>
              </p:cNvCxnSpPr>
              <p:nvPr/>
            </p:nvCxnSpPr>
            <p:spPr>
              <a:xfrm flipV="1">
                <a:off x="5723518" y="5389556"/>
                <a:ext cx="22009" cy="13712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49" name="Group 148"/>
              <p:cNvGrpSpPr/>
              <p:nvPr/>
            </p:nvGrpSpPr>
            <p:grpSpPr>
              <a:xfrm rot="6981496">
                <a:off x="8379512" y="2720320"/>
                <a:ext cx="498159" cy="679994"/>
                <a:chOff x="1857142" y="452564"/>
                <a:chExt cx="498159" cy="679994"/>
              </a:xfrm>
            </p:grpSpPr>
            <p:sp>
              <p:nvSpPr>
                <p:cNvPr id="150" name="TextBox 149"/>
                <p:cNvSpPr txBox="1"/>
                <p:nvPr/>
              </p:nvSpPr>
              <p:spPr>
                <a:xfrm rot="14190578">
                  <a:off x="1773427" y="607895"/>
                  <a:ext cx="67999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IN" dirty="0"/>
                    <a:t>5-mC</a:t>
                  </a:r>
                </a:p>
              </p:txBody>
            </p:sp>
            <p:sp>
              <p:nvSpPr>
                <p:cNvPr id="151" name="Rounded Rectangular Callout 150"/>
                <p:cNvSpPr/>
                <p:nvPr/>
              </p:nvSpPr>
              <p:spPr>
                <a:xfrm rot="8439582">
                  <a:off x="1857142" y="505784"/>
                  <a:ext cx="498159" cy="570389"/>
                </a:xfrm>
                <a:prstGeom prst="wedgeRoundRectCallout">
                  <a:avLst/>
                </a:prstGeom>
                <a:noFill/>
                <a:ln>
                  <a:solidFill>
                    <a:schemeClr val="accent5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</p:grpSp>
          <p:cxnSp>
            <p:nvCxnSpPr>
              <p:cNvPr id="156" name="Straight Arrow Connector 155"/>
              <p:cNvCxnSpPr>
                <a:endCxn id="11" idx="0"/>
              </p:cNvCxnSpPr>
              <p:nvPr/>
            </p:nvCxnSpPr>
            <p:spPr>
              <a:xfrm flipV="1">
                <a:off x="6598186" y="-94202"/>
                <a:ext cx="425995" cy="196908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0" name="TextBox 159"/>
              <p:cNvSpPr txBox="1"/>
              <p:nvPr/>
            </p:nvSpPr>
            <p:spPr>
              <a:xfrm>
                <a:off x="6556026" y="360601"/>
                <a:ext cx="30328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P</a:t>
                </a:r>
              </a:p>
            </p:txBody>
          </p:sp>
          <p:grpSp>
            <p:nvGrpSpPr>
              <p:cNvPr id="161" name="Group 160"/>
              <p:cNvGrpSpPr/>
              <p:nvPr/>
            </p:nvGrpSpPr>
            <p:grpSpPr>
              <a:xfrm rot="15675422">
                <a:off x="4213082" y="5046856"/>
                <a:ext cx="498159" cy="679994"/>
                <a:chOff x="1866885" y="469471"/>
                <a:chExt cx="498159" cy="679994"/>
              </a:xfrm>
            </p:grpSpPr>
            <p:sp>
              <p:nvSpPr>
                <p:cNvPr id="162" name="TextBox 161"/>
                <p:cNvSpPr txBox="1"/>
                <p:nvPr/>
              </p:nvSpPr>
              <p:spPr>
                <a:xfrm rot="3081728">
                  <a:off x="1811361" y="624802"/>
                  <a:ext cx="67999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IN" dirty="0"/>
                    <a:t>5-mC</a:t>
                  </a:r>
                </a:p>
              </p:txBody>
            </p:sp>
            <p:sp>
              <p:nvSpPr>
                <p:cNvPr id="163" name="Rounded Rectangular Callout 162"/>
                <p:cNvSpPr/>
                <p:nvPr/>
              </p:nvSpPr>
              <p:spPr>
                <a:xfrm rot="8439582">
                  <a:off x="1866885" y="502301"/>
                  <a:ext cx="498159" cy="601129"/>
                </a:xfrm>
                <a:prstGeom prst="wedgeRoundRectCallout">
                  <a:avLst/>
                </a:prstGeom>
                <a:noFill/>
                <a:ln>
                  <a:solidFill>
                    <a:schemeClr val="accent5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</p:grpSp>
        </p:grp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F1B9DB1-2BE5-B22F-1F02-91333430CAA1}"/>
                </a:ext>
              </a:extLst>
            </p:cNvPr>
            <p:cNvSpPr txBox="1"/>
            <p:nvPr/>
          </p:nvSpPr>
          <p:spPr>
            <a:xfrm>
              <a:off x="4438383" y="2339619"/>
              <a:ext cx="3420000" cy="1692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dirty="0"/>
                <a:t>The </a:t>
              </a:r>
              <a:r>
                <a:rPr lang="en-IN" dirty="0" err="1"/>
                <a:t>mtDNA</a:t>
              </a:r>
              <a:r>
                <a:rPr lang="en-IN" dirty="0"/>
                <a:t> methylation role was reported in neurodegenerative diseases but the role of ND region mutations in OXPHOS and </a:t>
              </a:r>
              <a:r>
                <a:rPr lang="en-IN" dirty="0" err="1"/>
                <a:t>chemoresistant</a:t>
              </a:r>
              <a:r>
                <a:rPr lang="en-IN" dirty="0"/>
                <a:t> CRCs (?) yet require future studies</a:t>
              </a:r>
            </a:p>
            <a:p>
              <a:endParaRPr lang="en-IN" dirty="0"/>
            </a:p>
          </p:txBody>
        </p:sp>
      </p:grpSp>
    </p:spTree>
    <p:extLst>
      <p:ext uri="{BB962C8B-B14F-4D97-AF65-F5344CB8AC3E}">
        <p14:creationId xmlns:p14="http://schemas.microsoft.com/office/powerpoint/2010/main" val="20280203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Group 45">
            <a:extLst>
              <a:ext uri="{FF2B5EF4-FFF2-40B4-BE49-F238E27FC236}">
                <a16:creationId xmlns:a16="http://schemas.microsoft.com/office/drawing/2014/main" id="{95E9C7CF-B798-14F3-EA89-6F73BFC95907}"/>
              </a:ext>
            </a:extLst>
          </p:cNvPr>
          <p:cNvGrpSpPr/>
          <p:nvPr/>
        </p:nvGrpSpPr>
        <p:grpSpPr>
          <a:xfrm>
            <a:off x="1743145" y="-2154620"/>
            <a:ext cx="8544070" cy="11519402"/>
            <a:chOff x="1743145" y="-2154620"/>
            <a:chExt cx="8544070" cy="11519402"/>
          </a:xfrm>
        </p:grpSpPr>
        <p:cxnSp>
          <p:nvCxnSpPr>
            <p:cNvPr id="353" name="Curved Connector 352"/>
            <p:cNvCxnSpPr>
              <a:stCxn id="315" idx="0"/>
            </p:cNvCxnSpPr>
            <p:nvPr/>
          </p:nvCxnSpPr>
          <p:spPr>
            <a:xfrm>
              <a:off x="3926561" y="4769749"/>
              <a:ext cx="3265948" cy="206148"/>
            </a:xfrm>
            <a:prstGeom prst="curvedConnector3">
              <a:avLst>
                <a:gd name="adj1" fmla="val 30446"/>
              </a:avLst>
            </a:prstGeom>
            <a:ln w="28575">
              <a:prstDash val="sysDot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5" name="Rounded Rectangle 324"/>
            <p:cNvSpPr/>
            <p:nvPr/>
          </p:nvSpPr>
          <p:spPr>
            <a:xfrm>
              <a:off x="4765691" y="4758289"/>
              <a:ext cx="518559" cy="299899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grpSp>
          <p:nvGrpSpPr>
            <p:cNvPr id="198" name="Group 197"/>
            <p:cNvGrpSpPr/>
            <p:nvPr/>
          </p:nvGrpSpPr>
          <p:grpSpPr>
            <a:xfrm>
              <a:off x="4076722" y="6110954"/>
              <a:ext cx="3869203" cy="2983832"/>
              <a:chOff x="3781442" y="1954253"/>
              <a:chExt cx="3869203" cy="2983832"/>
            </a:xfrm>
          </p:grpSpPr>
          <p:sp>
            <p:nvSpPr>
              <p:cNvPr id="199" name="Oval 24">
                <a:extLst>
                  <a:ext uri="{FF2B5EF4-FFF2-40B4-BE49-F238E27FC236}">
                    <a16:creationId xmlns:a16="http://schemas.microsoft.com/office/drawing/2014/main" id="{7EB8BC64-C218-6447-D504-65E073F3245E}"/>
                  </a:ext>
                </a:extLst>
              </p:cNvPr>
              <p:cNvSpPr/>
              <p:nvPr/>
            </p:nvSpPr>
            <p:spPr>
              <a:xfrm>
                <a:off x="3781442" y="1954253"/>
                <a:ext cx="3869203" cy="2983832"/>
              </a:xfrm>
              <a:custGeom>
                <a:avLst/>
                <a:gdLst>
                  <a:gd name="connsiteX0" fmla="*/ 0 w 2983832"/>
                  <a:gd name="connsiteY0" fmla="*/ 1491916 h 2983832"/>
                  <a:gd name="connsiteX1" fmla="*/ 1491916 w 2983832"/>
                  <a:gd name="connsiteY1" fmla="*/ 0 h 2983832"/>
                  <a:gd name="connsiteX2" fmla="*/ 2983832 w 2983832"/>
                  <a:gd name="connsiteY2" fmla="*/ 1491916 h 2983832"/>
                  <a:gd name="connsiteX3" fmla="*/ 1491916 w 2983832"/>
                  <a:gd name="connsiteY3" fmla="*/ 2983832 h 2983832"/>
                  <a:gd name="connsiteX4" fmla="*/ 0 w 2983832"/>
                  <a:gd name="connsiteY4" fmla="*/ 1491916 h 2983832"/>
                  <a:gd name="connsiteX0" fmla="*/ 0 w 3216061"/>
                  <a:gd name="connsiteY0" fmla="*/ 1491941 h 2983884"/>
                  <a:gd name="connsiteX1" fmla="*/ 1491916 w 3216061"/>
                  <a:gd name="connsiteY1" fmla="*/ 25 h 2983884"/>
                  <a:gd name="connsiteX2" fmla="*/ 3216061 w 3216061"/>
                  <a:gd name="connsiteY2" fmla="*/ 1520970 h 2983884"/>
                  <a:gd name="connsiteX3" fmla="*/ 1491916 w 3216061"/>
                  <a:gd name="connsiteY3" fmla="*/ 2983857 h 2983884"/>
                  <a:gd name="connsiteX4" fmla="*/ 0 w 3216061"/>
                  <a:gd name="connsiteY4" fmla="*/ 1491941 h 2983884"/>
                  <a:gd name="connsiteX0" fmla="*/ 0 w 3680518"/>
                  <a:gd name="connsiteY0" fmla="*/ 1491941 h 2983884"/>
                  <a:gd name="connsiteX1" fmla="*/ 1956373 w 3680518"/>
                  <a:gd name="connsiteY1" fmla="*/ 25 h 2983884"/>
                  <a:gd name="connsiteX2" fmla="*/ 3680518 w 3680518"/>
                  <a:gd name="connsiteY2" fmla="*/ 1520970 h 2983884"/>
                  <a:gd name="connsiteX3" fmla="*/ 1956373 w 3680518"/>
                  <a:gd name="connsiteY3" fmla="*/ 2983857 h 2983884"/>
                  <a:gd name="connsiteX4" fmla="*/ 0 w 3680518"/>
                  <a:gd name="connsiteY4" fmla="*/ 1491941 h 2983884"/>
                  <a:gd name="connsiteX0" fmla="*/ 0 w 3869203"/>
                  <a:gd name="connsiteY0" fmla="*/ 1491916 h 2983832"/>
                  <a:gd name="connsiteX1" fmla="*/ 1956373 w 3869203"/>
                  <a:gd name="connsiteY1" fmla="*/ 0 h 2983832"/>
                  <a:gd name="connsiteX2" fmla="*/ 3869203 w 3869203"/>
                  <a:gd name="connsiteY2" fmla="*/ 1491916 h 2983832"/>
                  <a:gd name="connsiteX3" fmla="*/ 1956373 w 3869203"/>
                  <a:gd name="connsiteY3" fmla="*/ 2983832 h 2983832"/>
                  <a:gd name="connsiteX4" fmla="*/ 0 w 3869203"/>
                  <a:gd name="connsiteY4" fmla="*/ 1491916 h 298383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3869203" h="2983832">
                    <a:moveTo>
                      <a:pt x="0" y="1491916"/>
                    </a:moveTo>
                    <a:cubicBezTo>
                      <a:pt x="0" y="667954"/>
                      <a:pt x="1311506" y="0"/>
                      <a:pt x="1956373" y="0"/>
                    </a:cubicBezTo>
                    <a:cubicBezTo>
                      <a:pt x="2601240" y="0"/>
                      <a:pt x="3869203" y="667954"/>
                      <a:pt x="3869203" y="1491916"/>
                    </a:cubicBezTo>
                    <a:cubicBezTo>
                      <a:pt x="3869203" y="2315878"/>
                      <a:pt x="2601240" y="2983832"/>
                      <a:pt x="1956373" y="2983832"/>
                    </a:cubicBezTo>
                    <a:cubicBezTo>
                      <a:pt x="1311506" y="2983832"/>
                      <a:pt x="0" y="2315878"/>
                      <a:pt x="0" y="1491916"/>
                    </a:cubicBezTo>
                    <a:close/>
                  </a:path>
                </a:pathLst>
              </a:custGeom>
              <a:solidFill>
                <a:schemeClr val="accent4">
                  <a:lumMod val="60000"/>
                  <a:lumOff val="40000"/>
                  <a:alpha val="74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200" name="Oval 25">
                <a:extLst>
                  <a:ext uri="{FF2B5EF4-FFF2-40B4-BE49-F238E27FC236}">
                    <a16:creationId xmlns:a16="http://schemas.microsoft.com/office/drawing/2014/main" id="{BA69F329-CF05-EA2B-FF55-7CDF5AAA9A0B}"/>
                  </a:ext>
                </a:extLst>
              </p:cNvPr>
              <p:cNvSpPr/>
              <p:nvPr/>
            </p:nvSpPr>
            <p:spPr>
              <a:xfrm>
                <a:off x="4108012" y="2259020"/>
                <a:ext cx="3216061" cy="2374298"/>
              </a:xfrm>
              <a:custGeom>
                <a:avLst/>
                <a:gdLst>
                  <a:gd name="connsiteX0" fmla="*/ 0 w 2374232"/>
                  <a:gd name="connsiteY0" fmla="*/ 1187116 h 2374232"/>
                  <a:gd name="connsiteX1" fmla="*/ 1187116 w 2374232"/>
                  <a:gd name="connsiteY1" fmla="*/ 0 h 2374232"/>
                  <a:gd name="connsiteX2" fmla="*/ 2374232 w 2374232"/>
                  <a:gd name="connsiteY2" fmla="*/ 1187116 h 2374232"/>
                  <a:gd name="connsiteX3" fmla="*/ 1187116 w 2374232"/>
                  <a:gd name="connsiteY3" fmla="*/ 2374232 h 2374232"/>
                  <a:gd name="connsiteX4" fmla="*/ 0 w 2374232"/>
                  <a:gd name="connsiteY4" fmla="*/ 1187116 h 2374232"/>
                  <a:gd name="connsiteX0" fmla="*/ 0 w 2751604"/>
                  <a:gd name="connsiteY0" fmla="*/ 1187116 h 2374232"/>
                  <a:gd name="connsiteX1" fmla="*/ 1187116 w 2751604"/>
                  <a:gd name="connsiteY1" fmla="*/ 0 h 2374232"/>
                  <a:gd name="connsiteX2" fmla="*/ 2751604 w 2751604"/>
                  <a:gd name="connsiteY2" fmla="*/ 1187116 h 2374232"/>
                  <a:gd name="connsiteX3" fmla="*/ 1187116 w 2751604"/>
                  <a:gd name="connsiteY3" fmla="*/ 2374232 h 2374232"/>
                  <a:gd name="connsiteX4" fmla="*/ 0 w 2751604"/>
                  <a:gd name="connsiteY4" fmla="*/ 1187116 h 2374232"/>
                  <a:gd name="connsiteX0" fmla="*/ 0 w 3216061"/>
                  <a:gd name="connsiteY0" fmla="*/ 1158122 h 2374298"/>
                  <a:gd name="connsiteX1" fmla="*/ 1651573 w 3216061"/>
                  <a:gd name="connsiteY1" fmla="*/ 34 h 2374298"/>
                  <a:gd name="connsiteX2" fmla="*/ 3216061 w 3216061"/>
                  <a:gd name="connsiteY2" fmla="*/ 1187150 h 2374298"/>
                  <a:gd name="connsiteX3" fmla="*/ 1651573 w 3216061"/>
                  <a:gd name="connsiteY3" fmla="*/ 2374266 h 2374298"/>
                  <a:gd name="connsiteX4" fmla="*/ 0 w 3216061"/>
                  <a:gd name="connsiteY4" fmla="*/ 1158122 h 237429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3216061" h="2374298">
                    <a:moveTo>
                      <a:pt x="0" y="1158122"/>
                    </a:moveTo>
                    <a:cubicBezTo>
                      <a:pt x="0" y="502496"/>
                      <a:pt x="1115563" y="-4804"/>
                      <a:pt x="1651573" y="34"/>
                    </a:cubicBezTo>
                    <a:cubicBezTo>
                      <a:pt x="2187583" y="4872"/>
                      <a:pt x="3216061" y="531524"/>
                      <a:pt x="3216061" y="1187150"/>
                    </a:cubicBezTo>
                    <a:cubicBezTo>
                      <a:pt x="3216061" y="1842776"/>
                      <a:pt x="2187583" y="2379104"/>
                      <a:pt x="1651573" y="2374266"/>
                    </a:cubicBezTo>
                    <a:cubicBezTo>
                      <a:pt x="1115563" y="2369428"/>
                      <a:pt x="0" y="1813748"/>
                      <a:pt x="0" y="1158122"/>
                    </a:cubicBezTo>
                    <a:close/>
                  </a:path>
                </a:pathLst>
              </a:custGeom>
              <a:solidFill>
                <a:schemeClr val="accent6">
                  <a:lumMod val="40000"/>
                  <a:lumOff val="60000"/>
                  <a:alpha val="74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pic>
          <p:nvPicPr>
            <p:cNvPr id="92" name="Picture 91"/>
            <p:cNvPicPr>
              <a:picLocks noChangeAspect="1"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  <a:alphaModFix amt="85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11245" y="-612671"/>
              <a:ext cx="8475970" cy="5513119"/>
            </a:xfrm>
            <a:prstGeom prst="rect">
              <a:avLst/>
            </a:prstGeom>
          </p:spPr>
        </p:pic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37C3B67F-A375-44EB-9660-7D046AAC4AB9}"/>
                </a:ext>
              </a:extLst>
            </p:cNvPr>
            <p:cNvGrpSpPr/>
            <p:nvPr/>
          </p:nvGrpSpPr>
          <p:grpSpPr>
            <a:xfrm>
              <a:off x="3246642" y="796980"/>
              <a:ext cx="1235594" cy="1223931"/>
              <a:chOff x="5127310" y="2478919"/>
              <a:chExt cx="1918776" cy="1900166"/>
            </a:xfrm>
          </p:grpSpPr>
          <p:sp>
            <p:nvSpPr>
              <p:cNvPr id="88" name="Rectangle: Rounded Corners 5">
                <a:extLst>
                  <a:ext uri="{FF2B5EF4-FFF2-40B4-BE49-F238E27FC236}">
                    <a16:creationId xmlns:a16="http://schemas.microsoft.com/office/drawing/2014/main" id="{83A621BB-CF28-4826-8ED3-E408D0053528}"/>
                  </a:ext>
                </a:extLst>
              </p:cNvPr>
              <p:cNvSpPr/>
              <p:nvPr/>
            </p:nvSpPr>
            <p:spPr>
              <a:xfrm rot="900000">
                <a:off x="5127310" y="2487211"/>
                <a:ext cx="1856270" cy="1856270"/>
              </a:xfrm>
              <a:prstGeom prst="roundRect">
                <a:avLst/>
              </a:prstGeom>
              <a:solidFill>
                <a:srgbClr val="FF9900">
                  <a:alpha val="72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9" name="Rectangle: Rounded Corners 3">
                <a:extLst>
                  <a:ext uri="{FF2B5EF4-FFF2-40B4-BE49-F238E27FC236}">
                    <a16:creationId xmlns:a16="http://schemas.microsoft.com/office/drawing/2014/main" id="{F3EBDAE3-3047-472F-ADF4-A8096D165724}"/>
                  </a:ext>
                </a:extLst>
              </p:cNvPr>
              <p:cNvSpPr/>
              <p:nvPr/>
            </p:nvSpPr>
            <p:spPr>
              <a:xfrm rot="18900000">
                <a:off x="5167866" y="2500866"/>
                <a:ext cx="1856270" cy="1856270"/>
              </a:xfrm>
              <a:prstGeom prst="roundRect">
                <a:avLst/>
              </a:prstGeom>
              <a:solidFill>
                <a:srgbClr val="660066">
                  <a:alpha val="72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0" name="Rectangle: Rounded Corners 4">
                <a:extLst>
                  <a:ext uri="{FF2B5EF4-FFF2-40B4-BE49-F238E27FC236}">
                    <a16:creationId xmlns:a16="http://schemas.microsoft.com/office/drawing/2014/main" id="{9D40A5AF-CE92-48B5-9530-66D95EAC6272}"/>
                  </a:ext>
                </a:extLst>
              </p:cNvPr>
              <p:cNvSpPr/>
              <p:nvPr/>
            </p:nvSpPr>
            <p:spPr>
              <a:xfrm rot="20700000">
                <a:off x="5167866" y="2500866"/>
                <a:ext cx="1856270" cy="1856270"/>
              </a:xfrm>
              <a:prstGeom prst="roundRect">
                <a:avLst/>
              </a:prstGeom>
              <a:solidFill>
                <a:srgbClr val="00CCFF">
                  <a:alpha val="72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1" name="Oval 90">
                <a:extLst>
                  <a:ext uri="{FF2B5EF4-FFF2-40B4-BE49-F238E27FC236}">
                    <a16:creationId xmlns:a16="http://schemas.microsoft.com/office/drawing/2014/main" id="{0BA96E1E-43CB-4149-83C2-FAB6773056FF}"/>
                  </a:ext>
                </a:extLst>
              </p:cNvPr>
              <p:cNvSpPr/>
              <p:nvPr/>
            </p:nvSpPr>
            <p:spPr>
              <a:xfrm>
                <a:off x="5145921" y="2478919"/>
                <a:ext cx="1900165" cy="1900166"/>
              </a:xfrm>
              <a:prstGeom prst="ellipse">
                <a:avLst/>
              </a:prstGeom>
              <a:solidFill>
                <a:schemeClr val="accent4">
                  <a:lumMod val="20000"/>
                  <a:lumOff val="80000"/>
                </a:schemeClr>
              </a:solidFill>
              <a:ln>
                <a:noFill/>
              </a:ln>
              <a:effectLst>
                <a:outerShdw blurRad="63500" sx="106000" sy="106000" algn="ctr" rotWithShape="0">
                  <a:prstClr val="black">
                    <a:alpha val="40000"/>
                  </a:prstClr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55" name="Flowchart: Connector 54"/>
            <p:cNvSpPr/>
            <p:nvPr/>
          </p:nvSpPr>
          <p:spPr bwMode="auto">
            <a:xfrm>
              <a:off x="4876147" y="7329643"/>
              <a:ext cx="933576" cy="349733"/>
            </a:xfrm>
            <a:prstGeom prst="flowChartConnector">
              <a:avLst/>
            </a:prstGeom>
            <a:solidFill>
              <a:srgbClr val="C00000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IN" b="1"/>
            </a:p>
          </p:txBody>
        </p:sp>
        <p:sp>
          <p:nvSpPr>
            <p:cNvPr id="56" name="Flowchart: Connector 55"/>
            <p:cNvSpPr/>
            <p:nvPr/>
          </p:nvSpPr>
          <p:spPr bwMode="auto">
            <a:xfrm>
              <a:off x="3194601" y="631132"/>
              <a:ext cx="141893" cy="178757"/>
            </a:xfrm>
            <a:prstGeom prst="flowChartConnector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IN" b="1"/>
            </a:p>
          </p:txBody>
        </p:sp>
        <p:sp>
          <p:nvSpPr>
            <p:cNvPr id="57" name="Flowchart: Connector 56"/>
            <p:cNvSpPr/>
            <p:nvPr/>
          </p:nvSpPr>
          <p:spPr bwMode="auto">
            <a:xfrm>
              <a:off x="3430304" y="276582"/>
              <a:ext cx="141893" cy="178757"/>
            </a:xfrm>
            <a:prstGeom prst="flowChartConnector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IN" b="1"/>
            </a:p>
          </p:txBody>
        </p:sp>
        <p:sp>
          <p:nvSpPr>
            <p:cNvPr id="62" name="Flowchart: Connector 61"/>
            <p:cNvSpPr/>
            <p:nvPr/>
          </p:nvSpPr>
          <p:spPr bwMode="auto">
            <a:xfrm>
              <a:off x="4574354" y="105418"/>
              <a:ext cx="141893" cy="178757"/>
            </a:xfrm>
            <a:prstGeom prst="flowChartConnector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IN" b="1"/>
            </a:p>
          </p:txBody>
        </p:sp>
        <p:sp>
          <p:nvSpPr>
            <p:cNvPr id="63" name="Flowchart: Connector 62"/>
            <p:cNvSpPr/>
            <p:nvPr/>
          </p:nvSpPr>
          <p:spPr bwMode="auto">
            <a:xfrm>
              <a:off x="4884718" y="119010"/>
              <a:ext cx="117874" cy="114934"/>
            </a:xfrm>
            <a:prstGeom prst="flowChartConnector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IN" b="1"/>
            </a:p>
          </p:txBody>
        </p:sp>
        <p:sp>
          <p:nvSpPr>
            <p:cNvPr id="64" name="Flowchart: Connector 63"/>
            <p:cNvSpPr/>
            <p:nvPr/>
          </p:nvSpPr>
          <p:spPr bwMode="auto">
            <a:xfrm>
              <a:off x="5411640" y="-126959"/>
              <a:ext cx="117874" cy="114934"/>
            </a:xfrm>
            <a:prstGeom prst="flowChartConnector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IN" b="1"/>
            </a:p>
          </p:txBody>
        </p:sp>
        <p:sp>
          <p:nvSpPr>
            <p:cNvPr id="65" name="Flowchart: Connector 64"/>
            <p:cNvSpPr/>
            <p:nvPr/>
          </p:nvSpPr>
          <p:spPr bwMode="auto">
            <a:xfrm>
              <a:off x="5208417" y="54782"/>
              <a:ext cx="117874" cy="114934"/>
            </a:xfrm>
            <a:prstGeom prst="flowChartConnector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IN" b="1"/>
            </a:p>
          </p:txBody>
        </p:sp>
        <p:sp>
          <p:nvSpPr>
            <p:cNvPr id="70" name="Flowchart: Connector 69"/>
            <p:cNvSpPr/>
            <p:nvPr/>
          </p:nvSpPr>
          <p:spPr bwMode="auto">
            <a:xfrm>
              <a:off x="7871959" y="4075"/>
              <a:ext cx="117874" cy="114934"/>
            </a:xfrm>
            <a:prstGeom prst="flowChartConnector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IN" b="1"/>
            </a:p>
          </p:txBody>
        </p:sp>
        <p:sp>
          <p:nvSpPr>
            <p:cNvPr id="71" name="Flowchart: Connector 70"/>
            <p:cNvSpPr/>
            <p:nvPr/>
          </p:nvSpPr>
          <p:spPr bwMode="auto">
            <a:xfrm>
              <a:off x="8106458" y="239051"/>
              <a:ext cx="117874" cy="114934"/>
            </a:xfrm>
            <a:prstGeom prst="flowChartConnector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IN" b="1"/>
            </a:p>
          </p:txBody>
        </p:sp>
        <p:sp>
          <p:nvSpPr>
            <p:cNvPr id="72" name="Flowchart: Connector 71"/>
            <p:cNvSpPr/>
            <p:nvPr/>
          </p:nvSpPr>
          <p:spPr bwMode="auto">
            <a:xfrm>
              <a:off x="8183315" y="467727"/>
              <a:ext cx="117874" cy="114934"/>
            </a:xfrm>
            <a:prstGeom prst="flowChartConnector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IN" b="1"/>
            </a:p>
          </p:txBody>
        </p:sp>
        <p:sp>
          <p:nvSpPr>
            <p:cNvPr id="73" name="Flowchart: Connector 72"/>
            <p:cNvSpPr/>
            <p:nvPr/>
          </p:nvSpPr>
          <p:spPr bwMode="auto">
            <a:xfrm>
              <a:off x="8417814" y="702703"/>
              <a:ext cx="117874" cy="114934"/>
            </a:xfrm>
            <a:prstGeom prst="flowChartConnector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IN" b="1"/>
            </a:p>
          </p:txBody>
        </p:sp>
        <p:sp>
          <p:nvSpPr>
            <p:cNvPr id="74" name="Flowchart: Connector 73"/>
            <p:cNvSpPr/>
            <p:nvPr/>
          </p:nvSpPr>
          <p:spPr bwMode="auto">
            <a:xfrm>
              <a:off x="8652313" y="937678"/>
              <a:ext cx="117874" cy="114934"/>
            </a:xfrm>
            <a:prstGeom prst="flowChartConnector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IN" b="1"/>
            </a:p>
          </p:txBody>
        </p:sp>
        <p:sp>
          <p:nvSpPr>
            <p:cNvPr id="75" name="Flowchart: Connector 74"/>
            <p:cNvSpPr/>
            <p:nvPr/>
          </p:nvSpPr>
          <p:spPr bwMode="auto">
            <a:xfrm>
              <a:off x="8233148" y="902171"/>
              <a:ext cx="117874" cy="114934"/>
            </a:xfrm>
            <a:prstGeom prst="flowChartConnector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IN" b="1"/>
            </a:p>
          </p:txBody>
        </p:sp>
        <p:sp>
          <p:nvSpPr>
            <p:cNvPr id="77" name="Flowchart: Connector 76"/>
            <p:cNvSpPr/>
            <p:nvPr/>
          </p:nvSpPr>
          <p:spPr bwMode="auto">
            <a:xfrm>
              <a:off x="8467647" y="1137146"/>
              <a:ext cx="117874" cy="114934"/>
            </a:xfrm>
            <a:prstGeom prst="flowChartConnector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IN" b="1"/>
            </a:p>
          </p:txBody>
        </p:sp>
        <p:grpSp>
          <p:nvGrpSpPr>
            <p:cNvPr id="83" name="Group 82">
              <a:extLst>
                <a:ext uri="{FF2B5EF4-FFF2-40B4-BE49-F238E27FC236}">
                  <a16:creationId xmlns:a16="http://schemas.microsoft.com/office/drawing/2014/main" id="{37C3B67F-A375-44EB-9660-7D046AAC4AB9}"/>
                </a:ext>
              </a:extLst>
            </p:cNvPr>
            <p:cNvGrpSpPr/>
            <p:nvPr/>
          </p:nvGrpSpPr>
          <p:grpSpPr>
            <a:xfrm>
              <a:off x="5902804" y="1156704"/>
              <a:ext cx="1235594" cy="1223931"/>
              <a:chOff x="5127310" y="2478919"/>
              <a:chExt cx="1918774" cy="1900166"/>
            </a:xfrm>
          </p:grpSpPr>
          <p:sp>
            <p:nvSpPr>
              <p:cNvPr id="84" name="Rectangle: Rounded Corners 5">
                <a:extLst>
                  <a:ext uri="{FF2B5EF4-FFF2-40B4-BE49-F238E27FC236}">
                    <a16:creationId xmlns:a16="http://schemas.microsoft.com/office/drawing/2014/main" id="{83A621BB-CF28-4826-8ED3-E408D0053528}"/>
                  </a:ext>
                </a:extLst>
              </p:cNvPr>
              <p:cNvSpPr/>
              <p:nvPr/>
            </p:nvSpPr>
            <p:spPr>
              <a:xfrm rot="900000">
                <a:off x="5127310" y="2487211"/>
                <a:ext cx="1856270" cy="1856270"/>
              </a:xfrm>
              <a:prstGeom prst="roundRect">
                <a:avLst/>
              </a:prstGeom>
              <a:solidFill>
                <a:srgbClr val="FF9900">
                  <a:alpha val="72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5" name="Rectangle: Rounded Corners 3">
                <a:extLst>
                  <a:ext uri="{FF2B5EF4-FFF2-40B4-BE49-F238E27FC236}">
                    <a16:creationId xmlns:a16="http://schemas.microsoft.com/office/drawing/2014/main" id="{F3EBDAE3-3047-472F-ADF4-A8096D165724}"/>
                  </a:ext>
                </a:extLst>
              </p:cNvPr>
              <p:cNvSpPr/>
              <p:nvPr/>
            </p:nvSpPr>
            <p:spPr>
              <a:xfrm rot="18900000">
                <a:off x="5167866" y="2500866"/>
                <a:ext cx="1856270" cy="1856270"/>
              </a:xfrm>
              <a:prstGeom prst="roundRect">
                <a:avLst/>
              </a:prstGeom>
              <a:solidFill>
                <a:srgbClr val="660066">
                  <a:alpha val="72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6" name="Rectangle: Rounded Corners 4">
                <a:extLst>
                  <a:ext uri="{FF2B5EF4-FFF2-40B4-BE49-F238E27FC236}">
                    <a16:creationId xmlns:a16="http://schemas.microsoft.com/office/drawing/2014/main" id="{9D40A5AF-CE92-48B5-9530-66D95EAC6272}"/>
                  </a:ext>
                </a:extLst>
              </p:cNvPr>
              <p:cNvSpPr/>
              <p:nvPr/>
            </p:nvSpPr>
            <p:spPr>
              <a:xfrm rot="20700000">
                <a:off x="5167866" y="2500866"/>
                <a:ext cx="1856270" cy="1856270"/>
              </a:xfrm>
              <a:prstGeom prst="roundRect">
                <a:avLst/>
              </a:prstGeom>
              <a:solidFill>
                <a:srgbClr val="00CCFF">
                  <a:alpha val="72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7" name="Oval 86">
                <a:extLst>
                  <a:ext uri="{FF2B5EF4-FFF2-40B4-BE49-F238E27FC236}">
                    <a16:creationId xmlns:a16="http://schemas.microsoft.com/office/drawing/2014/main" id="{0BA96E1E-43CB-4149-83C2-FAB6773056FF}"/>
                  </a:ext>
                </a:extLst>
              </p:cNvPr>
              <p:cNvSpPr/>
              <p:nvPr/>
            </p:nvSpPr>
            <p:spPr>
              <a:xfrm>
                <a:off x="5145918" y="2478919"/>
                <a:ext cx="1900166" cy="1900166"/>
              </a:xfrm>
              <a:prstGeom prst="ellipse">
                <a:avLst/>
              </a:prstGeom>
              <a:solidFill>
                <a:schemeClr val="accent4">
                  <a:lumMod val="20000"/>
                  <a:lumOff val="80000"/>
                </a:schemeClr>
              </a:solidFill>
              <a:ln>
                <a:noFill/>
              </a:ln>
              <a:effectLst>
                <a:outerShdw blurRad="63500" sx="106000" sy="106000" algn="ctr" rotWithShape="0">
                  <a:prstClr val="black">
                    <a:alpha val="40000"/>
                  </a:prstClr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4" name="Rectangle 3"/>
            <p:cNvSpPr/>
            <p:nvPr/>
          </p:nvSpPr>
          <p:spPr>
            <a:xfrm>
              <a:off x="4236985" y="-189000"/>
              <a:ext cx="574196" cy="38869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</a:t>
              </a:r>
              <a:r>
                <a:rPr lang="en-IN" kern="100" baseline="300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2+</a:t>
              </a:r>
              <a:endParaRPr lang="en-IN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ectangle 7"/>
            <p:cNvSpPr/>
            <p:nvPr/>
          </p:nvSpPr>
          <p:spPr>
            <a:xfrm>
              <a:off x="4204072" y="448667"/>
              <a:ext cx="739498" cy="37555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tress</a:t>
              </a:r>
              <a:endParaRPr lang="en-IN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Rectangle 8"/>
            <p:cNvSpPr/>
            <p:nvPr/>
          </p:nvSpPr>
          <p:spPr>
            <a:xfrm rot="20974106">
              <a:off x="5386604" y="485058"/>
              <a:ext cx="925382" cy="37555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 err="1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tPTAC</a:t>
              </a:r>
              <a:endParaRPr lang="en-IN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4353476" y="2125299"/>
              <a:ext cx="1906868" cy="28995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IN" sz="1200" kern="100" dirty="0" err="1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tDNA</a:t>
              </a:r>
              <a:r>
                <a:rPr lang="en-IN" sz="1200" kern="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IN" sz="1200" kern="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Transcription</a:t>
              </a: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3253839" y="2121132"/>
              <a:ext cx="970907" cy="77450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OXPHOS</a:t>
              </a:r>
            </a:p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damage</a:t>
              </a: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3325357" y="947412"/>
              <a:ext cx="1046953" cy="78765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 err="1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tDNA</a:t>
              </a:r>
              <a:endParaRPr lang="en-IN" kern="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utation</a:t>
              </a:r>
            </a:p>
          </p:txBody>
        </p:sp>
        <p:grpSp>
          <p:nvGrpSpPr>
            <p:cNvPr id="107" name="Group 106"/>
            <p:cNvGrpSpPr/>
            <p:nvPr/>
          </p:nvGrpSpPr>
          <p:grpSpPr>
            <a:xfrm rot="5785289">
              <a:off x="3043454" y="2257332"/>
              <a:ext cx="375552" cy="453032"/>
              <a:chOff x="1648919" y="-2055616"/>
              <a:chExt cx="375552" cy="453032"/>
            </a:xfrm>
          </p:grpSpPr>
          <p:sp>
            <p:nvSpPr>
              <p:cNvPr id="106" name="Flowchart: Extract 105"/>
              <p:cNvSpPr/>
              <p:nvPr/>
            </p:nvSpPr>
            <p:spPr>
              <a:xfrm>
                <a:off x="1657590" y="-2055616"/>
                <a:ext cx="351766" cy="453032"/>
              </a:xfrm>
              <a:prstGeom prst="flowChartExtra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8" name="Rectangle 17"/>
              <p:cNvSpPr/>
              <p:nvPr/>
            </p:nvSpPr>
            <p:spPr>
              <a:xfrm rot="15814711">
                <a:off x="1715508" y="-1957317"/>
                <a:ext cx="242374" cy="37555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N" kern="1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I</a:t>
                </a:r>
                <a:endParaRPr lang="en-IN" kern="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9" name="Rectangle 18"/>
            <p:cNvSpPr/>
            <p:nvPr/>
          </p:nvSpPr>
          <p:spPr>
            <a:xfrm>
              <a:off x="4932591" y="1117538"/>
              <a:ext cx="601447" cy="38869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 err="1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lpP</a:t>
              </a:r>
              <a:endParaRPr lang="en-IN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15" name="Group 114"/>
            <p:cNvGrpSpPr/>
            <p:nvPr/>
          </p:nvGrpSpPr>
          <p:grpSpPr>
            <a:xfrm>
              <a:off x="3825929" y="2833168"/>
              <a:ext cx="364676" cy="508556"/>
              <a:chOff x="1524798" y="-1856940"/>
              <a:chExt cx="364676" cy="508556"/>
            </a:xfrm>
          </p:grpSpPr>
          <p:sp>
            <p:nvSpPr>
              <p:cNvPr id="113" name="Flowchart: Extract 112"/>
              <p:cNvSpPr/>
              <p:nvPr/>
            </p:nvSpPr>
            <p:spPr>
              <a:xfrm>
                <a:off x="1537708" y="-1856940"/>
                <a:ext cx="351766" cy="453032"/>
              </a:xfrm>
              <a:prstGeom prst="flowChartExtra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dirty="0"/>
              </a:p>
            </p:txBody>
          </p:sp>
          <p:sp>
            <p:nvSpPr>
              <p:cNvPr id="21" name="Rectangle 20"/>
              <p:cNvSpPr/>
              <p:nvPr/>
            </p:nvSpPr>
            <p:spPr>
              <a:xfrm>
                <a:off x="1524798" y="-1723936"/>
                <a:ext cx="357790" cy="37555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N" kern="1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III</a:t>
                </a:r>
                <a:endParaRPr lang="en-IN" kern="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9" name="Group 118"/>
            <p:cNvGrpSpPr/>
            <p:nvPr/>
          </p:nvGrpSpPr>
          <p:grpSpPr>
            <a:xfrm rot="17122070">
              <a:off x="4089153" y="2256943"/>
              <a:ext cx="388696" cy="517100"/>
              <a:chOff x="1548748" y="-1077652"/>
              <a:chExt cx="388696" cy="517100"/>
            </a:xfrm>
          </p:grpSpPr>
          <p:sp>
            <p:nvSpPr>
              <p:cNvPr id="117" name="Flowchart: Extract 116"/>
              <p:cNvSpPr/>
              <p:nvPr/>
            </p:nvSpPr>
            <p:spPr>
              <a:xfrm>
                <a:off x="1557917" y="-1077652"/>
                <a:ext cx="351766" cy="453032"/>
              </a:xfrm>
              <a:prstGeom prst="flowChartExtra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dirty="0"/>
              </a:p>
            </p:txBody>
          </p:sp>
          <p:sp>
            <p:nvSpPr>
              <p:cNvPr id="22" name="Rectangle 21"/>
              <p:cNvSpPr/>
              <p:nvPr/>
            </p:nvSpPr>
            <p:spPr>
              <a:xfrm rot="4477930">
                <a:off x="1556186" y="-941810"/>
                <a:ext cx="373820" cy="38869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N" kern="1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IV</a:t>
                </a:r>
                <a:endParaRPr lang="en-IN" kern="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3" name="Rectangle 22"/>
            <p:cNvSpPr/>
            <p:nvPr/>
          </p:nvSpPr>
          <p:spPr>
            <a:xfrm>
              <a:off x="1747780" y="3815458"/>
              <a:ext cx="1452192" cy="77450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tabolic </a:t>
              </a:r>
            </a:p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rogramming</a:t>
              </a:r>
              <a:endParaRPr lang="en-IN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ctangle 24"/>
            <p:cNvSpPr/>
            <p:nvPr/>
          </p:nvSpPr>
          <p:spPr>
            <a:xfrm>
              <a:off x="1743145" y="5493998"/>
              <a:ext cx="590226" cy="38869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HD</a:t>
              </a:r>
              <a:endParaRPr lang="en-IN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Rectangle 26"/>
            <p:cNvSpPr/>
            <p:nvPr/>
          </p:nvSpPr>
          <p:spPr>
            <a:xfrm>
              <a:off x="4829290" y="7296186"/>
              <a:ext cx="1069395" cy="38869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l-GR" kern="100" dirty="0">
                  <a:solidFill>
                    <a:schemeClr val="bg1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β</a:t>
              </a:r>
              <a:r>
                <a:rPr lang="en-IN" kern="100" dirty="0">
                  <a:solidFill>
                    <a:schemeClr val="bg1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-catenin</a:t>
              </a:r>
              <a:endParaRPr lang="en-IN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ectangle 29"/>
            <p:cNvSpPr/>
            <p:nvPr/>
          </p:nvSpPr>
          <p:spPr>
            <a:xfrm>
              <a:off x="6469375" y="7910241"/>
              <a:ext cx="719941" cy="38869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FAM</a:t>
              </a:r>
              <a:endParaRPr lang="en-IN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30"/>
            <p:cNvSpPr/>
            <p:nvPr/>
          </p:nvSpPr>
          <p:spPr>
            <a:xfrm>
              <a:off x="3918049" y="8293911"/>
              <a:ext cx="2617027" cy="107087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ncer stem </a:t>
              </a:r>
            </a:p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ell signalling in chemo-resistant CRC</a:t>
              </a:r>
              <a:endParaRPr lang="en-IN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Rectangle 31"/>
            <p:cNvSpPr/>
            <p:nvPr/>
          </p:nvSpPr>
          <p:spPr>
            <a:xfrm>
              <a:off x="7837397" y="4894679"/>
              <a:ext cx="1348126" cy="1173463"/>
            </a:xfrm>
            <a:prstGeom prst="rect">
              <a:avLst/>
            </a:prstGeom>
            <a:ln>
              <a:solidFill>
                <a:schemeClr val="accent6"/>
              </a:solidFill>
            </a:ln>
          </p:spPr>
          <p:txBody>
            <a:bodyPr wrap="none">
              <a:spAutoFit/>
            </a:bodyPr>
            <a:lstStyle/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ell survival </a:t>
              </a:r>
            </a:p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nd </a:t>
              </a:r>
            </a:p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roliferation</a:t>
              </a:r>
              <a:endParaRPr lang="en-IN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tangle 34"/>
            <p:cNvSpPr/>
            <p:nvPr/>
          </p:nvSpPr>
          <p:spPr>
            <a:xfrm>
              <a:off x="4004824" y="5379042"/>
              <a:ext cx="1111138" cy="38869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poptosis</a:t>
              </a:r>
              <a:endParaRPr lang="en-IN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Rectangle 35"/>
            <p:cNvSpPr/>
            <p:nvPr/>
          </p:nvSpPr>
          <p:spPr>
            <a:xfrm>
              <a:off x="2382519" y="5437894"/>
              <a:ext cx="1624163" cy="78765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NK/p38 MAPK</a:t>
              </a:r>
            </a:p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IN" kern="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35/p-p53/p21</a:t>
              </a:r>
            </a:p>
          </p:txBody>
        </p:sp>
        <p:sp>
          <p:nvSpPr>
            <p:cNvPr id="37" name="Rectangle 36"/>
            <p:cNvSpPr/>
            <p:nvPr/>
          </p:nvSpPr>
          <p:spPr>
            <a:xfrm>
              <a:off x="5651767" y="5259112"/>
              <a:ext cx="1410835" cy="38869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MPK/</a:t>
              </a:r>
              <a:r>
                <a:rPr lang="en-IN" kern="100" dirty="0" err="1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TOR</a:t>
              </a:r>
              <a:endParaRPr lang="en-IN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Rectangle 37"/>
            <p:cNvSpPr/>
            <p:nvPr/>
          </p:nvSpPr>
          <p:spPr>
            <a:xfrm>
              <a:off x="4759319" y="4717308"/>
              <a:ext cx="550151" cy="38869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KT</a:t>
              </a:r>
              <a:endParaRPr lang="en-IN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Rectangle 38"/>
            <p:cNvSpPr/>
            <p:nvPr/>
          </p:nvSpPr>
          <p:spPr>
            <a:xfrm>
              <a:off x="1767528" y="4965089"/>
              <a:ext cx="643702" cy="38869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l-GR" kern="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α</a:t>
              </a:r>
              <a:r>
                <a:rPr lang="en-IN" kern="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-KG</a:t>
              </a:r>
              <a:endParaRPr lang="en-IN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Rectangle 41"/>
            <p:cNvSpPr/>
            <p:nvPr/>
          </p:nvSpPr>
          <p:spPr>
            <a:xfrm>
              <a:off x="7039236" y="4644433"/>
              <a:ext cx="657552" cy="38869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NF</a:t>
              </a:r>
              <a:r>
                <a:rPr lang="en-IN" sz="1200" kern="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K</a:t>
              </a:r>
              <a:r>
                <a:rPr lang="en-IN" kern="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B</a:t>
              </a:r>
              <a:endParaRPr lang="en-IN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Cloud 96"/>
            <p:cNvSpPr/>
            <p:nvPr/>
          </p:nvSpPr>
          <p:spPr>
            <a:xfrm>
              <a:off x="4988354" y="525194"/>
              <a:ext cx="440125" cy="473851"/>
            </a:xfrm>
            <a:prstGeom prst="cloud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IN" b="1">
                <a:solidFill>
                  <a:schemeClr val="tx1"/>
                </a:solidFill>
                <a:cs typeface="Times New Roman" pitchFamily="18" charset="0"/>
              </a:endParaRPr>
            </a:p>
          </p:txBody>
        </p:sp>
        <p:sp>
          <p:nvSpPr>
            <p:cNvPr id="98" name="Lightning Bolt 97"/>
            <p:cNvSpPr/>
            <p:nvPr/>
          </p:nvSpPr>
          <p:spPr>
            <a:xfrm rot="6556256">
              <a:off x="4335614" y="642228"/>
              <a:ext cx="673355" cy="464221"/>
            </a:xfrm>
            <a:prstGeom prst="lightningBol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b="1"/>
            </a:p>
          </p:txBody>
        </p:sp>
        <p:sp>
          <p:nvSpPr>
            <p:cNvPr id="99" name="Cloud 98"/>
            <p:cNvSpPr/>
            <p:nvPr/>
          </p:nvSpPr>
          <p:spPr>
            <a:xfrm>
              <a:off x="4682687" y="1462692"/>
              <a:ext cx="440125" cy="473851"/>
            </a:xfrm>
            <a:prstGeom prst="cloud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IN" b="1">
                <a:solidFill>
                  <a:schemeClr val="tx1"/>
                </a:solidFill>
                <a:cs typeface="Times New Roman" pitchFamily="18" charset="0"/>
              </a:endParaRPr>
            </a:p>
          </p:txBody>
        </p:sp>
        <p:grpSp>
          <p:nvGrpSpPr>
            <p:cNvPr id="105" name="Group 104"/>
            <p:cNvGrpSpPr/>
            <p:nvPr/>
          </p:nvGrpSpPr>
          <p:grpSpPr>
            <a:xfrm>
              <a:off x="6024158" y="192807"/>
              <a:ext cx="1385730" cy="1012768"/>
              <a:chOff x="7634163" y="-4287245"/>
              <a:chExt cx="1385730" cy="1012768"/>
            </a:xfrm>
          </p:grpSpPr>
          <p:grpSp>
            <p:nvGrpSpPr>
              <p:cNvPr id="2" name="Group 1"/>
              <p:cNvGrpSpPr/>
              <p:nvPr/>
            </p:nvGrpSpPr>
            <p:grpSpPr>
              <a:xfrm>
                <a:off x="7634163" y="-3849678"/>
                <a:ext cx="719941" cy="575201"/>
                <a:chOff x="0" y="-133229"/>
                <a:chExt cx="719941" cy="575201"/>
              </a:xfrm>
            </p:grpSpPr>
            <p:sp>
              <p:nvSpPr>
                <p:cNvPr id="100" name="Oval 454"/>
                <p:cNvSpPr/>
                <p:nvPr/>
              </p:nvSpPr>
              <p:spPr bwMode="auto">
                <a:xfrm rot="16369013">
                  <a:off x="101966" y="-126240"/>
                  <a:ext cx="575201" cy="561223"/>
                </a:xfrm>
                <a:custGeom>
                  <a:avLst/>
                  <a:gdLst>
                    <a:gd name="connsiteX0" fmla="*/ 0 w 628650"/>
                    <a:gd name="connsiteY0" fmla="*/ 342901 h 685801"/>
                    <a:gd name="connsiteX1" fmla="*/ 314325 w 628650"/>
                    <a:gd name="connsiteY1" fmla="*/ 0 h 685801"/>
                    <a:gd name="connsiteX2" fmla="*/ 628650 w 628650"/>
                    <a:gd name="connsiteY2" fmla="*/ 342901 h 685801"/>
                    <a:gd name="connsiteX3" fmla="*/ 314325 w 628650"/>
                    <a:gd name="connsiteY3" fmla="*/ 685802 h 685801"/>
                    <a:gd name="connsiteX4" fmla="*/ 0 w 628650"/>
                    <a:gd name="connsiteY4" fmla="*/ 342901 h 685801"/>
                    <a:gd name="connsiteX0" fmla="*/ 0 w 650253"/>
                    <a:gd name="connsiteY0" fmla="*/ 342901 h 688891"/>
                    <a:gd name="connsiteX1" fmla="*/ 314325 w 650253"/>
                    <a:gd name="connsiteY1" fmla="*/ 0 h 688891"/>
                    <a:gd name="connsiteX2" fmla="*/ 628650 w 650253"/>
                    <a:gd name="connsiteY2" fmla="*/ 342901 h 688891"/>
                    <a:gd name="connsiteX3" fmla="*/ 588683 w 650253"/>
                    <a:gd name="connsiteY3" fmla="*/ 502649 h 688891"/>
                    <a:gd name="connsiteX4" fmla="*/ 314325 w 650253"/>
                    <a:gd name="connsiteY4" fmla="*/ 685802 h 688891"/>
                    <a:gd name="connsiteX5" fmla="*/ 0 w 650253"/>
                    <a:gd name="connsiteY5" fmla="*/ 342901 h 688891"/>
                    <a:gd name="connsiteX0" fmla="*/ 0 w 646386"/>
                    <a:gd name="connsiteY0" fmla="*/ 342901 h 706454"/>
                    <a:gd name="connsiteX1" fmla="*/ 314325 w 646386"/>
                    <a:gd name="connsiteY1" fmla="*/ 0 h 706454"/>
                    <a:gd name="connsiteX2" fmla="*/ 628650 w 646386"/>
                    <a:gd name="connsiteY2" fmla="*/ 342901 h 706454"/>
                    <a:gd name="connsiteX3" fmla="*/ 588683 w 646386"/>
                    <a:gd name="connsiteY3" fmla="*/ 502649 h 706454"/>
                    <a:gd name="connsiteX4" fmla="*/ 434871 w 646386"/>
                    <a:gd name="connsiteY4" fmla="*/ 650086 h 706454"/>
                    <a:gd name="connsiteX5" fmla="*/ 314325 w 646386"/>
                    <a:gd name="connsiteY5" fmla="*/ 685802 h 706454"/>
                    <a:gd name="connsiteX6" fmla="*/ 0 w 646386"/>
                    <a:gd name="connsiteY6" fmla="*/ 342901 h 706454"/>
                    <a:gd name="connsiteX0" fmla="*/ 4180 w 650566"/>
                    <a:gd name="connsiteY0" fmla="*/ 342901 h 686680"/>
                    <a:gd name="connsiteX1" fmla="*/ 318505 w 650566"/>
                    <a:gd name="connsiteY1" fmla="*/ 0 h 686680"/>
                    <a:gd name="connsiteX2" fmla="*/ 632830 w 650566"/>
                    <a:gd name="connsiteY2" fmla="*/ 342901 h 686680"/>
                    <a:gd name="connsiteX3" fmla="*/ 592863 w 650566"/>
                    <a:gd name="connsiteY3" fmla="*/ 502649 h 686680"/>
                    <a:gd name="connsiteX4" fmla="*/ 439051 w 650566"/>
                    <a:gd name="connsiteY4" fmla="*/ 650086 h 686680"/>
                    <a:gd name="connsiteX5" fmla="*/ 318505 w 650566"/>
                    <a:gd name="connsiteY5" fmla="*/ 685802 h 686680"/>
                    <a:gd name="connsiteX6" fmla="*/ 149656 w 650566"/>
                    <a:gd name="connsiteY6" fmla="*/ 626177 h 686680"/>
                    <a:gd name="connsiteX7" fmla="*/ 4180 w 650566"/>
                    <a:gd name="connsiteY7" fmla="*/ 342901 h 686680"/>
                    <a:gd name="connsiteX0" fmla="*/ 4180 w 650566"/>
                    <a:gd name="connsiteY0" fmla="*/ 353175 h 696954"/>
                    <a:gd name="connsiteX1" fmla="*/ 102715 w 650566"/>
                    <a:gd name="connsiteY1" fmla="*/ 113196 h 696954"/>
                    <a:gd name="connsiteX2" fmla="*/ 318505 w 650566"/>
                    <a:gd name="connsiteY2" fmla="*/ 10274 h 696954"/>
                    <a:gd name="connsiteX3" fmla="*/ 632830 w 650566"/>
                    <a:gd name="connsiteY3" fmla="*/ 353175 h 696954"/>
                    <a:gd name="connsiteX4" fmla="*/ 592863 w 650566"/>
                    <a:gd name="connsiteY4" fmla="*/ 512923 h 696954"/>
                    <a:gd name="connsiteX5" fmla="*/ 439051 w 650566"/>
                    <a:gd name="connsiteY5" fmla="*/ 660360 h 696954"/>
                    <a:gd name="connsiteX6" fmla="*/ 318505 w 650566"/>
                    <a:gd name="connsiteY6" fmla="*/ 696076 h 696954"/>
                    <a:gd name="connsiteX7" fmla="*/ 149656 w 650566"/>
                    <a:gd name="connsiteY7" fmla="*/ 636451 h 696954"/>
                    <a:gd name="connsiteX8" fmla="*/ 4180 w 650566"/>
                    <a:gd name="connsiteY8" fmla="*/ 353175 h 696954"/>
                    <a:gd name="connsiteX0" fmla="*/ 4180 w 639547"/>
                    <a:gd name="connsiteY0" fmla="*/ 343504 h 687283"/>
                    <a:gd name="connsiteX1" fmla="*/ 102715 w 639547"/>
                    <a:gd name="connsiteY1" fmla="*/ 103525 h 687283"/>
                    <a:gd name="connsiteX2" fmla="*/ 318505 w 639547"/>
                    <a:gd name="connsiteY2" fmla="*/ 603 h 687283"/>
                    <a:gd name="connsiteX3" fmla="*/ 473484 w 639547"/>
                    <a:gd name="connsiteY3" fmla="*/ 144619 h 687283"/>
                    <a:gd name="connsiteX4" fmla="*/ 632830 w 639547"/>
                    <a:gd name="connsiteY4" fmla="*/ 343504 h 687283"/>
                    <a:gd name="connsiteX5" fmla="*/ 592863 w 639547"/>
                    <a:gd name="connsiteY5" fmla="*/ 503252 h 687283"/>
                    <a:gd name="connsiteX6" fmla="*/ 439051 w 639547"/>
                    <a:gd name="connsiteY6" fmla="*/ 650689 h 687283"/>
                    <a:gd name="connsiteX7" fmla="*/ 318505 w 639547"/>
                    <a:gd name="connsiteY7" fmla="*/ 686405 h 687283"/>
                    <a:gd name="connsiteX8" fmla="*/ 149656 w 639547"/>
                    <a:gd name="connsiteY8" fmla="*/ 626780 h 687283"/>
                    <a:gd name="connsiteX9" fmla="*/ 4180 w 639547"/>
                    <a:gd name="connsiteY9" fmla="*/ 343504 h 687283"/>
                    <a:gd name="connsiteX0" fmla="*/ 4180 w 639547"/>
                    <a:gd name="connsiteY0" fmla="*/ 347904 h 691683"/>
                    <a:gd name="connsiteX1" fmla="*/ 102715 w 639547"/>
                    <a:gd name="connsiteY1" fmla="*/ 107925 h 691683"/>
                    <a:gd name="connsiteX2" fmla="*/ 192614 w 639547"/>
                    <a:gd name="connsiteY2" fmla="*/ 39922 h 691683"/>
                    <a:gd name="connsiteX3" fmla="*/ 318505 w 639547"/>
                    <a:gd name="connsiteY3" fmla="*/ 5003 h 691683"/>
                    <a:gd name="connsiteX4" fmla="*/ 473484 w 639547"/>
                    <a:gd name="connsiteY4" fmla="*/ 149019 h 691683"/>
                    <a:gd name="connsiteX5" fmla="*/ 632830 w 639547"/>
                    <a:gd name="connsiteY5" fmla="*/ 347904 h 691683"/>
                    <a:gd name="connsiteX6" fmla="*/ 592863 w 639547"/>
                    <a:gd name="connsiteY6" fmla="*/ 507652 h 691683"/>
                    <a:gd name="connsiteX7" fmla="*/ 439051 w 639547"/>
                    <a:gd name="connsiteY7" fmla="*/ 655089 h 691683"/>
                    <a:gd name="connsiteX8" fmla="*/ 318505 w 639547"/>
                    <a:gd name="connsiteY8" fmla="*/ 690805 h 691683"/>
                    <a:gd name="connsiteX9" fmla="*/ 149656 w 639547"/>
                    <a:gd name="connsiteY9" fmla="*/ 631180 h 691683"/>
                    <a:gd name="connsiteX10" fmla="*/ 4180 w 639547"/>
                    <a:gd name="connsiteY10" fmla="*/ 347904 h 691683"/>
                    <a:gd name="connsiteX0" fmla="*/ 4180 w 643470"/>
                    <a:gd name="connsiteY0" fmla="*/ 347904 h 691683"/>
                    <a:gd name="connsiteX1" fmla="*/ 102715 w 643470"/>
                    <a:gd name="connsiteY1" fmla="*/ 107925 h 691683"/>
                    <a:gd name="connsiteX2" fmla="*/ 192614 w 643470"/>
                    <a:gd name="connsiteY2" fmla="*/ 39922 h 691683"/>
                    <a:gd name="connsiteX3" fmla="*/ 318505 w 643470"/>
                    <a:gd name="connsiteY3" fmla="*/ 5003 h 691683"/>
                    <a:gd name="connsiteX4" fmla="*/ 473484 w 643470"/>
                    <a:gd name="connsiteY4" fmla="*/ 149019 h 691683"/>
                    <a:gd name="connsiteX5" fmla="*/ 632830 w 643470"/>
                    <a:gd name="connsiteY5" fmla="*/ 347904 h 691683"/>
                    <a:gd name="connsiteX6" fmla="*/ 611857 w 643470"/>
                    <a:gd name="connsiteY6" fmla="*/ 549102 h 691683"/>
                    <a:gd name="connsiteX7" fmla="*/ 439051 w 643470"/>
                    <a:gd name="connsiteY7" fmla="*/ 655089 h 691683"/>
                    <a:gd name="connsiteX8" fmla="*/ 318505 w 643470"/>
                    <a:gd name="connsiteY8" fmla="*/ 690805 h 691683"/>
                    <a:gd name="connsiteX9" fmla="*/ 149656 w 643470"/>
                    <a:gd name="connsiteY9" fmla="*/ 631180 h 691683"/>
                    <a:gd name="connsiteX10" fmla="*/ 4180 w 643470"/>
                    <a:gd name="connsiteY10" fmla="*/ 347904 h 691683"/>
                    <a:gd name="connsiteX0" fmla="*/ 4180 w 643470"/>
                    <a:gd name="connsiteY0" fmla="*/ 351241 h 695020"/>
                    <a:gd name="connsiteX1" fmla="*/ 102715 w 643470"/>
                    <a:gd name="connsiteY1" fmla="*/ 111262 h 695020"/>
                    <a:gd name="connsiteX2" fmla="*/ 192614 w 643470"/>
                    <a:gd name="connsiteY2" fmla="*/ 43259 h 695020"/>
                    <a:gd name="connsiteX3" fmla="*/ 318505 w 643470"/>
                    <a:gd name="connsiteY3" fmla="*/ 8340 h 695020"/>
                    <a:gd name="connsiteX4" fmla="*/ 467526 w 643470"/>
                    <a:gd name="connsiteY4" fmla="*/ 203509 h 695020"/>
                    <a:gd name="connsiteX5" fmla="*/ 632830 w 643470"/>
                    <a:gd name="connsiteY5" fmla="*/ 351241 h 695020"/>
                    <a:gd name="connsiteX6" fmla="*/ 611857 w 643470"/>
                    <a:gd name="connsiteY6" fmla="*/ 552439 h 695020"/>
                    <a:gd name="connsiteX7" fmla="*/ 439051 w 643470"/>
                    <a:gd name="connsiteY7" fmla="*/ 658426 h 695020"/>
                    <a:gd name="connsiteX8" fmla="*/ 318505 w 643470"/>
                    <a:gd name="connsiteY8" fmla="*/ 694142 h 695020"/>
                    <a:gd name="connsiteX9" fmla="*/ 149656 w 643470"/>
                    <a:gd name="connsiteY9" fmla="*/ 634517 h 695020"/>
                    <a:gd name="connsiteX10" fmla="*/ 4180 w 643470"/>
                    <a:gd name="connsiteY10" fmla="*/ 351241 h 695020"/>
                    <a:gd name="connsiteX0" fmla="*/ 1874 w 641164"/>
                    <a:gd name="connsiteY0" fmla="*/ 351241 h 702699"/>
                    <a:gd name="connsiteX1" fmla="*/ 100409 w 641164"/>
                    <a:gd name="connsiteY1" fmla="*/ 111262 h 702699"/>
                    <a:gd name="connsiteX2" fmla="*/ 190308 w 641164"/>
                    <a:gd name="connsiteY2" fmla="*/ 43259 h 702699"/>
                    <a:gd name="connsiteX3" fmla="*/ 316199 w 641164"/>
                    <a:gd name="connsiteY3" fmla="*/ 8340 h 702699"/>
                    <a:gd name="connsiteX4" fmla="*/ 465220 w 641164"/>
                    <a:gd name="connsiteY4" fmla="*/ 203509 h 702699"/>
                    <a:gd name="connsiteX5" fmla="*/ 630524 w 641164"/>
                    <a:gd name="connsiteY5" fmla="*/ 351241 h 702699"/>
                    <a:gd name="connsiteX6" fmla="*/ 609551 w 641164"/>
                    <a:gd name="connsiteY6" fmla="*/ 552439 h 702699"/>
                    <a:gd name="connsiteX7" fmla="*/ 436745 w 641164"/>
                    <a:gd name="connsiteY7" fmla="*/ 658426 h 702699"/>
                    <a:gd name="connsiteX8" fmla="*/ 316199 w 641164"/>
                    <a:gd name="connsiteY8" fmla="*/ 694142 h 702699"/>
                    <a:gd name="connsiteX9" fmla="*/ 179786 w 641164"/>
                    <a:gd name="connsiteY9" fmla="*/ 518482 h 702699"/>
                    <a:gd name="connsiteX10" fmla="*/ 1874 w 641164"/>
                    <a:gd name="connsiteY10" fmla="*/ 351241 h 702699"/>
                    <a:gd name="connsiteX0" fmla="*/ 656 w 639946"/>
                    <a:gd name="connsiteY0" fmla="*/ 351241 h 699899"/>
                    <a:gd name="connsiteX1" fmla="*/ 99191 w 639946"/>
                    <a:gd name="connsiteY1" fmla="*/ 111262 h 699899"/>
                    <a:gd name="connsiteX2" fmla="*/ 189090 w 639946"/>
                    <a:gd name="connsiteY2" fmla="*/ 43259 h 699899"/>
                    <a:gd name="connsiteX3" fmla="*/ 314981 w 639946"/>
                    <a:gd name="connsiteY3" fmla="*/ 8340 h 699899"/>
                    <a:gd name="connsiteX4" fmla="*/ 464002 w 639946"/>
                    <a:gd name="connsiteY4" fmla="*/ 203509 h 699899"/>
                    <a:gd name="connsiteX5" fmla="*/ 629306 w 639946"/>
                    <a:gd name="connsiteY5" fmla="*/ 351241 h 699899"/>
                    <a:gd name="connsiteX6" fmla="*/ 608333 w 639946"/>
                    <a:gd name="connsiteY6" fmla="*/ 552439 h 699899"/>
                    <a:gd name="connsiteX7" fmla="*/ 435527 w 639946"/>
                    <a:gd name="connsiteY7" fmla="*/ 658426 h 699899"/>
                    <a:gd name="connsiteX8" fmla="*/ 314981 w 639946"/>
                    <a:gd name="connsiteY8" fmla="*/ 694142 h 699899"/>
                    <a:gd name="connsiteX9" fmla="*/ 142387 w 639946"/>
                    <a:gd name="connsiteY9" fmla="*/ 558407 h 699899"/>
                    <a:gd name="connsiteX10" fmla="*/ 656 w 639946"/>
                    <a:gd name="connsiteY10" fmla="*/ 351241 h 699899"/>
                    <a:gd name="connsiteX0" fmla="*/ 656 w 643588"/>
                    <a:gd name="connsiteY0" fmla="*/ 351241 h 699899"/>
                    <a:gd name="connsiteX1" fmla="*/ 99191 w 643588"/>
                    <a:gd name="connsiteY1" fmla="*/ 111262 h 699899"/>
                    <a:gd name="connsiteX2" fmla="*/ 189090 w 643588"/>
                    <a:gd name="connsiteY2" fmla="*/ 43259 h 699899"/>
                    <a:gd name="connsiteX3" fmla="*/ 314981 w 643588"/>
                    <a:gd name="connsiteY3" fmla="*/ 8340 h 699899"/>
                    <a:gd name="connsiteX4" fmla="*/ 464002 w 643588"/>
                    <a:gd name="connsiteY4" fmla="*/ 203509 h 699899"/>
                    <a:gd name="connsiteX5" fmla="*/ 629306 w 643588"/>
                    <a:gd name="connsiteY5" fmla="*/ 351241 h 699899"/>
                    <a:gd name="connsiteX6" fmla="*/ 632506 w 643588"/>
                    <a:gd name="connsiteY6" fmla="*/ 441041 h 699899"/>
                    <a:gd name="connsiteX7" fmla="*/ 608333 w 643588"/>
                    <a:gd name="connsiteY7" fmla="*/ 552439 h 699899"/>
                    <a:gd name="connsiteX8" fmla="*/ 435527 w 643588"/>
                    <a:gd name="connsiteY8" fmla="*/ 658426 h 699899"/>
                    <a:gd name="connsiteX9" fmla="*/ 314981 w 643588"/>
                    <a:gd name="connsiteY9" fmla="*/ 694142 h 699899"/>
                    <a:gd name="connsiteX10" fmla="*/ 142387 w 643588"/>
                    <a:gd name="connsiteY10" fmla="*/ 558407 h 699899"/>
                    <a:gd name="connsiteX11" fmla="*/ 656 w 643588"/>
                    <a:gd name="connsiteY11" fmla="*/ 351241 h 699899"/>
                    <a:gd name="connsiteX0" fmla="*/ 656 w 643588"/>
                    <a:gd name="connsiteY0" fmla="*/ 351241 h 698530"/>
                    <a:gd name="connsiteX1" fmla="*/ 99191 w 643588"/>
                    <a:gd name="connsiteY1" fmla="*/ 111262 h 698530"/>
                    <a:gd name="connsiteX2" fmla="*/ 189090 w 643588"/>
                    <a:gd name="connsiteY2" fmla="*/ 43259 h 698530"/>
                    <a:gd name="connsiteX3" fmla="*/ 314981 w 643588"/>
                    <a:gd name="connsiteY3" fmla="*/ 8340 h 698530"/>
                    <a:gd name="connsiteX4" fmla="*/ 464002 w 643588"/>
                    <a:gd name="connsiteY4" fmla="*/ 203509 h 698530"/>
                    <a:gd name="connsiteX5" fmla="*/ 629306 w 643588"/>
                    <a:gd name="connsiteY5" fmla="*/ 351241 h 698530"/>
                    <a:gd name="connsiteX6" fmla="*/ 632506 w 643588"/>
                    <a:gd name="connsiteY6" fmla="*/ 441041 h 698530"/>
                    <a:gd name="connsiteX7" fmla="*/ 608333 w 643588"/>
                    <a:gd name="connsiteY7" fmla="*/ 552439 h 698530"/>
                    <a:gd name="connsiteX8" fmla="*/ 542328 w 643588"/>
                    <a:gd name="connsiteY8" fmla="*/ 589587 h 698530"/>
                    <a:gd name="connsiteX9" fmla="*/ 435527 w 643588"/>
                    <a:gd name="connsiteY9" fmla="*/ 658426 h 698530"/>
                    <a:gd name="connsiteX10" fmla="*/ 314981 w 643588"/>
                    <a:gd name="connsiteY10" fmla="*/ 694142 h 698530"/>
                    <a:gd name="connsiteX11" fmla="*/ 142387 w 643588"/>
                    <a:gd name="connsiteY11" fmla="*/ 558407 h 698530"/>
                    <a:gd name="connsiteX12" fmla="*/ 656 w 643588"/>
                    <a:gd name="connsiteY12" fmla="*/ 351241 h 698530"/>
                    <a:gd name="connsiteX0" fmla="*/ 656 w 643588"/>
                    <a:gd name="connsiteY0" fmla="*/ 351241 h 698530"/>
                    <a:gd name="connsiteX1" fmla="*/ 99191 w 643588"/>
                    <a:gd name="connsiteY1" fmla="*/ 111262 h 698530"/>
                    <a:gd name="connsiteX2" fmla="*/ 189090 w 643588"/>
                    <a:gd name="connsiteY2" fmla="*/ 43259 h 698530"/>
                    <a:gd name="connsiteX3" fmla="*/ 314981 w 643588"/>
                    <a:gd name="connsiteY3" fmla="*/ 8340 h 698530"/>
                    <a:gd name="connsiteX4" fmla="*/ 464002 w 643588"/>
                    <a:gd name="connsiteY4" fmla="*/ 203509 h 698530"/>
                    <a:gd name="connsiteX5" fmla="*/ 629306 w 643588"/>
                    <a:gd name="connsiteY5" fmla="*/ 351241 h 698530"/>
                    <a:gd name="connsiteX6" fmla="*/ 632506 w 643588"/>
                    <a:gd name="connsiteY6" fmla="*/ 441041 h 698530"/>
                    <a:gd name="connsiteX7" fmla="*/ 608333 w 643588"/>
                    <a:gd name="connsiteY7" fmla="*/ 552439 h 698530"/>
                    <a:gd name="connsiteX8" fmla="*/ 548014 w 643588"/>
                    <a:gd name="connsiteY8" fmla="*/ 618976 h 698530"/>
                    <a:gd name="connsiteX9" fmla="*/ 435527 w 643588"/>
                    <a:gd name="connsiteY9" fmla="*/ 658426 h 698530"/>
                    <a:gd name="connsiteX10" fmla="*/ 314981 w 643588"/>
                    <a:gd name="connsiteY10" fmla="*/ 694142 h 698530"/>
                    <a:gd name="connsiteX11" fmla="*/ 142387 w 643588"/>
                    <a:gd name="connsiteY11" fmla="*/ 558407 h 698530"/>
                    <a:gd name="connsiteX12" fmla="*/ 656 w 643588"/>
                    <a:gd name="connsiteY12" fmla="*/ 351241 h 698530"/>
                    <a:gd name="connsiteX0" fmla="*/ 656 w 642979"/>
                    <a:gd name="connsiteY0" fmla="*/ 351241 h 698530"/>
                    <a:gd name="connsiteX1" fmla="*/ 99191 w 642979"/>
                    <a:gd name="connsiteY1" fmla="*/ 111262 h 698530"/>
                    <a:gd name="connsiteX2" fmla="*/ 189090 w 642979"/>
                    <a:gd name="connsiteY2" fmla="*/ 43259 h 698530"/>
                    <a:gd name="connsiteX3" fmla="*/ 314981 w 642979"/>
                    <a:gd name="connsiteY3" fmla="*/ 8340 h 698530"/>
                    <a:gd name="connsiteX4" fmla="*/ 464002 w 642979"/>
                    <a:gd name="connsiteY4" fmla="*/ 203509 h 698530"/>
                    <a:gd name="connsiteX5" fmla="*/ 629306 w 642979"/>
                    <a:gd name="connsiteY5" fmla="*/ 351241 h 698530"/>
                    <a:gd name="connsiteX6" fmla="*/ 632506 w 642979"/>
                    <a:gd name="connsiteY6" fmla="*/ 441041 h 698530"/>
                    <a:gd name="connsiteX7" fmla="*/ 622107 w 642979"/>
                    <a:gd name="connsiteY7" fmla="*/ 488177 h 698530"/>
                    <a:gd name="connsiteX8" fmla="*/ 608333 w 642979"/>
                    <a:gd name="connsiteY8" fmla="*/ 552439 h 698530"/>
                    <a:gd name="connsiteX9" fmla="*/ 548014 w 642979"/>
                    <a:gd name="connsiteY9" fmla="*/ 618976 h 698530"/>
                    <a:gd name="connsiteX10" fmla="*/ 435527 w 642979"/>
                    <a:gd name="connsiteY10" fmla="*/ 658426 h 698530"/>
                    <a:gd name="connsiteX11" fmla="*/ 314981 w 642979"/>
                    <a:gd name="connsiteY11" fmla="*/ 694142 h 698530"/>
                    <a:gd name="connsiteX12" fmla="*/ 142387 w 642979"/>
                    <a:gd name="connsiteY12" fmla="*/ 558407 h 698530"/>
                    <a:gd name="connsiteX13" fmla="*/ 656 w 642979"/>
                    <a:gd name="connsiteY13" fmla="*/ 351241 h 698530"/>
                    <a:gd name="connsiteX0" fmla="*/ 656 w 664488"/>
                    <a:gd name="connsiteY0" fmla="*/ 351241 h 698530"/>
                    <a:gd name="connsiteX1" fmla="*/ 99191 w 664488"/>
                    <a:gd name="connsiteY1" fmla="*/ 111262 h 698530"/>
                    <a:gd name="connsiteX2" fmla="*/ 189090 w 664488"/>
                    <a:gd name="connsiteY2" fmla="*/ 43259 h 698530"/>
                    <a:gd name="connsiteX3" fmla="*/ 314981 w 664488"/>
                    <a:gd name="connsiteY3" fmla="*/ 8340 h 698530"/>
                    <a:gd name="connsiteX4" fmla="*/ 464002 w 664488"/>
                    <a:gd name="connsiteY4" fmla="*/ 203509 h 698530"/>
                    <a:gd name="connsiteX5" fmla="*/ 629306 w 664488"/>
                    <a:gd name="connsiteY5" fmla="*/ 351241 h 698530"/>
                    <a:gd name="connsiteX6" fmla="*/ 632506 w 664488"/>
                    <a:gd name="connsiteY6" fmla="*/ 441041 h 698530"/>
                    <a:gd name="connsiteX7" fmla="*/ 664181 w 664488"/>
                    <a:gd name="connsiteY7" fmla="*/ 481868 h 698530"/>
                    <a:gd name="connsiteX8" fmla="*/ 608333 w 664488"/>
                    <a:gd name="connsiteY8" fmla="*/ 552439 h 698530"/>
                    <a:gd name="connsiteX9" fmla="*/ 548014 w 664488"/>
                    <a:gd name="connsiteY9" fmla="*/ 618976 h 698530"/>
                    <a:gd name="connsiteX10" fmla="*/ 435527 w 664488"/>
                    <a:gd name="connsiteY10" fmla="*/ 658426 h 698530"/>
                    <a:gd name="connsiteX11" fmla="*/ 314981 w 664488"/>
                    <a:gd name="connsiteY11" fmla="*/ 694142 h 698530"/>
                    <a:gd name="connsiteX12" fmla="*/ 142387 w 664488"/>
                    <a:gd name="connsiteY12" fmla="*/ 558407 h 698530"/>
                    <a:gd name="connsiteX13" fmla="*/ 656 w 664488"/>
                    <a:gd name="connsiteY13" fmla="*/ 351241 h 698530"/>
                    <a:gd name="connsiteX0" fmla="*/ 656 w 642979"/>
                    <a:gd name="connsiteY0" fmla="*/ 351241 h 698530"/>
                    <a:gd name="connsiteX1" fmla="*/ 99191 w 642979"/>
                    <a:gd name="connsiteY1" fmla="*/ 111262 h 698530"/>
                    <a:gd name="connsiteX2" fmla="*/ 189090 w 642979"/>
                    <a:gd name="connsiteY2" fmla="*/ 43259 h 698530"/>
                    <a:gd name="connsiteX3" fmla="*/ 314981 w 642979"/>
                    <a:gd name="connsiteY3" fmla="*/ 8340 h 698530"/>
                    <a:gd name="connsiteX4" fmla="*/ 464002 w 642979"/>
                    <a:gd name="connsiteY4" fmla="*/ 203509 h 698530"/>
                    <a:gd name="connsiteX5" fmla="*/ 629306 w 642979"/>
                    <a:gd name="connsiteY5" fmla="*/ 351241 h 698530"/>
                    <a:gd name="connsiteX6" fmla="*/ 632506 w 642979"/>
                    <a:gd name="connsiteY6" fmla="*/ 441041 h 698530"/>
                    <a:gd name="connsiteX7" fmla="*/ 514114 w 642979"/>
                    <a:gd name="connsiteY7" fmla="*/ 446866 h 698530"/>
                    <a:gd name="connsiteX8" fmla="*/ 608333 w 642979"/>
                    <a:gd name="connsiteY8" fmla="*/ 552439 h 698530"/>
                    <a:gd name="connsiteX9" fmla="*/ 548014 w 642979"/>
                    <a:gd name="connsiteY9" fmla="*/ 618976 h 698530"/>
                    <a:gd name="connsiteX10" fmla="*/ 435527 w 642979"/>
                    <a:gd name="connsiteY10" fmla="*/ 658426 h 698530"/>
                    <a:gd name="connsiteX11" fmla="*/ 314981 w 642979"/>
                    <a:gd name="connsiteY11" fmla="*/ 694142 h 698530"/>
                    <a:gd name="connsiteX12" fmla="*/ 142387 w 642979"/>
                    <a:gd name="connsiteY12" fmla="*/ 558407 h 698530"/>
                    <a:gd name="connsiteX13" fmla="*/ 656 w 642979"/>
                    <a:gd name="connsiteY13" fmla="*/ 351241 h 698530"/>
                    <a:gd name="connsiteX0" fmla="*/ 656 w 642979"/>
                    <a:gd name="connsiteY0" fmla="*/ 351241 h 698530"/>
                    <a:gd name="connsiteX1" fmla="*/ 99191 w 642979"/>
                    <a:gd name="connsiteY1" fmla="*/ 111262 h 698530"/>
                    <a:gd name="connsiteX2" fmla="*/ 189090 w 642979"/>
                    <a:gd name="connsiteY2" fmla="*/ 43259 h 698530"/>
                    <a:gd name="connsiteX3" fmla="*/ 314981 w 642979"/>
                    <a:gd name="connsiteY3" fmla="*/ 8340 h 698530"/>
                    <a:gd name="connsiteX4" fmla="*/ 464002 w 642979"/>
                    <a:gd name="connsiteY4" fmla="*/ 203509 h 698530"/>
                    <a:gd name="connsiteX5" fmla="*/ 629306 w 642979"/>
                    <a:gd name="connsiteY5" fmla="*/ 351241 h 698530"/>
                    <a:gd name="connsiteX6" fmla="*/ 632506 w 642979"/>
                    <a:gd name="connsiteY6" fmla="*/ 441041 h 698530"/>
                    <a:gd name="connsiteX7" fmla="*/ 514114 w 642979"/>
                    <a:gd name="connsiteY7" fmla="*/ 446866 h 698530"/>
                    <a:gd name="connsiteX8" fmla="*/ 608333 w 642979"/>
                    <a:gd name="connsiteY8" fmla="*/ 552439 h 698530"/>
                    <a:gd name="connsiteX9" fmla="*/ 429692 w 642979"/>
                    <a:gd name="connsiteY9" fmla="*/ 540027 h 698530"/>
                    <a:gd name="connsiteX10" fmla="*/ 435527 w 642979"/>
                    <a:gd name="connsiteY10" fmla="*/ 658426 h 698530"/>
                    <a:gd name="connsiteX11" fmla="*/ 314981 w 642979"/>
                    <a:gd name="connsiteY11" fmla="*/ 694142 h 698530"/>
                    <a:gd name="connsiteX12" fmla="*/ 142387 w 642979"/>
                    <a:gd name="connsiteY12" fmla="*/ 558407 h 698530"/>
                    <a:gd name="connsiteX13" fmla="*/ 656 w 642979"/>
                    <a:gd name="connsiteY13" fmla="*/ 351241 h 698530"/>
                    <a:gd name="connsiteX0" fmla="*/ 656 w 642979"/>
                    <a:gd name="connsiteY0" fmla="*/ 351241 h 698530"/>
                    <a:gd name="connsiteX1" fmla="*/ 99191 w 642979"/>
                    <a:gd name="connsiteY1" fmla="*/ 111262 h 698530"/>
                    <a:gd name="connsiteX2" fmla="*/ 189090 w 642979"/>
                    <a:gd name="connsiteY2" fmla="*/ 43259 h 698530"/>
                    <a:gd name="connsiteX3" fmla="*/ 314981 w 642979"/>
                    <a:gd name="connsiteY3" fmla="*/ 8340 h 698530"/>
                    <a:gd name="connsiteX4" fmla="*/ 464002 w 642979"/>
                    <a:gd name="connsiteY4" fmla="*/ 203509 h 698530"/>
                    <a:gd name="connsiteX5" fmla="*/ 629306 w 642979"/>
                    <a:gd name="connsiteY5" fmla="*/ 351241 h 698530"/>
                    <a:gd name="connsiteX6" fmla="*/ 632506 w 642979"/>
                    <a:gd name="connsiteY6" fmla="*/ 441041 h 698530"/>
                    <a:gd name="connsiteX7" fmla="*/ 514114 w 642979"/>
                    <a:gd name="connsiteY7" fmla="*/ 446866 h 698530"/>
                    <a:gd name="connsiteX8" fmla="*/ 608333 w 642979"/>
                    <a:gd name="connsiteY8" fmla="*/ 552439 h 698530"/>
                    <a:gd name="connsiteX9" fmla="*/ 465245 w 642979"/>
                    <a:gd name="connsiteY9" fmla="*/ 487421 h 698530"/>
                    <a:gd name="connsiteX10" fmla="*/ 429692 w 642979"/>
                    <a:gd name="connsiteY10" fmla="*/ 540027 h 698530"/>
                    <a:gd name="connsiteX11" fmla="*/ 435527 w 642979"/>
                    <a:gd name="connsiteY11" fmla="*/ 658426 h 698530"/>
                    <a:gd name="connsiteX12" fmla="*/ 314981 w 642979"/>
                    <a:gd name="connsiteY12" fmla="*/ 694142 h 698530"/>
                    <a:gd name="connsiteX13" fmla="*/ 142387 w 642979"/>
                    <a:gd name="connsiteY13" fmla="*/ 558407 h 698530"/>
                    <a:gd name="connsiteX14" fmla="*/ 656 w 642979"/>
                    <a:gd name="connsiteY14" fmla="*/ 351241 h 698530"/>
                    <a:gd name="connsiteX0" fmla="*/ 656 w 642979"/>
                    <a:gd name="connsiteY0" fmla="*/ 351241 h 694351"/>
                    <a:gd name="connsiteX1" fmla="*/ 99191 w 642979"/>
                    <a:gd name="connsiteY1" fmla="*/ 111262 h 694351"/>
                    <a:gd name="connsiteX2" fmla="*/ 189090 w 642979"/>
                    <a:gd name="connsiteY2" fmla="*/ 43259 h 694351"/>
                    <a:gd name="connsiteX3" fmla="*/ 314981 w 642979"/>
                    <a:gd name="connsiteY3" fmla="*/ 8340 h 694351"/>
                    <a:gd name="connsiteX4" fmla="*/ 464002 w 642979"/>
                    <a:gd name="connsiteY4" fmla="*/ 203509 h 694351"/>
                    <a:gd name="connsiteX5" fmla="*/ 629306 w 642979"/>
                    <a:gd name="connsiteY5" fmla="*/ 351241 h 694351"/>
                    <a:gd name="connsiteX6" fmla="*/ 632506 w 642979"/>
                    <a:gd name="connsiteY6" fmla="*/ 441041 h 694351"/>
                    <a:gd name="connsiteX7" fmla="*/ 514114 w 642979"/>
                    <a:gd name="connsiteY7" fmla="*/ 446866 h 694351"/>
                    <a:gd name="connsiteX8" fmla="*/ 608333 w 642979"/>
                    <a:gd name="connsiteY8" fmla="*/ 552439 h 694351"/>
                    <a:gd name="connsiteX9" fmla="*/ 465245 w 642979"/>
                    <a:gd name="connsiteY9" fmla="*/ 487421 h 694351"/>
                    <a:gd name="connsiteX10" fmla="*/ 429692 w 642979"/>
                    <a:gd name="connsiteY10" fmla="*/ 540027 h 694351"/>
                    <a:gd name="connsiteX11" fmla="*/ 372795 w 642979"/>
                    <a:gd name="connsiteY11" fmla="*/ 589459 h 694351"/>
                    <a:gd name="connsiteX12" fmla="*/ 314981 w 642979"/>
                    <a:gd name="connsiteY12" fmla="*/ 694142 h 694351"/>
                    <a:gd name="connsiteX13" fmla="*/ 142387 w 642979"/>
                    <a:gd name="connsiteY13" fmla="*/ 558407 h 694351"/>
                    <a:gd name="connsiteX14" fmla="*/ 656 w 642979"/>
                    <a:gd name="connsiteY14" fmla="*/ 351241 h 694351"/>
                    <a:gd name="connsiteX0" fmla="*/ 656 w 642979"/>
                    <a:gd name="connsiteY0" fmla="*/ 351241 h 596438"/>
                    <a:gd name="connsiteX1" fmla="*/ 99191 w 642979"/>
                    <a:gd name="connsiteY1" fmla="*/ 111262 h 596438"/>
                    <a:gd name="connsiteX2" fmla="*/ 189090 w 642979"/>
                    <a:gd name="connsiteY2" fmla="*/ 43259 h 596438"/>
                    <a:gd name="connsiteX3" fmla="*/ 314981 w 642979"/>
                    <a:gd name="connsiteY3" fmla="*/ 8340 h 596438"/>
                    <a:gd name="connsiteX4" fmla="*/ 464002 w 642979"/>
                    <a:gd name="connsiteY4" fmla="*/ 203509 h 596438"/>
                    <a:gd name="connsiteX5" fmla="*/ 629306 w 642979"/>
                    <a:gd name="connsiteY5" fmla="*/ 351241 h 596438"/>
                    <a:gd name="connsiteX6" fmla="*/ 632506 w 642979"/>
                    <a:gd name="connsiteY6" fmla="*/ 441041 h 596438"/>
                    <a:gd name="connsiteX7" fmla="*/ 514114 w 642979"/>
                    <a:gd name="connsiteY7" fmla="*/ 446866 h 596438"/>
                    <a:gd name="connsiteX8" fmla="*/ 608333 w 642979"/>
                    <a:gd name="connsiteY8" fmla="*/ 552439 h 596438"/>
                    <a:gd name="connsiteX9" fmla="*/ 465245 w 642979"/>
                    <a:gd name="connsiteY9" fmla="*/ 487421 h 596438"/>
                    <a:gd name="connsiteX10" fmla="*/ 429692 w 642979"/>
                    <a:gd name="connsiteY10" fmla="*/ 540027 h 596438"/>
                    <a:gd name="connsiteX11" fmla="*/ 372795 w 642979"/>
                    <a:gd name="connsiteY11" fmla="*/ 589459 h 596438"/>
                    <a:gd name="connsiteX12" fmla="*/ 275539 w 642979"/>
                    <a:gd name="connsiteY12" fmla="*/ 581644 h 596438"/>
                    <a:gd name="connsiteX13" fmla="*/ 142387 w 642979"/>
                    <a:gd name="connsiteY13" fmla="*/ 558407 h 596438"/>
                    <a:gd name="connsiteX14" fmla="*/ 656 w 642979"/>
                    <a:gd name="connsiteY14" fmla="*/ 351241 h 596438"/>
                    <a:gd name="connsiteX0" fmla="*/ 7365 w 582037"/>
                    <a:gd name="connsiteY0" fmla="*/ 347911 h 596438"/>
                    <a:gd name="connsiteX1" fmla="*/ 38249 w 582037"/>
                    <a:gd name="connsiteY1" fmla="*/ 111262 h 596438"/>
                    <a:gd name="connsiteX2" fmla="*/ 128148 w 582037"/>
                    <a:gd name="connsiteY2" fmla="*/ 43259 h 596438"/>
                    <a:gd name="connsiteX3" fmla="*/ 254039 w 582037"/>
                    <a:gd name="connsiteY3" fmla="*/ 8340 h 596438"/>
                    <a:gd name="connsiteX4" fmla="*/ 403060 w 582037"/>
                    <a:gd name="connsiteY4" fmla="*/ 203509 h 596438"/>
                    <a:gd name="connsiteX5" fmla="*/ 568364 w 582037"/>
                    <a:gd name="connsiteY5" fmla="*/ 351241 h 596438"/>
                    <a:gd name="connsiteX6" fmla="*/ 571564 w 582037"/>
                    <a:gd name="connsiteY6" fmla="*/ 441041 h 596438"/>
                    <a:gd name="connsiteX7" fmla="*/ 453172 w 582037"/>
                    <a:gd name="connsiteY7" fmla="*/ 446866 h 596438"/>
                    <a:gd name="connsiteX8" fmla="*/ 547391 w 582037"/>
                    <a:gd name="connsiteY8" fmla="*/ 552439 h 596438"/>
                    <a:gd name="connsiteX9" fmla="*/ 404303 w 582037"/>
                    <a:gd name="connsiteY9" fmla="*/ 487421 h 596438"/>
                    <a:gd name="connsiteX10" fmla="*/ 368750 w 582037"/>
                    <a:gd name="connsiteY10" fmla="*/ 540027 h 596438"/>
                    <a:gd name="connsiteX11" fmla="*/ 311853 w 582037"/>
                    <a:gd name="connsiteY11" fmla="*/ 589459 h 596438"/>
                    <a:gd name="connsiteX12" fmla="*/ 214597 w 582037"/>
                    <a:gd name="connsiteY12" fmla="*/ 581644 h 596438"/>
                    <a:gd name="connsiteX13" fmla="*/ 81445 w 582037"/>
                    <a:gd name="connsiteY13" fmla="*/ 558407 h 596438"/>
                    <a:gd name="connsiteX14" fmla="*/ 7365 w 582037"/>
                    <a:gd name="connsiteY14" fmla="*/ 347911 h 596438"/>
                    <a:gd name="connsiteX0" fmla="*/ 531 w 575203"/>
                    <a:gd name="connsiteY0" fmla="*/ 347911 h 596438"/>
                    <a:gd name="connsiteX1" fmla="*/ 57409 w 575203"/>
                    <a:gd name="connsiteY1" fmla="*/ 122698 h 596438"/>
                    <a:gd name="connsiteX2" fmla="*/ 121314 w 575203"/>
                    <a:gd name="connsiteY2" fmla="*/ 43259 h 596438"/>
                    <a:gd name="connsiteX3" fmla="*/ 247205 w 575203"/>
                    <a:gd name="connsiteY3" fmla="*/ 8340 h 596438"/>
                    <a:gd name="connsiteX4" fmla="*/ 396226 w 575203"/>
                    <a:gd name="connsiteY4" fmla="*/ 203509 h 596438"/>
                    <a:gd name="connsiteX5" fmla="*/ 561530 w 575203"/>
                    <a:gd name="connsiteY5" fmla="*/ 351241 h 596438"/>
                    <a:gd name="connsiteX6" fmla="*/ 564730 w 575203"/>
                    <a:gd name="connsiteY6" fmla="*/ 441041 h 596438"/>
                    <a:gd name="connsiteX7" fmla="*/ 446338 w 575203"/>
                    <a:gd name="connsiteY7" fmla="*/ 446866 h 596438"/>
                    <a:gd name="connsiteX8" fmla="*/ 540557 w 575203"/>
                    <a:gd name="connsiteY8" fmla="*/ 552439 h 596438"/>
                    <a:gd name="connsiteX9" fmla="*/ 397469 w 575203"/>
                    <a:gd name="connsiteY9" fmla="*/ 487421 h 596438"/>
                    <a:gd name="connsiteX10" fmla="*/ 361916 w 575203"/>
                    <a:gd name="connsiteY10" fmla="*/ 540027 h 596438"/>
                    <a:gd name="connsiteX11" fmla="*/ 305019 w 575203"/>
                    <a:gd name="connsiteY11" fmla="*/ 589459 h 596438"/>
                    <a:gd name="connsiteX12" fmla="*/ 207763 w 575203"/>
                    <a:gd name="connsiteY12" fmla="*/ 581644 h 596438"/>
                    <a:gd name="connsiteX13" fmla="*/ 74611 w 575203"/>
                    <a:gd name="connsiteY13" fmla="*/ 558407 h 596438"/>
                    <a:gd name="connsiteX14" fmla="*/ 531 w 575203"/>
                    <a:gd name="connsiteY14" fmla="*/ 347911 h 596438"/>
                    <a:gd name="connsiteX0" fmla="*/ 531 w 575203"/>
                    <a:gd name="connsiteY0" fmla="*/ 314228 h 562755"/>
                    <a:gd name="connsiteX1" fmla="*/ 57409 w 575203"/>
                    <a:gd name="connsiteY1" fmla="*/ 89015 h 562755"/>
                    <a:gd name="connsiteX2" fmla="*/ 121314 w 575203"/>
                    <a:gd name="connsiteY2" fmla="*/ 9576 h 562755"/>
                    <a:gd name="connsiteX3" fmla="*/ 249702 w 575203"/>
                    <a:gd name="connsiteY3" fmla="*/ 25395 h 562755"/>
                    <a:gd name="connsiteX4" fmla="*/ 396226 w 575203"/>
                    <a:gd name="connsiteY4" fmla="*/ 169826 h 562755"/>
                    <a:gd name="connsiteX5" fmla="*/ 561530 w 575203"/>
                    <a:gd name="connsiteY5" fmla="*/ 317558 h 562755"/>
                    <a:gd name="connsiteX6" fmla="*/ 564730 w 575203"/>
                    <a:gd name="connsiteY6" fmla="*/ 407358 h 562755"/>
                    <a:gd name="connsiteX7" fmla="*/ 446338 w 575203"/>
                    <a:gd name="connsiteY7" fmla="*/ 413183 h 562755"/>
                    <a:gd name="connsiteX8" fmla="*/ 540557 w 575203"/>
                    <a:gd name="connsiteY8" fmla="*/ 518756 h 562755"/>
                    <a:gd name="connsiteX9" fmla="*/ 397469 w 575203"/>
                    <a:gd name="connsiteY9" fmla="*/ 453738 h 562755"/>
                    <a:gd name="connsiteX10" fmla="*/ 361916 w 575203"/>
                    <a:gd name="connsiteY10" fmla="*/ 506344 h 562755"/>
                    <a:gd name="connsiteX11" fmla="*/ 305019 w 575203"/>
                    <a:gd name="connsiteY11" fmla="*/ 555776 h 562755"/>
                    <a:gd name="connsiteX12" fmla="*/ 207763 w 575203"/>
                    <a:gd name="connsiteY12" fmla="*/ 547961 h 562755"/>
                    <a:gd name="connsiteX13" fmla="*/ 74611 w 575203"/>
                    <a:gd name="connsiteY13" fmla="*/ 524724 h 562755"/>
                    <a:gd name="connsiteX14" fmla="*/ 531 w 575203"/>
                    <a:gd name="connsiteY14" fmla="*/ 314228 h 562755"/>
                    <a:gd name="connsiteX0" fmla="*/ 531 w 575203"/>
                    <a:gd name="connsiteY0" fmla="*/ 312695 h 561222"/>
                    <a:gd name="connsiteX1" fmla="*/ 57409 w 575203"/>
                    <a:gd name="connsiteY1" fmla="*/ 87482 h 561222"/>
                    <a:gd name="connsiteX2" fmla="*/ 121314 w 575203"/>
                    <a:gd name="connsiteY2" fmla="*/ 8043 h 561222"/>
                    <a:gd name="connsiteX3" fmla="*/ 249702 w 575203"/>
                    <a:gd name="connsiteY3" fmla="*/ 23862 h 561222"/>
                    <a:gd name="connsiteX4" fmla="*/ 398584 w 575203"/>
                    <a:gd name="connsiteY4" fmla="*/ 130031 h 561222"/>
                    <a:gd name="connsiteX5" fmla="*/ 561530 w 575203"/>
                    <a:gd name="connsiteY5" fmla="*/ 316025 h 561222"/>
                    <a:gd name="connsiteX6" fmla="*/ 564730 w 575203"/>
                    <a:gd name="connsiteY6" fmla="*/ 405825 h 561222"/>
                    <a:gd name="connsiteX7" fmla="*/ 446338 w 575203"/>
                    <a:gd name="connsiteY7" fmla="*/ 411650 h 561222"/>
                    <a:gd name="connsiteX8" fmla="*/ 540557 w 575203"/>
                    <a:gd name="connsiteY8" fmla="*/ 517223 h 561222"/>
                    <a:gd name="connsiteX9" fmla="*/ 397469 w 575203"/>
                    <a:gd name="connsiteY9" fmla="*/ 452205 h 561222"/>
                    <a:gd name="connsiteX10" fmla="*/ 361916 w 575203"/>
                    <a:gd name="connsiteY10" fmla="*/ 504811 h 561222"/>
                    <a:gd name="connsiteX11" fmla="*/ 305019 w 575203"/>
                    <a:gd name="connsiteY11" fmla="*/ 554243 h 561222"/>
                    <a:gd name="connsiteX12" fmla="*/ 207763 w 575203"/>
                    <a:gd name="connsiteY12" fmla="*/ 546428 h 561222"/>
                    <a:gd name="connsiteX13" fmla="*/ 74611 w 575203"/>
                    <a:gd name="connsiteY13" fmla="*/ 523191 h 561222"/>
                    <a:gd name="connsiteX14" fmla="*/ 531 w 575203"/>
                    <a:gd name="connsiteY14" fmla="*/ 312695 h 56122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</a:cxnLst>
                  <a:rect l="l" t="t" r="r" b="b"/>
                  <a:pathLst>
                    <a:path w="575203" h="561222">
                      <a:moveTo>
                        <a:pt x="531" y="312695"/>
                      </a:moveTo>
                      <a:cubicBezTo>
                        <a:pt x="-2336" y="240077"/>
                        <a:pt x="5022" y="144632"/>
                        <a:pt x="57409" y="87482"/>
                      </a:cubicBezTo>
                      <a:cubicBezTo>
                        <a:pt x="88815" y="36152"/>
                        <a:pt x="85349" y="25197"/>
                        <a:pt x="121314" y="8043"/>
                      </a:cubicBezTo>
                      <a:cubicBezTo>
                        <a:pt x="157279" y="-9111"/>
                        <a:pt x="203490" y="3531"/>
                        <a:pt x="249702" y="23862"/>
                      </a:cubicBezTo>
                      <a:cubicBezTo>
                        <a:pt x="295914" y="44193"/>
                        <a:pt x="346197" y="72881"/>
                        <a:pt x="398584" y="130031"/>
                      </a:cubicBezTo>
                      <a:cubicBezTo>
                        <a:pt x="450971" y="187181"/>
                        <a:pt x="533446" y="276436"/>
                        <a:pt x="561530" y="316025"/>
                      </a:cubicBezTo>
                      <a:cubicBezTo>
                        <a:pt x="589614" y="355614"/>
                        <a:pt x="565930" y="383002"/>
                        <a:pt x="564730" y="405825"/>
                      </a:cubicBezTo>
                      <a:cubicBezTo>
                        <a:pt x="563530" y="428648"/>
                        <a:pt x="450367" y="393084"/>
                        <a:pt x="446338" y="411650"/>
                      </a:cubicBezTo>
                      <a:cubicBezTo>
                        <a:pt x="442309" y="430216"/>
                        <a:pt x="529860" y="500795"/>
                        <a:pt x="540557" y="517223"/>
                      </a:cubicBezTo>
                      <a:cubicBezTo>
                        <a:pt x="551254" y="533651"/>
                        <a:pt x="427242" y="454274"/>
                        <a:pt x="397469" y="452205"/>
                      </a:cubicBezTo>
                      <a:cubicBezTo>
                        <a:pt x="367696" y="450136"/>
                        <a:pt x="385711" y="485979"/>
                        <a:pt x="361916" y="504811"/>
                      </a:cubicBezTo>
                      <a:cubicBezTo>
                        <a:pt x="338121" y="523643"/>
                        <a:pt x="342910" y="536817"/>
                        <a:pt x="305019" y="554243"/>
                      </a:cubicBezTo>
                      <a:cubicBezTo>
                        <a:pt x="267128" y="571669"/>
                        <a:pt x="246164" y="551603"/>
                        <a:pt x="207763" y="546428"/>
                      </a:cubicBezTo>
                      <a:cubicBezTo>
                        <a:pt x="169362" y="541253"/>
                        <a:pt x="126998" y="580341"/>
                        <a:pt x="74611" y="523191"/>
                      </a:cubicBezTo>
                      <a:cubicBezTo>
                        <a:pt x="22224" y="466041"/>
                        <a:pt x="3398" y="385313"/>
                        <a:pt x="531" y="312695"/>
                      </a:cubicBezTo>
                      <a:close/>
                    </a:path>
                  </a:pathLst>
                </a:cu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b="1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0" name="Rectangle 9"/>
                <p:cNvSpPr/>
                <p:nvPr/>
              </p:nvSpPr>
              <p:spPr>
                <a:xfrm>
                  <a:off x="0" y="65349"/>
                  <a:ext cx="719941" cy="37555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IN" kern="1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TFAM</a:t>
                  </a:r>
                  <a:endParaRPr lang="en-IN" kern="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3" name="Group 2"/>
              <p:cNvGrpSpPr/>
              <p:nvPr/>
            </p:nvGrpSpPr>
            <p:grpSpPr>
              <a:xfrm>
                <a:off x="7824666" y="-4287245"/>
                <a:ext cx="1195227" cy="576054"/>
                <a:chOff x="160186" y="-1398680"/>
                <a:chExt cx="1195227" cy="576054"/>
              </a:xfrm>
            </p:grpSpPr>
            <p:sp>
              <p:nvSpPr>
                <p:cNvPr id="101" name="Oval 455"/>
                <p:cNvSpPr/>
                <p:nvPr/>
              </p:nvSpPr>
              <p:spPr bwMode="auto">
                <a:xfrm rot="21228834">
                  <a:off x="160186" y="-1398680"/>
                  <a:ext cx="1195227" cy="513150"/>
                </a:xfrm>
                <a:custGeom>
                  <a:avLst/>
                  <a:gdLst>
                    <a:gd name="connsiteX0" fmla="*/ 0 w 196850"/>
                    <a:gd name="connsiteY0" fmla="*/ 100013 h 200025"/>
                    <a:gd name="connsiteX1" fmla="*/ 98425 w 196850"/>
                    <a:gd name="connsiteY1" fmla="*/ 0 h 200025"/>
                    <a:gd name="connsiteX2" fmla="*/ 196850 w 196850"/>
                    <a:gd name="connsiteY2" fmla="*/ 100013 h 200025"/>
                    <a:gd name="connsiteX3" fmla="*/ 98425 w 196850"/>
                    <a:gd name="connsiteY3" fmla="*/ 200026 h 200025"/>
                    <a:gd name="connsiteX4" fmla="*/ 0 w 196850"/>
                    <a:gd name="connsiteY4" fmla="*/ 100013 h 200025"/>
                    <a:gd name="connsiteX0" fmla="*/ 0 w 200436"/>
                    <a:gd name="connsiteY0" fmla="*/ 102821 h 202834"/>
                    <a:gd name="connsiteX1" fmla="*/ 98425 w 200436"/>
                    <a:gd name="connsiteY1" fmla="*/ 2808 h 202834"/>
                    <a:gd name="connsiteX2" fmla="*/ 171316 w 200436"/>
                    <a:gd name="connsiteY2" fmla="*/ 34173 h 202834"/>
                    <a:gd name="connsiteX3" fmla="*/ 196850 w 200436"/>
                    <a:gd name="connsiteY3" fmla="*/ 102821 h 202834"/>
                    <a:gd name="connsiteX4" fmla="*/ 98425 w 200436"/>
                    <a:gd name="connsiteY4" fmla="*/ 202834 h 202834"/>
                    <a:gd name="connsiteX5" fmla="*/ 0 w 200436"/>
                    <a:gd name="connsiteY5" fmla="*/ 102821 h 202834"/>
                    <a:gd name="connsiteX0" fmla="*/ 0 w 198381"/>
                    <a:gd name="connsiteY0" fmla="*/ 100336 h 200349"/>
                    <a:gd name="connsiteX1" fmla="*/ 98425 w 198381"/>
                    <a:gd name="connsiteY1" fmla="*/ 323 h 200349"/>
                    <a:gd name="connsiteX2" fmla="*/ 128966 w 198381"/>
                    <a:gd name="connsiteY2" fmla="*/ 69534 h 200349"/>
                    <a:gd name="connsiteX3" fmla="*/ 196850 w 198381"/>
                    <a:gd name="connsiteY3" fmla="*/ 100336 h 200349"/>
                    <a:gd name="connsiteX4" fmla="*/ 98425 w 198381"/>
                    <a:gd name="connsiteY4" fmla="*/ 200349 h 200349"/>
                    <a:gd name="connsiteX5" fmla="*/ 0 w 198381"/>
                    <a:gd name="connsiteY5" fmla="*/ 100336 h 200349"/>
                    <a:gd name="connsiteX0" fmla="*/ 55 w 198436"/>
                    <a:gd name="connsiteY0" fmla="*/ 100336 h 163586"/>
                    <a:gd name="connsiteX1" fmla="*/ 98480 w 198436"/>
                    <a:gd name="connsiteY1" fmla="*/ 323 h 163586"/>
                    <a:gd name="connsiteX2" fmla="*/ 129021 w 198436"/>
                    <a:gd name="connsiteY2" fmla="*/ 69534 h 163586"/>
                    <a:gd name="connsiteX3" fmla="*/ 196905 w 198436"/>
                    <a:gd name="connsiteY3" fmla="*/ 100336 h 163586"/>
                    <a:gd name="connsiteX4" fmla="*/ 88478 w 198436"/>
                    <a:gd name="connsiteY4" fmla="*/ 163586 h 163586"/>
                    <a:gd name="connsiteX5" fmla="*/ 55 w 198436"/>
                    <a:gd name="connsiteY5" fmla="*/ 100336 h 16358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98436" h="163586">
                      <a:moveTo>
                        <a:pt x="55" y="100336"/>
                      </a:moveTo>
                      <a:cubicBezTo>
                        <a:pt x="1722" y="73125"/>
                        <a:pt x="76986" y="5457"/>
                        <a:pt x="98480" y="323"/>
                      </a:cubicBezTo>
                      <a:cubicBezTo>
                        <a:pt x="119974" y="-4811"/>
                        <a:pt x="112617" y="52865"/>
                        <a:pt x="129021" y="69534"/>
                      </a:cubicBezTo>
                      <a:cubicBezTo>
                        <a:pt x="145425" y="86203"/>
                        <a:pt x="209053" y="72226"/>
                        <a:pt x="196905" y="100336"/>
                      </a:cubicBezTo>
                      <a:cubicBezTo>
                        <a:pt x="184757" y="128446"/>
                        <a:pt x="142837" y="163586"/>
                        <a:pt x="88478" y="163586"/>
                      </a:cubicBezTo>
                      <a:cubicBezTo>
                        <a:pt x="34119" y="163586"/>
                        <a:pt x="-1612" y="127547"/>
                        <a:pt x="55" y="100336"/>
                      </a:cubicBezTo>
                      <a:close/>
                    </a:path>
                  </a:pathLst>
                </a:custGeom>
                <a:solidFill>
                  <a:schemeClr val="accent5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IN" b="1"/>
                </a:p>
              </p:txBody>
            </p:sp>
            <p:sp>
              <p:nvSpPr>
                <p:cNvPr id="17" name="Rectangle 16"/>
                <p:cNvSpPr/>
                <p:nvPr/>
              </p:nvSpPr>
              <p:spPr>
                <a:xfrm>
                  <a:off x="250931" y="-1211322"/>
                  <a:ext cx="853119" cy="38869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IN" b="1" kern="100" dirty="0">
                      <a:solidFill>
                        <a:schemeClr val="bg1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TFB2M</a:t>
                  </a:r>
                  <a:endParaRPr lang="en-IN" b="1" kern="100" dirty="0">
                    <a:solidFill>
                      <a:schemeClr val="bg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04" name="Group 103"/>
              <p:cNvGrpSpPr/>
              <p:nvPr/>
            </p:nvGrpSpPr>
            <p:grpSpPr>
              <a:xfrm>
                <a:off x="7986734" y="-3832977"/>
                <a:ext cx="915635" cy="344069"/>
                <a:chOff x="184163" y="-1595093"/>
                <a:chExt cx="915635" cy="344069"/>
              </a:xfrm>
            </p:grpSpPr>
            <p:sp>
              <p:nvSpPr>
                <p:cNvPr id="102" name="Oval 101"/>
                <p:cNvSpPr/>
                <p:nvPr/>
              </p:nvSpPr>
              <p:spPr bwMode="auto">
                <a:xfrm rot="15850943">
                  <a:off x="499210" y="-1832220"/>
                  <a:ext cx="285542" cy="843862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IN" b="1"/>
                </a:p>
              </p:txBody>
            </p:sp>
            <p:sp>
              <p:nvSpPr>
                <p:cNvPr id="103" name="Rectangle 102"/>
                <p:cNvSpPr/>
                <p:nvPr/>
              </p:nvSpPr>
              <p:spPr>
                <a:xfrm>
                  <a:off x="184163" y="-1595093"/>
                  <a:ext cx="915635" cy="34406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IN" sz="1600" b="1" kern="100" dirty="0">
                      <a:solidFill>
                        <a:schemeClr val="bg1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POLRMT</a:t>
                  </a:r>
                  <a:endParaRPr lang="en-IN" sz="1600" b="1" kern="100" dirty="0">
                    <a:solidFill>
                      <a:schemeClr val="bg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11" name="Group 110"/>
            <p:cNvGrpSpPr/>
            <p:nvPr/>
          </p:nvGrpSpPr>
          <p:grpSpPr>
            <a:xfrm rot="549081">
              <a:off x="3259200" y="2890287"/>
              <a:ext cx="351766" cy="498992"/>
              <a:chOff x="1103823" y="-2381835"/>
              <a:chExt cx="351766" cy="498992"/>
            </a:xfrm>
          </p:grpSpPr>
          <p:sp>
            <p:nvSpPr>
              <p:cNvPr id="109" name="Flowchart: Extract 108"/>
              <p:cNvSpPr/>
              <p:nvPr/>
            </p:nvSpPr>
            <p:spPr>
              <a:xfrm>
                <a:off x="1103823" y="-2381835"/>
                <a:ext cx="351766" cy="453032"/>
              </a:xfrm>
              <a:prstGeom prst="flowChartExtra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20" name="Rectangle 19"/>
              <p:cNvSpPr/>
              <p:nvPr/>
            </p:nvSpPr>
            <p:spPr>
              <a:xfrm>
                <a:off x="1123964" y="-2258395"/>
                <a:ext cx="300082" cy="37555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N" kern="1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II</a:t>
                </a:r>
                <a:endParaRPr lang="en-IN" kern="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1" name="Group 120"/>
            <p:cNvGrpSpPr/>
            <p:nvPr/>
          </p:nvGrpSpPr>
          <p:grpSpPr>
            <a:xfrm>
              <a:off x="7046402" y="2775075"/>
              <a:ext cx="719941" cy="575201"/>
              <a:chOff x="0" y="-133229"/>
              <a:chExt cx="719941" cy="575201"/>
            </a:xfrm>
          </p:grpSpPr>
          <p:sp>
            <p:nvSpPr>
              <p:cNvPr id="128" name="Oval 454"/>
              <p:cNvSpPr/>
              <p:nvPr/>
            </p:nvSpPr>
            <p:spPr bwMode="auto">
              <a:xfrm rot="16369013">
                <a:off x="101966" y="-126240"/>
                <a:ext cx="575201" cy="561223"/>
              </a:xfrm>
              <a:custGeom>
                <a:avLst/>
                <a:gdLst>
                  <a:gd name="connsiteX0" fmla="*/ 0 w 628650"/>
                  <a:gd name="connsiteY0" fmla="*/ 342901 h 685801"/>
                  <a:gd name="connsiteX1" fmla="*/ 314325 w 628650"/>
                  <a:gd name="connsiteY1" fmla="*/ 0 h 685801"/>
                  <a:gd name="connsiteX2" fmla="*/ 628650 w 628650"/>
                  <a:gd name="connsiteY2" fmla="*/ 342901 h 685801"/>
                  <a:gd name="connsiteX3" fmla="*/ 314325 w 628650"/>
                  <a:gd name="connsiteY3" fmla="*/ 685802 h 685801"/>
                  <a:gd name="connsiteX4" fmla="*/ 0 w 628650"/>
                  <a:gd name="connsiteY4" fmla="*/ 342901 h 685801"/>
                  <a:gd name="connsiteX0" fmla="*/ 0 w 650253"/>
                  <a:gd name="connsiteY0" fmla="*/ 342901 h 688891"/>
                  <a:gd name="connsiteX1" fmla="*/ 314325 w 650253"/>
                  <a:gd name="connsiteY1" fmla="*/ 0 h 688891"/>
                  <a:gd name="connsiteX2" fmla="*/ 628650 w 650253"/>
                  <a:gd name="connsiteY2" fmla="*/ 342901 h 688891"/>
                  <a:gd name="connsiteX3" fmla="*/ 588683 w 650253"/>
                  <a:gd name="connsiteY3" fmla="*/ 502649 h 688891"/>
                  <a:gd name="connsiteX4" fmla="*/ 314325 w 650253"/>
                  <a:gd name="connsiteY4" fmla="*/ 685802 h 688891"/>
                  <a:gd name="connsiteX5" fmla="*/ 0 w 650253"/>
                  <a:gd name="connsiteY5" fmla="*/ 342901 h 688891"/>
                  <a:gd name="connsiteX0" fmla="*/ 0 w 646386"/>
                  <a:gd name="connsiteY0" fmla="*/ 342901 h 706454"/>
                  <a:gd name="connsiteX1" fmla="*/ 314325 w 646386"/>
                  <a:gd name="connsiteY1" fmla="*/ 0 h 706454"/>
                  <a:gd name="connsiteX2" fmla="*/ 628650 w 646386"/>
                  <a:gd name="connsiteY2" fmla="*/ 342901 h 706454"/>
                  <a:gd name="connsiteX3" fmla="*/ 588683 w 646386"/>
                  <a:gd name="connsiteY3" fmla="*/ 502649 h 706454"/>
                  <a:gd name="connsiteX4" fmla="*/ 434871 w 646386"/>
                  <a:gd name="connsiteY4" fmla="*/ 650086 h 706454"/>
                  <a:gd name="connsiteX5" fmla="*/ 314325 w 646386"/>
                  <a:gd name="connsiteY5" fmla="*/ 685802 h 706454"/>
                  <a:gd name="connsiteX6" fmla="*/ 0 w 646386"/>
                  <a:gd name="connsiteY6" fmla="*/ 342901 h 706454"/>
                  <a:gd name="connsiteX0" fmla="*/ 4180 w 650566"/>
                  <a:gd name="connsiteY0" fmla="*/ 342901 h 686680"/>
                  <a:gd name="connsiteX1" fmla="*/ 318505 w 650566"/>
                  <a:gd name="connsiteY1" fmla="*/ 0 h 686680"/>
                  <a:gd name="connsiteX2" fmla="*/ 632830 w 650566"/>
                  <a:gd name="connsiteY2" fmla="*/ 342901 h 686680"/>
                  <a:gd name="connsiteX3" fmla="*/ 592863 w 650566"/>
                  <a:gd name="connsiteY3" fmla="*/ 502649 h 686680"/>
                  <a:gd name="connsiteX4" fmla="*/ 439051 w 650566"/>
                  <a:gd name="connsiteY4" fmla="*/ 650086 h 686680"/>
                  <a:gd name="connsiteX5" fmla="*/ 318505 w 650566"/>
                  <a:gd name="connsiteY5" fmla="*/ 685802 h 686680"/>
                  <a:gd name="connsiteX6" fmla="*/ 149656 w 650566"/>
                  <a:gd name="connsiteY6" fmla="*/ 626177 h 686680"/>
                  <a:gd name="connsiteX7" fmla="*/ 4180 w 650566"/>
                  <a:gd name="connsiteY7" fmla="*/ 342901 h 686680"/>
                  <a:gd name="connsiteX0" fmla="*/ 4180 w 650566"/>
                  <a:gd name="connsiteY0" fmla="*/ 353175 h 696954"/>
                  <a:gd name="connsiteX1" fmla="*/ 102715 w 650566"/>
                  <a:gd name="connsiteY1" fmla="*/ 113196 h 696954"/>
                  <a:gd name="connsiteX2" fmla="*/ 318505 w 650566"/>
                  <a:gd name="connsiteY2" fmla="*/ 10274 h 696954"/>
                  <a:gd name="connsiteX3" fmla="*/ 632830 w 650566"/>
                  <a:gd name="connsiteY3" fmla="*/ 353175 h 696954"/>
                  <a:gd name="connsiteX4" fmla="*/ 592863 w 650566"/>
                  <a:gd name="connsiteY4" fmla="*/ 512923 h 696954"/>
                  <a:gd name="connsiteX5" fmla="*/ 439051 w 650566"/>
                  <a:gd name="connsiteY5" fmla="*/ 660360 h 696954"/>
                  <a:gd name="connsiteX6" fmla="*/ 318505 w 650566"/>
                  <a:gd name="connsiteY6" fmla="*/ 696076 h 696954"/>
                  <a:gd name="connsiteX7" fmla="*/ 149656 w 650566"/>
                  <a:gd name="connsiteY7" fmla="*/ 636451 h 696954"/>
                  <a:gd name="connsiteX8" fmla="*/ 4180 w 650566"/>
                  <a:gd name="connsiteY8" fmla="*/ 353175 h 696954"/>
                  <a:gd name="connsiteX0" fmla="*/ 4180 w 639547"/>
                  <a:gd name="connsiteY0" fmla="*/ 343504 h 687283"/>
                  <a:gd name="connsiteX1" fmla="*/ 102715 w 639547"/>
                  <a:gd name="connsiteY1" fmla="*/ 103525 h 687283"/>
                  <a:gd name="connsiteX2" fmla="*/ 318505 w 639547"/>
                  <a:gd name="connsiteY2" fmla="*/ 603 h 687283"/>
                  <a:gd name="connsiteX3" fmla="*/ 473484 w 639547"/>
                  <a:gd name="connsiteY3" fmla="*/ 144619 h 687283"/>
                  <a:gd name="connsiteX4" fmla="*/ 632830 w 639547"/>
                  <a:gd name="connsiteY4" fmla="*/ 343504 h 687283"/>
                  <a:gd name="connsiteX5" fmla="*/ 592863 w 639547"/>
                  <a:gd name="connsiteY5" fmla="*/ 503252 h 687283"/>
                  <a:gd name="connsiteX6" fmla="*/ 439051 w 639547"/>
                  <a:gd name="connsiteY6" fmla="*/ 650689 h 687283"/>
                  <a:gd name="connsiteX7" fmla="*/ 318505 w 639547"/>
                  <a:gd name="connsiteY7" fmla="*/ 686405 h 687283"/>
                  <a:gd name="connsiteX8" fmla="*/ 149656 w 639547"/>
                  <a:gd name="connsiteY8" fmla="*/ 626780 h 687283"/>
                  <a:gd name="connsiteX9" fmla="*/ 4180 w 639547"/>
                  <a:gd name="connsiteY9" fmla="*/ 343504 h 687283"/>
                  <a:gd name="connsiteX0" fmla="*/ 4180 w 639547"/>
                  <a:gd name="connsiteY0" fmla="*/ 347904 h 691683"/>
                  <a:gd name="connsiteX1" fmla="*/ 102715 w 639547"/>
                  <a:gd name="connsiteY1" fmla="*/ 107925 h 691683"/>
                  <a:gd name="connsiteX2" fmla="*/ 192614 w 639547"/>
                  <a:gd name="connsiteY2" fmla="*/ 39922 h 691683"/>
                  <a:gd name="connsiteX3" fmla="*/ 318505 w 639547"/>
                  <a:gd name="connsiteY3" fmla="*/ 5003 h 691683"/>
                  <a:gd name="connsiteX4" fmla="*/ 473484 w 639547"/>
                  <a:gd name="connsiteY4" fmla="*/ 149019 h 691683"/>
                  <a:gd name="connsiteX5" fmla="*/ 632830 w 639547"/>
                  <a:gd name="connsiteY5" fmla="*/ 347904 h 691683"/>
                  <a:gd name="connsiteX6" fmla="*/ 592863 w 639547"/>
                  <a:gd name="connsiteY6" fmla="*/ 507652 h 691683"/>
                  <a:gd name="connsiteX7" fmla="*/ 439051 w 639547"/>
                  <a:gd name="connsiteY7" fmla="*/ 655089 h 691683"/>
                  <a:gd name="connsiteX8" fmla="*/ 318505 w 639547"/>
                  <a:gd name="connsiteY8" fmla="*/ 690805 h 691683"/>
                  <a:gd name="connsiteX9" fmla="*/ 149656 w 639547"/>
                  <a:gd name="connsiteY9" fmla="*/ 631180 h 691683"/>
                  <a:gd name="connsiteX10" fmla="*/ 4180 w 639547"/>
                  <a:gd name="connsiteY10" fmla="*/ 347904 h 691683"/>
                  <a:gd name="connsiteX0" fmla="*/ 4180 w 643470"/>
                  <a:gd name="connsiteY0" fmla="*/ 347904 h 691683"/>
                  <a:gd name="connsiteX1" fmla="*/ 102715 w 643470"/>
                  <a:gd name="connsiteY1" fmla="*/ 107925 h 691683"/>
                  <a:gd name="connsiteX2" fmla="*/ 192614 w 643470"/>
                  <a:gd name="connsiteY2" fmla="*/ 39922 h 691683"/>
                  <a:gd name="connsiteX3" fmla="*/ 318505 w 643470"/>
                  <a:gd name="connsiteY3" fmla="*/ 5003 h 691683"/>
                  <a:gd name="connsiteX4" fmla="*/ 473484 w 643470"/>
                  <a:gd name="connsiteY4" fmla="*/ 149019 h 691683"/>
                  <a:gd name="connsiteX5" fmla="*/ 632830 w 643470"/>
                  <a:gd name="connsiteY5" fmla="*/ 347904 h 691683"/>
                  <a:gd name="connsiteX6" fmla="*/ 611857 w 643470"/>
                  <a:gd name="connsiteY6" fmla="*/ 549102 h 691683"/>
                  <a:gd name="connsiteX7" fmla="*/ 439051 w 643470"/>
                  <a:gd name="connsiteY7" fmla="*/ 655089 h 691683"/>
                  <a:gd name="connsiteX8" fmla="*/ 318505 w 643470"/>
                  <a:gd name="connsiteY8" fmla="*/ 690805 h 691683"/>
                  <a:gd name="connsiteX9" fmla="*/ 149656 w 643470"/>
                  <a:gd name="connsiteY9" fmla="*/ 631180 h 691683"/>
                  <a:gd name="connsiteX10" fmla="*/ 4180 w 643470"/>
                  <a:gd name="connsiteY10" fmla="*/ 347904 h 691683"/>
                  <a:gd name="connsiteX0" fmla="*/ 4180 w 643470"/>
                  <a:gd name="connsiteY0" fmla="*/ 351241 h 695020"/>
                  <a:gd name="connsiteX1" fmla="*/ 102715 w 643470"/>
                  <a:gd name="connsiteY1" fmla="*/ 111262 h 695020"/>
                  <a:gd name="connsiteX2" fmla="*/ 192614 w 643470"/>
                  <a:gd name="connsiteY2" fmla="*/ 43259 h 695020"/>
                  <a:gd name="connsiteX3" fmla="*/ 318505 w 643470"/>
                  <a:gd name="connsiteY3" fmla="*/ 8340 h 695020"/>
                  <a:gd name="connsiteX4" fmla="*/ 467526 w 643470"/>
                  <a:gd name="connsiteY4" fmla="*/ 203509 h 695020"/>
                  <a:gd name="connsiteX5" fmla="*/ 632830 w 643470"/>
                  <a:gd name="connsiteY5" fmla="*/ 351241 h 695020"/>
                  <a:gd name="connsiteX6" fmla="*/ 611857 w 643470"/>
                  <a:gd name="connsiteY6" fmla="*/ 552439 h 695020"/>
                  <a:gd name="connsiteX7" fmla="*/ 439051 w 643470"/>
                  <a:gd name="connsiteY7" fmla="*/ 658426 h 695020"/>
                  <a:gd name="connsiteX8" fmla="*/ 318505 w 643470"/>
                  <a:gd name="connsiteY8" fmla="*/ 694142 h 695020"/>
                  <a:gd name="connsiteX9" fmla="*/ 149656 w 643470"/>
                  <a:gd name="connsiteY9" fmla="*/ 634517 h 695020"/>
                  <a:gd name="connsiteX10" fmla="*/ 4180 w 643470"/>
                  <a:gd name="connsiteY10" fmla="*/ 351241 h 695020"/>
                  <a:gd name="connsiteX0" fmla="*/ 1874 w 641164"/>
                  <a:gd name="connsiteY0" fmla="*/ 351241 h 702699"/>
                  <a:gd name="connsiteX1" fmla="*/ 100409 w 641164"/>
                  <a:gd name="connsiteY1" fmla="*/ 111262 h 702699"/>
                  <a:gd name="connsiteX2" fmla="*/ 190308 w 641164"/>
                  <a:gd name="connsiteY2" fmla="*/ 43259 h 702699"/>
                  <a:gd name="connsiteX3" fmla="*/ 316199 w 641164"/>
                  <a:gd name="connsiteY3" fmla="*/ 8340 h 702699"/>
                  <a:gd name="connsiteX4" fmla="*/ 465220 w 641164"/>
                  <a:gd name="connsiteY4" fmla="*/ 203509 h 702699"/>
                  <a:gd name="connsiteX5" fmla="*/ 630524 w 641164"/>
                  <a:gd name="connsiteY5" fmla="*/ 351241 h 702699"/>
                  <a:gd name="connsiteX6" fmla="*/ 609551 w 641164"/>
                  <a:gd name="connsiteY6" fmla="*/ 552439 h 702699"/>
                  <a:gd name="connsiteX7" fmla="*/ 436745 w 641164"/>
                  <a:gd name="connsiteY7" fmla="*/ 658426 h 702699"/>
                  <a:gd name="connsiteX8" fmla="*/ 316199 w 641164"/>
                  <a:gd name="connsiteY8" fmla="*/ 694142 h 702699"/>
                  <a:gd name="connsiteX9" fmla="*/ 179786 w 641164"/>
                  <a:gd name="connsiteY9" fmla="*/ 518482 h 702699"/>
                  <a:gd name="connsiteX10" fmla="*/ 1874 w 641164"/>
                  <a:gd name="connsiteY10" fmla="*/ 351241 h 702699"/>
                  <a:gd name="connsiteX0" fmla="*/ 656 w 639946"/>
                  <a:gd name="connsiteY0" fmla="*/ 351241 h 699899"/>
                  <a:gd name="connsiteX1" fmla="*/ 99191 w 639946"/>
                  <a:gd name="connsiteY1" fmla="*/ 111262 h 699899"/>
                  <a:gd name="connsiteX2" fmla="*/ 189090 w 639946"/>
                  <a:gd name="connsiteY2" fmla="*/ 43259 h 699899"/>
                  <a:gd name="connsiteX3" fmla="*/ 314981 w 639946"/>
                  <a:gd name="connsiteY3" fmla="*/ 8340 h 699899"/>
                  <a:gd name="connsiteX4" fmla="*/ 464002 w 639946"/>
                  <a:gd name="connsiteY4" fmla="*/ 203509 h 699899"/>
                  <a:gd name="connsiteX5" fmla="*/ 629306 w 639946"/>
                  <a:gd name="connsiteY5" fmla="*/ 351241 h 699899"/>
                  <a:gd name="connsiteX6" fmla="*/ 608333 w 639946"/>
                  <a:gd name="connsiteY6" fmla="*/ 552439 h 699899"/>
                  <a:gd name="connsiteX7" fmla="*/ 435527 w 639946"/>
                  <a:gd name="connsiteY7" fmla="*/ 658426 h 699899"/>
                  <a:gd name="connsiteX8" fmla="*/ 314981 w 639946"/>
                  <a:gd name="connsiteY8" fmla="*/ 694142 h 699899"/>
                  <a:gd name="connsiteX9" fmla="*/ 142387 w 639946"/>
                  <a:gd name="connsiteY9" fmla="*/ 558407 h 699899"/>
                  <a:gd name="connsiteX10" fmla="*/ 656 w 639946"/>
                  <a:gd name="connsiteY10" fmla="*/ 351241 h 699899"/>
                  <a:gd name="connsiteX0" fmla="*/ 656 w 643588"/>
                  <a:gd name="connsiteY0" fmla="*/ 351241 h 699899"/>
                  <a:gd name="connsiteX1" fmla="*/ 99191 w 643588"/>
                  <a:gd name="connsiteY1" fmla="*/ 111262 h 699899"/>
                  <a:gd name="connsiteX2" fmla="*/ 189090 w 643588"/>
                  <a:gd name="connsiteY2" fmla="*/ 43259 h 699899"/>
                  <a:gd name="connsiteX3" fmla="*/ 314981 w 643588"/>
                  <a:gd name="connsiteY3" fmla="*/ 8340 h 699899"/>
                  <a:gd name="connsiteX4" fmla="*/ 464002 w 643588"/>
                  <a:gd name="connsiteY4" fmla="*/ 203509 h 699899"/>
                  <a:gd name="connsiteX5" fmla="*/ 629306 w 643588"/>
                  <a:gd name="connsiteY5" fmla="*/ 351241 h 699899"/>
                  <a:gd name="connsiteX6" fmla="*/ 632506 w 643588"/>
                  <a:gd name="connsiteY6" fmla="*/ 441041 h 699899"/>
                  <a:gd name="connsiteX7" fmla="*/ 608333 w 643588"/>
                  <a:gd name="connsiteY7" fmla="*/ 552439 h 699899"/>
                  <a:gd name="connsiteX8" fmla="*/ 435527 w 643588"/>
                  <a:gd name="connsiteY8" fmla="*/ 658426 h 699899"/>
                  <a:gd name="connsiteX9" fmla="*/ 314981 w 643588"/>
                  <a:gd name="connsiteY9" fmla="*/ 694142 h 699899"/>
                  <a:gd name="connsiteX10" fmla="*/ 142387 w 643588"/>
                  <a:gd name="connsiteY10" fmla="*/ 558407 h 699899"/>
                  <a:gd name="connsiteX11" fmla="*/ 656 w 643588"/>
                  <a:gd name="connsiteY11" fmla="*/ 351241 h 699899"/>
                  <a:gd name="connsiteX0" fmla="*/ 656 w 643588"/>
                  <a:gd name="connsiteY0" fmla="*/ 351241 h 698530"/>
                  <a:gd name="connsiteX1" fmla="*/ 99191 w 643588"/>
                  <a:gd name="connsiteY1" fmla="*/ 111262 h 698530"/>
                  <a:gd name="connsiteX2" fmla="*/ 189090 w 643588"/>
                  <a:gd name="connsiteY2" fmla="*/ 43259 h 698530"/>
                  <a:gd name="connsiteX3" fmla="*/ 314981 w 643588"/>
                  <a:gd name="connsiteY3" fmla="*/ 8340 h 698530"/>
                  <a:gd name="connsiteX4" fmla="*/ 464002 w 643588"/>
                  <a:gd name="connsiteY4" fmla="*/ 203509 h 698530"/>
                  <a:gd name="connsiteX5" fmla="*/ 629306 w 643588"/>
                  <a:gd name="connsiteY5" fmla="*/ 351241 h 698530"/>
                  <a:gd name="connsiteX6" fmla="*/ 632506 w 643588"/>
                  <a:gd name="connsiteY6" fmla="*/ 441041 h 698530"/>
                  <a:gd name="connsiteX7" fmla="*/ 608333 w 643588"/>
                  <a:gd name="connsiteY7" fmla="*/ 552439 h 698530"/>
                  <a:gd name="connsiteX8" fmla="*/ 542328 w 643588"/>
                  <a:gd name="connsiteY8" fmla="*/ 589587 h 698530"/>
                  <a:gd name="connsiteX9" fmla="*/ 435527 w 643588"/>
                  <a:gd name="connsiteY9" fmla="*/ 658426 h 698530"/>
                  <a:gd name="connsiteX10" fmla="*/ 314981 w 643588"/>
                  <a:gd name="connsiteY10" fmla="*/ 694142 h 698530"/>
                  <a:gd name="connsiteX11" fmla="*/ 142387 w 643588"/>
                  <a:gd name="connsiteY11" fmla="*/ 558407 h 698530"/>
                  <a:gd name="connsiteX12" fmla="*/ 656 w 643588"/>
                  <a:gd name="connsiteY12" fmla="*/ 351241 h 698530"/>
                  <a:gd name="connsiteX0" fmla="*/ 656 w 643588"/>
                  <a:gd name="connsiteY0" fmla="*/ 351241 h 698530"/>
                  <a:gd name="connsiteX1" fmla="*/ 99191 w 643588"/>
                  <a:gd name="connsiteY1" fmla="*/ 111262 h 698530"/>
                  <a:gd name="connsiteX2" fmla="*/ 189090 w 643588"/>
                  <a:gd name="connsiteY2" fmla="*/ 43259 h 698530"/>
                  <a:gd name="connsiteX3" fmla="*/ 314981 w 643588"/>
                  <a:gd name="connsiteY3" fmla="*/ 8340 h 698530"/>
                  <a:gd name="connsiteX4" fmla="*/ 464002 w 643588"/>
                  <a:gd name="connsiteY4" fmla="*/ 203509 h 698530"/>
                  <a:gd name="connsiteX5" fmla="*/ 629306 w 643588"/>
                  <a:gd name="connsiteY5" fmla="*/ 351241 h 698530"/>
                  <a:gd name="connsiteX6" fmla="*/ 632506 w 643588"/>
                  <a:gd name="connsiteY6" fmla="*/ 441041 h 698530"/>
                  <a:gd name="connsiteX7" fmla="*/ 608333 w 643588"/>
                  <a:gd name="connsiteY7" fmla="*/ 552439 h 698530"/>
                  <a:gd name="connsiteX8" fmla="*/ 548014 w 643588"/>
                  <a:gd name="connsiteY8" fmla="*/ 618976 h 698530"/>
                  <a:gd name="connsiteX9" fmla="*/ 435527 w 643588"/>
                  <a:gd name="connsiteY9" fmla="*/ 658426 h 698530"/>
                  <a:gd name="connsiteX10" fmla="*/ 314981 w 643588"/>
                  <a:gd name="connsiteY10" fmla="*/ 694142 h 698530"/>
                  <a:gd name="connsiteX11" fmla="*/ 142387 w 643588"/>
                  <a:gd name="connsiteY11" fmla="*/ 558407 h 698530"/>
                  <a:gd name="connsiteX12" fmla="*/ 656 w 643588"/>
                  <a:gd name="connsiteY12" fmla="*/ 351241 h 698530"/>
                  <a:gd name="connsiteX0" fmla="*/ 656 w 642979"/>
                  <a:gd name="connsiteY0" fmla="*/ 351241 h 698530"/>
                  <a:gd name="connsiteX1" fmla="*/ 99191 w 642979"/>
                  <a:gd name="connsiteY1" fmla="*/ 111262 h 698530"/>
                  <a:gd name="connsiteX2" fmla="*/ 189090 w 642979"/>
                  <a:gd name="connsiteY2" fmla="*/ 43259 h 698530"/>
                  <a:gd name="connsiteX3" fmla="*/ 314981 w 642979"/>
                  <a:gd name="connsiteY3" fmla="*/ 8340 h 698530"/>
                  <a:gd name="connsiteX4" fmla="*/ 464002 w 642979"/>
                  <a:gd name="connsiteY4" fmla="*/ 203509 h 698530"/>
                  <a:gd name="connsiteX5" fmla="*/ 629306 w 642979"/>
                  <a:gd name="connsiteY5" fmla="*/ 351241 h 698530"/>
                  <a:gd name="connsiteX6" fmla="*/ 632506 w 642979"/>
                  <a:gd name="connsiteY6" fmla="*/ 441041 h 698530"/>
                  <a:gd name="connsiteX7" fmla="*/ 622107 w 642979"/>
                  <a:gd name="connsiteY7" fmla="*/ 488177 h 698530"/>
                  <a:gd name="connsiteX8" fmla="*/ 608333 w 642979"/>
                  <a:gd name="connsiteY8" fmla="*/ 552439 h 698530"/>
                  <a:gd name="connsiteX9" fmla="*/ 548014 w 642979"/>
                  <a:gd name="connsiteY9" fmla="*/ 618976 h 698530"/>
                  <a:gd name="connsiteX10" fmla="*/ 435527 w 642979"/>
                  <a:gd name="connsiteY10" fmla="*/ 658426 h 698530"/>
                  <a:gd name="connsiteX11" fmla="*/ 314981 w 642979"/>
                  <a:gd name="connsiteY11" fmla="*/ 694142 h 698530"/>
                  <a:gd name="connsiteX12" fmla="*/ 142387 w 642979"/>
                  <a:gd name="connsiteY12" fmla="*/ 558407 h 698530"/>
                  <a:gd name="connsiteX13" fmla="*/ 656 w 642979"/>
                  <a:gd name="connsiteY13" fmla="*/ 351241 h 698530"/>
                  <a:gd name="connsiteX0" fmla="*/ 656 w 664488"/>
                  <a:gd name="connsiteY0" fmla="*/ 351241 h 698530"/>
                  <a:gd name="connsiteX1" fmla="*/ 99191 w 664488"/>
                  <a:gd name="connsiteY1" fmla="*/ 111262 h 698530"/>
                  <a:gd name="connsiteX2" fmla="*/ 189090 w 664488"/>
                  <a:gd name="connsiteY2" fmla="*/ 43259 h 698530"/>
                  <a:gd name="connsiteX3" fmla="*/ 314981 w 664488"/>
                  <a:gd name="connsiteY3" fmla="*/ 8340 h 698530"/>
                  <a:gd name="connsiteX4" fmla="*/ 464002 w 664488"/>
                  <a:gd name="connsiteY4" fmla="*/ 203509 h 698530"/>
                  <a:gd name="connsiteX5" fmla="*/ 629306 w 664488"/>
                  <a:gd name="connsiteY5" fmla="*/ 351241 h 698530"/>
                  <a:gd name="connsiteX6" fmla="*/ 632506 w 664488"/>
                  <a:gd name="connsiteY6" fmla="*/ 441041 h 698530"/>
                  <a:gd name="connsiteX7" fmla="*/ 664181 w 664488"/>
                  <a:gd name="connsiteY7" fmla="*/ 481868 h 698530"/>
                  <a:gd name="connsiteX8" fmla="*/ 608333 w 664488"/>
                  <a:gd name="connsiteY8" fmla="*/ 552439 h 698530"/>
                  <a:gd name="connsiteX9" fmla="*/ 548014 w 664488"/>
                  <a:gd name="connsiteY9" fmla="*/ 618976 h 698530"/>
                  <a:gd name="connsiteX10" fmla="*/ 435527 w 664488"/>
                  <a:gd name="connsiteY10" fmla="*/ 658426 h 698530"/>
                  <a:gd name="connsiteX11" fmla="*/ 314981 w 664488"/>
                  <a:gd name="connsiteY11" fmla="*/ 694142 h 698530"/>
                  <a:gd name="connsiteX12" fmla="*/ 142387 w 664488"/>
                  <a:gd name="connsiteY12" fmla="*/ 558407 h 698530"/>
                  <a:gd name="connsiteX13" fmla="*/ 656 w 664488"/>
                  <a:gd name="connsiteY13" fmla="*/ 351241 h 698530"/>
                  <a:gd name="connsiteX0" fmla="*/ 656 w 642979"/>
                  <a:gd name="connsiteY0" fmla="*/ 351241 h 698530"/>
                  <a:gd name="connsiteX1" fmla="*/ 99191 w 642979"/>
                  <a:gd name="connsiteY1" fmla="*/ 111262 h 698530"/>
                  <a:gd name="connsiteX2" fmla="*/ 189090 w 642979"/>
                  <a:gd name="connsiteY2" fmla="*/ 43259 h 698530"/>
                  <a:gd name="connsiteX3" fmla="*/ 314981 w 642979"/>
                  <a:gd name="connsiteY3" fmla="*/ 8340 h 698530"/>
                  <a:gd name="connsiteX4" fmla="*/ 464002 w 642979"/>
                  <a:gd name="connsiteY4" fmla="*/ 203509 h 698530"/>
                  <a:gd name="connsiteX5" fmla="*/ 629306 w 642979"/>
                  <a:gd name="connsiteY5" fmla="*/ 351241 h 698530"/>
                  <a:gd name="connsiteX6" fmla="*/ 632506 w 642979"/>
                  <a:gd name="connsiteY6" fmla="*/ 441041 h 698530"/>
                  <a:gd name="connsiteX7" fmla="*/ 514114 w 642979"/>
                  <a:gd name="connsiteY7" fmla="*/ 446866 h 698530"/>
                  <a:gd name="connsiteX8" fmla="*/ 608333 w 642979"/>
                  <a:gd name="connsiteY8" fmla="*/ 552439 h 698530"/>
                  <a:gd name="connsiteX9" fmla="*/ 548014 w 642979"/>
                  <a:gd name="connsiteY9" fmla="*/ 618976 h 698530"/>
                  <a:gd name="connsiteX10" fmla="*/ 435527 w 642979"/>
                  <a:gd name="connsiteY10" fmla="*/ 658426 h 698530"/>
                  <a:gd name="connsiteX11" fmla="*/ 314981 w 642979"/>
                  <a:gd name="connsiteY11" fmla="*/ 694142 h 698530"/>
                  <a:gd name="connsiteX12" fmla="*/ 142387 w 642979"/>
                  <a:gd name="connsiteY12" fmla="*/ 558407 h 698530"/>
                  <a:gd name="connsiteX13" fmla="*/ 656 w 642979"/>
                  <a:gd name="connsiteY13" fmla="*/ 351241 h 698530"/>
                  <a:gd name="connsiteX0" fmla="*/ 656 w 642979"/>
                  <a:gd name="connsiteY0" fmla="*/ 351241 h 698530"/>
                  <a:gd name="connsiteX1" fmla="*/ 99191 w 642979"/>
                  <a:gd name="connsiteY1" fmla="*/ 111262 h 698530"/>
                  <a:gd name="connsiteX2" fmla="*/ 189090 w 642979"/>
                  <a:gd name="connsiteY2" fmla="*/ 43259 h 698530"/>
                  <a:gd name="connsiteX3" fmla="*/ 314981 w 642979"/>
                  <a:gd name="connsiteY3" fmla="*/ 8340 h 698530"/>
                  <a:gd name="connsiteX4" fmla="*/ 464002 w 642979"/>
                  <a:gd name="connsiteY4" fmla="*/ 203509 h 698530"/>
                  <a:gd name="connsiteX5" fmla="*/ 629306 w 642979"/>
                  <a:gd name="connsiteY5" fmla="*/ 351241 h 698530"/>
                  <a:gd name="connsiteX6" fmla="*/ 632506 w 642979"/>
                  <a:gd name="connsiteY6" fmla="*/ 441041 h 698530"/>
                  <a:gd name="connsiteX7" fmla="*/ 514114 w 642979"/>
                  <a:gd name="connsiteY7" fmla="*/ 446866 h 698530"/>
                  <a:gd name="connsiteX8" fmla="*/ 608333 w 642979"/>
                  <a:gd name="connsiteY8" fmla="*/ 552439 h 698530"/>
                  <a:gd name="connsiteX9" fmla="*/ 429692 w 642979"/>
                  <a:gd name="connsiteY9" fmla="*/ 540027 h 698530"/>
                  <a:gd name="connsiteX10" fmla="*/ 435527 w 642979"/>
                  <a:gd name="connsiteY10" fmla="*/ 658426 h 698530"/>
                  <a:gd name="connsiteX11" fmla="*/ 314981 w 642979"/>
                  <a:gd name="connsiteY11" fmla="*/ 694142 h 698530"/>
                  <a:gd name="connsiteX12" fmla="*/ 142387 w 642979"/>
                  <a:gd name="connsiteY12" fmla="*/ 558407 h 698530"/>
                  <a:gd name="connsiteX13" fmla="*/ 656 w 642979"/>
                  <a:gd name="connsiteY13" fmla="*/ 351241 h 698530"/>
                  <a:gd name="connsiteX0" fmla="*/ 656 w 642979"/>
                  <a:gd name="connsiteY0" fmla="*/ 351241 h 698530"/>
                  <a:gd name="connsiteX1" fmla="*/ 99191 w 642979"/>
                  <a:gd name="connsiteY1" fmla="*/ 111262 h 698530"/>
                  <a:gd name="connsiteX2" fmla="*/ 189090 w 642979"/>
                  <a:gd name="connsiteY2" fmla="*/ 43259 h 698530"/>
                  <a:gd name="connsiteX3" fmla="*/ 314981 w 642979"/>
                  <a:gd name="connsiteY3" fmla="*/ 8340 h 698530"/>
                  <a:gd name="connsiteX4" fmla="*/ 464002 w 642979"/>
                  <a:gd name="connsiteY4" fmla="*/ 203509 h 698530"/>
                  <a:gd name="connsiteX5" fmla="*/ 629306 w 642979"/>
                  <a:gd name="connsiteY5" fmla="*/ 351241 h 698530"/>
                  <a:gd name="connsiteX6" fmla="*/ 632506 w 642979"/>
                  <a:gd name="connsiteY6" fmla="*/ 441041 h 698530"/>
                  <a:gd name="connsiteX7" fmla="*/ 514114 w 642979"/>
                  <a:gd name="connsiteY7" fmla="*/ 446866 h 698530"/>
                  <a:gd name="connsiteX8" fmla="*/ 608333 w 642979"/>
                  <a:gd name="connsiteY8" fmla="*/ 552439 h 698530"/>
                  <a:gd name="connsiteX9" fmla="*/ 465245 w 642979"/>
                  <a:gd name="connsiteY9" fmla="*/ 487421 h 698530"/>
                  <a:gd name="connsiteX10" fmla="*/ 429692 w 642979"/>
                  <a:gd name="connsiteY10" fmla="*/ 540027 h 698530"/>
                  <a:gd name="connsiteX11" fmla="*/ 435527 w 642979"/>
                  <a:gd name="connsiteY11" fmla="*/ 658426 h 698530"/>
                  <a:gd name="connsiteX12" fmla="*/ 314981 w 642979"/>
                  <a:gd name="connsiteY12" fmla="*/ 694142 h 698530"/>
                  <a:gd name="connsiteX13" fmla="*/ 142387 w 642979"/>
                  <a:gd name="connsiteY13" fmla="*/ 558407 h 698530"/>
                  <a:gd name="connsiteX14" fmla="*/ 656 w 642979"/>
                  <a:gd name="connsiteY14" fmla="*/ 351241 h 698530"/>
                  <a:gd name="connsiteX0" fmla="*/ 656 w 642979"/>
                  <a:gd name="connsiteY0" fmla="*/ 351241 h 694351"/>
                  <a:gd name="connsiteX1" fmla="*/ 99191 w 642979"/>
                  <a:gd name="connsiteY1" fmla="*/ 111262 h 694351"/>
                  <a:gd name="connsiteX2" fmla="*/ 189090 w 642979"/>
                  <a:gd name="connsiteY2" fmla="*/ 43259 h 694351"/>
                  <a:gd name="connsiteX3" fmla="*/ 314981 w 642979"/>
                  <a:gd name="connsiteY3" fmla="*/ 8340 h 694351"/>
                  <a:gd name="connsiteX4" fmla="*/ 464002 w 642979"/>
                  <a:gd name="connsiteY4" fmla="*/ 203509 h 694351"/>
                  <a:gd name="connsiteX5" fmla="*/ 629306 w 642979"/>
                  <a:gd name="connsiteY5" fmla="*/ 351241 h 694351"/>
                  <a:gd name="connsiteX6" fmla="*/ 632506 w 642979"/>
                  <a:gd name="connsiteY6" fmla="*/ 441041 h 694351"/>
                  <a:gd name="connsiteX7" fmla="*/ 514114 w 642979"/>
                  <a:gd name="connsiteY7" fmla="*/ 446866 h 694351"/>
                  <a:gd name="connsiteX8" fmla="*/ 608333 w 642979"/>
                  <a:gd name="connsiteY8" fmla="*/ 552439 h 694351"/>
                  <a:gd name="connsiteX9" fmla="*/ 465245 w 642979"/>
                  <a:gd name="connsiteY9" fmla="*/ 487421 h 694351"/>
                  <a:gd name="connsiteX10" fmla="*/ 429692 w 642979"/>
                  <a:gd name="connsiteY10" fmla="*/ 540027 h 694351"/>
                  <a:gd name="connsiteX11" fmla="*/ 372795 w 642979"/>
                  <a:gd name="connsiteY11" fmla="*/ 589459 h 694351"/>
                  <a:gd name="connsiteX12" fmla="*/ 314981 w 642979"/>
                  <a:gd name="connsiteY12" fmla="*/ 694142 h 694351"/>
                  <a:gd name="connsiteX13" fmla="*/ 142387 w 642979"/>
                  <a:gd name="connsiteY13" fmla="*/ 558407 h 694351"/>
                  <a:gd name="connsiteX14" fmla="*/ 656 w 642979"/>
                  <a:gd name="connsiteY14" fmla="*/ 351241 h 694351"/>
                  <a:gd name="connsiteX0" fmla="*/ 656 w 642979"/>
                  <a:gd name="connsiteY0" fmla="*/ 351241 h 596438"/>
                  <a:gd name="connsiteX1" fmla="*/ 99191 w 642979"/>
                  <a:gd name="connsiteY1" fmla="*/ 111262 h 596438"/>
                  <a:gd name="connsiteX2" fmla="*/ 189090 w 642979"/>
                  <a:gd name="connsiteY2" fmla="*/ 43259 h 596438"/>
                  <a:gd name="connsiteX3" fmla="*/ 314981 w 642979"/>
                  <a:gd name="connsiteY3" fmla="*/ 8340 h 596438"/>
                  <a:gd name="connsiteX4" fmla="*/ 464002 w 642979"/>
                  <a:gd name="connsiteY4" fmla="*/ 203509 h 596438"/>
                  <a:gd name="connsiteX5" fmla="*/ 629306 w 642979"/>
                  <a:gd name="connsiteY5" fmla="*/ 351241 h 596438"/>
                  <a:gd name="connsiteX6" fmla="*/ 632506 w 642979"/>
                  <a:gd name="connsiteY6" fmla="*/ 441041 h 596438"/>
                  <a:gd name="connsiteX7" fmla="*/ 514114 w 642979"/>
                  <a:gd name="connsiteY7" fmla="*/ 446866 h 596438"/>
                  <a:gd name="connsiteX8" fmla="*/ 608333 w 642979"/>
                  <a:gd name="connsiteY8" fmla="*/ 552439 h 596438"/>
                  <a:gd name="connsiteX9" fmla="*/ 465245 w 642979"/>
                  <a:gd name="connsiteY9" fmla="*/ 487421 h 596438"/>
                  <a:gd name="connsiteX10" fmla="*/ 429692 w 642979"/>
                  <a:gd name="connsiteY10" fmla="*/ 540027 h 596438"/>
                  <a:gd name="connsiteX11" fmla="*/ 372795 w 642979"/>
                  <a:gd name="connsiteY11" fmla="*/ 589459 h 596438"/>
                  <a:gd name="connsiteX12" fmla="*/ 275539 w 642979"/>
                  <a:gd name="connsiteY12" fmla="*/ 581644 h 596438"/>
                  <a:gd name="connsiteX13" fmla="*/ 142387 w 642979"/>
                  <a:gd name="connsiteY13" fmla="*/ 558407 h 596438"/>
                  <a:gd name="connsiteX14" fmla="*/ 656 w 642979"/>
                  <a:gd name="connsiteY14" fmla="*/ 351241 h 596438"/>
                  <a:gd name="connsiteX0" fmla="*/ 7365 w 582037"/>
                  <a:gd name="connsiteY0" fmla="*/ 347911 h 596438"/>
                  <a:gd name="connsiteX1" fmla="*/ 38249 w 582037"/>
                  <a:gd name="connsiteY1" fmla="*/ 111262 h 596438"/>
                  <a:gd name="connsiteX2" fmla="*/ 128148 w 582037"/>
                  <a:gd name="connsiteY2" fmla="*/ 43259 h 596438"/>
                  <a:gd name="connsiteX3" fmla="*/ 254039 w 582037"/>
                  <a:gd name="connsiteY3" fmla="*/ 8340 h 596438"/>
                  <a:gd name="connsiteX4" fmla="*/ 403060 w 582037"/>
                  <a:gd name="connsiteY4" fmla="*/ 203509 h 596438"/>
                  <a:gd name="connsiteX5" fmla="*/ 568364 w 582037"/>
                  <a:gd name="connsiteY5" fmla="*/ 351241 h 596438"/>
                  <a:gd name="connsiteX6" fmla="*/ 571564 w 582037"/>
                  <a:gd name="connsiteY6" fmla="*/ 441041 h 596438"/>
                  <a:gd name="connsiteX7" fmla="*/ 453172 w 582037"/>
                  <a:gd name="connsiteY7" fmla="*/ 446866 h 596438"/>
                  <a:gd name="connsiteX8" fmla="*/ 547391 w 582037"/>
                  <a:gd name="connsiteY8" fmla="*/ 552439 h 596438"/>
                  <a:gd name="connsiteX9" fmla="*/ 404303 w 582037"/>
                  <a:gd name="connsiteY9" fmla="*/ 487421 h 596438"/>
                  <a:gd name="connsiteX10" fmla="*/ 368750 w 582037"/>
                  <a:gd name="connsiteY10" fmla="*/ 540027 h 596438"/>
                  <a:gd name="connsiteX11" fmla="*/ 311853 w 582037"/>
                  <a:gd name="connsiteY11" fmla="*/ 589459 h 596438"/>
                  <a:gd name="connsiteX12" fmla="*/ 214597 w 582037"/>
                  <a:gd name="connsiteY12" fmla="*/ 581644 h 596438"/>
                  <a:gd name="connsiteX13" fmla="*/ 81445 w 582037"/>
                  <a:gd name="connsiteY13" fmla="*/ 558407 h 596438"/>
                  <a:gd name="connsiteX14" fmla="*/ 7365 w 582037"/>
                  <a:gd name="connsiteY14" fmla="*/ 347911 h 596438"/>
                  <a:gd name="connsiteX0" fmla="*/ 531 w 575203"/>
                  <a:gd name="connsiteY0" fmla="*/ 347911 h 596438"/>
                  <a:gd name="connsiteX1" fmla="*/ 57409 w 575203"/>
                  <a:gd name="connsiteY1" fmla="*/ 122698 h 596438"/>
                  <a:gd name="connsiteX2" fmla="*/ 121314 w 575203"/>
                  <a:gd name="connsiteY2" fmla="*/ 43259 h 596438"/>
                  <a:gd name="connsiteX3" fmla="*/ 247205 w 575203"/>
                  <a:gd name="connsiteY3" fmla="*/ 8340 h 596438"/>
                  <a:gd name="connsiteX4" fmla="*/ 396226 w 575203"/>
                  <a:gd name="connsiteY4" fmla="*/ 203509 h 596438"/>
                  <a:gd name="connsiteX5" fmla="*/ 561530 w 575203"/>
                  <a:gd name="connsiteY5" fmla="*/ 351241 h 596438"/>
                  <a:gd name="connsiteX6" fmla="*/ 564730 w 575203"/>
                  <a:gd name="connsiteY6" fmla="*/ 441041 h 596438"/>
                  <a:gd name="connsiteX7" fmla="*/ 446338 w 575203"/>
                  <a:gd name="connsiteY7" fmla="*/ 446866 h 596438"/>
                  <a:gd name="connsiteX8" fmla="*/ 540557 w 575203"/>
                  <a:gd name="connsiteY8" fmla="*/ 552439 h 596438"/>
                  <a:gd name="connsiteX9" fmla="*/ 397469 w 575203"/>
                  <a:gd name="connsiteY9" fmla="*/ 487421 h 596438"/>
                  <a:gd name="connsiteX10" fmla="*/ 361916 w 575203"/>
                  <a:gd name="connsiteY10" fmla="*/ 540027 h 596438"/>
                  <a:gd name="connsiteX11" fmla="*/ 305019 w 575203"/>
                  <a:gd name="connsiteY11" fmla="*/ 589459 h 596438"/>
                  <a:gd name="connsiteX12" fmla="*/ 207763 w 575203"/>
                  <a:gd name="connsiteY12" fmla="*/ 581644 h 596438"/>
                  <a:gd name="connsiteX13" fmla="*/ 74611 w 575203"/>
                  <a:gd name="connsiteY13" fmla="*/ 558407 h 596438"/>
                  <a:gd name="connsiteX14" fmla="*/ 531 w 575203"/>
                  <a:gd name="connsiteY14" fmla="*/ 347911 h 596438"/>
                  <a:gd name="connsiteX0" fmla="*/ 531 w 575203"/>
                  <a:gd name="connsiteY0" fmla="*/ 314228 h 562755"/>
                  <a:gd name="connsiteX1" fmla="*/ 57409 w 575203"/>
                  <a:gd name="connsiteY1" fmla="*/ 89015 h 562755"/>
                  <a:gd name="connsiteX2" fmla="*/ 121314 w 575203"/>
                  <a:gd name="connsiteY2" fmla="*/ 9576 h 562755"/>
                  <a:gd name="connsiteX3" fmla="*/ 249702 w 575203"/>
                  <a:gd name="connsiteY3" fmla="*/ 25395 h 562755"/>
                  <a:gd name="connsiteX4" fmla="*/ 396226 w 575203"/>
                  <a:gd name="connsiteY4" fmla="*/ 169826 h 562755"/>
                  <a:gd name="connsiteX5" fmla="*/ 561530 w 575203"/>
                  <a:gd name="connsiteY5" fmla="*/ 317558 h 562755"/>
                  <a:gd name="connsiteX6" fmla="*/ 564730 w 575203"/>
                  <a:gd name="connsiteY6" fmla="*/ 407358 h 562755"/>
                  <a:gd name="connsiteX7" fmla="*/ 446338 w 575203"/>
                  <a:gd name="connsiteY7" fmla="*/ 413183 h 562755"/>
                  <a:gd name="connsiteX8" fmla="*/ 540557 w 575203"/>
                  <a:gd name="connsiteY8" fmla="*/ 518756 h 562755"/>
                  <a:gd name="connsiteX9" fmla="*/ 397469 w 575203"/>
                  <a:gd name="connsiteY9" fmla="*/ 453738 h 562755"/>
                  <a:gd name="connsiteX10" fmla="*/ 361916 w 575203"/>
                  <a:gd name="connsiteY10" fmla="*/ 506344 h 562755"/>
                  <a:gd name="connsiteX11" fmla="*/ 305019 w 575203"/>
                  <a:gd name="connsiteY11" fmla="*/ 555776 h 562755"/>
                  <a:gd name="connsiteX12" fmla="*/ 207763 w 575203"/>
                  <a:gd name="connsiteY12" fmla="*/ 547961 h 562755"/>
                  <a:gd name="connsiteX13" fmla="*/ 74611 w 575203"/>
                  <a:gd name="connsiteY13" fmla="*/ 524724 h 562755"/>
                  <a:gd name="connsiteX14" fmla="*/ 531 w 575203"/>
                  <a:gd name="connsiteY14" fmla="*/ 314228 h 562755"/>
                  <a:gd name="connsiteX0" fmla="*/ 531 w 575203"/>
                  <a:gd name="connsiteY0" fmla="*/ 312695 h 561222"/>
                  <a:gd name="connsiteX1" fmla="*/ 57409 w 575203"/>
                  <a:gd name="connsiteY1" fmla="*/ 87482 h 561222"/>
                  <a:gd name="connsiteX2" fmla="*/ 121314 w 575203"/>
                  <a:gd name="connsiteY2" fmla="*/ 8043 h 561222"/>
                  <a:gd name="connsiteX3" fmla="*/ 249702 w 575203"/>
                  <a:gd name="connsiteY3" fmla="*/ 23862 h 561222"/>
                  <a:gd name="connsiteX4" fmla="*/ 398584 w 575203"/>
                  <a:gd name="connsiteY4" fmla="*/ 130031 h 561222"/>
                  <a:gd name="connsiteX5" fmla="*/ 561530 w 575203"/>
                  <a:gd name="connsiteY5" fmla="*/ 316025 h 561222"/>
                  <a:gd name="connsiteX6" fmla="*/ 564730 w 575203"/>
                  <a:gd name="connsiteY6" fmla="*/ 405825 h 561222"/>
                  <a:gd name="connsiteX7" fmla="*/ 446338 w 575203"/>
                  <a:gd name="connsiteY7" fmla="*/ 411650 h 561222"/>
                  <a:gd name="connsiteX8" fmla="*/ 540557 w 575203"/>
                  <a:gd name="connsiteY8" fmla="*/ 517223 h 561222"/>
                  <a:gd name="connsiteX9" fmla="*/ 397469 w 575203"/>
                  <a:gd name="connsiteY9" fmla="*/ 452205 h 561222"/>
                  <a:gd name="connsiteX10" fmla="*/ 361916 w 575203"/>
                  <a:gd name="connsiteY10" fmla="*/ 504811 h 561222"/>
                  <a:gd name="connsiteX11" fmla="*/ 305019 w 575203"/>
                  <a:gd name="connsiteY11" fmla="*/ 554243 h 561222"/>
                  <a:gd name="connsiteX12" fmla="*/ 207763 w 575203"/>
                  <a:gd name="connsiteY12" fmla="*/ 546428 h 561222"/>
                  <a:gd name="connsiteX13" fmla="*/ 74611 w 575203"/>
                  <a:gd name="connsiteY13" fmla="*/ 523191 h 561222"/>
                  <a:gd name="connsiteX14" fmla="*/ 531 w 575203"/>
                  <a:gd name="connsiteY14" fmla="*/ 312695 h 56122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</a:cxnLst>
                <a:rect l="l" t="t" r="r" b="b"/>
                <a:pathLst>
                  <a:path w="575203" h="561222">
                    <a:moveTo>
                      <a:pt x="531" y="312695"/>
                    </a:moveTo>
                    <a:cubicBezTo>
                      <a:pt x="-2336" y="240077"/>
                      <a:pt x="5022" y="144632"/>
                      <a:pt x="57409" y="87482"/>
                    </a:cubicBezTo>
                    <a:cubicBezTo>
                      <a:pt x="88815" y="36152"/>
                      <a:pt x="85349" y="25197"/>
                      <a:pt x="121314" y="8043"/>
                    </a:cubicBezTo>
                    <a:cubicBezTo>
                      <a:pt x="157279" y="-9111"/>
                      <a:pt x="203490" y="3531"/>
                      <a:pt x="249702" y="23862"/>
                    </a:cubicBezTo>
                    <a:cubicBezTo>
                      <a:pt x="295914" y="44193"/>
                      <a:pt x="346197" y="72881"/>
                      <a:pt x="398584" y="130031"/>
                    </a:cubicBezTo>
                    <a:cubicBezTo>
                      <a:pt x="450971" y="187181"/>
                      <a:pt x="533446" y="276436"/>
                      <a:pt x="561530" y="316025"/>
                    </a:cubicBezTo>
                    <a:cubicBezTo>
                      <a:pt x="589614" y="355614"/>
                      <a:pt x="565930" y="383002"/>
                      <a:pt x="564730" y="405825"/>
                    </a:cubicBezTo>
                    <a:cubicBezTo>
                      <a:pt x="563530" y="428648"/>
                      <a:pt x="450367" y="393084"/>
                      <a:pt x="446338" y="411650"/>
                    </a:cubicBezTo>
                    <a:cubicBezTo>
                      <a:pt x="442309" y="430216"/>
                      <a:pt x="529860" y="500795"/>
                      <a:pt x="540557" y="517223"/>
                    </a:cubicBezTo>
                    <a:cubicBezTo>
                      <a:pt x="551254" y="533651"/>
                      <a:pt x="427242" y="454274"/>
                      <a:pt x="397469" y="452205"/>
                    </a:cubicBezTo>
                    <a:cubicBezTo>
                      <a:pt x="367696" y="450136"/>
                      <a:pt x="385711" y="485979"/>
                      <a:pt x="361916" y="504811"/>
                    </a:cubicBezTo>
                    <a:cubicBezTo>
                      <a:pt x="338121" y="523643"/>
                      <a:pt x="342910" y="536817"/>
                      <a:pt x="305019" y="554243"/>
                    </a:cubicBezTo>
                    <a:cubicBezTo>
                      <a:pt x="267128" y="571669"/>
                      <a:pt x="246164" y="551603"/>
                      <a:pt x="207763" y="546428"/>
                    </a:cubicBezTo>
                    <a:cubicBezTo>
                      <a:pt x="169362" y="541253"/>
                      <a:pt x="126998" y="580341"/>
                      <a:pt x="74611" y="523191"/>
                    </a:cubicBezTo>
                    <a:cubicBezTo>
                      <a:pt x="22224" y="466041"/>
                      <a:pt x="3398" y="385313"/>
                      <a:pt x="531" y="312695"/>
                    </a:cubicBezTo>
                    <a:close/>
                  </a:path>
                </a:pathLst>
              </a:custGeom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b="1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9" name="Rectangle 128"/>
              <p:cNvSpPr/>
              <p:nvPr/>
            </p:nvSpPr>
            <p:spPr>
              <a:xfrm>
                <a:off x="0" y="65349"/>
                <a:ext cx="719941" cy="37555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N" kern="1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TFAM</a:t>
                </a:r>
                <a:endParaRPr lang="en-IN" kern="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2" name="Group 111"/>
            <p:cNvGrpSpPr/>
            <p:nvPr/>
          </p:nvGrpSpPr>
          <p:grpSpPr>
            <a:xfrm>
              <a:off x="5110179" y="2844282"/>
              <a:ext cx="1195227" cy="675627"/>
              <a:chOff x="6200590" y="-1469361"/>
              <a:chExt cx="1195227" cy="675627"/>
            </a:xfrm>
          </p:grpSpPr>
          <p:grpSp>
            <p:nvGrpSpPr>
              <p:cNvPr id="123" name="Group 122"/>
              <p:cNvGrpSpPr/>
              <p:nvPr/>
            </p:nvGrpSpPr>
            <p:grpSpPr>
              <a:xfrm rot="741834">
                <a:off x="6759089" y="-1469361"/>
                <a:ext cx="632167" cy="355803"/>
                <a:chOff x="184163" y="-1595093"/>
                <a:chExt cx="632167" cy="355803"/>
              </a:xfrm>
            </p:grpSpPr>
            <p:sp>
              <p:nvSpPr>
                <p:cNvPr id="124" name="Oval 123"/>
                <p:cNvSpPr/>
                <p:nvPr/>
              </p:nvSpPr>
              <p:spPr bwMode="auto">
                <a:xfrm rot="15850943">
                  <a:off x="375739" y="-1695530"/>
                  <a:ext cx="285542" cy="595641"/>
                </a:xfrm>
                <a:prstGeom prst="ellipse">
                  <a:avLst/>
                </a:prstGeom>
                <a:solidFill>
                  <a:schemeClr val="accent3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IN" b="1"/>
                </a:p>
              </p:txBody>
            </p:sp>
            <p:sp>
              <p:nvSpPr>
                <p:cNvPr id="125" name="Rectangle 124"/>
                <p:cNvSpPr/>
                <p:nvPr/>
              </p:nvSpPr>
              <p:spPr>
                <a:xfrm>
                  <a:off x="184163" y="-1595093"/>
                  <a:ext cx="631904" cy="35580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IN" sz="1600" b="1" kern="100" dirty="0" err="1">
                      <a:solidFill>
                        <a:schemeClr val="bg1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CypD</a:t>
                  </a:r>
                  <a:endParaRPr lang="en-IN" sz="1600" b="1" kern="100" dirty="0">
                    <a:solidFill>
                      <a:schemeClr val="bg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30" name="Group 129"/>
              <p:cNvGrpSpPr/>
              <p:nvPr/>
            </p:nvGrpSpPr>
            <p:grpSpPr>
              <a:xfrm>
                <a:off x="6200590" y="-1334830"/>
                <a:ext cx="1195227" cy="541096"/>
                <a:chOff x="160186" y="-1398680"/>
                <a:chExt cx="1195227" cy="576054"/>
              </a:xfrm>
            </p:grpSpPr>
            <p:sp>
              <p:nvSpPr>
                <p:cNvPr id="131" name="Oval 455"/>
                <p:cNvSpPr/>
                <p:nvPr/>
              </p:nvSpPr>
              <p:spPr bwMode="auto">
                <a:xfrm rot="21228834">
                  <a:off x="160186" y="-1398680"/>
                  <a:ext cx="1195227" cy="513150"/>
                </a:xfrm>
                <a:custGeom>
                  <a:avLst/>
                  <a:gdLst>
                    <a:gd name="connsiteX0" fmla="*/ 0 w 196850"/>
                    <a:gd name="connsiteY0" fmla="*/ 100013 h 200025"/>
                    <a:gd name="connsiteX1" fmla="*/ 98425 w 196850"/>
                    <a:gd name="connsiteY1" fmla="*/ 0 h 200025"/>
                    <a:gd name="connsiteX2" fmla="*/ 196850 w 196850"/>
                    <a:gd name="connsiteY2" fmla="*/ 100013 h 200025"/>
                    <a:gd name="connsiteX3" fmla="*/ 98425 w 196850"/>
                    <a:gd name="connsiteY3" fmla="*/ 200026 h 200025"/>
                    <a:gd name="connsiteX4" fmla="*/ 0 w 196850"/>
                    <a:gd name="connsiteY4" fmla="*/ 100013 h 200025"/>
                    <a:gd name="connsiteX0" fmla="*/ 0 w 200436"/>
                    <a:gd name="connsiteY0" fmla="*/ 102821 h 202834"/>
                    <a:gd name="connsiteX1" fmla="*/ 98425 w 200436"/>
                    <a:gd name="connsiteY1" fmla="*/ 2808 h 202834"/>
                    <a:gd name="connsiteX2" fmla="*/ 171316 w 200436"/>
                    <a:gd name="connsiteY2" fmla="*/ 34173 h 202834"/>
                    <a:gd name="connsiteX3" fmla="*/ 196850 w 200436"/>
                    <a:gd name="connsiteY3" fmla="*/ 102821 h 202834"/>
                    <a:gd name="connsiteX4" fmla="*/ 98425 w 200436"/>
                    <a:gd name="connsiteY4" fmla="*/ 202834 h 202834"/>
                    <a:gd name="connsiteX5" fmla="*/ 0 w 200436"/>
                    <a:gd name="connsiteY5" fmla="*/ 102821 h 202834"/>
                    <a:gd name="connsiteX0" fmla="*/ 0 w 198381"/>
                    <a:gd name="connsiteY0" fmla="*/ 100336 h 200349"/>
                    <a:gd name="connsiteX1" fmla="*/ 98425 w 198381"/>
                    <a:gd name="connsiteY1" fmla="*/ 323 h 200349"/>
                    <a:gd name="connsiteX2" fmla="*/ 128966 w 198381"/>
                    <a:gd name="connsiteY2" fmla="*/ 69534 h 200349"/>
                    <a:gd name="connsiteX3" fmla="*/ 196850 w 198381"/>
                    <a:gd name="connsiteY3" fmla="*/ 100336 h 200349"/>
                    <a:gd name="connsiteX4" fmla="*/ 98425 w 198381"/>
                    <a:gd name="connsiteY4" fmla="*/ 200349 h 200349"/>
                    <a:gd name="connsiteX5" fmla="*/ 0 w 198381"/>
                    <a:gd name="connsiteY5" fmla="*/ 100336 h 200349"/>
                    <a:gd name="connsiteX0" fmla="*/ 55 w 198436"/>
                    <a:gd name="connsiteY0" fmla="*/ 100336 h 163586"/>
                    <a:gd name="connsiteX1" fmla="*/ 98480 w 198436"/>
                    <a:gd name="connsiteY1" fmla="*/ 323 h 163586"/>
                    <a:gd name="connsiteX2" fmla="*/ 129021 w 198436"/>
                    <a:gd name="connsiteY2" fmla="*/ 69534 h 163586"/>
                    <a:gd name="connsiteX3" fmla="*/ 196905 w 198436"/>
                    <a:gd name="connsiteY3" fmla="*/ 100336 h 163586"/>
                    <a:gd name="connsiteX4" fmla="*/ 88478 w 198436"/>
                    <a:gd name="connsiteY4" fmla="*/ 163586 h 163586"/>
                    <a:gd name="connsiteX5" fmla="*/ 55 w 198436"/>
                    <a:gd name="connsiteY5" fmla="*/ 100336 h 16358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98436" h="163586">
                      <a:moveTo>
                        <a:pt x="55" y="100336"/>
                      </a:moveTo>
                      <a:cubicBezTo>
                        <a:pt x="1722" y="73125"/>
                        <a:pt x="76986" y="5457"/>
                        <a:pt x="98480" y="323"/>
                      </a:cubicBezTo>
                      <a:cubicBezTo>
                        <a:pt x="119974" y="-4811"/>
                        <a:pt x="112617" y="52865"/>
                        <a:pt x="129021" y="69534"/>
                      </a:cubicBezTo>
                      <a:cubicBezTo>
                        <a:pt x="145425" y="86203"/>
                        <a:pt x="209053" y="72226"/>
                        <a:pt x="196905" y="100336"/>
                      </a:cubicBezTo>
                      <a:cubicBezTo>
                        <a:pt x="184757" y="128446"/>
                        <a:pt x="142837" y="163586"/>
                        <a:pt x="88478" y="163586"/>
                      </a:cubicBezTo>
                      <a:cubicBezTo>
                        <a:pt x="34119" y="163586"/>
                        <a:pt x="-1612" y="127547"/>
                        <a:pt x="55" y="100336"/>
                      </a:cubicBezTo>
                      <a:close/>
                    </a:path>
                  </a:pathLst>
                </a:custGeom>
                <a:solidFill>
                  <a:schemeClr val="accent5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IN" b="1"/>
                </a:p>
              </p:txBody>
            </p:sp>
            <p:sp>
              <p:nvSpPr>
                <p:cNvPr id="132" name="Rectangle 131"/>
                <p:cNvSpPr/>
                <p:nvPr/>
              </p:nvSpPr>
              <p:spPr>
                <a:xfrm>
                  <a:off x="250931" y="-1211322"/>
                  <a:ext cx="853119" cy="38869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IN" b="1" kern="100" dirty="0">
                      <a:solidFill>
                        <a:schemeClr val="bg1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TFB2M</a:t>
                  </a:r>
                  <a:endParaRPr lang="en-IN" b="1" kern="100" dirty="0">
                    <a:solidFill>
                      <a:schemeClr val="bg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33" name="Group 132"/>
            <p:cNvGrpSpPr/>
            <p:nvPr/>
          </p:nvGrpSpPr>
          <p:grpSpPr>
            <a:xfrm>
              <a:off x="7351506" y="1765240"/>
              <a:ext cx="719941" cy="575201"/>
              <a:chOff x="0" y="-133229"/>
              <a:chExt cx="719941" cy="575201"/>
            </a:xfrm>
          </p:grpSpPr>
          <p:sp>
            <p:nvSpPr>
              <p:cNvPr id="134" name="Oval 454"/>
              <p:cNvSpPr/>
              <p:nvPr/>
            </p:nvSpPr>
            <p:spPr bwMode="auto">
              <a:xfrm rot="16369013">
                <a:off x="101966" y="-126240"/>
                <a:ext cx="575201" cy="561223"/>
              </a:xfrm>
              <a:custGeom>
                <a:avLst/>
                <a:gdLst>
                  <a:gd name="connsiteX0" fmla="*/ 0 w 628650"/>
                  <a:gd name="connsiteY0" fmla="*/ 342901 h 685801"/>
                  <a:gd name="connsiteX1" fmla="*/ 314325 w 628650"/>
                  <a:gd name="connsiteY1" fmla="*/ 0 h 685801"/>
                  <a:gd name="connsiteX2" fmla="*/ 628650 w 628650"/>
                  <a:gd name="connsiteY2" fmla="*/ 342901 h 685801"/>
                  <a:gd name="connsiteX3" fmla="*/ 314325 w 628650"/>
                  <a:gd name="connsiteY3" fmla="*/ 685802 h 685801"/>
                  <a:gd name="connsiteX4" fmla="*/ 0 w 628650"/>
                  <a:gd name="connsiteY4" fmla="*/ 342901 h 685801"/>
                  <a:gd name="connsiteX0" fmla="*/ 0 w 650253"/>
                  <a:gd name="connsiteY0" fmla="*/ 342901 h 688891"/>
                  <a:gd name="connsiteX1" fmla="*/ 314325 w 650253"/>
                  <a:gd name="connsiteY1" fmla="*/ 0 h 688891"/>
                  <a:gd name="connsiteX2" fmla="*/ 628650 w 650253"/>
                  <a:gd name="connsiteY2" fmla="*/ 342901 h 688891"/>
                  <a:gd name="connsiteX3" fmla="*/ 588683 w 650253"/>
                  <a:gd name="connsiteY3" fmla="*/ 502649 h 688891"/>
                  <a:gd name="connsiteX4" fmla="*/ 314325 w 650253"/>
                  <a:gd name="connsiteY4" fmla="*/ 685802 h 688891"/>
                  <a:gd name="connsiteX5" fmla="*/ 0 w 650253"/>
                  <a:gd name="connsiteY5" fmla="*/ 342901 h 688891"/>
                  <a:gd name="connsiteX0" fmla="*/ 0 w 646386"/>
                  <a:gd name="connsiteY0" fmla="*/ 342901 h 706454"/>
                  <a:gd name="connsiteX1" fmla="*/ 314325 w 646386"/>
                  <a:gd name="connsiteY1" fmla="*/ 0 h 706454"/>
                  <a:gd name="connsiteX2" fmla="*/ 628650 w 646386"/>
                  <a:gd name="connsiteY2" fmla="*/ 342901 h 706454"/>
                  <a:gd name="connsiteX3" fmla="*/ 588683 w 646386"/>
                  <a:gd name="connsiteY3" fmla="*/ 502649 h 706454"/>
                  <a:gd name="connsiteX4" fmla="*/ 434871 w 646386"/>
                  <a:gd name="connsiteY4" fmla="*/ 650086 h 706454"/>
                  <a:gd name="connsiteX5" fmla="*/ 314325 w 646386"/>
                  <a:gd name="connsiteY5" fmla="*/ 685802 h 706454"/>
                  <a:gd name="connsiteX6" fmla="*/ 0 w 646386"/>
                  <a:gd name="connsiteY6" fmla="*/ 342901 h 706454"/>
                  <a:gd name="connsiteX0" fmla="*/ 4180 w 650566"/>
                  <a:gd name="connsiteY0" fmla="*/ 342901 h 686680"/>
                  <a:gd name="connsiteX1" fmla="*/ 318505 w 650566"/>
                  <a:gd name="connsiteY1" fmla="*/ 0 h 686680"/>
                  <a:gd name="connsiteX2" fmla="*/ 632830 w 650566"/>
                  <a:gd name="connsiteY2" fmla="*/ 342901 h 686680"/>
                  <a:gd name="connsiteX3" fmla="*/ 592863 w 650566"/>
                  <a:gd name="connsiteY3" fmla="*/ 502649 h 686680"/>
                  <a:gd name="connsiteX4" fmla="*/ 439051 w 650566"/>
                  <a:gd name="connsiteY4" fmla="*/ 650086 h 686680"/>
                  <a:gd name="connsiteX5" fmla="*/ 318505 w 650566"/>
                  <a:gd name="connsiteY5" fmla="*/ 685802 h 686680"/>
                  <a:gd name="connsiteX6" fmla="*/ 149656 w 650566"/>
                  <a:gd name="connsiteY6" fmla="*/ 626177 h 686680"/>
                  <a:gd name="connsiteX7" fmla="*/ 4180 w 650566"/>
                  <a:gd name="connsiteY7" fmla="*/ 342901 h 686680"/>
                  <a:gd name="connsiteX0" fmla="*/ 4180 w 650566"/>
                  <a:gd name="connsiteY0" fmla="*/ 353175 h 696954"/>
                  <a:gd name="connsiteX1" fmla="*/ 102715 w 650566"/>
                  <a:gd name="connsiteY1" fmla="*/ 113196 h 696954"/>
                  <a:gd name="connsiteX2" fmla="*/ 318505 w 650566"/>
                  <a:gd name="connsiteY2" fmla="*/ 10274 h 696954"/>
                  <a:gd name="connsiteX3" fmla="*/ 632830 w 650566"/>
                  <a:gd name="connsiteY3" fmla="*/ 353175 h 696954"/>
                  <a:gd name="connsiteX4" fmla="*/ 592863 w 650566"/>
                  <a:gd name="connsiteY4" fmla="*/ 512923 h 696954"/>
                  <a:gd name="connsiteX5" fmla="*/ 439051 w 650566"/>
                  <a:gd name="connsiteY5" fmla="*/ 660360 h 696954"/>
                  <a:gd name="connsiteX6" fmla="*/ 318505 w 650566"/>
                  <a:gd name="connsiteY6" fmla="*/ 696076 h 696954"/>
                  <a:gd name="connsiteX7" fmla="*/ 149656 w 650566"/>
                  <a:gd name="connsiteY7" fmla="*/ 636451 h 696954"/>
                  <a:gd name="connsiteX8" fmla="*/ 4180 w 650566"/>
                  <a:gd name="connsiteY8" fmla="*/ 353175 h 696954"/>
                  <a:gd name="connsiteX0" fmla="*/ 4180 w 639547"/>
                  <a:gd name="connsiteY0" fmla="*/ 343504 h 687283"/>
                  <a:gd name="connsiteX1" fmla="*/ 102715 w 639547"/>
                  <a:gd name="connsiteY1" fmla="*/ 103525 h 687283"/>
                  <a:gd name="connsiteX2" fmla="*/ 318505 w 639547"/>
                  <a:gd name="connsiteY2" fmla="*/ 603 h 687283"/>
                  <a:gd name="connsiteX3" fmla="*/ 473484 w 639547"/>
                  <a:gd name="connsiteY3" fmla="*/ 144619 h 687283"/>
                  <a:gd name="connsiteX4" fmla="*/ 632830 w 639547"/>
                  <a:gd name="connsiteY4" fmla="*/ 343504 h 687283"/>
                  <a:gd name="connsiteX5" fmla="*/ 592863 w 639547"/>
                  <a:gd name="connsiteY5" fmla="*/ 503252 h 687283"/>
                  <a:gd name="connsiteX6" fmla="*/ 439051 w 639547"/>
                  <a:gd name="connsiteY6" fmla="*/ 650689 h 687283"/>
                  <a:gd name="connsiteX7" fmla="*/ 318505 w 639547"/>
                  <a:gd name="connsiteY7" fmla="*/ 686405 h 687283"/>
                  <a:gd name="connsiteX8" fmla="*/ 149656 w 639547"/>
                  <a:gd name="connsiteY8" fmla="*/ 626780 h 687283"/>
                  <a:gd name="connsiteX9" fmla="*/ 4180 w 639547"/>
                  <a:gd name="connsiteY9" fmla="*/ 343504 h 687283"/>
                  <a:gd name="connsiteX0" fmla="*/ 4180 w 639547"/>
                  <a:gd name="connsiteY0" fmla="*/ 347904 h 691683"/>
                  <a:gd name="connsiteX1" fmla="*/ 102715 w 639547"/>
                  <a:gd name="connsiteY1" fmla="*/ 107925 h 691683"/>
                  <a:gd name="connsiteX2" fmla="*/ 192614 w 639547"/>
                  <a:gd name="connsiteY2" fmla="*/ 39922 h 691683"/>
                  <a:gd name="connsiteX3" fmla="*/ 318505 w 639547"/>
                  <a:gd name="connsiteY3" fmla="*/ 5003 h 691683"/>
                  <a:gd name="connsiteX4" fmla="*/ 473484 w 639547"/>
                  <a:gd name="connsiteY4" fmla="*/ 149019 h 691683"/>
                  <a:gd name="connsiteX5" fmla="*/ 632830 w 639547"/>
                  <a:gd name="connsiteY5" fmla="*/ 347904 h 691683"/>
                  <a:gd name="connsiteX6" fmla="*/ 592863 w 639547"/>
                  <a:gd name="connsiteY6" fmla="*/ 507652 h 691683"/>
                  <a:gd name="connsiteX7" fmla="*/ 439051 w 639547"/>
                  <a:gd name="connsiteY7" fmla="*/ 655089 h 691683"/>
                  <a:gd name="connsiteX8" fmla="*/ 318505 w 639547"/>
                  <a:gd name="connsiteY8" fmla="*/ 690805 h 691683"/>
                  <a:gd name="connsiteX9" fmla="*/ 149656 w 639547"/>
                  <a:gd name="connsiteY9" fmla="*/ 631180 h 691683"/>
                  <a:gd name="connsiteX10" fmla="*/ 4180 w 639547"/>
                  <a:gd name="connsiteY10" fmla="*/ 347904 h 691683"/>
                  <a:gd name="connsiteX0" fmla="*/ 4180 w 643470"/>
                  <a:gd name="connsiteY0" fmla="*/ 347904 h 691683"/>
                  <a:gd name="connsiteX1" fmla="*/ 102715 w 643470"/>
                  <a:gd name="connsiteY1" fmla="*/ 107925 h 691683"/>
                  <a:gd name="connsiteX2" fmla="*/ 192614 w 643470"/>
                  <a:gd name="connsiteY2" fmla="*/ 39922 h 691683"/>
                  <a:gd name="connsiteX3" fmla="*/ 318505 w 643470"/>
                  <a:gd name="connsiteY3" fmla="*/ 5003 h 691683"/>
                  <a:gd name="connsiteX4" fmla="*/ 473484 w 643470"/>
                  <a:gd name="connsiteY4" fmla="*/ 149019 h 691683"/>
                  <a:gd name="connsiteX5" fmla="*/ 632830 w 643470"/>
                  <a:gd name="connsiteY5" fmla="*/ 347904 h 691683"/>
                  <a:gd name="connsiteX6" fmla="*/ 611857 w 643470"/>
                  <a:gd name="connsiteY6" fmla="*/ 549102 h 691683"/>
                  <a:gd name="connsiteX7" fmla="*/ 439051 w 643470"/>
                  <a:gd name="connsiteY7" fmla="*/ 655089 h 691683"/>
                  <a:gd name="connsiteX8" fmla="*/ 318505 w 643470"/>
                  <a:gd name="connsiteY8" fmla="*/ 690805 h 691683"/>
                  <a:gd name="connsiteX9" fmla="*/ 149656 w 643470"/>
                  <a:gd name="connsiteY9" fmla="*/ 631180 h 691683"/>
                  <a:gd name="connsiteX10" fmla="*/ 4180 w 643470"/>
                  <a:gd name="connsiteY10" fmla="*/ 347904 h 691683"/>
                  <a:gd name="connsiteX0" fmla="*/ 4180 w 643470"/>
                  <a:gd name="connsiteY0" fmla="*/ 351241 h 695020"/>
                  <a:gd name="connsiteX1" fmla="*/ 102715 w 643470"/>
                  <a:gd name="connsiteY1" fmla="*/ 111262 h 695020"/>
                  <a:gd name="connsiteX2" fmla="*/ 192614 w 643470"/>
                  <a:gd name="connsiteY2" fmla="*/ 43259 h 695020"/>
                  <a:gd name="connsiteX3" fmla="*/ 318505 w 643470"/>
                  <a:gd name="connsiteY3" fmla="*/ 8340 h 695020"/>
                  <a:gd name="connsiteX4" fmla="*/ 467526 w 643470"/>
                  <a:gd name="connsiteY4" fmla="*/ 203509 h 695020"/>
                  <a:gd name="connsiteX5" fmla="*/ 632830 w 643470"/>
                  <a:gd name="connsiteY5" fmla="*/ 351241 h 695020"/>
                  <a:gd name="connsiteX6" fmla="*/ 611857 w 643470"/>
                  <a:gd name="connsiteY6" fmla="*/ 552439 h 695020"/>
                  <a:gd name="connsiteX7" fmla="*/ 439051 w 643470"/>
                  <a:gd name="connsiteY7" fmla="*/ 658426 h 695020"/>
                  <a:gd name="connsiteX8" fmla="*/ 318505 w 643470"/>
                  <a:gd name="connsiteY8" fmla="*/ 694142 h 695020"/>
                  <a:gd name="connsiteX9" fmla="*/ 149656 w 643470"/>
                  <a:gd name="connsiteY9" fmla="*/ 634517 h 695020"/>
                  <a:gd name="connsiteX10" fmla="*/ 4180 w 643470"/>
                  <a:gd name="connsiteY10" fmla="*/ 351241 h 695020"/>
                  <a:gd name="connsiteX0" fmla="*/ 1874 w 641164"/>
                  <a:gd name="connsiteY0" fmla="*/ 351241 h 702699"/>
                  <a:gd name="connsiteX1" fmla="*/ 100409 w 641164"/>
                  <a:gd name="connsiteY1" fmla="*/ 111262 h 702699"/>
                  <a:gd name="connsiteX2" fmla="*/ 190308 w 641164"/>
                  <a:gd name="connsiteY2" fmla="*/ 43259 h 702699"/>
                  <a:gd name="connsiteX3" fmla="*/ 316199 w 641164"/>
                  <a:gd name="connsiteY3" fmla="*/ 8340 h 702699"/>
                  <a:gd name="connsiteX4" fmla="*/ 465220 w 641164"/>
                  <a:gd name="connsiteY4" fmla="*/ 203509 h 702699"/>
                  <a:gd name="connsiteX5" fmla="*/ 630524 w 641164"/>
                  <a:gd name="connsiteY5" fmla="*/ 351241 h 702699"/>
                  <a:gd name="connsiteX6" fmla="*/ 609551 w 641164"/>
                  <a:gd name="connsiteY6" fmla="*/ 552439 h 702699"/>
                  <a:gd name="connsiteX7" fmla="*/ 436745 w 641164"/>
                  <a:gd name="connsiteY7" fmla="*/ 658426 h 702699"/>
                  <a:gd name="connsiteX8" fmla="*/ 316199 w 641164"/>
                  <a:gd name="connsiteY8" fmla="*/ 694142 h 702699"/>
                  <a:gd name="connsiteX9" fmla="*/ 179786 w 641164"/>
                  <a:gd name="connsiteY9" fmla="*/ 518482 h 702699"/>
                  <a:gd name="connsiteX10" fmla="*/ 1874 w 641164"/>
                  <a:gd name="connsiteY10" fmla="*/ 351241 h 702699"/>
                  <a:gd name="connsiteX0" fmla="*/ 656 w 639946"/>
                  <a:gd name="connsiteY0" fmla="*/ 351241 h 699899"/>
                  <a:gd name="connsiteX1" fmla="*/ 99191 w 639946"/>
                  <a:gd name="connsiteY1" fmla="*/ 111262 h 699899"/>
                  <a:gd name="connsiteX2" fmla="*/ 189090 w 639946"/>
                  <a:gd name="connsiteY2" fmla="*/ 43259 h 699899"/>
                  <a:gd name="connsiteX3" fmla="*/ 314981 w 639946"/>
                  <a:gd name="connsiteY3" fmla="*/ 8340 h 699899"/>
                  <a:gd name="connsiteX4" fmla="*/ 464002 w 639946"/>
                  <a:gd name="connsiteY4" fmla="*/ 203509 h 699899"/>
                  <a:gd name="connsiteX5" fmla="*/ 629306 w 639946"/>
                  <a:gd name="connsiteY5" fmla="*/ 351241 h 699899"/>
                  <a:gd name="connsiteX6" fmla="*/ 608333 w 639946"/>
                  <a:gd name="connsiteY6" fmla="*/ 552439 h 699899"/>
                  <a:gd name="connsiteX7" fmla="*/ 435527 w 639946"/>
                  <a:gd name="connsiteY7" fmla="*/ 658426 h 699899"/>
                  <a:gd name="connsiteX8" fmla="*/ 314981 w 639946"/>
                  <a:gd name="connsiteY8" fmla="*/ 694142 h 699899"/>
                  <a:gd name="connsiteX9" fmla="*/ 142387 w 639946"/>
                  <a:gd name="connsiteY9" fmla="*/ 558407 h 699899"/>
                  <a:gd name="connsiteX10" fmla="*/ 656 w 639946"/>
                  <a:gd name="connsiteY10" fmla="*/ 351241 h 699899"/>
                  <a:gd name="connsiteX0" fmla="*/ 656 w 643588"/>
                  <a:gd name="connsiteY0" fmla="*/ 351241 h 699899"/>
                  <a:gd name="connsiteX1" fmla="*/ 99191 w 643588"/>
                  <a:gd name="connsiteY1" fmla="*/ 111262 h 699899"/>
                  <a:gd name="connsiteX2" fmla="*/ 189090 w 643588"/>
                  <a:gd name="connsiteY2" fmla="*/ 43259 h 699899"/>
                  <a:gd name="connsiteX3" fmla="*/ 314981 w 643588"/>
                  <a:gd name="connsiteY3" fmla="*/ 8340 h 699899"/>
                  <a:gd name="connsiteX4" fmla="*/ 464002 w 643588"/>
                  <a:gd name="connsiteY4" fmla="*/ 203509 h 699899"/>
                  <a:gd name="connsiteX5" fmla="*/ 629306 w 643588"/>
                  <a:gd name="connsiteY5" fmla="*/ 351241 h 699899"/>
                  <a:gd name="connsiteX6" fmla="*/ 632506 w 643588"/>
                  <a:gd name="connsiteY6" fmla="*/ 441041 h 699899"/>
                  <a:gd name="connsiteX7" fmla="*/ 608333 w 643588"/>
                  <a:gd name="connsiteY7" fmla="*/ 552439 h 699899"/>
                  <a:gd name="connsiteX8" fmla="*/ 435527 w 643588"/>
                  <a:gd name="connsiteY8" fmla="*/ 658426 h 699899"/>
                  <a:gd name="connsiteX9" fmla="*/ 314981 w 643588"/>
                  <a:gd name="connsiteY9" fmla="*/ 694142 h 699899"/>
                  <a:gd name="connsiteX10" fmla="*/ 142387 w 643588"/>
                  <a:gd name="connsiteY10" fmla="*/ 558407 h 699899"/>
                  <a:gd name="connsiteX11" fmla="*/ 656 w 643588"/>
                  <a:gd name="connsiteY11" fmla="*/ 351241 h 699899"/>
                  <a:gd name="connsiteX0" fmla="*/ 656 w 643588"/>
                  <a:gd name="connsiteY0" fmla="*/ 351241 h 698530"/>
                  <a:gd name="connsiteX1" fmla="*/ 99191 w 643588"/>
                  <a:gd name="connsiteY1" fmla="*/ 111262 h 698530"/>
                  <a:gd name="connsiteX2" fmla="*/ 189090 w 643588"/>
                  <a:gd name="connsiteY2" fmla="*/ 43259 h 698530"/>
                  <a:gd name="connsiteX3" fmla="*/ 314981 w 643588"/>
                  <a:gd name="connsiteY3" fmla="*/ 8340 h 698530"/>
                  <a:gd name="connsiteX4" fmla="*/ 464002 w 643588"/>
                  <a:gd name="connsiteY4" fmla="*/ 203509 h 698530"/>
                  <a:gd name="connsiteX5" fmla="*/ 629306 w 643588"/>
                  <a:gd name="connsiteY5" fmla="*/ 351241 h 698530"/>
                  <a:gd name="connsiteX6" fmla="*/ 632506 w 643588"/>
                  <a:gd name="connsiteY6" fmla="*/ 441041 h 698530"/>
                  <a:gd name="connsiteX7" fmla="*/ 608333 w 643588"/>
                  <a:gd name="connsiteY7" fmla="*/ 552439 h 698530"/>
                  <a:gd name="connsiteX8" fmla="*/ 542328 w 643588"/>
                  <a:gd name="connsiteY8" fmla="*/ 589587 h 698530"/>
                  <a:gd name="connsiteX9" fmla="*/ 435527 w 643588"/>
                  <a:gd name="connsiteY9" fmla="*/ 658426 h 698530"/>
                  <a:gd name="connsiteX10" fmla="*/ 314981 w 643588"/>
                  <a:gd name="connsiteY10" fmla="*/ 694142 h 698530"/>
                  <a:gd name="connsiteX11" fmla="*/ 142387 w 643588"/>
                  <a:gd name="connsiteY11" fmla="*/ 558407 h 698530"/>
                  <a:gd name="connsiteX12" fmla="*/ 656 w 643588"/>
                  <a:gd name="connsiteY12" fmla="*/ 351241 h 698530"/>
                  <a:gd name="connsiteX0" fmla="*/ 656 w 643588"/>
                  <a:gd name="connsiteY0" fmla="*/ 351241 h 698530"/>
                  <a:gd name="connsiteX1" fmla="*/ 99191 w 643588"/>
                  <a:gd name="connsiteY1" fmla="*/ 111262 h 698530"/>
                  <a:gd name="connsiteX2" fmla="*/ 189090 w 643588"/>
                  <a:gd name="connsiteY2" fmla="*/ 43259 h 698530"/>
                  <a:gd name="connsiteX3" fmla="*/ 314981 w 643588"/>
                  <a:gd name="connsiteY3" fmla="*/ 8340 h 698530"/>
                  <a:gd name="connsiteX4" fmla="*/ 464002 w 643588"/>
                  <a:gd name="connsiteY4" fmla="*/ 203509 h 698530"/>
                  <a:gd name="connsiteX5" fmla="*/ 629306 w 643588"/>
                  <a:gd name="connsiteY5" fmla="*/ 351241 h 698530"/>
                  <a:gd name="connsiteX6" fmla="*/ 632506 w 643588"/>
                  <a:gd name="connsiteY6" fmla="*/ 441041 h 698530"/>
                  <a:gd name="connsiteX7" fmla="*/ 608333 w 643588"/>
                  <a:gd name="connsiteY7" fmla="*/ 552439 h 698530"/>
                  <a:gd name="connsiteX8" fmla="*/ 548014 w 643588"/>
                  <a:gd name="connsiteY8" fmla="*/ 618976 h 698530"/>
                  <a:gd name="connsiteX9" fmla="*/ 435527 w 643588"/>
                  <a:gd name="connsiteY9" fmla="*/ 658426 h 698530"/>
                  <a:gd name="connsiteX10" fmla="*/ 314981 w 643588"/>
                  <a:gd name="connsiteY10" fmla="*/ 694142 h 698530"/>
                  <a:gd name="connsiteX11" fmla="*/ 142387 w 643588"/>
                  <a:gd name="connsiteY11" fmla="*/ 558407 h 698530"/>
                  <a:gd name="connsiteX12" fmla="*/ 656 w 643588"/>
                  <a:gd name="connsiteY12" fmla="*/ 351241 h 698530"/>
                  <a:gd name="connsiteX0" fmla="*/ 656 w 642979"/>
                  <a:gd name="connsiteY0" fmla="*/ 351241 h 698530"/>
                  <a:gd name="connsiteX1" fmla="*/ 99191 w 642979"/>
                  <a:gd name="connsiteY1" fmla="*/ 111262 h 698530"/>
                  <a:gd name="connsiteX2" fmla="*/ 189090 w 642979"/>
                  <a:gd name="connsiteY2" fmla="*/ 43259 h 698530"/>
                  <a:gd name="connsiteX3" fmla="*/ 314981 w 642979"/>
                  <a:gd name="connsiteY3" fmla="*/ 8340 h 698530"/>
                  <a:gd name="connsiteX4" fmla="*/ 464002 w 642979"/>
                  <a:gd name="connsiteY4" fmla="*/ 203509 h 698530"/>
                  <a:gd name="connsiteX5" fmla="*/ 629306 w 642979"/>
                  <a:gd name="connsiteY5" fmla="*/ 351241 h 698530"/>
                  <a:gd name="connsiteX6" fmla="*/ 632506 w 642979"/>
                  <a:gd name="connsiteY6" fmla="*/ 441041 h 698530"/>
                  <a:gd name="connsiteX7" fmla="*/ 622107 w 642979"/>
                  <a:gd name="connsiteY7" fmla="*/ 488177 h 698530"/>
                  <a:gd name="connsiteX8" fmla="*/ 608333 w 642979"/>
                  <a:gd name="connsiteY8" fmla="*/ 552439 h 698530"/>
                  <a:gd name="connsiteX9" fmla="*/ 548014 w 642979"/>
                  <a:gd name="connsiteY9" fmla="*/ 618976 h 698530"/>
                  <a:gd name="connsiteX10" fmla="*/ 435527 w 642979"/>
                  <a:gd name="connsiteY10" fmla="*/ 658426 h 698530"/>
                  <a:gd name="connsiteX11" fmla="*/ 314981 w 642979"/>
                  <a:gd name="connsiteY11" fmla="*/ 694142 h 698530"/>
                  <a:gd name="connsiteX12" fmla="*/ 142387 w 642979"/>
                  <a:gd name="connsiteY12" fmla="*/ 558407 h 698530"/>
                  <a:gd name="connsiteX13" fmla="*/ 656 w 642979"/>
                  <a:gd name="connsiteY13" fmla="*/ 351241 h 698530"/>
                  <a:gd name="connsiteX0" fmla="*/ 656 w 664488"/>
                  <a:gd name="connsiteY0" fmla="*/ 351241 h 698530"/>
                  <a:gd name="connsiteX1" fmla="*/ 99191 w 664488"/>
                  <a:gd name="connsiteY1" fmla="*/ 111262 h 698530"/>
                  <a:gd name="connsiteX2" fmla="*/ 189090 w 664488"/>
                  <a:gd name="connsiteY2" fmla="*/ 43259 h 698530"/>
                  <a:gd name="connsiteX3" fmla="*/ 314981 w 664488"/>
                  <a:gd name="connsiteY3" fmla="*/ 8340 h 698530"/>
                  <a:gd name="connsiteX4" fmla="*/ 464002 w 664488"/>
                  <a:gd name="connsiteY4" fmla="*/ 203509 h 698530"/>
                  <a:gd name="connsiteX5" fmla="*/ 629306 w 664488"/>
                  <a:gd name="connsiteY5" fmla="*/ 351241 h 698530"/>
                  <a:gd name="connsiteX6" fmla="*/ 632506 w 664488"/>
                  <a:gd name="connsiteY6" fmla="*/ 441041 h 698530"/>
                  <a:gd name="connsiteX7" fmla="*/ 664181 w 664488"/>
                  <a:gd name="connsiteY7" fmla="*/ 481868 h 698530"/>
                  <a:gd name="connsiteX8" fmla="*/ 608333 w 664488"/>
                  <a:gd name="connsiteY8" fmla="*/ 552439 h 698530"/>
                  <a:gd name="connsiteX9" fmla="*/ 548014 w 664488"/>
                  <a:gd name="connsiteY9" fmla="*/ 618976 h 698530"/>
                  <a:gd name="connsiteX10" fmla="*/ 435527 w 664488"/>
                  <a:gd name="connsiteY10" fmla="*/ 658426 h 698530"/>
                  <a:gd name="connsiteX11" fmla="*/ 314981 w 664488"/>
                  <a:gd name="connsiteY11" fmla="*/ 694142 h 698530"/>
                  <a:gd name="connsiteX12" fmla="*/ 142387 w 664488"/>
                  <a:gd name="connsiteY12" fmla="*/ 558407 h 698530"/>
                  <a:gd name="connsiteX13" fmla="*/ 656 w 664488"/>
                  <a:gd name="connsiteY13" fmla="*/ 351241 h 698530"/>
                  <a:gd name="connsiteX0" fmla="*/ 656 w 642979"/>
                  <a:gd name="connsiteY0" fmla="*/ 351241 h 698530"/>
                  <a:gd name="connsiteX1" fmla="*/ 99191 w 642979"/>
                  <a:gd name="connsiteY1" fmla="*/ 111262 h 698530"/>
                  <a:gd name="connsiteX2" fmla="*/ 189090 w 642979"/>
                  <a:gd name="connsiteY2" fmla="*/ 43259 h 698530"/>
                  <a:gd name="connsiteX3" fmla="*/ 314981 w 642979"/>
                  <a:gd name="connsiteY3" fmla="*/ 8340 h 698530"/>
                  <a:gd name="connsiteX4" fmla="*/ 464002 w 642979"/>
                  <a:gd name="connsiteY4" fmla="*/ 203509 h 698530"/>
                  <a:gd name="connsiteX5" fmla="*/ 629306 w 642979"/>
                  <a:gd name="connsiteY5" fmla="*/ 351241 h 698530"/>
                  <a:gd name="connsiteX6" fmla="*/ 632506 w 642979"/>
                  <a:gd name="connsiteY6" fmla="*/ 441041 h 698530"/>
                  <a:gd name="connsiteX7" fmla="*/ 514114 w 642979"/>
                  <a:gd name="connsiteY7" fmla="*/ 446866 h 698530"/>
                  <a:gd name="connsiteX8" fmla="*/ 608333 w 642979"/>
                  <a:gd name="connsiteY8" fmla="*/ 552439 h 698530"/>
                  <a:gd name="connsiteX9" fmla="*/ 548014 w 642979"/>
                  <a:gd name="connsiteY9" fmla="*/ 618976 h 698530"/>
                  <a:gd name="connsiteX10" fmla="*/ 435527 w 642979"/>
                  <a:gd name="connsiteY10" fmla="*/ 658426 h 698530"/>
                  <a:gd name="connsiteX11" fmla="*/ 314981 w 642979"/>
                  <a:gd name="connsiteY11" fmla="*/ 694142 h 698530"/>
                  <a:gd name="connsiteX12" fmla="*/ 142387 w 642979"/>
                  <a:gd name="connsiteY12" fmla="*/ 558407 h 698530"/>
                  <a:gd name="connsiteX13" fmla="*/ 656 w 642979"/>
                  <a:gd name="connsiteY13" fmla="*/ 351241 h 698530"/>
                  <a:gd name="connsiteX0" fmla="*/ 656 w 642979"/>
                  <a:gd name="connsiteY0" fmla="*/ 351241 h 698530"/>
                  <a:gd name="connsiteX1" fmla="*/ 99191 w 642979"/>
                  <a:gd name="connsiteY1" fmla="*/ 111262 h 698530"/>
                  <a:gd name="connsiteX2" fmla="*/ 189090 w 642979"/>
                  <a:gd name="connsiteY2" fmla="*/ 43259 h 698530"/>
                  <a:gd name="connsiteX3" fmla="*/ 314981 w 642979"/>
                  <a:gd name="connsiteY3" fmla="*/ 8340 h 698530"/>
                  <a:gd name="connsiteX4" fmla="*/ 464002 w 642979"/>
                  <a:gd name="connsiteY4" fmla="*/ 203509 h 698530"/>
                  <a:gd name="connsiteX5" fmla="*/ 629306 w 642979"/>
                  <a:gd name="connsiteY5" fmla="*/ 351241 h 698530"/>
                  <a:gd name="connsiteX6" fmla="*/ 632506 w 642979"/>
                  <a:gd name="connsiteY6" fmla="*/ 441041 h 698530"/>
                  <a:gd name="connsiteX7" fmla="*/ 514114 w 642979"/>
                  <a:gd name="connsiteY7" fmla="*/ 446866 h 698530"/>
                  <a:gd name="connsiteX8" fmla="*/ 608333 w 642979"/>
                  <a:gd name="connsiteY8" fmla="*/ 552439 h 698530"/>
                  <a:gd name="connsiteX9" fmla="*/ 429692 w 642979"/>
                  <a:gd name="connsiteY9" fmla="*/ 540027 h 698530"/>
                  <a:gd name="connsiteX10" fmla="*/ 435527 w 642979"/>
                  <a:gd name="connsiteY10" fmla="*/ 658426 h 698530"/>
                  <a:gd name="connsiteX11" fmla="*/ 314981 w 642979"/>
                  <a:gd name="connsiteY11" fmla="*/ 694142 h 698530"/>
                  <a:gd name="connsiteX12" fmla="*/ 142387 w 642979"/>
                  <a:gd name="connsiteY12" fmla="*/ 558407 h 698530"/>
                  <a:gd name="connsiteX13" fmla="*/ 656 w 642979"/>
                  <a:gd name="connsiteY13" fmla="*/ 351241 h 698530"/>
                  <a:gd name="connsiteX0" fmla="*/ 656 w 642979"/>
                  <a:gd name="connsiteY0" fmla="*/ 351241 h 698530"/>
                  <a:gd name="connsiteX1" fmla="*/ 99191 w 642979"/>
                  <a:gd name="connsiteY1" fmla="*/ 111262 h 698530"/>
                  <a:gd name="connsiteX2" fmla="*/ 189090 w 642979"/>
                  <a:gd name="connsiteY2" fmla="*/ 43259 h 698530"/>
                  <a:gd name="connsiteX3" fmla="*/ 314981 w 642979"/>
                  <a:gd name="connsiteY3" fmla="*/ 8340 h 698530"/>
                  <a:gd name="connsiteX4" fmla="*/ 464002 w 642979"/>
                  <a:gd name="connsiteY4" fmla="*/ 203509 h 698530"/>
                  <a:gd name="connsiteX5" fmla="*/ 629306 w 642979"/>
                  <a:gd name="connsiteY5" fmla="*/ 351241 h 698530"/>
                  <a:gd name="connsiteX6" fmla="*/ 632506 w 642979"/>
                  <a:gd name="connsiteY6" fmla="*/ 441041 h 698530"/>
                  <a:gd name="connsiteX7" fmla="*/ 514114 w 642979"/>
                  <a:gd name="connsiteY7" fmla="*/ 446866 h 698530"/>
                  <a:gd name="connsiteX8" fmla="*/ 608333 w 642979"/>
                  <a:gd name="connsiteY8" fmla="*/ 552439 h 698530"/>
                  <a:gd name="connsiteX9" fmla="*/ 465245 w 642979"/>
                  <a:gd name="connsiteY9" fmla="*/ 487421 h 698530"/>
                  <a:gd name="connsiteX10" fmla="*/ 429692 w 642979"/>
                  <a:gd name="connsiteY10" fmla="*/ 540027 h 698530"/>
                  <a:gd name="connsiteX11" fmla="*/ 435527 w 642979"/>
                  <a:gd name="connsiteY11" fmla="*/ 658426 h 698530"/>
                  <a:gd name="connsiteX12" fmla="*/ 314981 w 642979"/>
                  <a:gd name="connsiteY12" fmla="*/ 694142 h 698530"/>
                  <a:gd name="connsiteX13" fmla="*/ 142387 w 642979"/>
                  <a:gd name="connsiteY13" fmla="*/ 558407 h 698530"/>
                  <a:gd name="connsiteX14" fmla="*/ 656 w 642979"/>
                  <a:gd name="connsiteY14" fmla="*/ 351241 h 698530"/>
                  <a:gd name="connsiteX0" fmla="*/ 656 w 642979"/>
                  <a:gd name="connsiteY0" fmla="*/ 351241 h 694351"/>
                  <a:gd name="connsiteX1" fmla="*/ 99191 w 642979"/>
                  <a:gd name="connsiteY1" fmla="*/ 111262 h 694351"/>
                  <a:gd name="connsiteX2" fmla="*/ 189090 w 642979"/>
                  <a:gd name="connsiteY2" fmla="*/ 43259 h 694351"/>
                  <a:gd name="connsiteX3" fmla="*/ 314981 w 642979"/>
                  <a:gd name="connsiteY3" fmla="*/ 8340 h 694351"/>
                  <a:gd name="connsiteX4" fmla="*/ 464002 w 642979"/>
                  <a:gd name="connsiteY4" fmla="*/ 203509 h 694351"/>
                  <a:gd name="connsiteX5" fmla="*/ 629306 w 642979"/>
                  <a:gd name="connsiteY5" fmla="*/ 351241 h 694351"/>
                  <a:gd name="connsiteX6" fmla="*/ 632506 w 642979"/>
                  <a:gd name="connsiteY6" fmla="*/ 441041 h 694351"/>
                  <a:gd name="connsiteX7" fmla="*/ 514114 w 642979"/>
                  <a:gd name="connsiteY7" fmla="*/ 446866 h 694351"/>
                  <a:gd name="connsiteX8" fmla="*/ 608333 w 642979"/>
                  <a:gd name="connsiteY8" fmla="*/ 552439 h 694351"/>
                  <a:gd name="connsiteX9" fmla="*/ 465245 w 642979"/>
                  <a:gd name="connsiteY9" fmla="*/ 487421 h 694351"/>
                  <a:gd name="connsiteX10" fmla="*/ 429692 w 642979"/>
                  <a:gd name="connsiteY10" fmla="*/ 540027 h 694351"/>
                  <a:gd name="connsiteX11" fmla="*/ 372795 w 642979"/>
                  <a:gd name="connsiteY11" fmla="*/ 589459 h 694351"/>
                  <a:gd name="connsiteX12" fmla="*/ 314981 w 642979"/>
                  <a:gd name="connsiteY12" fmla="*/ 694142 h 694351"/>
                  <a:gd name="connsiteX13" fmla="*/ 142387 w 642979"/>
                  <a:gd name="connsiteY13" fmla="*/ 558407 h 694351"/>
                  <a:gd name="connsiteX14" fmla="*/ 656 w 642979"/>
                  <a:gd name="connsiteY14" fmla="*/ 351241 h 694351"/>
                  <a:gd name="connsiteX0" fmla="*/ 656 w 642979"/>
                  <a:gd name="connsiteY0" fmla="*/ 351241 h 596438"/>
                  <a:gd name="connsiteX1" fmla="*/ 99191 w 642979"/>
                  <a:gd name="connsiteY1" fmla="*/ 111262 h 596438"/>
                  <a:gd name="connsiteX2" fmla="*/ 189090 w 642979"/>
                  <a:gd name="connsiteY2" fmla="*/ 43259 h 596438"/>
                  <a:gd name="connsiteX3" fmla="*/ 314981 w 642979"/>
                  <a:gd name="connsiteY3" fmla="*/ 8340 h 596438"/>
                  <a:gd name="connsiteX4" fmla="*/ 464002 w 642979"/>
                  <a:gd name="connsiteY4" fmla="*/ 203509 h 596438"/>
                  <a:gd name="connsiteX5" fmla="*/ 629306 w 642979"/>
                  <a:gd name="connsiteY5" fmla="*/ 351241 h 596438"/>
                  <a:gd name="connsiteX6" fmla="*/ 632506 w 642979"/>
                  <a:gd name="connsiteY6" fmla="*/ 441041 h 596438"/>
                  <a:gd name="connsiteX7" fmla="*/ 514114 w 642979"/>
                  <a:gd name="connsiteY7" fmla="*/ 446866 h 596438"/>
                  <a:gd name="connsiteX8" fmla="*/ 608333 w 642979"/>
                  <a:gd name="connsiteY8" fmla="*/ 552439 h 596438"/>
                  <a:gd name="connsiteX9" fmla="*/ 465245 w 642979"/>
                  <a:gd name="connsiteY9" fmla="*/ 487421 h 596438"/>
                  <a:gd name="connsiteX10" fmla="*/ 429692 w 642979"/>
                  <a:gd name="connsiteY10" fmla="*/ 540027 h 596438"/>
                  <a:gd name="connsiteX11" fmla="*/ 372795 w 642979"/>
                  <a:gd name="connsiteY11" fmla="*/ 589459 h 596438"/>
                  <a:gd name="connsiteX12" fmla="*/ 275539 w 642979"/>
                  <a:gd name="connsiteY12" fmla="*/ 581644 h 596438"/>
                  <a:gd name="connsiteX13" fmla="*/ 142387 w 642979"/>
                  <a:gd name="connsiteY13" fmla="*/ 558407 h 596438"/>
                  <a:gd name="connsiteX14" fmla="*/ 656 w 642979"/>
                  <a:gd name="connsiteY14" fmla="*/ 351241 h 596438"/>
                  <a:gd name="connsiteX0" fmla="*/ 7365 w 582037"/>
                  <a:gd name="connsiteY0" fmla="*/ 347911 h 596438"/>
                  <a:gd name="connsiteX1" fmla="*/ 38249 w 582037"/>
                  <a:gd name="connsiteY1" fmla="*/ 111262 h 596438"/>
                  <a:gd name="connsiteX2" fmla="*/ 128148 w 582037"/>
                  <a:gd name="connsiteY2" fmla="*/ 43259 h 596438"/>
                  <a:gd name="connsiteX3" fmla="*/ 254039 w 582037"/>
                  <a:gd name="connsiteY3" fmla="*/ 8340 h 596438"/>
                  <a:gd name="connsiteX4" fmla="*/ 403060 w 582037"/>
                  <a:gd name="connsiteY4" fmla="*/ 203509 h 596438"/>
                  <a:gd name="connsiteX5" fmla="*/ 568364 w 582037"/>
                  <a:gd name="connsiteY5" fmla="*/ 351241 h 596438"/>
                  <a:gd name="connsiteX6" fmla="*/ 571564 w 582037"/>
                  <a:gd name="connsiteY6" fmla="*/ 441041 h 596438"/>
                  <a:gd name="connsiteX7" fmla="*/ 453172 w 582037"/>
                  <a:gd name="connsiteY7" fmla="*/ 446866 h 596438"/>
                  <a:gd name="connsiteX8" fmla="*/ 547391 w 582037"/>
                  <a:gd name="connsiteY8" fmla="*/ 552439 h 596438"/>
                  <a:gd name="connsiteX9" fmla="*/ 404303 w 582037"/>
                  <a:gd name="connsiteY9" fmla="*/ 487421 h 596438"/>
                  <a:gd name="connsiteX10" fmla="*/ 368750 w 582037"/>
                  <a:gd name="connsiteY10" fmla="*/ 540027 h 596438"/>
                  <a:gd name="connsiteX11" fmla="*/ 311853 w 582037"/>
                  <a:gd name="connsiteY11" fmla="*/ 589459 h 596438"/>
                  <a:gd name="connsiteX12" fmla="*/ 214597 w 582037"/>
                  <a:gd name="connsiteY12" fmla="*/ 581644 h 596438"/>
                  <a:gd name="connsiteX13" fmla="*/ 81445 w 582037"/>
                  <a:gd name="connsiteY13" fmla="*/ 558407 h 596438"/>
                  <a:gd name="connsiteX14" fmla="*/ 7365 w 582037"/>
                  <a:gd name="connsiteY14" fmla="*/ 347911 h 596438"/>
                  <a:gd name="connsiteX0" fmla="*/ 531 w 575203"/>
                  <a:gd name="connsiteY0" fmla="*/ 347911 h 596438"/>
                  <a:gd name="connsiteX1" fmla="*/ 57409 w 575203"/>
                  <a:gd name="connsiteY1" fmla="*/ 122698 h 596438"/>
                  <a:gd name="connsiteX2" fmla="*/ 121314 w 575203"/>
                  <a:gd name="connsiteY2" fmla="*/ 43259 h 596438"/>
                  <a:gd name="connsiteX3" fmla="*/ 247205 w 575203"/>
                  <a:gd name="connsiteY3" fmla="*/ 8340 h 596438"/>
                  <a:gd name="connsiteX4" fmla="*/ 396226 w 575203"/>
                  <a:gd name="connsiteY4" fmla="*/ 203509 h 596438"/>
                  <a:gd name="connsiteX5" fmla="*/ 561530 w 575203"/>
                  <a:gd name="connsiteY5" fmla="*/ 351241 h 596438"/>
                  <a:gd name="connsiteX6" fmla="*/ 564730 w 575203"/>
                  <a:gd name="connsiteY6" fmla="*/ 441041 h 596438"/>
                  <a:gd name="connsiteX7" fmla="*/ 446338 w 575203"/>
                  <a:gd name="connsiteY7" fmla="*/ 446866 h 596438"/>
                  <a:gd name="connsiteX8" fmla="*/ 540557 w 575203"/>
                  <a:gd name="connsiteY8" fmla="*/ 552439 h 596438"/>
                  <a:gd name="connsiteX9" fmla="*/ 397469 w 575203"/>
                  <a:gd name="connsiteY9" fmla="*/ 487421 h 596438"/>
                  <a:gd name="connsiteX10" fmla="*/ 361916 w 575203"/>
                  <a:gd name="connsiteY10" fmla="*/ 540027 h 596438"/>
                  <a:gd name="connsiteX11" fmla="*/ 305019 w 575203"/>
                  <a:gd name="connsiteY11" fmla="*/ 589459 h 596438"/>
                  <a:gd name="connsiteX12" fmla="*/ 207763 w 575203"/>
                  <a:gd name="connsiteY12" fmla="*/ 581644 h 596438"/>
                  <a:gd name="connsiteX13" fmla="*/ 74611 w 575203"/>
                  <a:gd name="connsiteY13" fmla="*/ 558407 h 596438"/>
                  <a:gd name="connsiteX14" fmla="*/ 531 w 575203"/>
                  <a:gd name="connsiteY14" fmla="*/ 347911 h 596438"/>
                  <a:gd name="connsiteX0" fmla="*/ 531 w 575203"/>
                  <a:gd name="connsiteY0" fmla="*/ 314228 h 562755"/>
                  <a:gd name="connsiteX1" fmla="*/ 57409 w 575203"/>
                  <a:gd name="connsiteY1" fmla="*/ 89015 h 562755"/>
                  <a:gd name="connsiteX2" fmla="*/ 121314 w 575203"/>
                  <a:gd name="connsiteY2" fmla="*/ 9576 h 562755"/>
                  <a:gd name="connsiteX3" fmla="*/ 249702 w 575203"/>
                  <a:gd name="connsiteY3" fmla="*/ 25395 h 562755"/>
                  <a:gd name="connsiteX4" fmla="*/ 396226 w 575203"/>
                  <a:gd name="connsiteY4" fmla="*/ 169826 h 562755"/>
                  <a:gd name="connsiteX5" fmla="*/ 561530 w 575203"/>
                  <a:gd name="connsiteY5" fmla="*/ 317558 h 562755"/>
                  <a:gd name="connsiteX6" fmla="*/ 564730 w 575203"/>
                  <a:gd name="connsiteY6" fmla="*/ 407358 h 562755"/>
                  <a:gd name="connsiteX7" fmla="*/ 446338 w 575203"/>
                  <a:gd name="connsiteY7" fmla="*/ 413183 h 562755"/>
                  <a:gd name="connsiteX8" fmla="*/ 540557 w 575203"/>
                  <a:gd name="connsiteY8" fmla="*/ 518756 h 562755"/>
                  <a:gd name="connsiteX9" fmla="*/ 397469 w 575203"/>
                  <a:gd name="connsiteY9" fmla="*/ 453738 h 562755"/>
                  <a:gd name="connsiteX10" fmla="*/ 361916 w 575203"/>
                  <a:gd name="connsiteY10" fmla="*/ 506344 h 562755"/>
                  <a:gd name="connsiteX11" fmla="*/ 305019 w 575203"/>
                  <a:gd name="connsiteY11" fmla="*/ 555776 h 562755"/>
                  <a:gd name="connsiteX12" fmla="*/ 207763 w 575203"/>
                  <a:gd name="connsiteY12" fmla="*/ 547961 h 562755"/>
                  <a:gd name="connsiteX13" fmla="*/ 74611 w 575203"/>
                  <a:gd name="connsiteY13" fmla="*/ 524724 h 562755"/>
                  <a:gd name="connsiteX14" fmla="*/ 531 w 575203"/>
                  <a:gd name="connsiteY14" fmla="*/ 314228 h 562755"/>
                  <a:gd name="connsiteX0" fmla="*/ 531 w 575203"/>
                  <a:gd name="connsiteY0" fmla="*/ 312695 h 561222"/>
                  <a:gd name="connsiteX1" fmla="*/ 57409 w 575203"/>
                  <a:gd name="connsiteY1" fmla="*/ 87482 h 561222"/>
                  <a:gd name="connsiteX2" fmla="*/ 121314 w 575203"/>
                  <a:gd name="connsiteY2" fmla="*/ 8043 h 561222"/>
                  <a:gd name="connsiteX3" fmla="*/ 249702 w 575203"/>
                  <a:gd name="connsiteY3" fmla="*/ 23862 h 561222"/>
                  <a:gd name="connsiteX4" fmla="*/ 398584 w 575203"/>
                  <a:gd name="connsiteY4" fmla="*/ 130031 h 561222"/>
                  <a:gd name="connsiteX5" fmla="*/ 561530 w 575203"/>
                  <a:gd name="connsiteY5" fmla="*/ 316025 h 561222"/>
                  <a:gd name="connsiteX6" fmla="*/ 564730 w 575203"/>
                  <a:gd name="connsiteY6" fmla="*/ 405825 h 561222"/>
                  <a:gd name="connsiteX7" fmla="*/ 446338 w 575203"/>
                  <a:gd name="connsiteY7" fmla="*/ 411650 h 561222"/>
                  <a:gd name="connsiteX8" fmla="*/ 540557 w 575203"/>
                  <a:gd name="connsiteY8" fmla="*/ 517223 h 561222"/>
                  <a:gd name="connsiteX9" fmla="*/ 397469 w 575203"/>
                  <a:gd name="connsiteY9" fmla="*/ 452205 h 561222"/>
                  <a:gd name="connsiteX10" fmla="*/ 361916 w 575203"/>
                  <a:gd name="connsiteY10" fmla="*/ 504811 h 561222"/>
                  <a:gd name="connsiteX11" fmla="*/ 305019 w 575203"/>
                  <a:gd name="connsiteY11" fmla="*/ 554243 h 561222"/>
                  <a:gd name="connsiteX12" fmla="*/ 207763 w 575203"/>
                  <a:gd name="connsiteY12" fmla="*/ 546428 h 561222"/>
                  <a:gd name="connsiteX13" fmla="*/ 74611 w 575203"/>
                  <a:gd name="connsiteY13" fmla="*/ 523191 h 561222"/>
                  <a:gd name="connsiteX14" fmla="*/ 531 w 575203"/>
                  <a:gd name="connsiteY14" fmla="*/ 312695 h 56122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</a:cxnLst>
                <a:rect l="l" t="t" r="r" b="b"/>
                <a:pathLst>
                  <a:path w="575203" h="561222">
                    <a:moveTo>
                      <a:pt x="531" y="312695"/>
                    </a:moveTo>
                    <a:cubicBezTo>
                      <a:pt x="-2336" y="240077"/>
                      <a:pt x="5022" y="144632"/>
                      <a:pt x="57409" y="87482"/>
                    </a:cubicBezTo>
                    <a:cubicBezTo>
                      <a:pt x="88815" y="36152"/>
                      <a:pt x="85349" y="25197"/>
                      <a:pt x="121314" y="8043"/>
                    </a:cubicBezTo>
                    <a:cubicBezTo>
                      <a:pt x="157279" y="-9111"/>
                      <a:pt x="203490" y="3531"/>
                      <a:pt x="249702" y="23862"/>
                    </a:cubicBezTo>
                    <a:cubicBezTo>
                      <a:pt x="295914" y="44193"/>
                      <a:pt x="346197" y="72881"/>
                      <a:pt x="398584" y="130031"/>
                    </a:cubicBezTo>
                    <a:cubicBezTo>
                      <a:pt x="450971" y="187181"/>
                      <a:pt x="533446" y="276436"/>
                      <a:pt x="561530" y="316025"/>
                    </a:cubicBezTo>
                    <a:cubicBezTo>
                      <a:pt x="589614" y="355614"/>
                      <a:pt x="565930" y="383002"/>
                      <a:pt x="564730" y="405825"/>
                    </a:cubicBezTo>
                    <a:cubicBezTo>
                      <a:pt x="563530" y="428648"/>
                      <a:pt x="450367" y="393084"/>
                      <a:pt x="446338" y="411650"/>
                    </a:cubicBezTo>
                    <a:cubicBezTo>
                      <a:pt x="442309" y="430216"/>
                      <a:pt x="529860" y="500795"/>
                      <a:pt x="540557" y="517223"/>
                    </a:cubicBezTo>
                    <a:cubicBezTo>
                      <a:pt x="551254" y="533651"/>
                      <a:pt x="427242" y="454274"/>
                      <a:pt x="397469" y="452205"/>
                    </a:cubicBezTo>
                    <a:cubicBezTo>
                      <a:pt x="367696" y="450136"/>
                      <a:pt x="385711" y="485979"/>
                      <a:pt x="361916" y="504811"/>
                    </a:cubicBezTo>
                    <a:cubicBezTo>
                      <a:pt x="338121" y="523643"/>
                      <a:pt x="342910" y="536817"/>
                      <a:pt x="305019" y="554243"/>
                    </a:cubicBezTo>
                    <a:cubicBezTo>
                      <a:pt x="267128" y="571669"/>
                      <a:pt x="246164" y="551603"/>
                      <a:pt x="207763" y="546428"/>
                    </a:cubicBezTo>
                    <a:cubicBezTo>
                      <a:pt x="169362" y="541253"/>
                      <a:pt x="126998" y="580341"/>
                      <a:pt x="74611" y="523191"/>
                    </a:cubicBezTo>
                    <a:cubicBezTo>
                      <a:pt x="22224" y="466041"/>
                      <a:pt x="3398" y="385313"/>
                      <a:pt x="531" y="312695"/>
                    </a:cubicBezTo>
                    <a:close/>
                  </a:path>
                </a:pathLst>
              </a:custGeom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b="1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5" name="Rectangle 134"/>
              <p:cNvSpPr/>
              <p:nvPr/>
            </p:nvSpPr>
            <p:spPr>
              <a:xfrm>
                <a:off x="0" y="65349"/>
                <a:ext cx="719941" cy="37555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N" kern="1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TFAM</a:t>
                </a:r>
                <a:endParaRPr lang="en-IN" kern="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36" name="Group 135"/>
            <p:cNvGrpSpPr/>
            <p:nvPr/>
          </p:nvGrpSpPr>
          <p:grpSpPr>
            <a:xfrm>
              <a:off x="8243961" y="1631993"/>
              <a:ext cx="719941" cy="575201"/>
              <a:chOff x="0" y="-133229"/>
              <a:chExt cx="719941" cy="575201"/>
            </a:xfrm>
          </p:grpSpPr>
          <p:sp>
            <p:nvSpPr>
              <p:cNvPr id="137" name="Oval 454"/>
              <p:cNvSpPr/>
              <p:nvPr/>
            </p:nvSpPr>
            <p:spPr bwMode="auto">
              <a:xfrm rot="16369013">
                <a:off x="101966" y="-126240"/>
                <a:ext cx="575201" cy="561223"/>
              </a:xfrm>
              <a:custGeom>
                <a:avLst/>
                <a:gdLst>
                  <a:gd name="connsiteX0" fmla="*/ 0 w 628650"/>
                  <a:gd name="connsiteY0" fmla="*/ 342901 h 685801"/>
                  <a:gd name="connsiteX1" fmla="*/ 314325 w 628650"/>
                  <a:gd name="connsiteY1" fmla="*/ 0 h 685801"/>
                  <a:gd name="connsiteX2" fmla="*/ 628650 w 628650"/>
                  <a:gd name="connsiteY2" fmla="*/ 342901 h 685801"/>
                  <a:gd name="connsiteX3" fmla="*/ 314325 w 628650"/>
                  <a:gd name="connsiteY3" fmla="*/ 685802 h 685801"/>
                  <a:gd name="connsiteX4" fmla="*/ 0 w 628650"/>
                  <a:gd name="connsiteY4" fmla="*/ 342901 h 685801"/>
                  <a:gd name="connsiteX0" fmla="*/ 0 w 650253"/>
                  <a:gd name="connsiteY0" fmla="*/ 342901 h 688891"/>
                  <a:gd name="connsiteX1" fmla="*/ 314325 w 650253"/>
                  <a:gd name="connsiteY1" fmla="*/ 0 h 688891"/>
                  <a:gd name="connsiteX2" fmla="*/ 628650 w 650253"/>
                  <a:gd name="connsiteY2" fmla="*/ 342901 h 688891"/>
                  <a:gd name="connsiteX3" fmla="*/ 588683 w 650253"/>
                  <a:gd name="connsiteY3" fmla="*/ 502649 h 688891"/>
                  <a:gd name="connsiteX4" fmla="*/ 314325 w 650253"/>
                  <a:gd name="connsiteY4" fmla="*/ 685802 h 688891"/>
                  <a:gd name="connsiteX5" fmla="*/ 0 w 650253"/>
                  <a:gd name="connsiteY5" fmla="*/ 342901 h 688891"/>
                  <a:gd name="connsiteX0" fmla="*/ 0 w 646386"/>
                  <a:gd name="connsiteY0" fmla="*/ 342901 h 706454"/>
                  <a:gd name="connsiteX1" fmla="*/ 314325 w 646386"/>
                  <a:gd name="connsiteY1" fmla="*/ 0 h 706454"/>
                  <a:gd name="connsiteX2" fmla="*/ 628650 w 646386"/>
                  <a:gd name="connsiteY2" fmla="*/ 342901 h 706454"/>
                  <a:gd name="connsiteX3" fmla="*/ 588683 w 646386"/>
                  <a:gd name="connsiteY3" fmla="*/ 502649 h 706454"/>
                  <a:gd name="connsiteX4" fmla="*/ 434871 w 646386"/>
                  <a:gd name="connsiteY4" fmla="*/ 650086 h 706454"/>
                  <a:gd name="connsiteX5" fmla="*/ 314325 w 646386"/>
                  <a:gd name="connsiteY5" fmla="*/ 685802 h 706454"/>
                  <a:gd name="connsiteX6" fmla="*/ 0 w 646386"/>
                  <a:gd name="connsiteY6" fmla="*/ 342901 h 706454"/>
                  <a:gd name="connsiteX0" fmla="*/ 4180 w 650566"/>
                  <a:gd name="connsiteY0" fmla="*/ 342901 h 686680"/>
                  <a:gd name="connsiteX1" fmla="*/ 318505 w 650566"/>
                  <a:gd name="connsiteY1" fmla="*/ 0 h 686680"/>
                  <a:gd name="connsiteX2" fmla="*/ 632830 w 650566"/>
                  <a:gd name="connsiteY2" fmla="*/ 342901 h 686680"/>
                  <a:gd name="connsiteX3" fmla="*/ 592863 w 650566"/>
                  <a:gd name="connsiteY3" fmla="*/ 502649 h 686680"/>
                  <a:gd name="connsiteX4" fmla="*/ 439051 w 650566"/>
                  <a:gd name="connsiteY4" fmla="*/ 650086 h 686680"/>
                  <a:gd name="connsiteX5" fmla="*/ 318505 w 650566"/>
                  <a:gd name="connsiteY5" fmla="*/ 685802 h 686680"/>
                  <a:gd name="connsiteX6" fmla="*/ 149656 w 650566"/>
                  <a:gd name="connsiteY6" fmla="*/ 626177 h 686680"/>
                  <a:gd name="connsiteX7" fmla="*/ 4180 w 650566"/>
                  <a:gd name="connsiteY7" fmla="*/ 342901 h 686680"/>
                  <a:gd name="connsiteX0" fmla="*/ 4180 w 650566"/>
                  <a:gd name="connsiteY0" fmla="*/ 353175 h 696954"/>
                  <a:gd name="connsiteX1" fmla="*/ 102715 w 650566"/>
                  <a:gd name="connsiteY1" fmla="*/ 113196 h 696954"/>
                  <a:gd name="connsiteX2" fmla="*/ 318505 w 650566"/>
                  <a:gd name="connsiteY2" fmla="*/ 10274 h 696954"/>
                  <a:gd name="connsiteX3" fmla="*/ 632830 w 650566"/>
                  <a:gd name="connsiteY3" fmla="*/ 353175 h 696954"/>
                  <a:gd name="connsiteX4" fmla="*/ 592863 w 650566"/>
                  <a:gd name="connsiteY4" fmla="*/ 512923 h 696954"/>
                  <a:gd name="connsiteX5" fmla="*/ 439051 w 650566"/>
                  <a:gd name="connsiteY5" fmla="*/ 660360 h 696954"/>
                  <a:gd name="connsiteX6" fmla="*/ 318505 w 650566"/>
                  <a:gd name="connsiteY6" fmla="*/ 696076 h 696954"/>
                  <a:gd name="connsiteX7" fmla="*/ 149656 w 650566"/>
                  <a:gd name="connsiteY7" fmla="*/ 636451 h 696954"/>
                  <a:gd name="connsiteX8" fmla="*/ 4180 w 650566"/>
                  <a:gd name="connsiteY8" fmla="*/ 353175 h 696954"/>
                  <a:gd name="connsiteX0" fmla="*/ 4180 w 639547"/>
                  <a:gd name="connsiteY0" fmla="*/ 343504 h 687283"/>
                  <a:gd name="connsiteX1" fmla="*/ 102715 w 639547"/>
                  <a:gd name="connsiteY1" fmla="*/ 103525 h 687283"/>
                  <a:gd name="connsiteX2" fmla="*/ 318505 w 639547"/>
                  <a:gd name="connsiteY2" fmla="*/ 603 h 687283"/>
                  <a:gd name="connsiteX3" fmla="*/ 473484 w 639547"/>
                  <a:gd name="connsiteY3" fmla="*/ 144619 h 687283"/>
                  <a:gd name="connsiteX4" fmla="*/ 632830 w 639547"/>
                  <a:gd name="connsiteY4" fmla="*/ 343504 h 687283"/>
                  <a:gd name="connsiteX5" fmla="*/ 592863 w 639547"/>
                  <a:gd name="connsiteY5" fmla="*/ 503252 h 687283"/>
                  <a:gd name="connsiteX6" fmla="*/ 439051 w 639547"/>
                  <a:gd name="connsiteY6" fmla="*/ 650689 h 687283"/>
                  <a:gd name="connsiteX7" fmla="*/ 318505 w 639547"/>
                  <a:gd name="connsiteY7" fmla="*/ 686405 h 687283"/>
                  <a:gd name="connsiteX8" fmla="*/ 149656 w 639547"/>
                  <a:gd name="connsiteY8" fmla="*/ 626780 h 687283"/>
                  <a:gd name="connsiteX9" fmla="*/ 4180 w 639547"/>
                  <a:gd name="connsiteY9" fmla="*/ 343504 h 687283"/>
                  <a:gd name="connsiteX0" fmla="*/ 4180 w 639547"/>
                  <a:gd name="connsiteY0" fmla="*/ 347904 h 691683"/>
                  <a:gd name="connsiteX1" fmla="*/ 102715 w 639547"/>
                  <a:gd name="connsiteY1" fmla="*/ 107925 h 691683"/>
                  <a:gd name="connsiteX2" fmla="*/ 192614 w 639547"/>
                  <a:gd name="connsiteY2" fmla="*/ 39922 h 691683"/>
                  <a:gd name="connsiteX3" fmla="*/ 318505 w 639547"/>
                  <a:gd name="connsiteY3" fmla="*/ 5003 h 691683"/>
                  <a:gd name="connsiteX4" fmla="*/ 473484 w 639547"/>
                  <a:gd name="connsiteY4" fmla="*/ 149019 h 691683"/>
                  <a:gd name="connsiteX5" fmla="*/ 632830 w 639547"/>
                  <a:gd name="connsiteY5" fmla="*/ 347904 h 691683"/>
                  <a:gd name="connsiteX6" fmla="*/ 592863 w 639547"/>
                  <a:gd name="connsiteY6" fmla="*/ 507652 h 691683"/>
                  <a:gd name="connsiteX7" fmla="*/ 439051 w 639547"/>
                  <a:gd name="connsiteY7" fmla="*/ 655089 h 691683"/>
                  <a:gd name="connsiteX8" fmla="*/ 318505 w 639547"/>
                  <a:gd name="connsiteY8" fmla="*/ 690805 h 691683"/>
                  <a:gd name="connsiteX9" fmla="*/ 149656 w 639547"/>
                  <a:gd name="connsiteY9" fmla="*/ 631180 h 691683"/>
                  <a:gd name="connsiteX10" fmla="*/ 4180 w 639547"/>
                  <a:gd name="connsiteY10" fmla="*/ 347904 h 691683"/>
                  <a:gd name="connsiteX0" fmla="*/ 4180 w 643470"/>
                  <a:gd name="connsiteY0" fmla="*/ 347904 h 691683"/>
                  <a:gd name="connsiteX1" fmla="*/ 102715 w 643470"/>
                  <a:gd name="connsiteY1" fmla="*/ 107925 h 691683"/>
                  <a:gd name="connsiteX2" fmla="*/ 192614 w 643470"/>
                  <a:gd name="connsiteY2" fmla="*/ 39922 h 691683"/>
                  <a:gd name="connsiteX3" fmla="*/ 318505 w 643470"/>
                  <a:gd name="connsiteY3" fmla="*/ 5003 h 691683"/>
                  <a:gd name="connsiteX4" fmla="*/ 473484 w 643470"/>
                  <a:gd name="connsiteY4" fmla="*/ 149019 h 691683"/>
                  <a:gd name="connsiteX5" fmla="*/ 632830 w 643470"/>
                  <a:gd name="connsiteY5" fmla="*/ 347904 h 691683"/>
                  <a:gd name="connsiteX6" fmla="*/ 611857 w 643470"/>
                  <a:gd name="connsiteY6" fmla="*/ 549102 h 691683"/>
                  <a:gd name="connsiteX7" fmla="*/ 439051 w 643470"/>
                  <a:gd name="connsiteY7" fmla="*/ 655089 h 691683"/>
                  <a:gd name="connsiteX8" fmla="*/ 318505 w 643470"/>
                  <a:gd name="connsiteY8" fmla="*/ 690805 h 691683"/>
                  <a:gd name="connsiteX9" fmla="*/ 149656 w 643470"/>
                  <a:gd name="connsiteY9" fmla="*/ 631180 h 691683"/>
                  <a:gd name="connsiteX10" fmla="*/ 4180 w 643470"/>
                  <a:gd name="connsiteY10" fmla="*/ 347904 h 691683"/>
                  <a:gd name="connsiteX0" fmla="*/ 4180 w 643470"/>
                  <a:gd name="connsiteY0" fmla="*/ 351241 h 695020"/>
                  <a:gd name="connsiteX1" fmla="*/ 102715 w 643470"/>
                  <a:gd name="connsiteY1" fmla="*/ 111262 h 695020"/>
                  <a:gd name="connsiteX2" fmla="*/ 192614 w 643470"/>
                  <a:gd name="connsiteY2" fmla="*/ 43259 h 695020"/>
                  <a:gd name="connsiteX3" fmla="*/ 318505 w 643470"/>
                  <a:gd name="connsiteY3" fmla="*/ 8340 h 695020"/>
                  <a:gd name="connsiteX4" fmla="*/ 467526 w 643470"/>
                  <a:gd name="connsiteY4" fmla="*/ 203509 h 695020"/>
                  <a:gd name="connsiteX5" fmla="*/ 632830 w 643470"/>
                  <a:gd name="connsiteY5" fmla="*/ 351241 h 695020"/>
                  <a:gd name="connsiteX6" fmla="*/ 611857 w 643470"/>
                  <a:gd name="connsiteY6" fmla="*/ 552439 h 695020"/>
                  <a:gd name="connsiteX7" fmla="*/ 439051 w 643470"/>
                  <a:gd name="connsiteY7" fmla="*/ 658426 h 695020"/>
                  <a:gd name="connsiteX8" fmla="*/ 318505 w 643470"/>
                  <a:gd name="connsiteY8" fmla="*/ 694142 h 695020"/>
                  <a:gd name="connsiteX9" fmla="*/ 149656 w 643470"/>
                  <a:gd name="connsiteY9" fmla="*/ 634517 h 695020"/>
                  <a:gd name="connsiteX10" fmla="*/ 4180 w 643470"/>
                  <a:gd name="connsiteY10" fmla="*/ 351241 h 695020"/>
                  <a:gd name="connsiteX0" fmla="*/ 1874 w 641164"/>
                  <a:gd name="connsiteY0" fmla="*/ 351241 h 702699"/>
                  <a:gd name="connsiteX1" fmla="*/ 100409 w 641164"/>
                  <a:gd name="connsiteY1" fmla="*/ 111262 h 702699"/>
                  <a:gd name="connsiteX2" fmla="*/ 190308 w 641164"/>
                  <a:gd name="connsiteY2" fmla="*/ 43259 h 702699"/>
                  <a:gd name="connsiteX3" fmla="*/ 316199 w 641164"/>
                  <a:gd name="connsiteY3" fmla="*/ 8340 h 702699"/>
                  <a:gd name="connsiteX4" fmla="*/ 465220 w 641164"/>
                  <a:gd name="connsiteY4" fmla="*/ 203509 h 702699"/>
                  <a:gd name="connsiteX5" fmla="*/ 630524 w 641164"/>
                  <a:gd name="connsiteY5" fmla="*/ 351241 h 702699"/>
                  <a:gd name="connsiteX6" fmla="*/ 609551 w 641164"/>
                  <a:gd name="connsiteY6" fmla="*/ 552439 h 702699"/>
                  <a:gd name="connsiteX7" fmla="*/ 436745 w 641164"/>
                  <a:gd name="connsiteY7" fmla="*/ 658426 h 702699"/>
                  <a:gd name="connsiteX8" fmla="*/ 316199 w 641164"/>
                  <a:gd name="connsiteY8" fmla="*/ 694142 h 702699"/>
                  <a:gd name="connsiteX9" fmla="*/ 179786 w 641164"/>
                  <a:gd name="connsiteY9" fmla="*/ 518482 h 702699"/>
                  <a:gd name="connsiteX10" fmla="*/ 1874 w 641164"/>
                  <a:gd name="connsiteY10" fmla="*/ 351241 h 702699"/>
                  <a:gd name="connsiteX0" fmla="*/ 656 w 639946"/>
                  <a:gd name="connsiteY0" fmla="*/ 351241 h 699899"/>
                  <a:gd name="connsiteX1" fmla="*/ 99191 w 639946"/>
                  <a:gd name="connsiteY1" fmla="*/ 111262 h 699899"/>
                  <a:gd name="connsiteX2" fmla="*/ 189090 w 639946"/>
                  <a:gd name="connsiteY2" fmla="*/ 43259 h 699899"/>
                  <a:gd name="connsiteX3" fmla="*/ 314981 w 639946"/>
                  <a:gd name="connsiteY3" fmla="*/ 8340 h 699899"/>
                  <a:gd name="connsiteX4" fmla="*/ 464002 w 639946"/>
                  <a:gd name="connsiteY4" fmla="*/ 203509 h 699899"/>
                  <a:gd name="connsiteX5" fmla="*/ 629306 w 639946"/>
                  <a:gd name="connsiteY5" fmla="*/ 351241 h 699899"/>
                  <a:gd name="connsiteX6" fmla="*/ 608333 w 639946"/>
                  <a:gd name="connsiteY6" fmla="*/ 552439 h 699899"/>
                  <a:gd name="connsiteX7" fmla="*/ 435527 w 639946"/>
                  <a:gd name="connsiteY7" fmla="*/ 658426 h 699899"/>
                  <a:gd name="connsiteX8" fmla="*/ 314981 w 639946"/>
                  <a:gd name="connsiteY8" fmla="*/ 694142 h 699899"/>
                  <a:gd name="connsiteX9" fmla="*/ 142387 w 639946"/>
                  <a:gd name="connsiteY9" fmla="*/ 558407 h 699899"/>
                  <a:gd name="connsiteX10" fmla="*/ 656 w 639946"/>
                  <a:gd name="connsiteY10" fmla="*/ 351241 h 699899"/>
                  <a:gd name="connsiteX0" fmla="*/ 656 w 643588"/>
                  <a:gd name="connsiteY0" fmla="*/ 351241 h 699899"/>
                  <a:gd name="connsiteX1" fmla="*/ 99191 w 643588"/>
                  <a:gd name="connsiteY1" fmla="*/ 111262 h 699899"/>
                  <a:gd name="connsiteX2" fmla="*/ 189090 w 643588"/>
                  <a:gd name="connsiteY2" fmla="*/ 43259 h 699899"/>
                  <a:gd name="connsiteX3" fmla="*/ 314981 w 643588"/>
                  <a:gd name="connsiteY3" fmla="*/ 8340 h 699899"/>
                  <a:gd name="connsiteX4" fmla="*/ 464002 w 643588"/>
                  <a:gd name="connsiteY4" fmla="*/ 203509 h 699899"/>
                  <a:gd name="connsiteX5" fmla="*/ 629306 w 643588"/>
                  <a:gd name="connsiteY5" fmla="*/ 351241 h 699899"/>
                  <a:gd name="connsiteX6" fmla="*/ 632506 w 643588"/>
                  <a:gd name="connsiteY6" fmla="*/ 441041 h 699899"/>
                  <a:gd name="connsiteX7" fmla="*/ 608333 w 643588"/>
                  <a:gd name="connsiteY7" fmla="*/ 552439 h 699899"/>
                  <a:gd name="connsiteX8" fmla="*/ 435527 w 643588"/>
                  <a:gd name="connsiteY8" fmla="*/ 658426 h 699899"/>
                  <a:gd name="connsiteX9" fmla="*/ 314981 w 643588"/>
                  <a:gd name="connsiteY9" fmla="*/ 694142 h 699899"/>
                  <a:gd name="connsiteX10" fmla="*/ 142387 w 643588"/>
                  <a:gd name="connsiteY10" fmla="*/ 558407 h 699899"/>
                  <a:gd name="connsiteX11" fmla="*/ 656 w 643588"/>
                  <a:gd name="connsiteY11" fmla="*/ 351241 h 699899"/>
                  <a:gd name="connsiteX0" fmla="*/ 656 w 643588"/>
                  <a:gd name="connsiteY0" fmla="*/ 351241 h 698530"/>
                  <a:gd name="connsiteX1" fmla="*/ 99191 w 643588"/>
                  <a:gd name="connsiteY1" fmla="*/ 111262 h 698530"/>
                  <a:gd name="connsiteX2" fmla="*/ 189090 w 643588"/>
                  <a:gd name="connsiteY2" fmla="*/ 43259 h 698530"/>
                  <a:gd name="connsiteX3" fmla="*/ 314981 w 643588"/>
                  <a:gd name="connsiteY3" fmla="*/ 8340 h 698530"/>
                  <a:gd name="connsiteX4" fmla="*/ 464002 w 643588"/>
                  <a:gd name="connsiteY4" fmla="*/ 203509 h 698530"/>
                  <a:gd name="connsiteX5" fmla="*/ 629306 w 643588"/>
                  <a:gd name="connsiteY5" fmla="*/ 351241 h 698530"/>
                  <a:gd name="connsiteX6" fmla="*/ 632506 w 643588"/>
                  <a:gd name="connsiteY6" fmla="*/ 441041 h 698530"/>
                  <a:gd name="connsiteX7" fmla="*/ 608333 w 643588"/>
                  <a:gd name="connsiteY7" fmla="*/ 552439 h 698530"/>
                  <a:gd name="connsiteX8" fmla="*/ 542328 w 643588"/>
                  <a:gd name="connsiteY8" fmla="*/ 589587 h 698530"/>
                  <a:gd name="connsiteX9" fmla="*/ 435527 w 643588"/>
                  <a:gd name="connsiteY9" fmla="*/ 658426 h 698530"/>
                  <a:gd name="connsiteX10" fmla="*/ 314981 w 643588"/>
                  <a:gd name="connsiteY10" fmla="*/ 694142 h 698530"/>
                  <a:gd name="connsiteX11" fmla="*/ 142387 w 643588"/>
                  <a:gd name="connsiteY11" fmla="*/ 558407 h 698530"/>
                  <a:gd name="connsiteX12" fmla="*/ 656 w 643588"/>
                  <a:gd name="connsiteY12" fmla="*/ 351241 h 698530"/>
                  <a:gd name="connsiteX0" fmla="*/ 656 w 643588"/>
                  <a:gd name="connsiteY0" fmla="*/ 351241 h 698530"/>
                  <a:gd name="connsiteX1" fmla="*/ 99191 w 643588"/>
                  <a:gd name="connsiteY1" fmla="*/ 111262 h 698530"/>
                  <a:gd name="connsiteX2" fmla="*/ 189090 w 643588"/>
                  <a:gd name="connsiteY2" fmla="*/ 43259 h 698530"/>
                  <a:gd name="connsiteX3" fmla="*/ 314981 w 643588"/>
                  <a:gd name="connsiteY3" fmla="*/ 8340 h 698530"/>
                  <a:gd name="connsiteX4" fmla="*/ 464002 w 643588"/>
                  <a:gd name="connsiteY4" fmla="*/ 203509 h 698530"/>
                  <a:gd name="connsiteX5" fmla="*/ 629306 w 643588"/>
                  <a:gd name="connsiteY5" fmla="*/ 351241 h 698530"/>
                  <a:gd name="connsiteX6" fmla="*/ 632506 w 643588"/>
                  <a:gd name="connsiteY6" fmla="*/ 441041 h 698530"/>
                  <a:gd name="connsiteX7" fmla="*/ 608333 w 643588"/>
                  <a:gd name="connsiteY7" fmla="*/ 552439 h 698530"/>
                  <a:gd name="connsiteX8" fmla="*/ 548014 w 643588"/>
                  <a:gd name="connsiteY8" fmla="*/ 618976 h 698530"/>
                  <a:gd name="connsiteX9" fmla="*/ 435527 w 643588"/>
                  <a:gd name="connsiteY9" fmla="*/ 658426 h 698530"/>
                  <a:gd name="connsiteX10" fmla="*/ 314981 w 643588"/>
                  <a:gd name="connsiteY10" fmla="*/ 694142 h 698530"/>
                  <a:gd name="connsiteX11" fmla="*/ 142387 w 643588"/>
                  <a:gd name="connsiteY11" fmla="*/ 558407 h 698530"/>
                  <a:gd name="connsiteX12" fmla="*/ 656 w 643588"/>
                  <a:gd name="connsiteY12" fmla="*/ 351241 h 698530"/>
                  <a:gd name="connsiteX0" fmla="*/ 656 w 642979"/>
                  <a:gd name="connsiteY0" fmla="*/ 351241 h 698530"/>
                  <a:gd name="connsiteX1" fmla="*/ 99191 w 642979"/>
                  <a:gd name="connsiteY1" fmla="*/ 111262 h 698530"/>
                  <a:gd name="connsiteX2" fmla="*/ 189090 w 642979"/>
                  <a:gd name="connsiteY2" fmla="*/ 43259 h 698530"/>
                  <a:gd name="connsiteX3" fmla="*/ 314981 w 642979"/>
                  <a:gd name="connsiteY3" fmla="*/ 8340 h 698530"/>
                  <a:gd name="connsiteX4" fmla="*/ 464002 w 642979"/>
                  <a:gd name="connsiteY4" fmla="*/ 203509 h 698530"/>
                  <a:gd name="connsiteX5" fmla="*/ 629306 w 642979"/>
                  <a:gd name="connsiteY5" fmla="*/ 351241 h 698530"/>
                  <a:gd name="connsiteX6" fmla="*/ 632506 w 642979"/>
                  <a:gd name="connsiteY6" fmla="*/ 441041 h 698530"/>
                  <a:gd name="connsiteX7" fmla="*/ 622107 w 642979"/>
                  <a:gd name="connsiteY7" fmla="*/ 488177 h 698530"/>
                  <a:gd name="connsiteX8" fmla="*/ 608333 w 642979"/>
                  <a:gd name="connsiteY8" fmla="*/ 552439 h 698530"/>
                  <a:gd name="connsiteX9" fmla="*/ 548014 w 642979"/>
                  <a:gd name="connsiteY9" fmla="*/ 618976 h 698530"/>
                  <a:gd name="connsiteX10" fmla="*/ 435527 w 642979"/>
                  <a:gd name="connsiteY10" fmla="*/ 658426 h 698530"/>
                  <a:gd name="connsiteX11" fmla="*/ 314981 w 642979"/>
                  <a:gd name="connsiteY11" fmla="*/ 694142 h 698530"/>
                  <a:gd name="connsiteX12" fmla="*/ 142387 w 642979"/>
                  <a:gd name="connsiteY12" fmla="*/ 558407 h 698530"/>
                  <a:gd name="connsiteX13" fmla="*/ 656 w 642979"/>
                  <a:gd name="connsiteY13" fmla="*/ 351241 h 698530"/>
                  <a:gd name="connsiteX0" fmla="*/ 656 w 664488"/>
                  <a:gd name="connsiteY0" fmla="*/ 351241 h 698530"/>
                  <a:gd name="connsiteX1" fmla="*/ 99191 w 664488"/>
                  <a:gd name="connsiteY1" fmla="*/ 111262 h 698530"/>
                  <a:gd name="connsiteX2" fmla="*/ 189090 w 664488"/>
                  <a:gd name="connsiteY2" fmla="*/ 43259 h 698530"/>
                  <a:gd name="connsiteX3" fmla="*/ 314981 w 664488"/>
                  <a:gd name="connsiteY3" fmla="*/ 8340 h 698530"/>
                  <a:gd name="connsiteX4" fmla="*/ 464002 w 664488"/>
                  <a:gd name="connsiteY4" fmla="*/ 203509 h 698530"/>
                  <a:gd name="connsiteX5" fmla="*/ 629306 w 664488"/>
                  <a:gd name="connsiteY5" fmla="*/ 351241 h 698530"/>
                  <a:gd name="connsiteX6" fmla="*/ 632506 w 664488"/>
                  <a:gd name="connsiteY6" fmla="*/ 441041 h 698530"/>
                  <a:gd name="connsiteX7" fmla="*/ 664181 w 664488"/>
                  <a:gd name="connsiteY7" fmla="*/ 481868 h 698530"/>
                  <a:gd name="connsiteX8" fmla="*/ 608333 w 664488"/>
                  <a:gd name="connsiteY8" fmla="*/ 552439 h 698530"/>
                  <a:gd name="connsiteX9" fmla="*/ 548014 w 664488"/>
                  <a:gd name="connsiteY9" fmla="*/ 618976 h 698530"/>
                  <a:gd name="connsiteX10" fmla="*/ 435527 w 664488"/>
                  <a:gd name="connsiteY10" fmla="*/ 658426 h 698530"/>
                  <a:gd name="connsiteX11" fmla="*/ 314981 w 664488"/>
                  <a:gd name="connsiteY11" fmla="*/ 694142 h 698530"/>
                  <a:gd name="connsiteX12" fmla="*/ 142387 w 664488"/>
                  <a:gd name="connsiteY12" fmla="*/ 558407 h 698530"/>
                  <a:gd name="connsiteX13" fmla="*/ 656 w 664488"/>
                  <a:gd name="connsiteY13" fmla="*/ 351241 h 698530"/>
                  <a:gd name="connsiteX0" fmla="*/ 656 w 642979"/>
                  <a:gd name="connsiteY0" fmla="*/ 351241 h 698530"/>
                  <a:gd name="connsiteX1" fmla="*/ 99191 w 642979"/>
                  <a:gd name="connsiteY1" fmla="*/ 111262 h 698530"/>
                  <a:gd name="connsiteX2" fmla="*/ 189090 w 642979"/>
                  <a:gd name="connsiteY2" fmla="*/ 43259 h 698530"/>
                  <a:gd name="connsiteX3" fmla="*/ 314981 w 642979"/>
                  <a:gd name="connsiteY3" fmla="*/ 8340 h 698530"/>
                  <a:gd name="connsiteX4" fmla="*/ 464002 w 642979"/>
                  <a:gd name="connsiteY4" fmla="*/ 203509 h 698530"/>
                  <a:gd name="connsiteX5" fmla="*/ 629306 w 642979"/>
                  <a:gd name="connsiteY5" fmla="*/ 351241 h 698530"/>
                  <a:gd name="connsiteX6" fmla="*/ 632506 w 642979"/>
                  <a:gd name="connsiteY6" fmla="*/ 441041 h 698530"/>
                  <a:gd name="connsiteX7" fmla="*/ 514114 w 642979"/>
                  <a:gd name="connsiteY7" fmla="*/ 446866 h 698530"/>
                  <a:gd name="connsiteX8" fmla="*/ 608333 w 642979"/>
                  <a:gd name="connsiteY8" fmla="*/ 552439 h 698530"/>
                  <a:gd name="connsiteX9" fmla="*/ 548014 w 642979"/>
                  <a:gd name="connsiteY9" fmla="*/ 618976 h 698530"/>
                  <a:gd name="connsiteX10" fmla="*/ 435527 w 642979"/>
                  <a:gd name="connsiteY10" fmla="*/ 658426 h 698530"/>
                  <a:gd name="connsiteX11" fmla="*/ 314981 w 642979"/>
                  <a:gd name="connsiteY11" fmla="*/ 694142 h 698530"/>
                  <a:gd name="connsiteX12" fmla="*/ 142387 w 642979"/>
                  <a:gd name="connsiteY12" fmla="*/ 558407 h 698530"/>
                  <a:gd name="connsiteX13" fmla="*/ 656 w 642979"/>
                  <a:gd name="connsiteY13" fmla="*/ 351241 h 698530"/>
                  <a:gd name="connsiteX0" fmla="*/ 656 w 642979"/>
                  <a:gd name="connsiteY0" fmla="*/ 351241 h 698530"/>
                  <a:gd name="connsiteX1" fmla="*/ 99191 w 642979"/>
                  <a:gd name="connsiteY1" fmla="*/ 111262 h 698530"/>
                  <a:gd name="connsiteX2" fmla="*/ 189090 w 642979"/>
                  <a:gd name="connsiteY2" fmla="*/ 43259 h 698530"/>
                  <a:gd name="connsiteX3" fmla="*/ 314981 w 642979"/>
                  <a:gd name="connsiteY3" fmla="*/ 8340 h 698530"/>
                  <a:gd name="connsiteX4" fmla="*/ 464002 w 642979"/>
                  <a:gd name="connsiteY4" fmla="*/ 203509 h 698530"/>
                  <a:gd name="connsiteX5" fmla="*/ 629306 w 642979"/>
                  <a:gd name="connsiteY5" fmla="*/ 351241 h 698530"/>
                  <a:gd name="connsiteX6" fmla="*/ 632506 w 642979"/>
                  <a:gd name="connsiteY6" fmla="*/ 441041 h 698530"/>
                  <a:gd name="connsiteX7" fmla="*/ 514114 w 642979"/>
                  <a:gd name="connsiteY7" fmla="*/ 446866 h 698530"/>
                  <a:gd name="connsiteX8" fmla="*/ 608333 w 642979"/>
                  <a:gd name="connsiteY8" fmla="*/ 552439 h 698530"/>
                  <a:gd name="connsiteX9" fmla="*/ 429692 w 642979"/>
                  <a:gd name="connsiteY9" fmla="*/ 540027 h 698530"/>
                  <a:gd name="connsiteX10" fmla="*/ 435527 w 642979"/>
                  <a:gd name="connsiteY10" fmla="*/ 658426 h 698530"/>
                  <a:gd name="connsiteX11" fmla="*/ 314981 w 642979"/>
                  <a:gd name="connsiteY11" fmla="*/ 694142 h 698530"/>
                  <a:gd name="connsiteX12" fmla="*/ 142387 w 642979"/>
                  <a:gd name="connsiteY12" fmla="*/ 558407 h 698530"/>
                  <a:gd name="connsiteX13" fmla="*/ 656 w 642979"/>
                  <a:gd name="connsiteY13" fmla="*/ 351241 h 698530"/>
                  <a:gd name="connsiteX0" fmla="*/ 656 w 642979"/>
                  <a:gd name="connsiteY0" fmla="*/ 351241 h 698530"/>
                  <a:gd name="connsiteX1" fmla="*/ 99191 w 642979"/>
                  <a:gd name="connsiteY1" fmla="*/ 111262 h 698530"/>
                  <a:gd name="connsiteX2" fmla="*/ 189090 w 642979"/>
                  <a:gd name="connsiteY2" fmla="*/ 43259 h 698530"/>
                  <a:gd name="connsiteX3" fmla="*/ 314981 w 642979"/>
                  <a:gd name="connsiteY3" fmla="*/ 8340 h 698530"/>
                  <a:gd name="connsiteX4" fmla="*/ 464002 w 642979"/>
                  <a:gd name="connsiteY4" fmla="*/ 203509 h 698530"/>
                  <a:gd name="connsiteX5" fmla="*/ 629306 w 642979"/>
                  <a:gd name="connsiteY5" fmla="*/ 351241 h 698530"/>
                  <a:gd name="connsiteX6" fmla="*/ 632506 w 642979"/>
                  <a:gd name="connsiteY6" fmla="*/ 441041 h 698530"/>
                  <a:gd name="connsiteX7" fmla="*/ 514114 w 642979"/>
                  <a:gd name="connsiteY7" fmla="*/ 446866 h 698530"/>
                  <a:gd name="connsiteX8" fmla="*/ 608333 w 642979"/>
                  <a:gd name="connsiteY8" fmla="*/ 552439 h 698530"/>
                  <a:gd name="connsiteX9" fmla="*/ 465245 w 642979"/>
                  <a:gd name="connsiteY9" fmla="*/ 487421 h 698530"/>
                  <a:gd name="connsiteX10" fmla="*/ 429692 w 642979"/>
                  <a:gd name="connsiteY10" fmla="*/ 540027 h 698530"/>
                  <a:gd name="connsiteX11" fmla="*/ 435527 w 642979"/>
                  <a:gd name="connsiteY11" fmla="*/ 658426 h 698530"/>
                  <a:gd name="connsiteX12" fmla="*/ 314981 w 642979"/>
                  <a:gd name="connsiteY12" fmla="*/ 694142 h 698530"/>
                  <a:gd name="connsiteX13" fmla="*/ 142387 w 642979"/>
                  <a:gd name="connsiteY13" fmla="*/ 558407 h 698530"/>
                  <a:gd name="connsiteX14" fmla="*/ 656 w 642979"/>
                  <a:gd name="connsiteY14" fmla="*/ 351241 h 698530"/>
                  <a:gd name="connsiteX0" fmla="*/ 656 w 642979"/>
                  <a:gd name="connsiteY0" fmla="*/ 351241 h 694351"/>
                  <a:gd name="connsiteX1" fmla="*/ 99191 w 642979"/>
                  <a:gd name="connsiteY1" fmla="*/ 111262 h 694351"/>
                  <a:gd name="connsiteX2" fmla="*/ 189090 w 642979"/>
                  <a:gd name="connsiteY2" fmla="*/ 43259 h 694351"/>
                  <a:gd name="connsiteX3" fmla="*/ 314981 w 642979"/>
                  <a:gd name="connsiteY3" fmla="*/ 8340 h 694351"/>
                  <a:gd name="connsiteX4" fmla="*/ 464002 w 642979"/>
                  <a:gd name="connsiteY4" fmla="*/ 203509 h 694351"/>
                  <a:gd name="connsiteX5" fmla="*/ 629306 w 642979"/>
                  <a:gd name="connsiteY5" fmla="*/ 351241 h 694351"/>
                  <a:gd name="connsiteX6" fmla="*/ 632506 w 642979"/>
                  <a:gd name="connsiteY6" fmla="*/ 441041 h 694351"/>
                  <a:gd name="connsiteX7" fmla="*/ 514114 w 642979"/>
                  <a:gd name="connsiteY7" fmla="*/ 446866 h 694351"/>
                  <a:gd name="connsiteX8" fmla="*/ 608333 w 642979"/>
                  <a:gd name="connsiteY8" fmla="*/ 552439 h 694351"/>
                  <a:gd name="connsiteX9" fmla="*/ 465245 w 642979"/>
                  <a:gd name="connsiteY9" fmla="*/ 487421 h 694351"/>
                  <a:gd name="connsiteX10" fmla="*/ 429692 w 642979"/>
                  <a:gd name="connsiteY10" fmla="*/ 540027 h 694351"/>
                  <a:gd name="connsiteX11" fmla="*/ 372795 w 642979"/>
                  <a:gd name="connsiteY11" fmla="*/ 589459 h 694351"/>
                  <a:gd name="connsiteX12" fmla="*/ 314981 w 642979"/>
                  <a:gd name="connsiteY12" fmla="*/ 694142 h 694351"/>
                  <a:gd name="connsiteX13" fmla="*/ 142387 w 642979"/>
                  <a:gd name="connsiteY13" fmla="*/ 558407 h 694351"/>
                  <a:gd name="connsiteX14" fmla="*/ 656 w 642979"/>
                  <a:gd name="connsiteY14" fmla="*/ 351241 h 694351"/>
                  <a:gd name="connsiteX0" fmla="*/ 656 w 642979"/>
                  <a:gd name="connsiteY0" fmla="*/ 351241 h 596438"/>
                  <a:gd name="connsiteX1" fmla="*/ 99191 w 642979"/>
                  <a:gd name="connsiteY1" fmla="*/ 111262 h 596438"/>
                  <a:gd name="connsiteX2" fmla="*/ 189090 w 642979"/>
                  <a:gd name="connsiteY2" fmla="*/ 43259 h 596438"/>
                  <a:gd name="connsiteX3" fmla="*/ 314981 w 642979"/>
                  <a:gd name="connsiteY3" fmla="*/ 8340 h 596438"/>
                  <a:gd name="connsiteX4" fmla="*/ 464002 w 642979"/>
                  <a:gd name="connsiteY4" fmla="*/ 203509 h 596438"/>
                  <a:gd name="connsiteX5" fmla="*/ 629306 w 642979"/>
                  <a:gd name="connsiteY5" fmla="*/ 351241 h 596438"/>
                  <a:gd name="connsiteX6" fmla="*/ 632506 w 642979"/>
                  <a:gd name="connsiteY6" fmla="*/ 441041 h 596438"/>
                  <a:gd name="connsiteX7" fmla="*/ 514114 w 642979"/>
                  <a:gd name="connsiteY7" fmla="*/ 446866 h 596438"/>
                  <a:gd name="connsiteX8" fmla="*/ 608333 w 642979"/>
                  <a:gd name="connsiteY8" fmla="*/ 552439 h 596438"/>
                  <a:gd name="connsiteX9" fmla="*/ 465245 w 642979"/>
                  <a:gd name="connsiteY9" fmla="*/ 487421 h 596438"/>
                  <a:gd name="connsiteX10" fmla="*/ 429692 w 642979"/>
                  <a:gd name="connsiteY10" fmla="*/ 540027 h 596438"/>
                  <a:gd name="connsiteX11" fmla="*/ 372795 w 642979"/>
                  <a:gd name="connsiteY11" fmla="*/ 589459 h 596438"/>
                  <a:gd name="connsiteX12" fmla="*/ 275539 w 642979"/>
                  <a:gd name="connsiteY12" fmla="*/ 581644 h 596438"/>
                  <a:gd name="connsiteX13" fmla="*/ 142387 w 642979"/>
                  <a:gd name="connsiteY13" fmla="*/ 558407 h 596438"/>
                  <a:gd name="connsiteX14" fmla="*/ 656 w 642979"/>
                  <a:gd name="connsiteY14" fmla="*/ 351241 h 596438"/>
                  <a:gd name="connsiteX0" fmla="*/ 7365 w 582037"/>
                  <a:gd name="connsiteY0" fmla="*/ 347911 h 596438"/>
                  <a:gd name="connsiteX1" fmla="*/ 38249 w 582037"/>
                  <a:gd name="connsiteY1" fmla="*/ 111262 h 596438"/>
                  <a:gd name="connsiteX2" fmla="*/ 128148 w 582037"/>
                  <a:gd name="connsiteY2" fmla="*/ 43259 h 596438"/>
                  <a:gd name="connsiteX3" fmla="*/ 254039 w 582037"/>
                  <a:gd name="connsiteY3" fmla="*/ 8340 h 596438"/>
                  <a:gd name="connsiteX4" fmla="*/ 403060 w 582037"/>
                  <a:gd name="connsiteY4" fmla="*/ 203509 h 596438"/>
                  <a:gd name="connsiteX5" fmla="*/ 568364 w 582037"/>
                  <a:gd name="connsiteY5" fmla="*/ 351241 h 596438"/>
                  <a:gd name="connsiteX6" fmla="*/ 571564 w 582037"/>
                  <a:gd name="connsiteY6" fmla="*/ 441041 h 596438"/>
                  <a:gd name="connsiteX7" fmla="*/ 453172 w 582037"/>
                  <a:gd name="connsiteY7" fmla="*/ 446866 h 596438"/>
                  <a:gd name="connsiteX8" fmla="*/ 547391 w 582037"/>
                  <a:gd name="connsiteY8" fmla="*/ 552439 h 596438"/>
                  <a:gd name="connsiteX9" fmla="*/ 404303 w 582037"/>
                  <a:gd name="connsiteY9" fmla="*/ 487421 h 596438"/>
                  <a:gd name="connsiteX10" fmla="*/ 368750 w 582037"/>
                  <a:gd name="connsiteY10" fmla="*/ 540027 h 596438"/>
                  <a:gd name="connsiteX11" fmla="*/ 311853 w 582037"/>
                  <a:gd name="connsiteY11" fmla="*/ 589459 h 596438"/>
                  <a:gd name="connsiteX12" fmla="*/ 214597 w 582037"/>
                  <a:gd name="connsiteY12" fmla="*/ 581644 h 596438"/>
                  <a:gd name="connsiteX13" fmla="*/ 81445 w 582037"/>
                  <a:gd name="connsiteY13" fmla="*/ 558407 h 596438"/>
                  <a:gd name="connsiteX14" fmla="*/ 7365 w 582037"/>
                  <a:gd name="connsiteY14" fmla="*/ 347911 h 596438"/>
                  <a:gd name="connsiteX0" fmla="*/ 531 w 575203"/>
                  <a:gd name="connsiteY0" fmla="*/ 347911 h 596438"/>
                  <a:gd name="connsiteX1" fmla="*/ 57409 w 575203"/>
                  <a:gd name="connsiteY1" fmla="*/ 122698 h 596438"/>
                  <a:gd name="connsiteX2" fmla="*/ 121314 w 575203"/>
                  <a:gd name="connsiteY2" fmla="*/ 43259 h 596438"/>
                  <a:gd name="connsiteX3" fmla="*/ 247205 w 575203"/>
                  <a:gd name="connsiteY3" fmla="*/ 8340 h 596438"/>
                  <a:gd name="connsiteX4" fmla="*/ 396226 w 575203"/>
                  <a:gd name="connsiteY4" fmla="*/ 203509 h 596438"/>
                  <a:gd name="connsiteX5" fmla="*/ 561530 w 575203"/>
                  <a:gd name="connsiteY5" fmla="*/ 351241 h 596438"/>
                  <a:gd name="connsiteX6" fmla="*/ 564730 w 575203"/>
                  <a:gd name="connsiteY6" fmla="*/ 441041 h 596438"/>
                  <a:gd name="connsiteX7" fmla="*/ 446338 w 575203"/>
                  <a:gd name="connsiteY7" fmla="*/ 446866 h 596438"/>
                  <a:gd name="connsiteX8" fmla="*/ 540557 w 575203"/>
                  <a:gd name="connsiteY8" fmla="*/ 552439 h 596438"/>
                  <a:gd name="connsiteX9" fmla="*/ 397469 w 575203"/>
                  <a:gd name="connsiteY9" fmla="*/ 487421 h 596438"/>
                  <a:gd name="connsiteX10" fmla="*/ 361916 w 575203"/>
                  <a:gd name="connsiteY10" fmla="*/ 540027 h 596438"/>
                  <a:gd name="connsiteX11" fmla="*/ 305019 w 575203"/>
                  <a:gd name="connsiteY11" fmla="*/ 589459 h 596438"/>
                  <a:gd name="connsiteX12" fmla="*/ 207763 w 575203"/>
                  <a:gd name="connsiteY12" fmla="*/ 581644 h 596438"/>
                  <a:gd name="connsiteX13" fmla="*/ 74611 w 575203"/>
                  <a:gd name="connsiteY13" fmla="*/ 558407 h 596438"/>
                  <a:gd name="connsiteX14" fmla="*/ 531 w 575203"/>
                  <a:gd name="connsiteY14" fmla="*/ 347911 h 596438"/>
                  <a:gd name="connsiteX0" fmla="*/ 531 w 575203"/>
                  <a:gd name="connsiteY0" fmla="*/ 314228 h 562755"/>
                  <a:gd name="connsiteX1" fmla="*/ 57409 w 575203"/>
                  <a:gd name="connsiteY1" fmla="*/ 89015 h 562755"/>
                  <a:gd name="connsiteX2" fmla="*/ 121314 w 575203"/>
                  <a:gd name="connsiteY2" fmla="*/ 9576 h 562755"/>
                  <a:gd name="connsiteX3" fmla="*/ 249702 w 575203"/>
                  <a:gd name="connsiteY3" fmla="*/ 25395 h 562755"/>
                  <a:gd name="connsiteX4" fmla="*/ 396226 w 575203"/>
                  <a:gd name="connsiteY4" fmla="*/ 169826 h 562755"/>
                  <a:gd name="connsiteX5" fmla="*/ 561530 w 575203"/>
                  <a:gd name="connsiteY5" fmla="*/ 317558 h 562755"/>
                  <a:gd name="connsiteX6" fmla="*/ 564730 w 575203"/>
                  <a:gd name="connsiteY6" fmla="*/ 407358 h 562755"/>
                  <a:gd name="connsiteX7" fmla="*/ 446338 w 575203"/>
                  <a:gd name="connsiteY7" fmla="*/ 413183 h 562755"/>
                  <a:gd name="connsiteX8" fmla="*/ 540557 w 575203"/>
                  <a:gd name="connsiteY8" fmla="*/ 518756 h 562755"/>
                  <a:gd name="connsiteX9" fmla="*/ 397469 w 575203"/>
                  <a:gd name="connsiteY9" fmla="*/ 453738 h 562755"/>
                  <a:gd name="connsiteX10" fmla="*/ 361916 w 575203"/>
                  <a:gd name="connsiteY10" fmla="*/ 506344 h 562755"/>
                  <a:gd name="connsiteX11" fmla="*/ 305019 w 575203"/>
                  <a:gd name="connsiteY11" fmla="*/ 555776 h 562755"/>
                  <a:gd name="connsiteX12" fmla="*/ 207763 w 575203"/>
                  <a:gd name="connsiteY12" fmla="*/ 547961 h 562755"/>
                  <a:gd name="connsiteX13" fmla="*/ 74611 w 575203"/>
                  <a:gd name="connsiteY13" fmla="*/ 524724 h 562755"/>
                  <a:gd name="connsiteX14" fmla="*/ 531 w 575203"/>
                  <a:gd name="connsiteY14" fmla="*/ 314228 h 562755"/>
                  <a:gd name="connsiteX0" fmla="*/ 531 w 575203"/>
                  <a:gd name="connsiteY0" fmla="*/ 312695 h 561222"/>
                  <a:gd name="connsiteX1" fmla="*/ 57409 w 575203"/>
                  <a:gd name="connsiteY1" fmla="*/ 87482 h 561222"/>
                  <a:gd name="connsiteX2" fmla="*/ 121314 w 575203"/>
                  <a:gd name="connsiteY2" fmla="*/ 8043 h 561222"/>
                  <a:gd name="connsiteX3" fmla="*/ 249702 w 575203"/>
                  <a:gd name="connsiteY3" fmla="*/ 23862 h 561222"/>
                  <a:gd name="connsiteX4" fmla="*/ 398584 w 575203"/>
                  <a:gd name="connsiteY4" fmla="*/ 130031 h 561222"/>
                  <a:gd name="connsiteX5" fmla="*/ 561530 w 575203"/>
                  <a:gd name="connsiteY5" fmla="*/ 316025 h 561222"/>
                  <a:gd name="connsiteX6" fmla="*/ 564730 w 575203"/>
                  <a:gd name="connsiteY6" fmla="*/ 405825 h 561222"/>
                  <a:gd name="connsiteX7" fmla="*/ 446338 w 575203"/>
                  <a:gd name="connsiteY7" fmla="*/ 411650 h 561222"/>
                  <a:gd name="connsiteX8" fmla="*/ 540557 w 575203"/>
                  <a:gd name="connsiteY8" fmla="*/ 517223 h 561222"/>
                  <a:gd name="connsiteX9" fmla="*/ 397469 w 575203"/>
                  <a:gd name="connsiteY9" fmla="*/ 452205 h 561222"/>
                  <a:gd name="connsiteX10" fmla="*/ 361916 w 575203"/>
                  <a:gd name="connsiteY10" fmla="*/ 504811 h 561222"/>
                  <a:gd name="connsiteX11" fmla="*/ 305019 w 575203"/>
                  <a:gd name="connsiteY11" fmla="*/ 554243 h 561222"/>
                  <a:gd name="connsiteX12" fmla="*/ 207763 w 575203"/>
                  <a:gd name="connsiteY12" fmla="*/ 546428 h 561222"/>
                  <a:gd name="connsiteX13" fmla="*/ 74611 w 575203"/>
                  <a:gd name="connsiteY13" fmla="*/ 523191 h 561222"/>
                  <a:gd name="connsiteX14" fmla="*/ 531 w 575203"/>
                  <a:gd name="connsiteY14" fmla="*/ 312695 h 56122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</a:cxnLst>
                <a:rect l="l" t="t" r="r" b="b"/>
                <a:pathLst>
                  <a:path w="575203" h="561222">
                    <a:moveTo>
                      <a:pt x="531" y="312695"/>
                    </a:moveTo>
                    <a:cubicBezTo>
                      <a:pt x="-2336" y="240077"/>
                      <a:pt x="5022" y="144632"/>
                      <a:pt x="57409" y="87482"/>
                    </a:cubicBezTo>
                    <a:cubicBezTo>
                      <a:pt x="88815" y="36152"/>
                      <a:pt x="85349" y="25197"/>
                      <a:pt x="121314" y="8043"/>
                    </a:cubicBezTo>
                    <a:cubicBezTo>
                      <a:pt x="157279" y="-9111"/>
                      <a:pt x="203490" y="3531"/>
                      <a:pt x="249702" y="23862"/>
                    </a:cubicBezTo>
                    <a:cubicBezTo>
                      <a:pt x="295914" y="44193"/>
                      <a:pt x="346197" y="72881"/>
                      <a:pt x="398584" y="130031"/>
                    </a:cubicBezTo>
                    <a:cubicBezTo>
                      <a:pt x="450971" y="187181"/>
                      <a:pt x="533446" y="276436"/>
                      <a:pt x="561530" y="316025"/>
                    </a:cubicBezTo>
                    <a:cubicBezTo>
                      <a:pt x="589614" y="355614"/>
                      <a:pt x="565930" y="383002"/>
                      <a:pt x="564730" y="405825"/>
                    </a:cubicBezTo>
                    <a:cubicBezTo>
                      <a:pt x="563530" y="428648"/>
                      <a:pt x="450367" y="393084"/>
                      <a:pt x="446338" y="411650"/>
                    </a:cubicBezTo>
                    <a:cubicBezTo>
                      <a:pt x="442309" y="430216"/>
                      <a:pt x="529860" y="500795"/>
                      <a:pt x="540557" y="517223"/>
                    </a:cubicBezTo>
                    <a:cubicBezTo>
                      <a:pt x="551254" y="533651"/>
                      <a:pt x="427242" y="454274"/>
                      <a:pt x="397469" y="452205"/>
                    </a:cubicBezTo>
                    <a:cubicBezTo>
                      <a:pt x="367696" y="450136"/>
                      <a:pt x="385711" y="485979"/>
                      <a:pt x="361916" y="504811"/>
                    </a:cubicBezTo>
                    <a:cubicBezTo>
                      <a:pt x="338121" y="523643"/>
                      <a:pt x="342910" y="536817"/>
                      <a:pt x="305019" y="554243"/>
                    </a:cubicBezTo>
                    <a:cubicBezTo>
                      <a:pt x="267128" y="571669"/>
                      <a:pt x="246164" y="551603"/>
                      <a:pt x="207763" y="546428"/>
                    </a:cubicBezTo>
                    <a:cubicBezTo>
                      <a:pt x="169362" y="541253"/>
                      <a:pt x="126998" y="580341"/>
                      <a:pt x="74611" y="523191"/>
                    </a:cubicBezTo>
                    <a:cubicBezTo>
                      <a:pt x="22224" y="466041"/>
                      <a:pt x="3398" y="385313"/>
                      <a:pt x="531" y="312695"/>
                    </a:cubicBezTo>
                    <a:close/>
                  </a:path>
                </a:pathLst>
              </a:custGeom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b="1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8" name="Rectangle 137"/>
              <p:cNvSpPr/>
              <p:nvPr/>
            </p:nvSpPr>
            <p:spPr>
              <a:xfrm>
                <a:off x="0" y="65349"/>
                <a:ext cx="719941" cy="37555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N" kern="1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TFAM</a:t>
                </a:r>
                <a:endParaRPr lang="en-IN" kern="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39" name="Rectangle 138"/>
            <p:cNvSpPr/>
            <p:nvPr/>
          </p:nvSpPr>
          <p:spPr>
            <a:xfrm>
              <a:off x="2455929" y="526162"/>
              <a:ext cx="574196" cy="38869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</a:t>
              </a:r>
              <a:r>
                <a:rPr lang="en-IN" kern="100" baseline="300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2+</a:t>
              </a:r>
              <a:endParaRPr lang="en-IN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Rectangle 140"/>
            <p:cNvSpPr/>
            <p:nvPr/>
          </p:nvSpPr>
          <p:spPr>
            <a:xfrm>
              <a:off x="8257130" y="383914"/>
              <a:ext cx="574196" cy="38869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</a:t>
              </a:r>
              <a:r>
                <a:rPr lang="en-IN" kern="100" baseline="300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2+</a:t>
              </a:r>
              <a:endParaRPr lang="en-IN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4" name="Straight Arrow Connector 43"/>
            <p:cNvCxnSpPr/>
            <p:nvPr/>
          </p:nvCxnSpPr>
          <p:spPr>
            <a:xfrm flipV="1">
              <a:off x="4294527" y="1926279"/>
              <a:ext cx="350773" cy="412742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Straight Arrow Connector 142"/>
            <p:cNvCxnSpPr/>
            <p:nvPr/>
          </p:nvCxnSpPr>
          <p:spPr>
            <a:xfrm flipV="1">
              <a:off x="4904072" y="1006217"/>
              <a:ext cx="201922" cy="445544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4" name="Group 143"/>
            <p:cNvGrpSpPr/>
            <p:nvPr/>
          </p:nvGrpSpPr>
          <p:grpSpPr>
            <a:xfrm>
              <a:off x="5479521" y="1154802"/>
              <a:ext cx="1004887" cy="699194"/>
              <a:chOff x="8460432" y="3666660"/>
              <a:chExt cx="2159000" cy="1719482"/>
            </a:xfrm>
          </p:grpSpPr>
          <p:grpSp>
            <p:nvGrpSpPr>
              <p:cNvPr id="145" name="Group 144"/>
              <p:cNvGrpSpPr/>
              <p:nvPr/>
            </p:nvGrpSpPr>
            <p:grpSpPr>
              <a:xfrm>
                <a:off x="8460810" y="3666660"/>
                <a:ext cx="761146" cy="792986"/>
                <a:chOff x="-1281058" y="6974434"/>
                <a:chExt cx="494082" cy="462284"/>
              </a:xfrm>
            </p:grpSpPr>
            <p:sp>
              <p:nvSpPr>
                <p:cNvPr id="147" name="Oval 146"/>
                <p:cNvSpPr/>
                <p:nvPr/>
              </p:nvSpPr>
              <p:spPr>
                <a:xfrm rot="16369013">
                  <a:off x="-1265159" y="6958535"/>
                  <a:ext cx="462284" cy="494082"/>
                </a:xfrm>
                <a:prstGeom prst="ellipse">
                  <a:avLst/>
                </a:prstGeom>
                <a:solidFill>
                  <a:srgbClr val="FFFF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b="1">
                    <a:solidFill>
                      <a:schemeClr val="tx1"/>
                    </a:solidFill>
                    <a:cs typeface="Times New Roman" pitchFamily="18" charset="0"/>
                  </a:endParaRPr>
                </a:p>
              </p:txBody>
            </p:sp>
            <p:sp>
              <p:nvSpPr>
                <p:cNvPr id="148" name="Flowchart: Sort 147"/>
                <p:cNvSpPr/>
                <p:nvPr/>
              </p:nvSpPr>
              <p:spPr>
                <a:xfrm>
                  <a:off x="-1163063" y="7084074"/>
                  <a:ext cx="222206" cy="243004"/>
                </a:xfrm>
                <a:prstGeom prst="flowChartSort">
                  <a:avLst/>
                </a:prstGeom>
                <a:solidFill>
                  <a:srgbClr val="FFFF00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IN" b="1"/>
                </a:p>
              </p:txBody>
            </p:sp>
          </p:grpSp>
          <p:sp>
            <p:nvSpPr>
              <p:cNvPr id="146" name="TextBox 168"/>
              <p:cNvSpPr txBox="1">
                <a:spLocks noChangeArrowheads="1"/>
              </p:cNvSpPr>
              <p:nvPr/>
            </p:nvSpPr>
            <p:spPr bwMode="auto">
              <a:xfrm>
                <a:off x="8460432" y="4477868"/>
                <a:ext cx="2159000" cy="9082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pPr>
                  <a:spcAft>
                    <a:spcPts val="0"/>
                  </a:spcAft>
                </a:pPr>
                <a:endParaRPr lang="en-IN" b="1" dirty="0">
                  <a:effectLst/>
                  <a:ea typeface="Times New Roman"/>
                </a:endParaRPr>
              </a:p>
            </p:txBody>
          </p:sp>
        </p:grpSp>
        <p:grpSp>
          <p:nvGrpSpPr>
            <p:cNvPr id="149" name="Group 148"/>
            <p:cNvGrpSpPr/>
            <p:nvPr/>
          </p:nvGrpSpPr>
          <p:grpSpPr>
            <a:xfrm rot="13742951">
              <a:off x="5313108" y="-703441"/>
              <a:ext cx="1312553" cy="992536"/>
              <a:chOff x="1328362" y="5639815"/>
              <a:chExt cx="500458" cy="290160"/>
            </a:xfrm>
          </p:grpSpPr>
          <p:cxnSp>
            <p:nvCxnSpPr>
              <p:cNvPr id="150" name="Straight Connector 149"/>
              <p:cNvCxnSpPr/>
              <p:nvPr/>
            </p:nvCxnSpPr>
            <p:spPr>
              <a:xfrm>
                <a:off x="1328362" y="5659156"/>
                <a:ext cx="0" cy="255083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Straight Connector 150"/>
              <p:cNvCxnSpPr>
                <a:cxnSpLocks/>
              </p:cNvCxnSpPr>
              <p:nvPr/>
            </p:nvCxnSpPr>
            <p:spPr>
              <a:xfrm rot="7857049">
                <a:off x="1469277" y="5570432"/>
                <a:ext cx="290160" cy="428926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2" name="Freeform 151"/>
            <p:cNvSpPr/>
            <p:nvPr/>
          </p:nvSpPr>
          <p:spPr>
            <a:xfrm rot="10800000">
              <a:off x="5381102" y="1731599"/>
              <a:ext cx="368195" cy="109138"/>
            </a:xfrm>
            <a:custGeom>
              <a:avLst/>
              <a:gdLst>
                <a:gd name="connsiteX0" fmla="*/ 0 w 3352874"/>
                <a:gd name="connsiteY0" fmla="*/ 876335 h 3219485"/>
                <a:gd name="connsiteX1" fmla="*/ 381000 w 3352874"/>
                <a:gd name="connsiteY1" fmla="*/ 361985 h 3219485"/>
                <a:gd name="connsiteX2" fmla="*/ 666750 w 3352874"/>
                <a:gd name="connsiteY2" fmla="*/ 914435 h 3219485"/>
                <a:gd name="connsiteX3" fmla="*/ 1409700 w 3352874"/>
                <a:gd name="connsiteY3" fmla="*/ 35 h 3219485"/>
                <a:gd name="connsiteX4" fmla="*/ 2266950 w 3352874"/>
                <a:gd name="connsiteY4" fmla="*/ 876335 h 3219485"/>
                <a:gd name="connsiteX5" fmla="*/ 2743200 w 3352874"/>
                <a:gd name="connsiteY5" fmla="*/ 247685 h 3219485"/>
                <a:gd name="connsiteX6" fmla="*/ 3352800 w 3352874"/>
                <a:gd name="connsiteY6" fmla="*/ 1219235 h 3219485"/>
                <a:gd name="connsiteX7" fmla="*/ 2781300 w 3352874"/>
                <a:gd name="connsiteY7" fmla="*/ 2971835 h 3219485"/>
                <a:gd name="connsiteX8" fmla="*/ 2305050 w 3352874"/>
                <a:gd name="connsiteY8" fmla="*/ 2266985 h 3219485"/>
                <a:gd name="connsiteX9" fmla="*/ 1409700 w 3352874"/>
                <a:gd name="connsiteY9" fmla="*/ 3219485 h 3219485"/>
                <a:gd name="connsiteX10" fmla="*/ 723900 w 3352874"/>
                <a:gd name="connsiteY10" fmla="*/ 2266985 h 3219485"/>
                <a:gd name="connsiteX11" fmla="*/ 361950 w 3352874"/>
                <a:gd name="connsiteY11" fmla="*/ 2819435 h 3219485"/>
                <a:gd name="connsiteX12" fmla="*/ 19050 w 3352874"/>
                <a:gd name="connsiteY12" fmla="*/ 2266985 h 3219485"/>
                <a:gd name="connsiteX13" fmla="*/ 19050 w 3352874"/>
                <a:gd name="connsiteY13" fmla="*/ 2266985 h 321948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</a:cxnLst>
              <a:rect l="l" t="t" r="r" b="b"/>
              <a:pathLst>
                <a:path w="3352874" h="3219485">
                  <a:moveTo>
                    <a:pt x="0" y="876335"/>
                  </a:moveTo>
                  <a:cubicBezTo>
                    <a:pt x="134937" y="615985"/>
                    <a:pt x="269875" y="355635"/>
                    <a:pt x="381000" y="361985"/>
                  </a:cubicBezTo>
                  <a:cubicBezTo>
                    <a:pt x="492125" y="368335"/>
                    <a:pt x="495300" y="974760"/>
                    <a:pt x="666750" y="914435"/>
                  </a:cubicBezTo>
                  <a:cubicBezTo>
                    <a:pt x="838200" y="854110"/>
                    <a:pt x="1143000" y="6385"/>
                    <a:pt x="1409700" y="35"/>
                  </a:cubicBezTo>
                  <a:cubicBezTo>
                    <a:pt x="1676400" y="-6315"/>
                    <a:pt x="2044700" y="835060"/>
                    <a:pt x="2266950" y="876335"/>
                  </a:cubicBezTo>
                  <a:cubicBezTo>
                    <a:pt x="2489200" y="917610"/>
                    <a:pt x="2562225" y="190535"/>
                    <a:pt x="2743200" y="247685"/>
                  </a:cubicBezTo>
                  <a:cubicBezTo>
                    <a:pt x="2924175" y="304835"/>
                    <a:pt x="3346450" y="765210"/>
                    <a:pt x="3352800" y="1219235"/>
                  </a:cubicBezTo>
                  <a:cubicBezTo>
                    <a:pt x="3359150" y="1673260"/>
                    <a:pt x="2955925" y="2797210"/>
                    <a:pt x="2781300" y="2971835"/>
                  </a:cubicBezTo>
                  <a:cubicBezTo>
                    <a:pt x="2606675" y="3146460"/>
                    <a:pt x="2533650" y="2225710"/>
                    <a:pt x="2305050" y="2266985"/>
                  </a:cubicBezTo>
                  <a:cubicBezTo>
                    <a:pt x="2076450" y="2308260"/>
                    <a:pt x="1673225" y="3219485"/>
                    <a:pt x="1409700" y="3219485"/>
                  </a:cubicBezTo>
                  <a:cubicBezTo>
                    <a:pt x="1146175" y="3219485"/>
                    <a:pt x="898525" y="2333660"/>
                    <a:pt x="723900" y="2266985"/>
                  </a:cubicBezTo>
                  <a:cubicBezTo>
                    <a:pt x="549275" y="2200310"/>
                    <a:pt x="479425" y="2819435"/>
                    <a:pt x="361950" y="2819435"/>
                  </a:cubicBezTo>
                  <a:cubicBezTo>
                    <a:pt x="244475" y="2819435"/>
                    <a:pt x="19050" y="2266985"/>
                    <a:pt x="19050" y="2266985"/>
                  </a:cubicBezTo>
                  <a:lnTo>
                    <a:pt x="19050" y="2266985"/>
                  </a:lnTo>
                </a:path>
              </a:pathLst>
            </a:custGeom>
            <a:noFill/>
            <a:ln w="28575" cap="flat" cmpd="sng" algn="ctr">
              <a:solidFill>
                <a:schemeClr val="accent6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IN" b="1" i="0" u="none" strike="noStrike" kern="0" cap="none" spc="0" normalizeH="0" baseline="0" noProof="0" dirty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ea typeface="+mn-ea"/>
                <a:cs typeface="+mn-cs"/>
              </a:endParaRPr>
            </a:p>
          </p:txBody>
        </p:sp>
        <p:cxnSp>
          <p:nvCxnSpPr>
            <p:cNvPr id="153" name="Straight Arrow Connector 152"/>
            <p:cNvCxnSpPr/>
            <p:nvPr/>
          </p:nvCxnSpPr>
          <p:spPr>
            <a:xfrm>
              <a:off x="5546274" y="1480756"/>
              <a:ext cx="13157" cy="218861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55" name="Group 154"/>
            <p:cNvGrpSpPr/>
            <p:nvPr/>
          </p:nvGrpSpPr>
          <p:grpSpPr>
            <a:xfrm rot="5400000">
              <a:off x="5489749" y="2615768"/>
              <a:ext cx="382992" cy="255083"/>
              <a:chOff x="1328362" y="5659156"/>
              <a:chExt cx="382992" cy="255083"/>
            </a:xfrm>
          </p:grpSpPr>
          <p:cxnSp>
            <p:nvCxnSpPr>
              <p:cNvPr id="156" name="Straight Connector 155"/>
              <p:cNvCxnSpPr/>
              <p:nvPr/>
            </p:nvCxnSpPr>
            <p:spPr>
              <a:xfrm>
                <a:off x="1328362" y="5659156"/>
                <a:ext cx="0" cy="255083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Straight Connector 156"/>
              <p:cNvCxnSpPr/>
              <p:nvPr/>
            </p:nvCxnSpPr>
            <p:spPr>
              <a:xfrm flipH="1" flipV="1">
                <a:off x="1328362" y="5786697"/>
                <a:ext cx="382992" cy="903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6" name="Group 115"/>
            <p:cNvGrpSpPr/>
            <p:nvPr/>
          </p:nvGrpSpPr>
          <p:grpSpPr>
            <a:xfrm>
              <a:off x="4682687" y="3335011"/>
              <a:ext cx="1195227" cy="773897"/>
              <a:chOff x="5609933" y="-627389"/>
              <a:chExt cx="1195227" cy="773897"/>
            </a:xfrm>
          </p:grpSpPr>
          <p:grpSp>
            <p:nvGrpSpPr>
              <p:cNvPr id="122" name="Group 121"/>
              <p:cNvGrpSpPr/>
              <p:nvPr/>
            </p:nvGrpSpPr>
            <p:grpSpPr>
              <a:xfrm>
                <a:off x="5609933" y="-429546"/>
                <a:ext cx="1195227" cy="576054"/>
                <a:chOff x="160186" y="-1398680"/>
                <a:chExt cx="1195227" cy="576054"/>
              </a:xfrm>
            </p:grpSpPr>
            <p:sp>
              <p:nvSpPr>
                <p:cNvPr id="126" name="Oval 455"/>
                <p:cNvSpPr/>
                <p:nvPr/>
              </p:nvSpPr>
              <p:spPr bwMode="auto">
                <a:xfrm rot="21228834">
                  <a:off x="160186" y="-1398680"/>
                  <a:ext cx="1195227" cy="513150"/>
                </a:xfrm>
                <a:custGeom>
                  <a:avLst/>
                  <a:gdLst>
                    <a:gd name="connsiteX0" fmla="*/ 0 w 196850"/>
                    <a:gd name="connsiteY0" fmla="*/ 100013 h 200025"/>
                    <a:gd name="connsiteX1" fmla="*/ 98425 w 196850"/>
                    <a:gd name="connsiteY1" fmla="*/ 0 h 200025"/>
                    <a:gd name="connsiteX2" fmla="*/ 196850 w 196850"/>
                    <a:gd name="connsiteY2" fmla="*/ 100013 h 200025"/>
                    <a:gd name="connsiteX3" fmla="*/ 98425 w 196850"/>
                    <a:gd name="connsiteY3" fmla="*/ 200026 h 200025"/>
                    <a:gd name="connsiteX4" fmla="*/ 0 w 196850"/>
                    <a:gd name="connsiteY4" fmla="*/ 100013 h 200025"/>
                    <a:gd name="connsiteX0" fmla="*/ 0 w 200436"/>
                    <a:gd name="connsiteY0" fmla="*/ 102821 h 202834"/>
                    <a:gd name="connsiteX1" fmla="*/ 98425 w 200436"/>
                    <a:gd name="connsiteY1" fmla="*/ 2808 h 202834"/>
                    <a:gd name="connsiteX2" fmla="*/ 171316 w 200436"/>
                    <a:gd name="connsiteY2" fmla="*/ 34173 h 202834"/>
                    <a:gd name="connsiteX3" fmla="*/ 196850 w 200436"/>
                    <a:gd name="connsiteY3" fmla="*/ 102821 h 202834"/>
                    <a:gd name="connsiteX4" fmla="*/ 98425 w 200436"/>
                    <a:gd name="connsiteY4" fmla="*/ 202834 h 202834"/>
                    <a:gd name="connsiteX5" fmla="*/ 0 w 200436"/>
                    <a:gd name="connsiteY5" fmla="*/ 102821 h 202834"/>
                    <a:gd name="connsiteX0" fmla="*/ 0 w 198381"/>
                    <a:gd name="connsiteY0" fmla="*/ 100336 h 200349"/>
                    <a:gd name="connsiteX1" fmla="*/ 98425 w 198381"/>
                    <a:gd name="connsiteY1" fmla="*/ 323 h 200349"/>
                    <a:gd name="connsiteX2" fmla="*/ 128966 w 198381"/>
                    <a:gd name="connsiteY2" fmla="*/ 69534 h 200349"/>
                    <a:gd name="connsiteX3" fmla="*/ 196850 w 198381"/>
                    <a:gd name="connsiteY3" fmla="*/ 100336 h 200349"/>
                    <a:gd name="connsiteX4" fmla="*/ 98425 w 198381"/>
                    <a:gd name="connsiteY4" fmla="*/ 200349 h 200349"/>
                    <a:gd name="connsiteX5" fmla="*/ 0 w 198381"/>
                    <a:gd name="connsiteY5" fmla="*/ 100336 h 200349"/>
                    <a:gd name="connsiteX0" fmla="*/ 55 w 198436"/>
                    <a:gd name="connsiteY0" fmla="*/ 100336 h 163586"/>
                    <a:gd name="connsiteX1" fmla="*/ 98480 w 198436"/>
                    <a:gd name="connsiteY1" fmla="*/ 323 h 163586"/>
                    <a:gd name="connsiteX2" fmla="*/ 129021 w 198436"/>
                    <a:gd name="connsiteY2" fmla="*/ 69534 h 163586"/>
                    <a:gd name="connsiteX3" fmla="*/ 196905 w 198436"/>
                    <a:gd name="connsiteY3" fmla="*/ 100336 h 163586"/>
                    <a:gd name="connsiteX4" fmla="*/ 88478 w 198436"/>
                    <a:gd name="connsiteY4" fmla="*/ 163586 h 163586"/>
                    <a:gd name="connsiteX5" fmla="*/ 55 w 198436"/>
                    <a:gd name="connsiteY5" fmla="*/ 100336 h 16358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98436" h="163586">
                      <a:moveTo>
                        <a:pt x="55" y="100336"/>
                      </a:moveTo>
                      <a:cubicBezTo>
                        <a:pt x="1722" y="73125"/>
                        <a:pt x="76986" y="5457"/>
                        <a:pt x="98480" y="323"/>
                      </a:cubicBezTo>
                      <a:cubicBezTo>
                        <a:pt x="119974" y="-4811"/>
                        <a:pt x="112617" y="52865"/>
                        <a:pt x="129021" y="69534"/>
                      </a:cubicBezTo>
                      <a:cubicBezTo>
                        <a:pt x="145425" y="86203"/>
                        <a:pt x="209053" y="72226"/>
                        <a:pt x="196905" y="100336"/>
                      </a:cubicBezTo>
                      <a:cubicBezTo>
                        <a:pt x="184757" y="128446"/>
                        <a:pt x="142837" y="163586"/>
                        <a:pt x="88478" y="163586"/>
                      </a:cubicBezTo>
                      <a:cubicBezTo>
                        <a:pt x="34119" y="163586"/>
                        <a:pt x="-1612" y="127547"/>
                        <a:pt x="55" y="100336"/>
                      </a:cubicBezTo>
                      <a:close/>
                    </a:path>
                  </a:pathLst>
                </a:custGeom>
                <a:solidFill>
                  <a:schemeClr val="accent5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IN" b="1"/>
                </a:p>
              </p:txBody>
            </p:sp>
            <p:sp>
              <p:nvSpPr>
                <p:cNvPr id="127" name="Rectangle 126"/>
                <p:cNvSpPr/>
                <p:nvPr/>
              </p:nvSpPr>
              <p:spPr>
                <a:xfrm>
                  <a:off x="250931" y="-1211322"/>
                  <a:ext cx="853119" cy="38869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IN" b="1" kern="100" dirty="0">
                      <a:solidFill>
                        <a:schemeClr val="bg1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TFB2M</a:t>
                  </a:r>
                  <a:endParaRPr lang="en-IN" b="1" kern="100" dirty="0">
                    <a:solidFill>
                      <a:schemeClr val="bg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158" name="Straight Arrow Connector 157"/>
              <p:cNvCxnSpPr>
                <a:cxnSpLocks/>
              </p:cNvCxnSpPr>
              <p:nvPr/>
            </p:nvCxnSpPr>
            <p:spPr>
              <a:xfrm flipV="1">
                <a:off x="5768537" y="-627389"/>
                <a:ext cx="160549" cy="633769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8" name="Group 117"/>
            <p:cNvGrpSpPr/>
            <p:nvPr/>
          </p:nvGrpSpPr>
          <p:grpSpPr>
            <a:xfrm>
              <a:off x="6227786" y="2574361"/>
              <a:ext cx="965329" cy="400743"/>
              <a:chOff x="5731150" y="1441016"/>
              <a:chExt cx="965329" cy="400743"/>
            </a:xfrm>
          </p:grpSpPr>
          <p:sp>
            <p:nvSpPr>
              <p:cNvPr id="159" name="Oval 455"/>
              <p:cNvSpPr/>
              <p:nvPr/>
            </p:nvSpPr>
            <p:spPr bwMode="auto">
              <a:xfrm rot="21138274" flipV="1">
                <a:off x="5774860" y="1441016"/>
                <a:ext cx="900379" cy="368737"/>
              </a:xfrm>
              <a:custGeom>
                <a:avLst/>
                <a:gdLst>
                  <a:gd name="connsiteX0" fmla="*/ 0 w 196850"/>
                  <a:gd name="connsiteY0" fmla="*/ 100013 h 200025"/>
                  <a:gd name="connsiteX1" fmla="*/ 98425 w 196850"/>
                  <a:gd name="connsiteY1" fmla="*/ 0 h 200025"/>
                  <a:gd name="connsiteX2" fmla="*/ 196850 w 196850"/>
                  <a:gd name="connsiteY2" fmla="*/ 100013 h 200025"/>
                  <a:gd name="connsiteX3" fmla="*/ 98425 w 196850"/>
                  <a:gd name="connsiteY3" fmla="*/ 200026 h 200025"/>
                  <a:gd name="connsiteX4" fmla="*/ 0 w 196850"/>
                  <a:gd name="connsiteY4" fmla="*/ 100013 h 200025"/>
                  <a:gd name="connsiteX0" fmla="*/ 0 w 200436"/>
                  <a:gd name="connsiteY0" fmla="*/ 102821 h 202834"/>
                  <a:gd name="connsiteX1" fmla="*/ 98425 w 200436"/>
                  <a:gd name="connsiteY1" fmla="*/ 2808 h 202834"/>
                  <a:gd name="connsiteX2" fmla="*/ 171316 w 200436"/>
                  <a:gd name="connsiteY2" fmla="*/ 34173 h 202834"/>
                  <a:gd name="connsiteX3" fmla="*/ 196850 w 200436"/>
                  <a:gd name="connsiteY3" fmla="*/ 102821 h 202834"/>
                  <a:gd name="connsiteX4" fmla="*/ 98425 w 200436"/>
                  <a:gd name="connsiteY4" fmla="*/ 202834 h 202834"/>
                  <a:gd name="connsiteX5" fmla="*/ 0 w 200436"/>
                  <a:gd name="connsiteY5" fmla="*/ 102821 h 202834"/>
                  <a:gd name="connsiteX0" fmla="*/ 0 w 198381"/>
                  <a:gd name="connsiteY0" fmla="*/ 100336 h 200349"/>
                  <a:gd name="connsiteX1" fmla="*/ 98425 w 198381"/>
                  <a:gd name="connsiteY1" fmla="*/ 323 h 200349"/>
                  <a:gd name="connsiteX2" fmla="*/ 128966 w 198381"/>
                  <a:gd name="connsiteY2" fmla="*/ 69534 h 200349"/>
                  <a:gd name="connsiteX3" fmla="*/ 196850 w 198381"/>
                  <a:gd name="connsiteY3" fmla="*/ 100336 h 200349"/>
                  <a:gd name="connsiteX4" fmla="*/ 98425 w 198381"/>
                  <a:gd name="connsiteY4" fmla="*/ 200349 h 200349"/>
                  <a:gd name="connsiteX5" fmla="*/ 0 w 198381"/>
                  <a:gd name="connsiteY5" fmla="*/ 100336 h 200349"/>
                  <a:gd name="connsiteX0" fmla="*/ 55 w 198436"/>
                  <a:gd name="connsiteY0" fmla="*/ 100336 h 163586"/>
                  <a:gd name="connsiteX1" fmla="*/ 98480 w 198436"/>
                  <a:gd name="connsiteY1" fmla="*/ 323 h 163586"/>
                  <a:gd name="connsiteX2" fmla="*/ 129021 w 198436"/>
                  <a:gd name="connsiteY2" fmla="*/ 69534 h 163586"/>
                  <a:gd name="connsiteX3" fmla="*/ 196905 w 198436"/>
                  <a:gd name="connsiteY3" fmla="*/ 100336 h 163586"/>
                  <a:gd name="connsiteX4" fmla="*/ 88478 w 198436"/>
                  <a:gd name="connsiteY4" fmla="*/ 163586 h 163586"/>
                  <a:gd name="connsiteX5" fmla="*/ 55 w 198436"/>
                  <a:gd name="connsiteY5" fmla="*/ 100336 h 16358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98436" h="163586">
                    <a:moveTo>
                      <a:pt x="55" y="100336"/>
                    </a:moveTo>
                    <a:cubicBezTo>
                      <a:pt x="1722" y="73125"/>
                      <a:pt x="76986" y="5457"/>
                      <a:pt x="98480" y="323"/>
                    </a:cubicBezTo>
                    <a:cubicBezTo>
                      <a:pt x="119974" y="-4811"/>
                      <a:pt x="112617" y="52865"/>
                      <a:pt x="129021" y="69534"/>
                    </a:cubicBezTo>
                    <a:cubicBezTo>
                      <a:pt x="145425" y="86203"/>
                      <a:pt x="209053" y="72226"/>
                      <a:pt x="196905" y="100336"/>
                    </a:cubicBezTo>
                    <a:cubicBezTo>
                      <a:pt x="184757" y="128446"/>
                      <a:pt x="142837" y="163586"/>
                      <a:pt x="88478" y="163586"/>
                    </a:cubicBezTo>
                    <a:cubicBezTo>
                      <a:pt x="34119" y="163586"/>
                      <a:pt x="-1612" y="127547"/>
                      <a:pt x="55" y="100336"/>
                    </a:cubicBezTo>
                    <a:close/>
                  </a:path>
                </a:pathLst>
              </a:cu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IN" b="1"/>
              </a:p>
            </p:txBody>
          </p:sp>
          <p:sp>
            <p:nvSpPr>
              <p:cNvPr id="160" name="Rectangle 159"/>
              <p:cNvSpPr/>
              <p:nvPr/>
            </p:nvSpPr>
            <p:spPr>
              <a:xfrm>
                <a:off x="5731150" y="1453063"/>
                <a:ext cx="965329" cy="38869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N" b="1" kern="1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MTERF1</a:t>
                </a:r>
                <a:endParaRPr lang="en-IN" b="1" kern="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61" name="Flowchart: Connector 160"/>
            <p:cNvSpPr/>
            <p:nvPr/>
          </p:nvSpPr>
          <p:spPr bwMode="auto">
            <a:xfrm>
              <a:off x="7730375" y="1638818"/>
              <a:ext cx="216263" cy="215178"/>
            </a:xfrm>
            <a:prstGeom prst="flowChartConnector">
              <a:avLst/>
            </a:prstGeom>
            <a:solidFill>
              <a:schemeClr val="accent2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IN" b="1"/>
            </a:p>
          </p:txBody>
        </p:sp>
        <p:sp>
          <p:nvSpPr>
            <p:cNvPr id="162" name="Rectangle 161"/>
            <p:cNvSpPr/>
            <p:nvPr/>
          </p:nvSpPr>
          <p:spPr>
            <a:xfrm>
              <a:off x="7724921" y="1623940"/>
              <a:ext cx="256802" cy="27347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IN" sz="1050" kern="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endParaRPr lang="en-IN" sz="105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3" name="Straight Arrow Connector 162"/>
            <p:cNvCxnSpPr/>
            <p:nvPr/>
          </p:nvCxnSpPr>
          <p:spPr>
            <a:xfrm flipH="1">
              <a:off x="7580423" y="2367439"/>
              <a:ext cx="91660" cy="40350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Straight Arrow Connector 164"/>
            <p:cNvCxnSpPr>
              <a:endCxn id="42" idx="0"/>
            </p:cNvCxnSpPr>
            <p:nvPr/>
          </p:nvCxnSpPr>
          <p:spPr>
            <a:xfrm flipH="1">
              <a:off x="7368012" y="3377274"/>
              <a:ext cx="150990" cy="1267159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Straight Arrow Connector 166"/>
            <p:cNvCxnSpPr/>
            <p:nvPr/>
          </p:nvCxnSpPr>
          <p:spPr>
            <a:xfrm flipH="1">
              <a:off x="8922942" y="1873226"/>
              <a:ext cx="91660" cy="40350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Straight Arrow Connector 169"/>
            <p:cNvCxnSpPr/>
            <p:nvPr/>
          </p:nvCxnSpPr>
          <p:spPr>
            <a:xfrm flipH="1">
              <a:off x="7120838" y="2628951"/>
              <a:ext cx="34541" cy="325201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Straight Arrow Connector 172"/>
            <p:cNvCxnSpPr/>
            <p:nvPr/>
          </p:nvCxnSpPr>
          <p:spPr>
            <a:xfrm flipV="1">
              <a:off x="7719924" y="2965232"/>
              <a:ext cx="4997" cy="28719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Straight Arrow Connector 174"/>
            <p:cNvCxnSpPr/>
            <p:nvPr/>
          </p:nvCxnSpPr>
          <p:spPr>
            <a:xfrm flipH="1">
              <a:off x="7978893" y="2008637"/>
              <a:ext cx="34541" cy="325201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Straight Arrow Connector 175"/>
            <p:cNvCxnSpPr/>
            <p:nvPr/>
          </p:nvCxnSpPr>
          <p:spPr>
            <a:xfrm flipH="1">
              <a:off x="8013434" y="1301909"/>
              <a:ext cx="449718" cy="51362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Straight Arrow Connector 177"/>
            <p:cNvCxnSpPr/>
            <p:nvPr/>
          </p:nvCxnSpPr>
          <p:spPr>
            <a:xfrm>
              <a:off x="7224485" y="1428123"/>
              <a:ext cx="1301743" cy="318284"/>
            </a:xfrm>
            <a:prstGeom prst="straightConnector1">
              <a:avLst/>
            </a:prstGeom>
            <a:ln w="28575">
              <a:solidFill>
                <a:schemeClr val="tx1"/>
              </a:solidFill>
              <a:prstDash val="sysDot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2" name="Lightning Bolt 181"/>
            <p:cNvSpPr/>
            <p:nvPr/>
          </p:nvSpPr>
          <p:spPr>
            <a:xfrm rot="6556256" flipV="1">
              <a:off x="6022450" y="-208836"/>
              <a:ext cx="2250137" cy="653509"/>
            </a:xfrm>
            <a:prstGeom prst="lightningBol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b="1"/>
            </a:p>
          </p:txBody>
        </p:sp>
        <p:cxnSp>
          <p:nvCxnSpPr>
            <p:cNvPr id="185" name="Curved Connector 184"/>
            <p:cNvCxnSpPr/>
            <p:nvPr/>
          </p:nvCxnSpPr>
          <p:spPr>
            <a:xfrm flipV="1">
              <a:off x="5626551" y="730820"/>
              <a:ext cx="857857" cy="415472"/>
            </a:xfrm>
            <a:prstGeom prst="curvedConnector3">
              <a:avLst>
                <a:gd name="adj1" fmla="val -5516"/>
              </a:avLst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89" name="Group 188"/>
            <p:cNvGrpSpPr/>
            <p:nvPr/>
          </p:nvGrpSpPr>
          <p:grpSpPr>
            <a:xfrm rot="16405762">
              <a:off x="3818118" y="1845591"/>
              <a:ext cx="382992" cy="255083"/>
              <a:chOff x="1328362" y="5659156"/>
              <a:chExt cx="382992" cy="255083"/>
            </a:xfrm>
          </p:grpSpPr>
          <p:cxnSp>
            <p:nvCxnSpPr>
              <p:cNvPr id="190" name="Straight Connector 189"/>
              <p:cNvCxnSpPr/>
              <p:nvPr/>
            </p:nvCxnSpPr>
            <p:spPr>
              <a:xfrm>
                <a:off x="1328362" y="5659156"/>
                <a:ext cx="0" cy="255083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1" name="Straight Connector 190"/>
              <p:cNvCxnSpPr/>
              <p:nvPr/>
            </p:nvCxnSpPr>
            <p:spPr>
              <a:xfrm flipH="1" flipV="1">
                <a:off x="1328362" y="5786697"/>
                <a:ext cx="382992" cy="903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92" name="Straight Arrow Connector 191"/>
            <p:cNvCxnSpPr/>
            <p:nvPr/>
          </p:nvCxnSpPr>
          <p:spPr>
            <a:xfrm>
              <a:off x="3653437" y="2850830"/>
              <a:ext cx="57433" cy="1660922"/>
            </a:xfrm>
            <a:prstGeom prst="straightConnector1">
              <a:avLst/>
            </a:prstGeom>
            <a:ln w="28575">
              <a:solidFill>
                <a:schemeClr val="tx1"/>
              </a:solidFill>
              <a:prstDash val="sysDot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4" name="Straight Arrow Connector 193"/>
            <p:cNvCxnSpPr/>
            <p:nvPr/>
          </p:nvCxnSpPr>
          <p:spPr>
            <a:xfrm flipH="1">
              <a:off x="2719769" y="2806817"/>
              <a:ext cx="490096" cy="1056389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7" name="Straight Arrow Connector 196"/>
            <p:cNvCxnSpPr/>
            <p:nvPr/>
          </p:nvCxnSpPr>
          <p:spPr>
            <a:xfrm flipH="1">
              <a:off x="2137679" y="4561704"/>
              <a:ext cx="84943" cy="485932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01" name="Group 200"/>
            <p:cNvGrpSpPr/>
            <p:nvPr/>
          </p:nvGrpSpPr>
          <p:grpSpPr>
            <a:xfrm rot="854834">
              <a:off x="5395204" y="6953794"/>
              <a:ext cx="1200016" cy="1188952"/>
              <a:chOff x="274641" y="133552"/>
              <a:chExt cx="10725077" cy="6697606"/>
            </a:xfrm>
          </p:grpSpPr>
          <p:grpSp>
            <p:nvGrpSpPr>
              <p:cNvPr id="202" name="Group 201">
                <a:extLst>
                  <a:ext uri="{FF2B5EF4-FFF2-40B4-BE49-F238E27FC236}">
                    <a16:creationId xmlns:a16="http://schemas.microsoft.com/office/drawing/2014/main" id="{4C23194E-9DED-4A59-AD95-5B73C7C995A4}"/>
                  </a:ext>
                </a:extLst>
              </p:cNvPr>
              <p:cNvGrpSpPr/>
              <p:nvPr/>
            </p:nvGrpSpPr>
            <p:grpSpPr>
              <a:xfrm rot="3708124">
                <a:off x="4597488" y="-1937690"/>
                <a:ext cx="1936078" cy="10581771"/>
                <a:chOff x="1374335" y="-216311"/>
                <a:chExt cx="1306816" cy="7142496"/>
              </a:xfrm>
              <a:solidFill>
                <a:schemeClr val="bg1"/>
              </a:solidFill>
            </p:grpSpPr>
            <p:grpSp>
              <p:nvGrpSpPr>
                <p:cNvPr id="289" name="Group 288">
                  <a:extLst>
                    <a:ext uri="{FF2B5EF4-FFF2-40B4-BE49-F238E27FC236}">
                      <a16:creationId xmlns:a16="http://schemas.microsoft.com/office/drawing/2014/main" id="{FEBE308C-B048-4B63-BB54-D1B3220716F1}"/>
                    </a:ext>
                  </a:extLst>
                </p:cNvPr>
                <p:cNvGrpSpPr/>
                <p:nvPr/>
              </p:nvGrpSpPr>
              <p:grpSpPr>
                <a:xfrm flipH="1">
                  <a:off x="1464912" y="460176"/>
                  <a:ext cx="1216239" cy="5651986"/>
                  <a:chOff x="3024554" y="-1570904"/>
                  <a:chExt cx="2025748" cy="7864574"/>
                </a:xfrm>
                <a:grpFill/>
              </p:grpSpPr>
              <p:sp>
                <p:nvSpPr>
                  <p:cNvPr id="292" name="Freeform: Shape 16">
                    <a:extLst>
                      <a:ext uri="{FF2B5EF4-FFF2-40B4-BE49-F238E27FC236}">
                        <a16:creationId xmlns:a16="http://schemas.microsoft.com/office/drawing/2014/main" id="{1BE6C8AA-3034-4FF9-B426-53D489D8DDBE}"/>
                      </a:ext>
                    </a:extLst>
                  </p:cNvPr>
                  <p:cNvSpPr/>
                  <p:nvPr/>
                </p:nvSpPr>
                <p:spPr>
                  <a:xfrm>
                    <a:off x="3024554" y="3539648"/>
                    <a:ext cx="1012874" cy="2754022"/>
                  </a:xfrm>
                  <a:custGeom>
                    <a:avLst/>
                    <a:gdLst>
                      <a:gd name="connsiteX0" fmla="*/ 1012874 w 1012874"/>
                      <a:gd name="connsiteY0" fmla="*/ 0 h 2754022"/>
                      <a:gd name="connsiteX1" fmla="*/ 1012874 w 1012874"/>
                      <a:gd name="connsiteY1" fmla="*/ 198230 h 2754022"/>
                      <a:gd name="connsiteX2" fmla="*/ 953198 w 1012874"/>
                      <a:gd name="connsiteY2" fmla="*/ 220072 h 2754022"/>
                      <a:gd name="connsiteX3" fmla="*/ 186327 w 1012874"/>
                      <a:gd name="connsiteY3" fmla="*/ 1377011 h 2754022"/>
                      <a:gd name="connsiteX4" fmla="*/ 953198 w 1012874"/>
                      <a:gd name="connsiteY4" fmla="*/ 2533950 h 2754022"/>
                      <a:gd name="connsiteX5" fmla="*/ 1012874 w 1012874"/>
                      <a:gd name="connsiteY5" fmla="*/ 2555792 h 2754022"/>
                      <a:gd name="connsiteX6" fmla="*/ 1012874 w 1012874"/>
                      <a:gd name="connsiteY6" fmla="*/ 2754022 h 2754022"/>
                      <a:gd name="connsiteX7" fmla="*/ 880671 w 1012874"/>
                      <a:gd name="connsiteY7" fmla="*/ 2705636 h 2754022"/>
                      <a:gd name="connsiteX8" fmla="*/ 0 w 1012874"/>
                      <a:gd name="connsiteY8" fmla="*/ 1377011 h 2754022"/>
                      <a:gd name="connsiteX9" fmla="*/ 880671 w 1012874"/>
                      <a:gd name="connsiteY9" fmla="*/ 48387 h 275402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</a:cxnLst>
                    <a:rect l="l" t="t" r="r" b="b"/>
                    <a:pathLst>
                      <a:path w="1012874" h="2754022">
                        <a:moveTo>
                          <a:pt x="1012874" y="0"/>
                        </a:moveTo>
                        <a:lnTo>
                          <a:pt x="1012874" y="198230"/>
                        </a:lnTo>
                        <a:lnTo>
                          <a:pt x="953198" y="220072"/>
                        </a:lnTo>
                        <a:cubicBezTo>
                          <a:pt x="502540" y="410684"/>
                          <a:pt x="186327" y="856920"/>
                          <a:pt x="186327" y="1377011"/>
                        </a:cubicBezTo>
                        <a:cubicBezTo>
                          <a:pt x="186327" y="1897102"/>
                          <a:pt x="502540" y="2343338"/>
                          <a:pt x="953198" y="2533950"/>
                        </a:cubicBezTo>
                        <a:lnTo>
                          <a:pt x="1012874" y="2555792"/>
                        </a:lnTo>
                        <a:lnTo>
                          <a:pt x="1012874" y="2754022"/>
                        </a:lnTo>
                        <a:lnTo>
                          <a:pt x="880671" y="2705636"/>
                        </a:lnTo>
                        <a:cubicBezTo>
                          <a:pt x="363138" y="2486737"/>
                          <a:pt x="0" y="1974282"/>
                          <a:pt x="0" y="1377011"/>
                        </a:cubicBezTo>
                        <a:cubicBezTo>
                          <a:pt x="0" y="779740"/>
                          <a:pt x="363138" y="267285"/>
                          <a:pt x="880671" y="48387"/>
                        </a:cubicBezTo>
                        <a:close/>
                      </a:path>
                    </a:pathLst>
                  </a:cu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93" name="Freeform: Shape 17">
                    <a:extLst>
                      <a:ext uri="{FF2B5EF4-FFF2-40B4-BE49-F238E27FC236}">
                        <a16:creationId xmlns:a16="http://schemas.microsoft.com/office/drawing/2014/main" id="{33422DED-F1F0-4D13-BC74-ADB211C8F9D9}"/>
                      </a:ext>
                    </a:extLst>
                  </p:cNvPr>
                  <p:cNvSpPr/>
                  <p:nvPr/>
                </p:nvSpPr>
                <p:spPr>
                  <a:xfrm flipH="1">
                    <a:off x="4037428" y="984372"/>
                    <a:ext cx="1012874" cy="2754022"/>
                  </a:xfrm>
                  <a:custGeom>
                    <a:avLst/>
                    <a:gdLst>
                      <a:gd name="connsiteX0" fmla="*/ 1012874 w 1012874"/>
                      <a:gd name="connsiteY0" fmla="*/ 0 h 2754022"/>
                      <a:gd name="connsiteX1" fmla="*/ 1012874 w 1012874"/>
                      <a:gd name="connsiteY1" fmla="*/ 198230 h 2754022"/>
                      <a:gd name="connsiteX2" fmla="*/ 953198 w 1012874"/>
                      <a:gd name="connsiteY2" fmla="*/ 220072 h 2754022"/>
                      <a:gd name="connsiteX3" fmla="*/ 186327 w 1012874"/>
                      <a:gd name="connsiteY3" fmla="*/ 1377011 h 2754022"/>
                      <a:gd name="connsiteX4" fmla="*/ 953198 w 1012874"/>
                      <a:gd name="connsiteY4" fmla="*/ 2533950 h 2754022"/>
                      <a:gd name="connsiteX5" fmla="*/ 1012874 w 1012874"/>
                      <a:gd name="connsiteY5" fmla="*/ 2555792 h 2754022"/>
                      <a:gd name="connsiteX6" fmla="*/ 1012874 w 1012874"/>
                      <a:gd name="connsiteY6" fmla="*/ 2754022 h 2754022"/>
                      <a:gd name="connsiteX7" fmla="*/ 880671 w 1012874"/>
                      <a:gd name="connsiteY7" fmla="*/ 2705636 h 2754022"/>
                      <a:gd name="connsiteX8" fmla="*/ 0 w 1012874"/>
                      <a:gd name="connsiteY8" fmla="*/ 1377011 h 2754022"/>
                      <a:gd name="connsiteX9" fmla="*/ 880671 w 1012874"/>
                      <a:gd name="connsiteY9" fmla="*/ 48387 h 275402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</a:cxnLst>
                    <a:rect l="l" t="t" r="r" b="b"/>
                    <a:pathLst>
                      <a:path w="1012874" h="2754022">
                        <a:moveTo>
                          <a:pt x="1012874" y="0"/>
                        </a:moveTo>
                        <a:lnTo>
                          <a:pt x="1012874" y="198230"/>
                        </a:lnTo>
                        <a:lnTo>
                          <a:pt x="953198" y="220072"/>
                        </a:lnTo>
                        <a:cubicBezTo>
                          <a:pt x="502540" y="410684"/>
                          <a:pt x="186327" y="856920"/>
                          <a:pt x="186327" y="1377011"/>
                        </a:cubicBezTo>
                        <a:cubicBezTo>
                          <a:pt x="186327" y="1897102"/>
                          <a:pt x="502540" y="2343338"/>
                          <a:pt x="953198" y="2533950"/>
                        </a:cubicBezTo>
                        <a:lnTo>
                          <a:pt x="1012874" y="2555792"/>
                        </a:lnTo>
                        <a:lnTo>
                          <a:pt x="1012874" y="2754022"/>
                        </a:lnTo>
                        <a:lnTo>
                          <a:pt x="880671" y="2705636"/>
                        </a:lnTo>
                        <a:cubicBezTo>
                          <a:pt x="363138" y="2486737"/>
                          <a:pt x="0" y="1974282"/>
                          <a:pt x="0" y="1377011"/>
                        </a:cubicBezTo>
                        <a:cubicBezTo>
                          <a:pt x="0" y="779740"/>
                          <a:pt x="363138" y="267285"/>
                          <a:pt x="880671" y="48387"/>
                        </a:cubicBezTo>
                        <a:close/>
                      </a:path>
                    </a:pathLst>
                  </a:cu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94" name="Freeform: Shape 18">
                    <a:extLst>
                      <a:ext uri="{FF2B5EF4-FFF2-40B4-BE49-F238E27FC236}">
                        <a16:creationId xmlns:a16="http://schemas.microsoft.com/office/drawing/2014/main" id="{41196978-B02B-46D9-B166-47887F5D14F4}"/>
                      </a:ext>
                    </a:extLst>
                  </p:cNvPr>
                  <p:cNvSpPr/>
                  <p:nvPr/>
                </p:nvSpPr>
                <p:spPr>
                  <a:xfrm>
                    <a:off x="3024554" y="-1570904"/>
                    <a:ext cx="1012874" cy="2754022"/>
                  </a:xfrm>
                  <a:custGeom>
                    <a:avLst/>
                    <a:gdLst>
                      <a:gd name="connsiteX0" fmla="*/ 1012874 w 1012874"/>
                      <a:gd name="connsiteY0" fmla="*/ 0 h 2754022"/>
                      <a:gd name="connsiteX1" fmla="*/ 1012874 w 1012874"/>
                      <a:gd name="connsiteY1" fmla="*/ 198230 h 2754022"/>
                      <a:gd name="connsiteX2" fmla="*/ 953198 w 1012874"/>
                      <a:gd name="connsiteY2" fmla="*/ 220072 h 2754022"/>
                      <a:gd name="connsiteX3" fmla="*/ 186327 w 1012874"/>
                      <a:gd name="connsiteY3" fmla="*/ 1377011 h 2754022"/>
                      <a:gd name="connsiteX4" fmla="*/ 953198 w 1012874"/>
                      <a:gd name="connsiteY4" fmla="*/ 2533950 h 2754022"/>
                      <a:gd name="connsiteX5" fmla="*/ 1012874 w 1012874"/>
                      <a:gd name="connsiteY5" fmla="*/ 2555792 h 2754022"/>
                      <a:gd name="connsiteX6" fmla="*/ 1012874 w 1012874"/>
                      <a:gd name="connsiteY6" fmla="*/ 2754022 h 2754022"/>
                      <a:gd name="connsiteX7" fmla="*/ 880671 w 1012874"/>
                      <a:gd name="connsiteY7" fmla="*/ 2705636 h 2754022"/>
                      <a:gd name="connsiteX8" fmla="*/ 0 w 1012874"/>
                      <a:gd name="connsiteY8" fmla="*/ 1377011 h 2754022"/>
                      <a:gd name="connsiteX9" fmla="*/ 880671 w 1012874"/>
                      <a:gd name="connsiteY9" fmla="*/ 48387 h 275402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</a:cxnLst>
                    <a:rect l="l" t="t" r="r" b="b"/>
                    <a:pathLst>
                      <a:path w="1012874" h="2754022">
                        <a:moveTo>
                          <a:pt x="1012874" y="0"/>
                        </a:moveTo>
                        <a:lnTo>
                          <a:pt x="1012874" y="198230"/>
                        </a:lnTo>
                        <a:lnTo>
                          <a:pt x="953198" y="220072"/>
                        </a:lnTo>
                        <a:cubicBezTo>
                          <a:pt x="502540" y="410684"/>
                          <a:pt x="186327" y="856920"/>
                          <a:pt x="186327" y="1377011"/>
                        </a:cubicBezTo>
                        <a:cubicBezTo>
                          <a:pt x="186327" y="1897102"/>
                          <a:pt x="502540" y="2343338"/>
                          <a:pt x="953198" y="2533950"/>
                        </a:cubicBezTo>
                        <a:lnTo>
                          <a:pt x="1012874" y="2555792"/>
                        </a:lnTo>
                        <a:lnTo>
                          <a:pt x="1012874" y="2754022"/>
                        </a:lnTo>
                        <a:lnTo>
                          <a:pt x="880671" y="2705636"/>
                        </a:lnTo>
                        <a:cubicBezTo>
                          <a:pt x="363138" y="2486737"/>
                          <a:pt x="0" y="1974282"/>
                          <a:pt x="0" y="1377011"/>
                        </a:cubicBezTo>
                        <a:cubicBezTo>
                          <a:pt x="0" y="779740"/>
                          <a:pt x="363138" y="267285"/>
                          <a:pt x="880671" y="48387"/>
                        </a:cubicBezTo>
                        <a:close/>
                      </a:path>
                    </a:pathLst>
                  </a:cu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solidFill>
                        <a:prstClr val="black"/>
                      </a:solidFill>
                    </a:endParaRPr>
                  </a:p>
                </p:txBody>
              </p:sp>
            </p:grpSp>
            <p:sp>
              <p:nvSpPr>
                <p:cNvPr id="290" name="Freeform: Shape 22">
                  <a:extLst>
                    <a:ext uri="{FF2B5EF4-FFF2-40B4-BE49-F238E27FC236}">
                      <a16:creationId xmlns:a16="http://schemas.microsoft.com/office/drawing/2014/main" id="{93828622-6720-4081-B434-DAC656BF0E89}"/>
                    </a:ext>
                  </a:extLst>
                </p:cNvPr>
                <p:cNvSpPr/>
                <p:nvPr/>
              </p:nvSpPr>
              <p:spPr>
                <a:xfrm>
                  <a:off x="1504365" y="5969331"/>
                  <a:ext cx="606050" cy="956854"/>
                </a:xfrm>
                <a:custGeom>
                  <a:avLst/>
                  <a:gdLst>
                    <a:gd name="connsiteX0" fmla="*/ 606050 w 606050"/>
                    <a:gd name="connsiteY0" fmla="*/ 0 h 956854"/>
                    <a:gd name="connsiteX1" fmla="*/ 526677 w 606050"/>
                    <a:gd name="connsiteY1" fmla="*/ 34774 h 956854"/>
                    <a:gd name="connsiteX2" fmla="*/ 7905 w 606050"/>
                    <a:gd name="connsiteY2" fmla="*/ 831795 h 956854"/>
                    <a:gd name="connsiteX3" fmla="*/ 0 w 606050"/>
                    <a:gd name="connsiteY3" fmla="*/ 956854 h 956854"/>
                    <a:gd name="connsiteX4" fmla="*/ 111869 w 606050"/>
                    <a:gd name="connsiteY4" fmla="*/ 956854 h 956854"/>
                    <a:gd name="connsiteX5" fmla="*/ 118485 w 606050"/>
                    <a:gd name="connsiteY5" fmla="*/ 852187 h 956854"/>
                    <a:gd name="connsiteX6" fmla="*/ 570221 w 606050"/>
                    <a:gd name="connsiteY6" fmla="*/ 158158 h 956854"/>
                    <a:gd name="connsiteX7" fmla="*/ 606050 w 606050"/>
                    <a:gd name="connsiteY7" fmla="*/ 142461 h 95685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</a:cxnLst>
                  <a:rect l="l" t="t" r="r" b="b"/>
                  <a:pathLst>
                    <a:path w="606050" h="956854">
                      <a:moveTo>
                        <a:pt x="606050" y="0"/>
                      </a:moveTo>
                      <a:lnTo>
                        <a:pt x="526677" y="34774"/>
                      </a:lnTo>
                      <a:cubicBezTo>
                        <a:pt x="254795" y="172424"/>
                        <a:pt x="53885" y="471597"/>
                        <a:pt x="7905" y="831795"/>
                      </a:cubicBezTo>
                      <a:lnTo>
                        <a:pt x="0" y="956854"/>
                      </a:lnTo>
                      <a:lnTo>
                        <a:pt x="111869" y="956854"/>
                      </a:lnTo>
                      <a:lnTo>
                        <a:pt x="118485" y="852187"/>
                      </a:lnTo>
                      <a:cubicBezTo>
                        <a:pt x="158523" y="538535"/>
                        <a:pt x="333472" y="278021"/>
                        <a:pt x="570221" y="158158"/>
                      </a:cubicBezTo>
                      <a:lnTo>
                        <a:pt x="606050" y="142461"/>
                      </a:lnTo>
                      <a:close/>
                    </a:path>
                  </a:pathLst>
                </a:cu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291" name="Freeform: Shape 25">
                  <a:extLst>
                    <a:ext uri="{FF2B5EF4-FFF2-40B4-BE49-F238E27FC236}">
                      <a16:creationId xmlns:a16="http://schemas.microsoft.com/office/drawing/2014/main" id="{CDB6410D-7A48-42C9-BFB1-F4C12D085B5E}"/>
                    </a:ext>
                  </a:extLst>
                </p:cNvPr>
                <p:cNvSpPr/>
                <p:nvPr/>
              </p:nvSpPr>
              <p:spPr>
                <a:xfrm rot="18203236">
                  <a:off x="1549737" y="-391713"/>
                  <a:ext cx="606050" cy="956854"/>
                </a:xfrm>
                <a:custGeom>
                  <a:avLst/>
                  <a:gdLst>
                    <a:gd name="connsiteX0" fmla="*/ 606050 w 606050"/>
                    <a:gd name="connsiteY0" fmla="*/ 0 h 956854"/>
                    <a:gd name="connsiteX1" fmla="*/ 526677 w 606050"/>
                    <a:gd name="connsiteY1" fmla="*/ 34774 h 956854"/>
                    <a:gd name="connsiteX2" fmla="*/ 7905 w 606050"/>
                    <a:gd name="connsiteY2" fmla="*/ 831795 h 956854"/>
                    <a:gd name="connsiteX3" fmla="*/ 0 w 606050"/>
                    <a:gd name="connsiteY3" fmla="*/ 956854 h 956854"/>
                    <a:gd name="connsiteX4" fmla="*/ 111869 w 606050"/>
                    <a:gd name="connsiteY4" fmla="*/ 956854 h 956854"/>
                    <a:gd name="connsiteX5" fmla="*/ 118485 w 606050"/>
                    <a:gd name="connsiteY5" fmla="*/ 852187 h 956854"/>
                    <a:gd name="connsiteX6" fmla="*/ 570221 w 606050"/>
                    <a:gd name="connsiteY6" fmla="*/ 158158 h 956854"/>
                    <a:gd name="connsiteX7" fmla="*/ 606050 w 606050"/>
                    <a:gd name="connsiteY7" fmla="*/ 142461 h 95685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</a:cxnLst>
                  <a:rect l="l" t="t" r="r" b="b"/>
                  <a:pathLst>
                    <a:path w="606050" h="956854">
                      <a:moveTo>
                        <a:pt x="606050" y="0"/>
                      </a:moveTo>
                      <a:lnTo>
                        <a:pt x="526677" y="34774"/>
                      </a:lnTo>
                      <a:cubicBezTo>
                        <a:pt x="254795" y="172424"/>
                        <a:pt x="53885" y="471597"/>
                        <a:pt x="7905" y="831795"/>
                      </a:cubicBezTo>
                      <a:lnTo>
                        <a:pt x="0" y="956854"/>
                      </a:lnTo>
                      <a:lnTo>
                        <a:pt x="111869" y="956854"/>
                      </a:lnTo>
                      <a:lnTo>
                        <a:pt x="118485" y="852187"/>
                      </a:lnTo>
                      <a:cubicBezTo>
                        <a:pt x="158523" y="538535"/>
                        <a:pt x="333472" y="278021"/>
                        <a:pt x="570221" y="158158"/>
                      </a:cubicBezTo>
                      <a:lnTo>
                        <a:pt x="606050" y="142461"/>
                      </a:lnTo>
                      <a:close/>
                    </a:path>
                  </a:pathLst>
                </a:cu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solidFill>
                      <a:prstClr val="black"/>
                    </a:solidFill>
                  </a:endParaRPr>
                </a:p>
              </p:txBody>
            </p:sp>
          </p:grpSp>
          <p:grpSp>
            <p:nvGrpSpPr>
              <p:cNvPr id="203" name="Group 202">
                <a:extLst>
                  <a:ext uri="{FF2B5EF4-FFF2-40B4-BE49-F238E27FC236}">
                    <a16:creationId xmlns:a16="http://schemas.microsoft.com/office/drawing/2014/main" id="{6EE93265-09AD-4A23-833A-6002581923B6}"/>
                  </a:ext>
                </a:extLst>
              </p:cNvPr>
              <p:cNvGrpSpPr/>
              <p:nvPr/>
            </p:nvGrpSpPr>
            <p:grpSpPr>
              <a:xfrm rot="3708124">
                <a:off x="4719801" y="-1670402"/>
                <a:ext cx="1978064" cy="10581771"/>
                <a:chOff x="3821248" y="-73480"/>
                <a:chExt cx="1335156" cy="7142496"/>
              </a:xfrm>
              <a:solidFill>
                <a:schemeClr val="bg1"/>
              </a:solidFill>
            </p:grpSpPr>
            <p:sp>
              <p:nvSpPr>
                <p:cNvPr id="284" name="Freeform: Shape 11">
                  <a:extLst>
                    <a:ext uri="{FF2B5EF4-FFF2-40B4-BE49-F238E27FC236}">
                      <a16:creationId xmlns:a16="http://schemas.microsoft.com/office/drawing/2014/main" id="{115AC08B-2013-49CE-A52C-252952A54D79}"/>
                    </a:ext>
                  </a:extLst>
                </p:cNvPr>
                <p:cNvSpPr/>
                <p:nvPr/>
              </p:nvSpPr>
              <p:spPr>
                <a:xfrm>
                  <a:off x="3821248" y="4275777"/>
                  <a:ext cx="608120" cy="1979216"/>
                </a:xfrm>
                <a:custGeom>
                  <a:avLst/>
                  <a:gdLst>
                    <a:gd name="connsiteX0" fmla="*/ 1012874 w 1012874"/>
                    <a:gd name="connsiteY0" fmla="*/ 0 h 2754022"/>
                    <a:gd name="connsiteX1" fmla="*/ 1012874 w 1012874"/>
                    <a:gd name="connsiteY1" fmla="*/ 198230 h 2754022"/>
                    <a:gd name="connsiteX2" fmla="*/ 953198 w 1012874"/>
                    <a:gd name="connsiteY2" fmla="*/ 220072 h 2754022"/>
                    <a:gd name="connsiteX3" fmla="*/ 186327 w 1012874"/>
                    <a:gd name="connsiteY3" fmla="*/ 1377011 h 2754022"/>
                    <a:gd name="connsiteX4" fmla="*/ 953198 w 1012874"/>
                    <a:gd name="connsiteY4" fmla="*/ 2533950 h 2754022"/>
                    <a:gd name="connsiteX5" fmla="*/ 1012874 w 1012874"/>
                    <a:gd name="connsiteY5" fmla="*/ 2555792 h 2754022"/>
                    <a:gd name="connsiteX6" fmla="*/ 1012874 w 1012874"/>
                    <a:gd name="connsiteY6" fmla="*/ 2754022 h 2754022"/>
                    <a:gd name="connsiteX7" fmla="*/ 880671 w 1012874"/>
                    <a:gd name="connsiteY7" fmla="*/ 2705636 h 2754022"/>
                    <a:gd name="connsiteX8" fmla="*/ 0 w 1012874"/>
                    <a:gd name="connsiteY8" fmla="*/ 1377011 h 2754022"/>
                    <a:gd name="connsiteX9" fmla="*/ 880671 w 1012874"/>
                    <a:gd name="connsiteY9" fmla="*/ 48387 h 275402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1012874" h="2754022">
                      <a:moveTo>
                        <a:pt x="1012874" y="0"/>
                      </a:moveTo>
                      <a:lnTo>
                        <a:pt x="1012874" y="198230"/>
                      </a:lnTo>
                      <a:lnTo>
                        <a:pt x="953198" y="220072"/>
                      </a:lnTo>
                      <a:cubicBezTo>
                        <a:pt x="502540" y="410684"/>
                        <a:pt x="186327" y="856920"/>
                        <a:pt x="186327" y="1377011"/>
                      </a:cubicBezTo>
                      <a:cubicBezTo>
                        <a:pt x="186327" y="1897102"/>
                        <a:pt x="502540" y="2343338"/>
                        <a:pt x="953198" y="2533950"/>
                      </a:cubicBezTo>
                      <a:lnTo>
                        <a:pt x="1012874" y="2555792"/>
                      </a:lnTo>
                      <a:lnTo>
                        <a:pt x="1012874" y="2754022"/>
                      </a:lnTo>
                      <a:lnTo>
                        <a:pt x="880671" y="2705636"/>
                      </a:lnTo>
                      <a:cubicBezTo>
                        <a:pt x="363138" y="2486737"/>
                        <a:pt x="0" y="1974282"/>
                        <a:pt x="0" y="1377011"/>
                      </a:cubicBezTo>
                      <a:cubicBezTo>
                        <a:pt x="0" y="779740"/>
                        <a:pt x="363138" y="267285"/>
                        <a:pt x="880671" y="48387"/>
                      </a:cubicBezTo>
                      <a:close/>
                    </a:path>
                  </a:pathLst>
                </a:cu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285" name="Freeform: Shape 12">
                  <a:extLst>
                    <a:ext uri="{FF2B5EF4-FFF2-40B4-BE49-F238E27FC236}">
                      <a16:creationId xmlns:a16="http://schemas.microsoft.com/office/drawing/2014/main" id="{FC48F3F6-524E-4959-B1BF-B382D39B5C84}"/>
                    </a:ext>
                  </a:extLst>
                </p:cNvPr>
                <p:cNvSpPr/>
                <p:nvPr/>
              </p:nvSpPr>
              <p:spPr>
                <a:xfrm flipH="1">
                  <a:off x="4429368" y="2439392"/>
                  <a:ext cx="608120" cy="1979216"/>
                </a:xfrm>
                <a:custGeom>
                  <a:avLst/>
                  <a:gdLst>
                    <a:gd name="connsiteX0" fmla="*/ 1012874 w 1012874"/>
                    <a:gd name="connsiteY0" fmla="*/ 0 h 2754022"/>
                    <a:gd name="connsiteX1" fmla="*/ 1012874 w 1012874"/>
                    <a:gd name="connsiteY1" fmla="*/ 198230 h 2754022"/>
                    <a:gd name="connsiteX2" fmla="*/ 953198 w 1012874"/>
                    <a:gd name="connsiteY2" fmla="*/ 220072 h 2754022"/>
                    <a:gd name="connsiteX3" fmla="*/ 186327 w 1012874"/>
                    <a:gd name="connsiteY3" fmla="*/ 1377011 h 2754022"/>
                    <a:gd name="connsiteX4" fmla="*/ 953198 w 1012874"/>
                    <a:gd name="connsiteY4" fmla="*/ 2533950 h 2754022"/>
                    <a:gd name="connsiteX5" fmla="*/ 1012874 w 1012874"/>
                    <a:gd name="connsiteY5" fmla="*/ 2555792 h 2754022"/>
                    <a:gd name="connsiteX6" fmla="*/ 1012874 w 1012874"/>
                    <a:gd name="connsiteY6" fmla="*/ 2754022 h 2754022"/>
                    <a:gd name="connsiteX7" fmla="*/ 880671 w 1012874"/>
                    <a:gd name="connsiteY7" fmla="*/ 2705636 h 2754022"/>
                    <a:gd name="connsiteX8" fmla="*/ 0 w 1012874"/>
                    <a:gd name="connsiteY8" fmla="*/ 1377011 h 2754022"/>
                    <a:gd name="connsiteX9" fmla="*/ 880671 w 1012874"/>
                    <a:gd name="connsiteY9" fmla="*/ 48387 h 275402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1012874" h="2754022">
                      <a:moveTo>
                        <a:pt x="1012874" y="0"/>
                      </a:moveTo>
                      <a:lnTo>
                        <a:pt x="1012874" y="198230"/>
                      </a:lnTo>
                      <a:lnTo>
                        <a:pt x="953198" y="220072"/>
                      </a:lnTo>
                      <a:cubicBezTo>
                        <a:pt x="502540" y="410684"/>
                        <a:pt x="186327" y="856920"/>
                        <a:pt x="186327" y="1377011"/>
                      </a:cubicBezTo>
                      <a:cubicBezTo>
                        <a:pt x="186327" y="1897102"/>
                        <a:pt x="502540" y="2343338"/>
                        <a:pt x="953198" y="2533950"/>
                      </a:cubicBezTo>
                      <a:lnTo>
                        <a:pt x="1012874" y="2555792"/>
                      </a:lnTo>
                      <a:lnTo>
                        <a:pt x="1012874" y="2754022"/>
                      </a:lnTo>
                      <a:lnTo>
                        <a:pt x="880671" y="2705636"/>
                      </a:lnTo>
                      <a:cubicBezTo>
                        <a:pt x="363138" y="2486737"/>
                        <a:pt x="0" y="1974282"/>
                        <a:pt x="0" y="1377011"/>
                      </a:cubicBezTo>
                      <a:cubicBezTo>
                        <a:pt x="0" y="779740"/>
                        <a:pt x="363138" y="267285"/>
                        <a:pt x="880671" y="48387"/>
                      </a:cubicBezTo>
                      <a:close/>
                    </a:path>
                  </a:pathLst>
                </a:cu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286" name="Freeform: Shape 13">
                  <a:extLst>
                    <a:ext uri="{FF2B5EF4-FFF2-40B4-BE49-F238E27FC236}">
                      <a16:creationId xmlns:a16="http://schemas.microsoft.com/office/drawing/2014/main" id="{DD76D0D8-B789-4771-884D-43DD38521513}"/>
                    </a:ext>
                  </a:extLst>
                </p:cNvPr>
                <p:cNvSpPr/>
                <p:nvPr/>
              </p:nvSpPr>
              <p:spPr>
                <a:xfrm>
                  <a:off x="3821248" y="603007"/>
                  <a:ext cx="608120" cy="1979216"/>
                </a:xfrm>
                <a:custGeom>
                  <a:avLst/>
                  <a:gdLst>
                    <a:gd name="connsiteX0" fmla="*/ 1012874 w 1012874"/>
                    <a:gd name="connsiteY0" fmla="*/ 0 h 2754022"/>
                    <a:gd name="connsiteX1" fmla="*/ 1012874 w 1012874"/>
                    <a:gd name="connsiteY1" fmla="*/ 198230 h 2754022"/>
                    <a:gd name="connsiteX2" fmla="*/ 953198 w 1012874"/>
                    <a:gd name="connsiteY2" fmla="*/ 220072 h 2754022"/>
                    <a:gd name="connsiteX3" fmla="*/ 186327 w 1012874"/>
                    <a:gd name="connsiteY3" fmla="*/ 1377011 h 2754022"/>
                    <a:gd name="connsiteX4" fmla="*/ 953198 w 1012874"/>
                    <a:gd name="connsiteY4" fmla="*/ 2533950 h 2754022"/>
                    <a:gd name="connsiteX5" fmla="*/ 1012874 w 1012874"/>
                    <a:gd name="connsiteY5" fmla="*/ 2555792 h 2754022"/>
                    <a:gd name="connsiteX6" fmla="*/ 1012874 w 1012874"/>
                    <a:gd name="connsiteY6" fmla="*/ 2754022 h 2754022"/>
                    <a:gd name="connsiteX7" fmla="*/ 880671 w 1012874"/>
                    <a:gd name="connsiteY7" fmla="*/ 2705636 h 2754022"/>
                    <a:gd name="connsiteX8" fmla="*/ 0 w 1012874"/>
                    <a:gd name="connsiteY8" fmla="*/ 1377011 h 2754022"/>
                    <a:gd name="connsiteX9" fmla="*/ 880671 w 1012874"/>
                    <a:gd name="connsiteY9" fmla="*/ 48387 h 275402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1012874" h="2754022">
                      <a:moveTo>
                        <a:pt x="1012874" y="0"/>
                      </a:moveTo>
                      <a:lnTo>
                        <a:pt x="1012874" y="198230"/>
                      </a:lnTo>
                      <a:lnTo>
                        <a:pt x="953198" y="220072"/>
                      </a:lnTo>
                      <a:cubicBezTo>
                        <a:pt x="502540" y="410684"/>
                        <a:pt x="186327" y="856920"/>
                        <a:pt x="186327" y="1377011"/>
                      </a:cubicBezTo>
                      <a:cubicBezTo>
                        <a:pt x="186327" y="1897102"/>
                        <a:pt x="502540" y="2343338"/>
                        <a:pt x="953198" y="2533950"/>
                      </a:cubicBezTo>
                      <a:lnTo>
                        <a:pt x="1012874" y="2555792"/>
                      </a:lnTo>
                      <a:lnTo>
                        <a:pt x="1012874" y="2754022"/>
                      </a:lnTo>
                      <a:lnTo>
                        <a:pt x="880671" y="2705636"/>
                      </a:lnTo>
                      <a:cubicBezTo>
                        <a:pt x="363138" y="2486737"/>
                        <a:pt x="0" y="1974282"/>
                        <a:pt x="0" y="1377011"/>
                      </a:cubicBezTo>
                      <a:cubicBezTo>
                        <a:pt x="0" y="779740"/>
                        <a:pt x="363138" y="267285"/>
                        <a:pt x="880671" y="48387"/>
                      </a:cubicBezTo>
                      <a:close/>
                    </a:path>
                  </a:pathLst>
                </a:cu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287" name="Freeform: Shape 21">
                  <a:extLst>
                    <a:ext uri="{FF2B5EF4-FFF2-40B4-BE49-F238E27FC236}">
                      <a16:creationId xmlns:a16="http://schemas.microsoft.com/office/drawing/2014/main" id="{05098B81-FB29-49D0-B111-2BAA45C58F1B}"/>
                    </a:ext>
                  </a:extLst>
                </p:cNvPr>
                <p:cNvSpPr/>
                <p:nvPr/>
              </p:nvSpPr>
              <p:spPr>
                <a:xfrm flipH="1">
                  <a:off x="4416553" y="6112162"/>
                  <a:ext cx="606050" cy="956854"/>
                </a:xfrm>
                <a:custGeom>
                  <a:avLst/>
                  <a:gdLst>
                    <a:gd name="connsiteX0" fmla="*/ 606050 w 606050"/>
                    <a:gd name="connsiteY0" fmla="*/ 0 h 956854"/>
                    <a:gd name="connsiteX1" fmla="*/ 526677 w 606050"/>
                    <a:gd name="connsiteY1" fmla="*/ 34774 h 956854"/>
                    <a:gd name="connsiteX2" fmla="*/ 7905 w 606050"/>
                    <a:gd name="connsiteY2" fmla="*/ 831795 h 956854"/>
                    <a:gd name="connsiteX3" fmla="*/ 0 w 606050"/>
                    <a:gd name="connsiteY3" fmla="*/ 956854 h 956854"/>
                    <a:gd name="connsiteX4" fmla="*/ 111869 w 606050"/>
                    <a:gd name="connsiteY4" fmla="*/ 956854 h 956854"/>
                    <a:gd name="connsiteX5" fmla="*/ 118485 w 606050"/>
                    <a:gd name="connsiteY5" fmla="*/ 852187 h 956854"/>
                    <a:gd name="connsiteX6" fmla="*/ 570221 w 606050"/>
                    <a:gd name="connsiteY6" fmla="*/ 158158 h 956854"/>
                    <a:gd name="connsiteX7" fmla="*/ 606050 w 606050"/>
                    <a:gd name="connsiteY7" fmla="*/ 142461 h 95685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</a:cxnLst>
                  <a:rect l="l" t="t" r="r" b="b"/>
                  <a:pathLst>
                    <a:path w="606050" h="956854">
                      <a:moveTo>
                        <a:pt x="606050" y="0"/>
                      </a:moveTo>
                      <a:lnTo>
                        <a:pt x="526677" y="34774"/>
                      </a:lnTo>
                      <a:cubicBezTo>
                        <a:pt x="254795" y="172424"/>
                        <a:pt x="53885" y="471597"/>
                        <a:pt x="7905" y="831795"/>
                      </a:cubicBezTo>
                      <a:lnTo>
                        <a:pt x="0" y="956854"/>
                      </a:lnTo>
                      <a:lnTo>
                        <a:pt x="111869" y="956854"/>
                      </a:lnTo>
                      <a:lnTo>
                        <a:pt x="118485" y="852187"/>
                      </a:lnTo>
                      <a:cubicBezTo>
                        <a:pt x="158523" y="538535"/>
                        <a:pt x="333472" y="278021"/>
                        <a:pt x="570221" y="158158"/>
                      </a:cubicBezTo>
                      <a:lnTo>
                        <a:pt x="606050" y="142461"/>
                      </a:lnTo>
                      <a:close/>
                    </a:path>
                  </a:pathLst>
                </a:cu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288" name="Freeform: Shape 26">
                  <a:extLst>
                    <a:ext uri="{FF2B5EF4-FFF2-40B4-BE49-F238E27FC236}">
                      <a16:creationId xmlns:a16="http://schemas.microsoft.com/office/drawing/2014/main" id="{13D635EA-6BAE-40F9-B45F-4D87AFD06A05}"/>
                    </a:ext>
                  </a:extLst>
                </p:cNvPr>
                <p:cNvSpPr/>
                <p:nvPr/>
              </p:nvSpPr>
              <p:spPr>
                <a:xfrm rot="3396764" flipH="1">
                  <a:off x="4374952" y="-248882"/>
                  <a:ext cx="606050" cy="956854"/>
                </a:xfrm>
                <a:custGeom>
                  <a:avLst/>
                  <a:gdLst>
                    <a:gd name="connsiteX0" fmla="*/ 606050 w 606050"/>
                    <a:gd name="connsiteY0" fmla="*/ 0 h 956854"/>
                    <a:gd name="connsiteX1" fmla="*/ 526677 w 606050"/>
                    <a:gd name="connsiteY1" fmla="*/ 34774 h 956854"/>
                    <a:gd name="connsiteX2" fmla="*/ 7905 w 606050"/>
                    <a:gd name="connsiteY2" fmla="*/ 831795 h 956854"/>
                    <a:gd name="connsiteX3" fmla="*/ 0 w 606050"/>
                    <a:gd name="connsiteY3" fmla="*/ 956854 h 956854"/>
                    <a:gd name="connsiteX4" fmla="*/ 111869 w 606050"/>
                    <a:gd name="connsiteY4" fmla="*/ 956854 h 956854"/>
                    <a:gd name="connsiteX5" fmla="*/ 118485 w 606050"/>
                    <a:gd name="connsiteY5" fmla="*/ 852187 h 956854"/>
                    <a:gd name="connsiteX6" fmla="*/ 570221 w 606050"/>
                    <a:gd name="connsiteY6" fmla="*/ 158158 h 956854"/>
                    <a:gd name="connsiteX7" fmla="*/ 606050 w 606050"/>
                    <a:gd name="connsiteY7" fmla="*/ 142461 h 95685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</a:cxnLst>
                  <a:rect l="l" t="t" r="r" b="b"/>
                  <a:pathLst>
                    <a:path w="606050" h="956854">
                      <a:moveTo>
                        <a:pt x="606050" y="0"/>
                      </a:moveTo>
                      <a:lnTo>
                        <a:pt x="526677" y="34774"/>
                      </a:lnTo>
                      <a:cubicBezTo>
                        <a:pt x="254795" y="172424"/>
                        <a:pt x="53885" y="471597"/>
                        <a:pt x="7905" y="831795"/>
                      </a:cubicBezTo>
                      <a:lnTo>
                        <a:pt x="0" y="956854"/>
                      </a:lnTo>
                      <a:lnTo>
                        <a:pt x="111869" y="956854"/>
                      </a:lnTo>
                      <a:lnTo>
                        <a:pt x="118485" y="852187"/>
                      </a:lnTo>
                      <a:cubicBezTo>
                        <a:pt x="158523" y="538535"/>
                        <a:pt x="333472" y="278021"/>
                        <a:pt x="570221" y="158158"/>
                      </a:cubicBezTo>
                      <a:lnTo>
                        <a:pt x="606050" y="142461"/>
                      </a:lnTo>
                      <a:close/>
                    </a:path>
                  </a:pathLst>
                </a:cu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solidFill>
                      <a:prstClr val="black"/>
                    </a:solidFill>
                  </a:endParaRPr>
                </a:p>
              </p:txBody>
            </p:sp>
          </p:grpSp>
          <p:sp>
            <p:nvSpPr>
              <p:cNvPr id="204" name="Oval 203">
                <a:extLst>
                  <a:ext uri="{FF2B5EF4-FFF2-40B4-BE49-F238E27FC236}">
                    <a16:creationId xmlns:a16="http://schemas.microsoft.com/office/drawing/2014/main" id="{C22006D1-2B07-46CC-8F6C-C710B260AF8B}"/>
                  </a:ext>
                </a:extLst>
              </p:cNvPr>
              <p:cNvSpPr/>
              <p:nvPr/>
            </p:nvSpPr>
            <p:spPr>
              <a:xfrm>
                <a:off x="2046812" y="5097378"/>
                <a:ext cx="243054" cy="243054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05" name="Oval 204">
                <a:extLst>
                  <a:ext uri="{FF2B5EF4-FFF2-40B4-BE49-F238E27FC236}">
                    <a16:creationId xmlns:a16="http://schemas.microsoft.com/office/drawing/2014/main" id="{7BE603FD-5A31-45C0-8CAE-8B1172276DCB}"/>
                  </a:ext>
                </a:extLst>
              </p:cNvPr>
              <p:cNvSpPr/>
              <p:nvPr/>
            </p:nvSpPr>
            <p:spPr>
              <a:xfrm>
                <a:off x="2089534" y="4598797"/>
                <a:ext cx="374814" cy="374814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06" name="Oval 205">
                <a:extLst>
                  <a:ext uri="{FF2B5EF4-FFF2-40B4-BE49-F238E27FC236}">
                    <a16:creationId xmlns:a16="http://schemas.microsoft.com/office/drawing/2014/main" id="{3C32FB34-8851-4E7D-BDA4-E8BF1672E435}"/>
                  </a:ext>
                </a:extLst>
              </p:cNvPr>
              <p:cNvSpPr/>
              <p:nvPr/>
            </p:nvSpPr>
            <p:spPr>
              <a:xfrm>
                <a:off x="2371946" y="4195849"/>
                <a:ext cx="374814" cy="374814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07" name="Oval 206">
                <a:extLst>
                  <a:ext uri="{FF2B5EF4-FFF2-40B4-BE49-F238E27FC236}">
                    <a16:creationId xmlns:a16="http://schemas.microsoft.com/office/drawing/2014/main" id="{CBBE6732-CEF0-438B-B439-519008CD0066}"/>
                  </a:ext>
                </a:extLst>
              </p:cNvPr>
              <p:cNvSpPr/>
              <p:nvPr/>
            </p:nvSpPr>
            <p:spPr>
              <a:xfrm>
                <a:off x="2721503" y="3907152"/>
                <a:ext cx="374814" cy="374814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08" name="Oval 207">
                <a:extLst>
                  <a:ext uri="{FF2B5EF4-FFF2-40B4-BE49-F238E27FC236}">
                    <a16:creationId xmlns:a16="http://schemas.microsoft.com/office/drawing/2014/main" id="{890275A2-4197-4D71-BFEC-70C66241107D}"/>
                  </a:ext>
                </a:extLst>
              </p:cNvPr>
              <p:cNvSpPr/>
              <p:nvPr/>
            </p:nvSpPr>
            <p:spPr>
              <a:xfrm>
                <a:off x="3165339" y="3719745"/>
                <a:ext cx="374814" cy="374814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09" name="Oval 208">
                <a:extLst>
                  <a:ext uri="{FF2B5EF4-FFF2-40B4-BE49-F238E27FC236}">
                    <a16:creationId xmlns:a16="http://schemas.microsoft.com/office/drawing/2014/main" id="{C7AADA8C-3FDE-4BB7-A15A-245790894864}"/>
                  </a:ext>
                </a:extLst>
              </p:cNvPr>
              <p:cNvSpPr/>
              <p:nvPr/>
            </p:nvSpPr>
            <p:spPr>
              <a:xfrm>
                <a:off x="3654805" y="3682146"/>
                <a:ext cx="374814" cy="374814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10" name="Oval 209">
                <a:extLst>
                  <a:ext uri="{FF2B5EF4-FFF2-40B4-BE49-F238E27FC236}">
                    <a16:creationId xmlns:a16="http://schemas.microsoft.com/office/drawing/2014/main" id="{F8BDD9BB-471E-4DA9-B48C-70982F84ABFA}"/>
                  </a:ext>
                </a:extLst>
              </p:cNvPr>
              <p:cNvSpPr/>
              <p:nvPr/>
            </p:nvSpPr>
            <p:spPr>
              <a:xfrm>
                <a:off x="4121645" y="3812811"/>
                <a:ext cx="299485" cy="299485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11" name="Oval 210">
                <a:extLst>
                  <a:ext uri="{FF2B5EF4-FFF2-40B4-BE49-F238E27FC236}">
                    <a16:creationId xmlns:a16="http://schemas.microsoft.com/office/drawing/2014/main" id="{392AAD3F-2E4A-49F4-B80B-74D660166AA3}"/>
                  </a:ext>
                </a:extLst>
              </p:cNvPr>
              <p:cNvSpPr/>
              <p:nvPr/>
            </p:nvSpPr>
            <p:spPr>
              <a:xfrm>
                <a:off x="4380282" y="3427611"/>
                <a:ext cx="306483" cy="306483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12" name="Oval 211">
                <a:extLst>
                  <a:ext uri="{FF2B5EF4-FFF2-40B4-BE49-F238E27FC236}">
                    <a16:creationId xmlns:a16="http://schemas.microsoft.com/office/drawing/2014/main" id="{995A1AEE-D48D-46A8-9561-C9FB42BBB24D}"/>
                  </a:ext>
                </a:extLst>
              </p:cNvPr>
              <p:cNvSpPr/>
              <p:nvPr/>
            </p:nvSpPr>
            <p:spPr>
              <a:xfrm>
                <a:off x="4560327" y="2932833"/>
                <a:ext cx="374814" cy="374814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13" name="Oval 212">
                <a:extLst>
                  <a:ext uri="{FF2B5EF4-FFF2-40B4-BE49-F238E27FC236}">
                    <a16:creationId xmlns:a16="http://schemas.microsoft.com/office/drawing/2014/main" id="{ACEB7989-DC5C-4D61-B960-BA2CB803BD23}"/>
                  </a:ext>
                </a:extLst>
              </p:cNvPr>
              <p:cNvSpPr/>
              <p:nvPr/>
            </p:nvSpPr>
            <p:spPr>
              <a:xfrm>
                <a:off x="4838932" y="2592363"/>
                <a:ext cx="374814" cy="374814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14" name="Oval 213">
                <a:extLst>
                  <a:ext uri="{FF2B5EF4-FFF2-40B4-BE49-F238E27FC236}">
                    <a16:creationId xmlns:a16="http://schemas.microsoft.com/office/drawing/2014/main" id="{AAD44983-0522-49F8-95EA-B295AF454158}"/>
                  </a:ext>
                </a:extLst>
              </p:cNvPr>
              <p:cNvSpPr/>
              <p:nvPr/>
            </p:nvSpPr>
            <p:spPr>
              <a:xfrm>
                <a:off x="5224959" y="2333264"/>
                <a:ext cx="374814" cy="374814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15" name="Oval 214">
                <a:extLst>
                  <a:ext uri="{FF2B5EF4-FFF2-40B4-BE49-F238E27FC236}">
                    <a16:creationId xmlns:a16="http://schemas.microsoft.com/office/drawing/2014/main" id="{E6661D5C-6EC5-435B-AFE3-FBAAFDDB0E70}"/>
                  </a:ext>
                </a:extLst>
              </p:cNvPr>
              <p:cNvSpPr/>
              <p:nvPr/>
            </p:nvSpPr>
            <p:spPr>
              <a:xfrm>
                <a:off x="5678599" y="2226760"/>
                <a:ext cx="374814" cy="374814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16" name="Oval 215">
                <a:extLst>
                  <a:ext uri="{FF2B5EF4-FFF2-40B4-BE49-F238E27FC236}">
                    <a16:creationId xmlns:a16="http://schemas.microsoft.com/office/drawing/2014/main" id="{59B39714-C3B0-4661-A745-160A63141DA5}"/>
                  </a:ext>
                </a:extLst>
              </p:cNvPr>
              <p:cNvSpPr/>
              <p:nvPr/>
            </p:nvSpPr>
            <p:spPr>
              <a:xfrm>
                <a:off x="6109555" y="2233934"/>
                <a:ext cx="374814" cy="374814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17" name="Oval 216">
                <a:extLst>
                  <a:ext uri="{FF2B5EF4-FFF2-40B4-BE49-F238E27FC236}">
                    <a16:creationId xmlns:a16="http://schemas.microsoft.com/office/drawing/2014/main" id="{D70276EB-1E33-4E98-A5CC-E588EBE4AF72}"/>
                  </a:ext>
                </a:extLst>
              </p:cNvPr>
              <p:cNvSpPr/>
              <p:nvPr/>
            </p:nvSpPr>
            <p:spPr>
              <a:xfrm>
                <a:off x="6523098" y="2362645"/>
                <a:ext cx="374814" cy="374814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18" name="Oval 217">
                <a:extLst>
                  <a:ext uri="{FF2B5EF4-FFF2-40B4-BE49-F238E27FC236}">
                    <a16:creationId xmlns:a16="http://schemas.microsoft.com/office/drawing/2014/main" id="{BB3B1070-6A56-4E14-A23A-E03421FFB917}"/>
                  </a:ext>
                </a:extLst>
              </p:cNvPr>
              <p:cNvSpPr/>
              <p:nvPr/>
            </p:nvSpPr>
            <p:spPr>
              <a:xfrm>
                <a:off x="6900055" y="2160958"/>
                <a:ext cx="285773" cy="285773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19" name="Oval 218">
                <a:extLst>
                  <a:ext uri="{FF2B5EF4-FFF2-40B4-BE49-F238E27FC236}">
                    <a16:creationId xmlns:a16="http://schemas.microsoft.com/office/drawing/2014/main" id="{C23C14A0-B8AA-4F4D-B0D4-A8D4F036AA8F}"/>
                  </a:ext>
                </a:extLst>
              </p:cNvPr>
              <p:cNvSpPr/>
              <p:nvPr/>
            </p:nvSpPr>
            <p:spPr>
              <a:xfrm>
                <a:off x="7069576" y="1682014"/>
                <a:ext cx="374814" cy="374814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20" name="Oval 219">
                <a:extLst>
                  <a:ext uri="{FF2B5EF4-FFF2-40B4-BE49-F238E27FC236}">
                    <a16:creationId xmlns:a16="http://schemas.microsoft.com/office/drawing/2014/main" id="{8F8D6072-76C4-4160-BAC0-BD08CE12404C}"/>
                  </a:ext>
                </a:extLst>
              </p:cNvPr>
              <p:cNvSpPr/>
              <p:nvPr/>
            </p:nvSpPr>
            <p:spPr>
              <a:xfrm>
                <a:off x="7377861" y="1394829"/>
                <a:ext cx="374814" cy="374814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21" name="Oval 220">
                <a:extLst>
                  <a:ext uri="{FF2B5EF4-FFF2-40B4-BE49-F238E27FC236}">
                    <a16:creationId xmlns:a16="http://schemas.microsoft.com/office/drawing/2014/main" id="{DFF69682-198E-4B32-BAC4-E6804B9E8962}"/>
                  </a:ext>
                </a:extLst>
              </p:cNvPr>
              <p:cNvSpPr/>
              <p:nvPr/>
            </p:nvSpPr>
            <p:spPr>
              <a:xfrm>
                <a:off x="7765189" y="1204731"/>
                <a:ext cx="374814" cy="374814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22" name="Oval 221">
                <a:extLst>
                  <a:ext uri="{FF2B5EF4-FFF2-40B4-BE49-F238E27FC236}">
                    <a16:creationId xmlns:a16="http://schemas.microsoft.com/office/drawing/2014/main" id="{5AADB719-6665-4091-BDE1-A9D6CC03A113}"/>
                  </a:ext>
                </a:extLst>
              </p:cNvPr>
              <p:cNvSpPr/>
              <p:nvPr/>
            </p:nvSpPr>
            <p:spPr>
              <a:xfrm>
                <a:off x="8169383" y="1107887"/>
                <a:ext cx="374814" cy="374814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23" name="Oval 222">
                <a:extLst>
                  <a:ext uri="{FF2B5EF4-FFF2-40B4-BE49-F238E27FC236}">
                    <a16:creationId xmlns:a16="http://schemas.microsoft.com/office/drawing/2014/main" id="{0C46E748-EC2A-4CB0-A222-D04193F05360}"/>
                  </a:ext>
                </a:extLst>
              </p:cNvPr>
              <p:cNvSpPr/>
              <p:nvPr/>
            </p:nvSpPr>
            <p:spPr>
              <a:xfrm>
                <a:off x="8645535" y="1154209"/>
                <a:ext cx="282169" cy="282169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24" name="Oval 223">
                <a:extLst>
                  <a:ext uri="{FF2B5EF4-FFF2-40B4-BE49-F238E27FC236}">
                    <a16:creationId xmlns:a16="http://schemas.microsoft.com/office/drawing/2014/main" id="{BD5D71E7-0876-4F0D-8DCE-A9A366DA30A5}"/>
                  </a:ext>
                </a:extLst>
              </p:cNvPr>
              <p:cNvSpPr/>
              <p:nvPr/>
            </p:nvSpPr>
            <p:spPr>
              <a:xfrm>
                <a:off x="9026151" y="1250621"/>
                <a:ext cx="282170" cy="282170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25" name="Oval 224">
                <a:extLst>
                  <a:ext uri="{FF2B5EF4-FFF2-40B4-BE49-F238E27FC236}">
                    <a16:creationId xmlns:a16="http://schemas.microsoft.com/office/drawing/2014/main" id="{876E9749-A8B6-452F-9BF9-76CD5486FB27}"/>
                  </a:ext>
                </a:extLst>
              </p:cNvPr>
              <p:cNvSpPr/>
              <p:nvPr/>
            </p:nvSpPr>
            <p:spPr>
              <a:xfrm>
                <a:off x="9249331" y="1042850"/>
                <a:ext cx="247225" cy="247225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26" name="Oval 225">
                <a:extLst>
                  <a:ext uri="{FF2B5EF4-FFF2-40B4-BE49-F238E27FC236}">
                    <a16:creationId xmlns:a16="http://schemas.microsoft.com/office/drawing/2014/main" id="{C41D7587-533E-4590-ACB1-1F443D5D9713}"/>
                  </a:ext>
                </a:extLst>
              </p:cNvPr>
              <p:cNvSpPr/>
              <p:nvPr/>
            </p:nvSpPr>
            <p:spPr>
              <a:xfrm>
                <a:off x="9389449" y="543892"/>
                <a:ext cx="374814" cy="374814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27" name="Oval 226">
                <a:extLst>
                  <a:ext uri="{FF2B5EF4-FFF2-40B4-BE49-F238E27FC236}">
                    <a16:creationId xmlns:a16="http://schemas.microsoft.com/office/drawing/2014/main" id="{07AF14EB-176C-4501-A160-2CC0CF49123B}"/>
                  </a:ext>
                </a:extLst>
              </p:cNvPr>
              <p:cNvSpPr/>
              <p:nvPr/>
            </p:nvSpPr>
            <p:spPr>
              <a:xfrm>
                <a:off x="9699670" y="203370"/>
                <a:ext cx="374814" cy="374814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28" name="Oval 227">
                <a:extLst>
                  <a:ext uri="{FF2B5EF4-FFF2-40B4-BE49-F238E27FC236}">
                    <a16:creationId xmlns:a16="http://schemas.microsoft.com/office/drawing/2014/main" id="{CBDA5236-A8E1-4BC9-BB49-A235D7EC6C51}"/>
                  </a:ext>
                </a:extLst>
              </p:cNvPr>
              <p:cNvSpPr/>
              <p:nvPr/>
            </p:nvSpPr>
            <p:spPr>
              <a:xfrm>
                <a:off x="1674737" y="5040676"/>
                <a:ext cx="264935" cy="264935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29" name="Oval 228">
                <a:extLst>
                  <a:ext uri="{FF2B5EF4-FFF2-40B4-BE49-F238E27FC236}">
                    <a16:creationId xmlns:a16="http://schemas.microsoft.com/office/drawing/2014/main" id="{35EF7494-E345-4E12-9082-D8D475922511}"/>
                  </a:ext>
                </a:extLst>
              </p:cNvPr>
              <p:cNvSpPr/>
              <p:nvPr/>
            </p:nvSpPr>
            <p:spPr>
              <a:xfrm>
                <a:off x="1146078" y="4897384"/>
                <a:ext cx="374814" cy="374814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30" name="Oval 229">
                <a:extLst>
                  <a:ext uri="{FF2B5EF4-FFF2-40B4-BE49-F238E27FC236}">
                    <a16:creationId xmlns:a16="http://schemas.microsoft.com/office/drawing/2014/main" id="{61D97BC5-D302-4CAE-8E6E-F0DD3B24DEE4}"/>
                  </a:ext>
                </a:extLst>
              </p:cNvPr>
              <p:cNvSpPr/>
              <p:nvPr/>
            </p:nvSpPr>
            <p:spPr>
              <a:xfrm>
                <a:off x="661719" y="4930797"/>
                <a:ext cx="374814" cy="374814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31" name="Oval 230">
                <a:extLst>
                  <a:ext uri="{FF2B5EF4-FFF2-40B4-BE49-F238E27FC236}">
                    <a16:creationId xmlns:a16="http://schemas.microsoft.com/office/drawing/2014/main" id="{4DA4D6A7-E99C-499A-B9AA-94CC602585D6}"/>
                  </a:ext>
                </a:extLst>
              </p:cNvPr>
              <p:cNvSpPr/>
              <p:nvPr/>
            </p:nvSpPr>
            <p:spPr>
              <a:xfrm>
                <a:off x="1266595" y="6456344"/>
                <a:ext cx="374814" cy="374814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32" name="Oval 231">
                <a:extLst>
                  <a:ext uri="{FF2B5EF4-FFF2-40B4-BE49-F238E27FC236}">
                    <a16:creationId xmlns:a16="http://schemas.microsoft.com/office/drawing/2014/main" id="{DDBD377C-9C58-479E-A71F-21238BA3A5C4}"/>
                  </a:ext>
                </a:extLst>
              </p:cNvPr>
              <p:cNvSpPr/>
              <p:nvPr/>
            </p:nvSpPr>
            <p:spPr>
              <a:xfrm>
                <a:off x="1644678" y="6122364"/>
                <a:ext cx="374814" cy="374814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33" name="Oval 232">
                <a:extLst>
                  <a:ext uri="{FF2B5EF4-FFF2-40B4-BE49-F238E27FC236}">
                    <a16:creationId xmlns:a16="http://schemas.microsoft.com/office/drawing/2014/main" id="{301A5518-BB7E-4B77-93F6-3C855CB735F0}"/>
                  </a:ext>
                </a:extLst>
              </p:cNvPr>
              <p:cNvSpPr/>
              <p:nvPr/>
            </p:nvSpPr>
            <p:spPr>
              <a:xfrm>
                <a:off x="1915052" y="5766691"/>
                <a:ext cx="374814" cy="374814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34" name="Oval 233">
                <a:extLst>
                  <a:ext uri="{FF2B5EF4-FFF2-40B4-BE49-F238E27FC236}">
                    <a16:creationId xmlns:a16="http://schemas.microsoft.com/office/drawing/2014/main" id="{400260BC-B2ED-49A0-8622-F5BDBB6453F7}"/>
                  </a:ext>
                </a:extLst>
              </p:cNvPr>
              <p:cNvSpPr/>
              <p:nvPr/>
            </p:nvSpPr>
            <p:spPr>
              <a:xfrm>
                <a:off x="2075867" y="5432345"/>
                <a:ext cx="250274" cy="250274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35" name="Oval 234">
                <a:extLst>
                  <a:ext uri="{FF2B5EF4-FFF2-40B4-BE49-F238E27FC236}">
                    <a16:creationId xmlns:a16="http://schemas.microsoft.com/office/drawing/2014/main" id="{29B5CA71-B696-4227-A3FE-F3156035417D}"/>
                  </a:ext>
                </a:extLst>
              </p:cNvPr>
              <p:cNvSpPr/>
              <p:nvPr/>
            </p:nvSpPr>
            <p:spPr>
              <a:xfrm>
                <a:off x="2468935" y="5410931"/>
                <a:ext cx="250274" cy="246888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36" name="Oval 235">
                <a:extLst>
                  <a:ext uri="{FF2B5EF4-FFF2-40B4-BE49-F238E27FC236}">
                    <a16:creationId xmlns:a16="http://schemas.microsoft.com/office/drawing/2014/main" id="{41DB2006-93AF-4D61-B13B-5EBC2A559770}"/>
                  </a:ext>
                </a:extLst>
              </p:cNvPr>
              <p:cNvSpPr/>
              <p:nvPr/>
            </p:nvSpPr>
            <p:spPr>
              <a:xfrm>
                <a:off x="2894070" y="5348372"/>
                <a:ext cx="374814" cy="374814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37" name="Oval 236">
                <a:extLst>
                  <a:ext uri="{FF2B5EF4-FFF2-40B4-BE49-F238E27FC236}">
                    <a16:creationId xmlns:a16="http://schemas.microsoft.com/office/drawing/2014/main" id="{7D4313DA-18EC-4673-9ABB-2D947C2BDD78}"/>
                  </a:ext>
                </a:extLst>
              </p:cNvPr>
              <p:cNvSpPr/>
              <p:nvPr/>
            </p:nvSpPr>
            <p:spPr>
              <a:xfrm>
                <a:off x="3350087" y="5230603"/>
                <a:ext cx="374814" cy="374814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38" name="Oval 237">
                <a:extLst>
                  <a:ext uri="{FF2B5EF4-FFF2-40B4-BE49-F238E27FC236}">
                    <a16:creationId xmlns:a16="http://schemas.microsoft.com/office/drawing/2014/main" id="{07C94B67-9CDA-48D0-A2F5-F92575A45335}"/>
                  </a:ext>
                </a:extLst>
              </p:cNvPr>
              <p:cNvSpPr/>
              <p:nvPr/>
            </p:nvSpPr>
            <p:spPr>
              <a:xfrm>
                <a:off x="3762666" y="5035892"/>
                <a:ext cx="374814" cy="374814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39" name="Oval 238">
                <a:extLst>
                  <a:ext uri="{FF2B5EF4-FFF2-40B4-BE49-F238E27FC236}">
                    <a16:creationId xmlns:a16="http://schemas.microsoft.com/office/drawing/2014/main" id="{529C083D-5065-41FF-8241-F6D985CD89E5}"/>
                  </a:ext>
                </a:extLst>
              </p:cNvPr>
              <p:cNvSpPr/>
              <p:nvPr/>
            </p:nvSpPr>
            <p:spPr>
              <a:xfrm>
                <a:off x="4078641" y="4713026"/>
                <a:ext cx="374814" cy="374814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40" name="Oval 239">
                <a:extLst>
                  <a:ext uri="{FF2B5EF4-FFF2-40B4-BE49-F238E27FC236}">
                    <a16:creationId xmlns:a16="http://schemas.microsoft.com/office/drawing/2014/main" id="{9B1E4F6B-05BA-49B5-B3B2-DBB681F6DB97}"/>
                  </a:ext>
                </a:extLst>
              </p:cNvPr>
              <p:cNvSpPr/>
              <p:nvPr/>
            </p:nvSpPr>
            <p:spPr>
              <a:xfrm>
                <a:off x="4286712" y="4312616"/>
                <a:ext cx="374814" cy="374814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41" name="Oval 240">
                <a:extLst>
                  <a:ext uri="{FF2B5EF4-FFF2-40B4-BE49-F238E27FC236}">
                    <a16:creationId xmlns:a16="http://schemas.microsoft.com/office/drawing/2014/main" id="{91FD0A14-F7F3-41BA-9032-73897BC885C9}"/>
                  </a:ext>
                </a:extLst>
              </p:cNvPr>
              <p:cNvSpPr/>
              <p:nvPr/>
            </p:nvSpPr>
            <p:spPr>
              <a:xfrm>
                <a:off x="4429473" y="4024902"/>
                <a:ext cx="230747" cy="230747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42" name="Oval 241">
                <a:extLst>
                  <a:ext uri="{FF2B5EF4-FFF2-40B4-BE49-F238E27FC236}">
                    <a16:creationId xmlns:a16="http://schemas.microsoft.com/office/drawing/2014/main" id="{73D664B4-0C79-4CCF-A4AE-E638D3CE367C}"/>
                  </a:ext>
                </a:extLst>
              </p:cNvPr>
              <p:cNvSpPr/>
              <p:nvPr/>
            </p:nvSpPr>
            <p:spPr>
              <a:xfrm>
                <a:off x="4694328" y="4168114"/>
                <a:ext cx="254041" cy="254041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43" name="Oval 242">
                <a:extLst>
                  <a:ext uri="{FF2B5EF4-FFF2-40B4-BE49-F238E27FC236}">
                    <a16:creationId xmlns:a16="http://schemas.microsoft.com/office/drawing/2014/main" id="{653EF898-326D-4D7B-A3EB-6E304793D466}"/>
                  </a:ext>
                </a:extLst>
              </p:cNvPr>
              <p:cNvSpPr/>
              <p:nvPr/>
            </p:nvSpPr>
            <p:spPr>
              <a:xfrm>
                <a:off x="5315385" y="4195849"/>
                <a:ext cx="374814" cy="374814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44" name="Oval 243">
                <a:extLst>
                  <a:ext uri="{FF2B5EF4-FFF2-40B4-BE49-F238E27FC236}">
                    <a16:creationId xmlns:a16="http://schemas.microsoft.com/office/drawing/2014/main" id="{F7D2C714-BD4A-4656-A9D2-B86F48EA0C17}"/>
                  </a:ext>
                </a:extLst>
              </p:cNvPr>
              <p:cNvSpPr/>
              <p:nvPr/>
            </p:nvSpPr>
            <p:spPr>
              <a:xfrm>
                <a:off x="5734741" y="4100001"/>
                <a:ext cx="374814" cy="374814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45" name="Oval 244">
                <a:extLst>
                  <a:ext uri="{FF2B5EF4-FFF2-40B4-BE49-F238E27FC236}">
                    <a16:creationId xmlns:a16="http://schemas.microsoft.com/office/drawing/2014/main" id="{C21717BD-3383-4372-8D0D-57CD8DCD0616}"/>
                  </a:ext>
                </a:extLst>
              </p:cNvPr>
              <p:cNvSpPr/>
              <p:nvPr/>
            </p:nvSpPr>
            <p:spPr>
              <a:xfrm>
                <a:off x="6169995" y="3912594"/>
                <a:ext cx="374814" cy="374814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46" name="Oval 245">
                <a:extLst>
                  <a:ext uri="{FF2B5EF4-FFF2-40B4-BE49-F238E27FC236}">
                    <a16:creationId xmlns:a16="http://schemas.microsoft.com/office/drawing/2014/main" id="{FCFDE979-A717-4AE3-9F47-C7B4BB67D8B3}"/>
                  </a:ext>
                </a:extLst>
              </p:cNvPr>
              <p:cNvSpPr/>
              <p:nvPr/>
            </p:nvSpPr>
            <p:spPr>
              <a:xfrm>
                <a:off x="6507590" y="3620401"/>
                <a:ext cx="374814" cy="374814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47" name="Oval 246">
                <a:extLst>
                  <a:ext uri="{FF2B5EF4-FFF2-40B4-BE49-F238E27FC236}">
                    <a16:creationId xmlns:a16="http://schemas.microsoft.com/office/drawing/2014/main" id="{627ADC8F-A674-48EC-A1F7-1010C199C52D}"/>
                  </a:ext>
                </a:extLst>
              </p:cNvPr>
              <p:cNvSpPr/>
              <p:nvPr/>
            </p:nvSpPr>
            <p:spPr>
              <a:xfrm>
                <a:off x="6737413" y="3270393"/>
                <a:ext cx="320997" cy="320997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48" name="Oval 247">
                <a:extLst>
                  <a:ext uri="{FF2B5EF4-FFF2-40B4-BE49-F238E27FC236}">
                    <a16:creationId xmlns:a16="http://schemas.microsoft.com/office/drawing/2014/main" id="{6B70D0BA-91F1-4615-9463-2C91B6CD510E}"/>
                  </a:ext>
                </a:extLst>
              </p:cNvPr>
              <p:cNvSpPr/>
              <p:nvPr/>
            </p:nvSpPr>
            <p:spPr>
              <a:xfrm>
                <a:off x="6852224" y="2946167"/>
                <a:ext cx="224284" cy="224284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49" name="Oval 248">
                <a:extLst>
                  <a:ext uri="{FF2B5EF4-FFF2-40B4-BE49-F238E27FC236}">
                    <a16:creationId xmlns:a16="http://schemas.microsoft.com/office/drawing/2014/main" id="{8625B453-7E4A-4C10-87AC-EA5FF71AA007}"/>
                  </a:ext>
                </a:extLst>
              </p:cNvPr>
              <p:cNvSpPr/>
              <p:nvPr/>
            </p:nvSpPr>
            <p:spPr>
              <a:xfrm>
                <a:off x="7222505" y="2795709"/>
                <a:ext cx="274247" cy="274247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50" name="Oval 249">
                <a:extLst>
                  <a:ext uri="{FF2B5EF4-FFF2-40B4-BE49-F238E27FC236}">
                    <a16:creationId xmlns:a16="http://schemas.microsoft.com/office/drawing/2014/main" id="{C9B1BFAE-C9BE-4D1B-8452-D58307710C35}"/>
                  </a:ext>
                </a:extLst>
              </p:cNvPr>
              <p:cNvSpPr/>
              <p:nvPr/>
            </p:nvSpPr>
            <p:spPr>
              <a:xfrm>
                <a:off x="7622199" y="2779770"/>
                <a:ext cx="374814" cy="374814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51" name="Oval 250">
                <a:extLst>
                  <a:ext uri="{FF2B5EF4-FFF2-40B4-BE49-F238E27FC236}">
                    <a16:creationId xmlns:a16="http://schemas.microsoft.com/office/drawing/2014/main" id="{DFC6CEBA-B19E-4034-A68A-5A875FBCDDD7}"/>
                  </a:ext>
                </a:extLst>
              </p:cNvPr>
              <p:cNvSpPr/>
              <p:nvPr/>
            </p:nvSpPr>
            <p:spPr>
              <a:xfrm>
                <a:off x="8110231" y="2708238"/>
                <a:ext cx="374814" cy="374814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52" name="Oval 251">
                <a:extLst>
                  <a:ext uri="{FF2B5EF4-FFF2-40B4-BE49-F238E27FC236}">
                    <a16:creationId xmlns:a16="http://schemas.microsoft.com/office/drawing/2014/main" id="{A3744FBD-8B38-42A1-BBAA-96BD810B7B80}"/>
                  </a:ext>
                </a:extLst>
              </p:cNvPr>
              <p:cNvSpPr/>
              <p:nvPr/>
            </p:nvSpPr>
            <p:spPr>
              <a:xfrm>
                <a:off x="8502597" y="2490022"/>
                <a:ext cx="374814" cy="374814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53" name="Oval 252">
                <a:extLst>
                  <a:ext uri="{FF2B5EF4-FFF2-40B4-BE49-F238E27FC236}">
                    <a16:creationId xmlns:a16="http://schemas.microsoft.com/office/drawing/2014/main" id="{8D76BEA8-25AA-406D-B85D-33126DAC9ED9}"/>
                  </a:ext>
                </a:extLst>
              </p:cNvPr>
              <p:cNvSpPr/>
              <p:nvPr/>
            </p:nvSpPr>
            <p:spPr>
              <a:xfrm>
                <a:off x="8832911" y="2192167"/>
                <a:ext cx="374814" cy="374814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54" name="Oval 253">
                <a:extLst>
                  <a:ext uri="{FF2B5EF4-FFF2-40B4-BE49-F238E27FC236}">
                    <a16:creationId xmlns:a16="http://schemas.microsoft.com/office/drawing/2014/main" id="{D062E712-7BC4-4E44-9814-4A9E5B5631AC}"/>
                  </a:ext>
                </a:extLst>
              </p:cNvPr>
              <p:cNvSpPr/>
              <p:nvPr/>
            </p:nvSpPr>
            <p:spPr>
              <a:xfrm>
                <a:off x="9036327" y="1831601"/>
                <a:ext cx="374814" cy="374814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55" name="Oval 254">
                <a:extLst>
                  <a:ext uri="{FF2B5EF4-FFF2-40B4-BE49-F238E27FC236}">
                    <a16:creationId xmlns:a16="http://schemas.microsoft.com/office/drawing/2014/main" id="{DCF55850-A594-46CF-86FA-B48A269B4C89}"/>
                  </a:ext>
                </a:extLst>
              </p:cNvPr>
              <p:cNvSpPr/>
              <p:nvPr/>
            </p:nvSpPr>
            <p:spPr>
              <a:xfrm>
                <a:off x="9482799" y="1500467"/>
                <a:ext cx="281464" cy="281464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56" name="Oval 255">
                <a:extLst>
                  <a:ext uri="{FF2B5EF4-FFF2-40B4-BE49-F238E27FC236}">
                    <a16:creationId xmlns:a16="http://schemas.microsoft.com/office/drawing/2014/main" id="{01193FF1-3213-4EEF-B0E5-011390D422A0}"/>
                  </a:ext>
                </a:extLst>
              </p:cNvPr>
              <p:cNvSpPr/>
              <p:nvPr/>
            </p:nvSpPr>
            <p:spPr>
              <a:xfrm>
                <a:off x="9818632" y="1542503"/>
                <a:ext cx="374814" cy="374814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57" name="Oval 256">
                <a:extLst>
                  <a:ext uri="{FF2B5EF4-FFF2-40B4-BE49-F238E27FC236}">
                    <a16:creationId xmlns:a16="http://schemas.microsoft.com/office/drawing/2014/main" id="{B55BA343-6D81-4DE9-B3A9-003631240EFD}"/>
                  </a:ext>
                </a:extLst>
              </p:cNvPr>
              <p:cNvSpPr/>
              <p:nvPr/>
            </p:nvSpPr>
            <p:spPr>
              <a:xfrm>
                <a:off x="10302184" y="1502580"/>
                <a:ext cx="374814" cy="374814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58" name="Oval 257">
                <a:extLst>
                  <a:ext uri="{FF2B5EF4-FFF2-40B4-BE49-F238E27FC236}">
                    <a16:creationId xmlns:a16="http://schemas.microsoft.com/office/drawing/2014/main" id="{3D95422A-733E-4EA6-B7D2-DAE0C63B5C04}"/>
                  </a:ext>
                </a:extLst>
              </p:cNvPr>
              <p:cNvSpPr/>
              <p:nvPr/>
            </p:nvSpPr>
            <p:spPr>
              <a:xfrm>
                <a:off x="10761759" y="1395733"/>
                <a:ext cx="209467" cy="209467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59" name="Oval 258">
                <a:extLst>
                  <a:ext uri="{FF2B5EF4-FFF2-40B4-BE49-F238E27FC236}">
                    <a16:creationId xmlns:a16="http://schemas.microsoft.com/office/drawing/2014/main" id="{806249CC-897E-422B-AA4A-4A22AAE71B69}"/>
                  </a:ext>
                </a:extLst>
              </p:cNvPr>
              <p:cNvSpPr/>
              <p:nvPr/>
            </p:nvSpPr>
            <p:spPr>
              <a:xfrm>
                <a:off x="4974547" y="4257321"/>
                <a:ext cx="286746" cy="28674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60" name="Oval 259">
                <a:extLst>
                  <a:ext uri="{FF2B5EF4-FFF2-40B4-BE49-F238E27FC236}">
                    <a16:creationId xmlns:a16="http://schemas.microsoft.com/office/drawing/2014/main" id="{8691960F-54B0-4A18-88C1-934ABF469FDB}"/>
                  </a:ext>
                </a:extLst>
              </p:cNvPr>
              <p:cNvSpPr/>
              <p:nvPr/>
            </p:nvSpPr>
            <p:spPr>
              <a:xfrm>
                <a:off x="6892028" y="2653675"/>
                <a:ext cx="230747" cy="230747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61" name="Oval 260">
                <a:extLst>
                  <a:ext uri="{FF2B5EF4-FFF2-40B4-BE49-F238E27FC236}">
                    <a16:creationId xmlns:a16="http://schemas.microsoft.com/office/drawing/2014/main" id="{1AC0417E-9ABD-48BC-B485-747C3B044EB9}"/>
                  </a:ext>
                </a:extLst>
              </p:cNvPr>
              <p:cNvSpPr/>
              <p:nvPr/>
            </p:nvSpPr>
            <p:spPr>
              <a:xfrm>
                <a:off x="9167236" y="1556001"/>
                <a:ext cx="230747" cy="230747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62" name="Oval 261">
                <a:extLst>
                  <a:ext uri="{FF2B5EF4-FFF2-40B4-BE49-F238E27FC236}">
                    <a16:creationId xmlns:a16="http://schemas.microsoft.com/office/drawing/2014/main" id="{520E1BB0-8BAD-4399-9DA8-C938C3C5BE09}"/>
                  </a:ext>
                </a:extLst>
              </p:cNvPr>
              <p:cNvSpPr/>
              <p:nvPr/>
            </p:nvSpPr>
            <p:spPr>
              <a:xfrm>
                <a:off x="10129830" y="133552"/>
                <a:ext cx="247225" cy="247225"/>
              </a:xfrm>
              <a:prstGeom prst="ellipse">
                <a:avLst/>
              </a:prstGeom>
              <a:solidFill>
                <a:srgbClr val="FF99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prstClr val="white"/>
                  </a:solidFill>
                </a:endParaRPr>
              </a:p>
            </p:txBody>
          </p:sp>
          <p:cxnSp>
            <p:nvCxnSpPr>
              <p:cNvPr id="263" name="Straight Connector 262">
                <a:extLst>
                  <a:ext uri="{FF2B5EF4-FFF2-40B4-BE49-F238E27FC236}">
                    <a16:creationId xmlns:a16="http://schemas.microsoft.com/office/drawing/2014/main" id="{7E26D931-090F-4C32-A05F-99188FEA821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56785" y="4933290"/>
                <a:ext cx="215125" cy="432628"/>
              </a:xfrm>
              <a:prstGeom prst="line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4" name="Straight Connector 263">
                <a:extLst>
                  <a:ext uri="{FF2B5EF4-FFF2-40B4-BE49-F238E27FC236}">
                    <a16:creationId xmlns:a16="http://schemas.microsoft.com/office/drawing/2014/main" id="{BCC91887-BC42-4F93-BB59-95E4D5772ABE}"/>
                  </a:ext>
                </a:extLst>
              </p:cNvPr>
              <p:cNvCxnSpPr>
                <a:cxnSpLocks/>
                <a:endCxn id="236" idx="0"/>
              </p:cNvCxnSpPr>
              <p:nvPr/>
            </p:nvCxnSpPr>
            <p:spPr>
              <a:xfrm>
                <a:off x="2668898" y="4573757"/>
                <a:ext cx="412579" cy="774615"/>
              </a:xfrm>
              <a:prstGeom prst="line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5" name="Straight Connector 264">
                <a:extLst>
                  <a:ext uri="{FF2B5EF4-FFF2-40B4-BE49-F238E27FC236}">
                    <a16:creationId xmlns:a16="http://schemas.microsoft.com/office/drawing/2014/main" id="{9C1AF5D7-747D-428B-9B44-3005CD6A1BD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17032" y="4228097"/>
                <a:ext cx="556483" cy="1016379"/>
              </a:xfrm>
              <a:prstGeom prst="line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6" name="Straight Connector 265">
                <a:extLst>
                  <a:ext uri="{FF2B5EF4-FFF2-40B4-BE49-F238E27FC236}">
                    <a16:creationId xmlns:a16="http://schemas.microsoft.com/office/drawing/2014/main" id="{35A0223C-980C-4575-9CB8-F5996D262E0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23840" y="4188136"/>
                <a:ext cx="407634" cy="746314"/>
              </a:xfrm>
              <a:prstGeom prst="line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7" name="Straight Connector 266">
                <a:extLst>
                  <a:ext uri="{FF2B5EF4-FFF2-40B4-BE49-F238E27FC236}">
                    <a16:creationId xmlns:a16="http://schemas.microsoft.com/office/drawing/2014/main" id="{E22265BE-B8D7-4109-972D-2073348C60F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852186" y="4135677"/>
                <a:ext cx="301473" cy="548958"/>
              </a:xfrm>
              <a:prstGeom prst="line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8" name="Straight Connector 267">
                <a:extLst>
                  <a:ext uri="{FF2B5EF4-FFF2-40B4-BE49-F238E27FC236}">
                    <a16:creationId xmlns:a16="http://schemas.microsoft.com/office/drawing/2014/main" id="{E2730F7F-EF44-46E3-943C-DB37D69C15E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39209" y="3624921"/>
                <a:ext cx="215125" cy="432628"/>
              </a:xfrm>
              <a:prstGeom prst="line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9" name="Straight Connector 268">
                <a:extLst>
                  <a:ext uri="{FF2B5EF4-FFF2-40B4-BE49-F238E27FC236}">
                    <a16:creationId xmlns:a16="http://schemas.microsoft.com/office/drawing/2014/main" id="{5C3AE3FD-812B-4666-B1CE-402A3E6F4E2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51322" y="3265388"/>
                <a:ext cx="412579" cy="774615"/>
              </a:xfrm>
              <a:prstGeom prst="line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0" name="Straight Connector 269">
                <a:extLst>
                  <a:ext uri="{FF2B5EF4-FFF2-40B4-BE49-F238E27FC236}">
                    <a16:creationId xmlns:a16="http://schemas.microsoft.com/office/drawing/2014/main" id="{EB15BFA7-8F72-489C-95C3-DCC8F4C4492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299456" y="2919728"/>
                <a:ext cx="556483" cy="1016379"/>
              </a:xfrm>
              <a:prstGeom prst="line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1" name="Straight Connector 270">
                <a:extLst>
                  <a:ext uri="{FF2B5EF4-FFF2-40B4-BE49-F238E27FC236}">
                    <a16:creationId xmlns:a16="http://schemas.microsoft.com/office/drawing/2014/main" id="{C295D8B5-5245-4D35-A2E2-8870E671177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06264" y="2879767"/>
                <a:ext cx="407634" cy="746314"/>
              </a:xfrm>
              <a:prstGeom prst="line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2" name="Straight Connector 271">
                <a:extLst>
                  <a:ext uri="{FF2B5EF4-FFF2-40B4-BE49-F238E27FC236}">
                    <a16:creationId xmlns:a16="http://schemas.microsoft.com/office/drawing/2014/main" id="{C31AA150-C5FA-4EAF-B7AB-D5015A33C88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34610" y="2827308"/>
                <a:ext cx="301473" cy="548958"/>
              </a:xfrm>
              <a:prstGeom prst="line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3" name="Straight Connector 272">
                <a:extLst>
                  <a:ext uri="{FF2B5EF4-FFF2-40B4-BE49-F238E27FC236}">
                    <a16:creationId xmlns:a16="http://schemas.microsoft.com/office/drawing/2014/main" id="{6E094F7B-9BCD-4D41-BBBF-5116A147FA1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186662" y="2349494"/>
                <a:ext cx="215125" cy="432628"/>
              </a:xfrm>
              <a:prstGeom prst="line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4" name="Straight Connector 273">
                <a:extLst>
                  <a:ext uri="{FF2B5EF4-FFF2-40B4-BE49-F238E27FC236}">
                    <a16:creationId xmlns:a16="http://schemas.microsoft.com/office/drawing/2014/main" id="{1EA4AE13-7277-46B9-8A53-42E5A152D54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498775" y="1989961"/>
                <a:ext cx="412579" cy="774615"/>
              </a:xfrm>
              <a:prstGeom prst="line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5" name="Straight Connector 274">
                <a:extLst>
                  <a:ext uri="{FF2B5EF4-FFF2-40B4-BE49-F238E27FC236}">
                    <a16:creationId xmlns:a16="http://schemas.microsoft.com/office/drawing/2014/main" id="{4C5740A0-7DC0-4DC0-88A6-8E4438B090F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746909" y="1644301"/>
                <a:ext cx="556483" cy="1016379"/>
              </a:xfrm>
              <a:prstGeom prst="line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6" name="Straight Connector 275">
                <a:extLst>
                  <a:ext uri="{FF2B5EF4-FFF2-40B4-BE49-F238E27FC236}">
                    <a16:creationId xmlns:a16="http://schemas.microsoft.com/office/drawing/2014/main" id="{41494EDE-4305-4930-B485-6C21A8F9314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253717" y="1604340"/>
                <a:ext cx="407634" cy="746314"/>
              </a:xfrm>
              <a:prstGeom prst="line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7" name="Straight Connector 276">
                <a:extLst>
                  <a:ext uri="{FF2B5EF4-FFF2-40B4-BE49-F238E27FC236}">
                    <a16:creationId xmlns:a16="http://schemas.microsoft.com/office/drawing/2014/main" id="{F79115B8-8610-4905-A8D6-ADA3E85831A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682063" y="1551881"/>
                <a:ext cx="301473" cy="548958"/>
              </a:xfrm>
              <a:prstGeom prst="line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8" name="Straight Connector 277">
                <a:extLst>
                  <a:ext uri="{FF2B5EF4-FFF2-40B4-BE49-F238E27FC236}">
                    <a16:creationId xmlns:a16="http://schemas.microsoft.com/office/drawing/2014/main" id="{1412EA98-CA2F-40BF-A82F-793DD618C37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79302" y="5472306"/>
                <a:ext cx="556483" cy="1016379"/>
              </a:xfrm>
              <a:prstGeom prst="line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9" name="Straight Connector 278">
                <a:extLst>
                  <a:ext uri="{FF2B5EF4-FFF2-40B4-BE49-F238E27FC236}">
                    <a16:creationId xmlns:a16="http://schemas.microsoft.com/office/drawing/2014/main" id="{BC61F0E9-15BF-4D92-ADCC-49FDE2FF540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86110" y="5432345"/>
                <a:ext cx="407634" cy="746314"/>
              </a:xfrm>
              <a:prstGeom prst="line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0" name="Straight Connector 279">
                <a:extLst>
                  <a:ext uri="{FF2B5EF4-FFF2-40B4-BE49-F238E27FC236}">
                    <a16:creationId xmlns:a16="http://schemas.microsoft.com/office/drawing/2014/main" id="{5A45F445-B545-4A66-8174-69C2C5408F0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14456" y="5379886"/>
                <a:ext cx="301473" cy="548958"/>
              </a:xfrm>
              <a:prstGeom prst="line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1" name="Straight Connector 280">
                <a:extLst>
                  <a:ext uri="{FF2B5EF4-FFF2-40B4-BE49-F238E27FC236}">
                    <a16:creationId xmlns:a16="http://schemas.microsoft.com/office/drawing/2014/main" id="{9EBFBF2E-470D-44E0-AFE4-9BC08B459B2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638360" y="1067293"/>
                <a:ext cx="215125" cy="432628"/>
              </a:xfrm>
              <a:prstGeom prst="line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2" name="Straight Connector 281">
                <a:extLst>
                  <a:ext uri="{FF2B5EF4-FFF2-40B4-BE49-F238E27FC236}">
                    <a16:creationId xmlns:a16="http://schemas.microsoft.com/office/drawing/2014/main" id="{F4EA3780-6812-491F-82C1-97FF45BE9E9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950473" y="707760"/>
                <a:ext cx="412579" cy="774615"/>
              </a:xfrm>
              <a:prstGeom prst="line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3" name="Straight Connector 282">
                <a:extLst>
                  <a:ext uri="{FF2B5EF4-FFF2-40B4-BE49-F238E27FC236}">
                    <a16:creationId xmlns:a16="http://schemas.microsoft.com/office/drawing/2014/main" id="{B1C27732-60FD-4235-BB9C-0981E0A5109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98607" y="362100"/>
                <a:ext cx="556483" cy="1016379"/>
              </a:xfrm>
              <a:prstGeom prst="line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95" name="Flowchart: Connector 294"/>
            <p:cNvSpPr/>
            <p:nvPr/>
          </p:nvSpPr>
          <p:spPr bwMode="auto">
            <a:xfrm>
              <a:off x="6042595" y="7042470"/>
              <a:ext cx="552118" cy="16877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IN" b="1"/>
            </a:p>
          </p:txBody>
        </p:sp>
        <p:sp>
          <p:nvSpPr>
            <p:cNvPr id="29" name="Rectangle 28"/>
            <p:cNvSpPr/>
            <p:nvPr/>
          </p:nvSpPr>
          <p:spPr>
            <a:xfrm>
              <a:off x="5969790" y="6938906"/>
              <a:ext cx="749179" cy="38869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solidFill>
                    <a:schemeClr val="bg1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-</a:t>
              </a:r>
              <a:r>
                <a:rPr lang="en-IN" kern="100" dirty="0" err="1">
                  <a:solidFill>
                    <a:schemeClr val="bg1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Myc</a:t>
              </a:r>
              <a:endParaRPr lang="en-IN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96" name="Flowchart: Connector 295"/>
            <p:cNvSpPr/>
            <p:nvPr/>
          </p:nvSpPr>
          <p:spPr bwMode="auto">
            <a:xfrm>
              <a:off x="5934636" y="6723083"/>
              <a:ext cx="513274" cy="351459"/>
            </a:xfrm>
            <a:prstGeom prst="flowChartConnector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IN" b="1"/>
            </a:p>
          </p:txBody>
        </p:sp>
        <p:sp>
          <p:nvSpPr>
            <p:cNvPr id="28" name="Rectangle 27"/>
            <p:cNvSpPr/>
            <p:nvPr/>
          </p:nvSpPr>
          <p:spPr>
            <a:xfrm>
              <a:off x="5887258" y="6724302"/>
              <a:ext cx="651140" cy="38869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FBP2</a:t>
              </a:r>
              <a:endParaRPr lang="en-IN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98" name="Curved Connector 297"/>
            <p:cNvCxnSpPr/>
            <p:nvPr/>
          </p:nvCxnSpPr>
          <p:spPr>
            <a:xfrm rot="16200000" flipH="1">
              <a:off x="6325264" y="7436338"/>
              <a:ext cx="718724" cy="268546"/>
            </a:xfrm>
            <a:prstGeom prst="curvedConnector3">
              <a:avLst>
                <a:gd name="adj1" fmla="val 7592"/>
              </a:avLst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4" name="TextBox 168"/>
            <p:cNvSpPr txBox="1">
              <a:spLocks noChangeArrowheads="1"/>
            </p:cNvSpPr>
            <p:nvPr/>
          </p:nvSpPr>
          <p:spPr bwMode="auto">
            <a:xfrm rot="802727">
              <a:off x="6484891" y="7287742"/>
              <a:ext cx="2159057" cy="9233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IN" sz="5400" b="1" dirty="0">
                  <a:solidFill>
                    <a:srgbClr val="FF0000"/>
                  </a:solidFill>
                  <a:latin typeface="+mn-lt"/>
                </a:rPr>
                <a:t>+</a:t>
              </a:r>
            </a:p>
          </p:txBody>
        </p:sp>
        <p:sp>
          <p:nvSpPr>
            <p:cNvPr id="307" name="Oval 454"/>
            <p:cNvSpPr/>
            <p:nvPr/>
          </p:nvSpPr>
          <p:spPr bwMode="auto">
            <a:xfrm rot="16369013">
              <a:off x="4689008" y="6853076"/>
              <a:ext cx="575201" cy="561223"/>
            </a:xfrm>
            <a:custGeom>
              <a:avLst/>
              <a:gdLst>
                <a:gd name="connsiteX0" fmla="*/ 0 w 628650"/>
                <a:gd name="connsiteY0" fmla="*/ 342901 h 685801"/>
                <a:gd name="connsiteX1" fmla="*/ 314325 w 628650"/>
                <a:gd name="connsiteY1" fmla="*/ 0 h 685801"/>
                <a:gd name="connsiteX2" fmla="*/ 628650 w 628650"/>
                <a:gd name="connsiteY2" fmla="*/ 342901 h 685801"/>
                <a:gd name="connsiteX3" fmla="*/ 314325 w 628650"/>
                <a:gd name="connsiteY3" fmla="*/ 685802 h 685801"/>
                <a:gd name="connsiteX4" fmla="*/ 0 w 628650"/>
                <a:gd name="connsiteY4" fmla="*/ 342901 h 685801"/>
                <a:gd name="connsiteX0" fmla="*/ 0 w 650253"/>
                <a:gd name="connsiteY0" fmla="*/ 342901 h 688891"/>
                <a:gd name="connsiteX1" fmla="*/ 314325 w 650253"/>
                <a:gd name="connsiteY1" fmla="*/ 0 h 688891"/>
                <a:gd name="connsiteX2" fmla="*/ 628650 w 650253"/>
                <a:gd name="connsiteY2" fmla="*/ 342901 h 688891"/>
                <a:gd name="connsiteX3" fmla="*/ 588683 w 650253"/>
                <a:gd name="connsiteY3" fmla="*/ 502649 h 688891"/>
                <a:gd name="connsiteX4" fmla="*/ 314325 w 650253"/>
                <a:gd name="connsiteY4" fmla="*/ 685802 h 688891"/>
                <a:gd name="connsiteX5" fmla="*/ 0 w 650253"/>
                <a:gd name="connsiteY5" fmla="*/ 342901 h 688891"/>
                <a:gd name="connsiteX0" fmla="*/ 0 w 646386"/>
                <a:gd name="connsiteY0" fmla="*/ 342901 h 706454"/>
                <a:gd name="connsiteX1" fmla="*/ 314325 w 646386"/>
                <a:gd name="connsiteY1" fmla="*/ 0 h 706454"/>
                <a:gd name="connsiteX2" fmla="*/ 628650 w 646386"/>
                <a:gd name="connsiteY2" fmla="*/ 342901 h 706454"/>
                <a:gd name="connsiteX3" fmla="*/ 588683 w 646386"/>
                <a:gd name="connsiteY3" fmla="*/ 502649 h 706454"/>
                <a:gd name="connsiteX4" fmla="*/ 434871 w 646386"/>
                <a:gd name="connsiteY4" fmla="*/ 650086 h 706454"/>
                <a:gd name="connsiteX5" fmla="*/ 314325 w 646386"/>
                <a:gd name="connsiteY5" fmla="*/ 685802 h 706454"/>
                <a:gd name="connsiteX6" fmla="*/ 0 w 646386"/>
                <a:gd name="connsiteY6" fmla="*/ 342901 h 706454"/>
                <a:gd name="connsiteX0" fmla="*/ 4180 w 650566"/>
                <a:gd name="connsiteY0" fmla="*/ 342901 h 686680"/>
                <a:gd name="connsiteX1" fmla="*/ 318505 w 650566"/>
                <a:gd name="connsiteY1" fmla="*/ 0 h 686680"/>
                <a:gd name="connsiteX2" fmla="*/ 632830 w 650566"/>
                <a:gd name="connsiteY2" fmla="*/ 342901 h 686680"/>
                <a:gd name="connsiteX3" fmla="*/ 592863 w 650566"/>
                <a:gd name="connsiteY3" fmla="*/ 502649 h 686680"/>
                <a:gd name="connsiteX4" fmla="*/ 439051 w 650566"/>
                <a:gd name="connsiteY4" fmla="*/ 650086 h 686680"/>
                <a:gd name="connsiteX5" fmla="*/ 318505 w 650566"/>
                <a:gd name="connsiteY5" fmla="*/ 685802 h 686680"/>
                <a:gd name="connsiteX6" fmla="*/ 149656 w 650566"/>
                <a:gd name="connsiteY6" fmla="*/ 626177 h 686680"/>
                <a:gd name="connsiteX7" fmla="*/ 4180 w 650566"/>
                <a:gd name="connsiteY7" fmla="*/ 342901 h 686680"/>
                <a:gd name="connsiteX0" fmla="*/ 4180 w 650566"/>
                <a:gd name="connsiteY0" fmla="*/ 353175 h 696954"/>
                <a:gd name="connsiteX1" fmla="*/ 102715 w 650566"/>
                <a:gd name="connsiteY1" fmla="*/ 113196 h 696954"/>
                <a:gd name="connsiteX2" fmla="*/ 318505 w 650566"/>
                <a:gd name="connsiteY2" fmla="*/ 10274 h 696954"/>
                <a:gd name="connsiteX3" fmla="*/ 632830 w 650566"/>
                <a:gd name="connsiteY3" fmla="*/ 353175 h 696954"/>
                <a:gd name="connsiteX4" fmla="*/ 592863 w 650566"/>
                <a:gd name="connsiteY4" fmla="*/ 512923 h 696954"/>
                <a:gd name="connsiteX5" fmla="*/ 439051 w 650566"/>
                <a:gd name="connsiteY5" fmla="*/ 660360 h 696954"/>
                <a:gd name="connsiteX6" fmla="*/ 318505 w 650566"/>
                <a:gd name="connsiteY6" fmla="*/ 696076 h 696954"/>
                <a:gd name="connsiteX7" fmla="*/ 149656 w 650566"/>
                <a:gd name="connsiteY7" fmla="*/ 636451 h 696954"/>
                <a:gd name="connsiteX8" fmla="*/ 4180 w 650566"/>
                <a:gd name="connsiteY8" fmla="*/ 353175 h 696954"/>
                <a:gd name="connsiteX0" fmla="*/ 4180 w 639547"/>
                <a:gd name="connsiteY0" fmla="*/ 343504 h 687283"/>
                <a:gd name="connsiteX1" fmla="*/ 102715 w 639547"/>
                <a:gd name="connsiteY1" fmla="*/ 103525 h 687283"/>
                <a:gd name="connsiteX2" fmla="*/ 318505 w 639547"/>
                <a:gd name="connsiteY2" fmla="*/ 603 h 687283"/>
                <a:gd name="connsiteX3" fmla="*/ 473484 w 639547"/>
                <a:gd name="connsiteY3" fmla="*/ 144619 h 687283"/>
                <a:gd name="connsiteX4" fmla="*/ 632830 w 639547"/>
                <a:gd name="connsiteY4" fmla="*/ 343504 h 687283"/>
                <a:gd name="connsiteX5" fmla="*/ 592863 w 639547"/>
                <a:gd name="connsiteY5" fmla="*/ 503252 h 687283"/>
                <a:gd name="connsiteX6" fmla="*/ 439051 w 639547"/>
                <a:gd name="connsiteY6" fmla="*/ 650689 h 687283"/>
                <a:gd name="connsiteX7" fmla="*/ 318505 w 639547"/>
                <a:gd name="connsiteY7" fmla="*/ 686405 h 687283"/>
                <a:gd name="connsiteX8" fmla="*/ 149656 w 639547"/>
                <a:gd name="connsiteY8" fmla="*/ 626780 h 687283"/>
                <a:gd name="connsiteX9" fmla="*/ 4180 w 639547"/>
                <a:gd name="connsiteY9" fmla="*/ 343504 h 687283"/>
                <a:gd name="connsiteX0" fmla="*/ 4180 w 639547"/>
                <a:gd name="connsiteY0" fmla="*/ 347904 h 691683"/>
                <a:gd name="connsiteX1" fmla="*/ 102715 w 639547"/>
                <a:gd name="connsiteY1" fmla="*/ 107925 h 691683"/>
                <a:gd name="connsiteX2" fmla="*/ 192614 w 639547"/>
                <a:gd name="connsiteY2" fmla="*/ 39922 h 691683"/>
                <a:gd name="connsiteX3" fmla="*/ 318505 w 639547"/>
                <a:gd name="connsiteY3" fmla="*/ 5003 h 691683"/>
                <a:gd name="connsiteX4" fmla="*/ 473484 w 639547"/>
                <a:gd name="connsiteY4" fmla="*/ 149019 h 691683"/>
                <a:gd name="connsiteX5" fmla="*/ 632830 w 639547"/>
                <a:gd name="connsiteY5" fmla="*/ 347904 h 691683"/>
                <a:gd name="connsiteX6" fmla="*/ 592863 w 639547"/>
                <a:gd name="connsiteY6" fmla="*/ 507652 h 691683"/>
                <a:gd name="connsiteX7" fmla="*/ 439051 w 639547"/>
                <a:gd name="connsiteY7" fmla="*/ 655089 h 691683"/>
                <a:gd name="connsiteX8" fmla="*/ 318505 w 639547"/>
                <a:gd name="connsiteY8" fmla="*/ 690805 h 691683"/>
                <a:gd name="connsiteX9" fmla="*/ 149656 w 639547"/>
                <a:gd name="connsiteY9" fmla="*/ 631180 h 691683"/>
                <a:gd name="connsiteX10" fmla="*/ 4180 w 639547"/>
                <a:gd name="connsiteY10" fmla="*/ 347904 h 691683"/>
                <a:gd name="connsiteX0" fmla="*/ 4180 w 643470"/>
                <a:gd name="connsiteY0" fmla="*/ 347904 h 691683"/>
                <a:gd name="connsiteX1" fmla="*/ 102715 w 643470"/>
                <a:gd name="connsiteY1" fmla="*/ 107925 h 691683"/>
                <a:gd name="connsiteX2" fmla="*/ 192614 w 643470"/>
                <a:gd name="connsiteY2" fmla="*/ 39922 h 691683"/>
                <a:gd name="connsiteX3" fmla="*/ 318505 w 643470"/>
                <a:gd name="connsiteY3" fmla="*/ 5003 h 691683"/>
                <a:gd name="connsiteX4" fmla="*/ 473484 w 643470"/>
                <a:gd name="connsiteY4" fmla="*/ 149019 h 691683"/>
                <a:gd name="connsiteX5" fmla="*/ 632830 w 643470"/>
                <a:gd name="connsiteY5" fmla="*/ 347904 h 691683"/>
                <a:gd name="connsiteX6" fmla="*/ 611857 w 643470"/>
                <a:gd name="connsiteY6" fmla="*/ 549102 h 691683"/>
                <a:gd name="connsiteX7" fmla="*/ 439051 w 643470"/>
                <a:gd name="connsiteY7" fmla="*/ 655089 h 691683"/>
                <a:gd name="connsiteX8" fmla="*/ 318505 w 643470"/>
                <a:gd name="connsiteY8" fmla="*/ 690805 h 691683"/>
                <a:gd name="connsiteX9" fmla="*/ 149656 w 643470"/>
                <a:gd name="connsiteY9" fmla="*/ 631180 h 691683"/>
                <a:gd name="connsiteX10" fmla="*/ 4180 w 643470"/>
                <a:gd name="connsiteY10" fmla="*/ 347904 h 691683"/>
                <a:gd name="connsiteX0" fmla="*/ 4180 w 643470"/>
                <a:gd name="connsiteY0" fmla="*/ 351241 h 695020"/>
                <a:gd name="connsiteX1" fmla="*/ 102715 w 643470"/>
                <a:gd name="connsiteY1" fmla="*/ 111262 h 695020"/>
                <a:gd name="connsiteX2" fmla="*/ 192614 w 643470"/>
                <a:gd name="connsiteY2" fmla="*/ 43259 h 695020"/>
                <a:gd name="connsiteX3" fmla="*/ 318505 w 643470"/>
                <a:gd name="connsiteY3" fmla="*/ 8340 h 695020"/>
                <a:gd name="connsiteX4" fmla="*/ 467526 w 643470"/>
                <a:gd name="connsiteY4" fmla="*/ 203509 h 695020"/>
                <a:gd name="connsiteX5" fmla="*/ 632830 w 643470"/>
                <a:gd name="connsiteY5" fmla="*/ 351241 h 695020"/>
                <a:gd name="connsiteX6" fmla="*/ 611857 w 643470"/>
                <a:gd name="connsiteY6" fmla="*/ 552439 h 695020"/>
                <a:gd name="connsiteX7" fmla="*/ 439051 w 643470"/>
                <a:gd name="connsiteY7" fmla="*/ 658426 h 695020"/>
                <a:gd name="connsiteX8" fmla="*/ 318505 w 643470"/>
                <a:gd name="connsiteY8" fmla="*/ 694142 h 695020"/>
                <a:gd name="connsiteX9" fmla="*/ 149656 w 643470"/>
                <a:gd name="connsiteY9" fmla="*/ 634517 h 695020"/>
                <a:gd name="connsiteX10" fmla="*/ 4180 w 643470"/>
                <a:gd name="connsiteY10" fmla="*/ 351241 h 695020"/>
                <a:gd name="connsiteX0" fmla="*/ 1874 w 641164"/>
                <a:gd name="connsiteY0" fmla="*/ 351241 h 702699"/>
                <a:gd name="connsiteX1" fmla="*/ 100409 w 641164"/>
                <a:gd name="connsiteY1" fmla="*/ 111262 h 702699"/>
                <a:gd name="connsiteX2" fmla="*/ 190308 w 641164"/>
                <a:gd name="connsiteY2" fmla="*/ 43259 h 702699"/>
                <a:gd name="connsiteX3" fmla="*/ 316199 w 641164"/>
                <a:gd name="connsiteY3" fmla="*/ 8340 h 702699"/>
                <a:gd name="connsiteX4" fmla="*/ 465220 w 641164"/>
                <a:gd name="connsiteY4" fmla="*/ 203509 h 702699"/>
                <a:gd name="connsiteX5" fmla="*/ 630524 w 641164"/>
                <a:gd name="connsiteY5" fmla="*/ 351241 h 702699"/>
                <a:gd name="connsiteX6" fmla="*/ 609551 w 641164"/>
                <a:gd name="connsiteY6" fmla="*/ 552439 h 702699"/>
                <a:gd name="connsiteX7" fmla="*/ 436745 w 641164"/>
                <a:gd name="connsiteY7" fmla="*/ 658426 h 702699"/>
                <a:gd name="connsiteX8" fmla="*/ 316199 w 641164"/>
                <a:gd name="connsiteY8" fmla="*/ 694142 h 702699"/>
                <a:gd name="connsiteX9" fmla="*/ 179786 w 641164"/>
                <a:gd name="connsiteY9" fmla="*/ 518482 h 702699"/>
                <a:gd name="connsiteX10" fmla="*/ 1874 w 641164"/>
                <a:gd name="connsiteY10" fmla="*/ 351241 h 702699"/>
                <a:gd name="connsiteX0" fmla="*/ 656 w 639946"/>
                <a:gd name="connsiteY0" fmla="*/ 351241 h 699899"/>
                <a:gd name="connsiteX1" fmla="*/ 99191 w 639946"/>
                <a:gd name="connsiteY1" fmla="*/ 111262 h 699899"/>
                <a:gd name="connsiteX2" fmla="*/ 189090 w 639946"/>
                <a:gd name="connsiteY2" fmla="*/ 43259 h 699899"/>
                <a:gd name="connsiteX3" fmla="*/ 314981 w 639946"/>
                <a:gd name="connsiteY3" fmla="*/ 8340 h 699899"/>
                <a:gd name="connsiteX4" fmla="*/ 464002 w 639946"/>
                <a:gd name="connsiteY4" fmla="*/ 203509 h 699899"/>
                <a:gd name="connsiteX5" fmla="*/ 629306 w 639946"/>
                <a:gd name="connsiteY5" fmla="*/ 351241 h 699899"/>
                <a:gd name="connsiteX6" fmla="*/ 608333 w 639946"/>
                <a:gd name="connsiteY6" fmla="*/ 552439 h 699899"/>
                <a:gd name="connsiteX7" fmla="*/ 435527 w 639946"/>
                <a:gd name="connsiteY7" fmla="*/ 658426 h 699899"/>
                <a:gd name="connsiteX8" fmla="*/ 314981 w 639946"/>
                <a:gd name="connsiteY8" fmla="*/ 694142 h 699899"/>
                <a:gd name="connsiteX9" fmla="*/ 142387 w 639946"/>
                <a:gd name="connsiteY9" fmla="*/ 558407 h 699899"/>
                <a:gd name="connsiteX10" fmla="*/ 656 w 639946"/>
                <a:gd name="connsiteY10" fmla="*/ 351241 h 699899"/>
                <a:gd name="connsiteX0" fmla="*/ 656 w 643588"/>
                <a:gd name="connsiteY0" fmla="*/ 351241 h 699899"/>
                <a:gd name="connsiteX1" fmla="*/ 99191 w 643588"/>
                <a:gd name="connsiteY1" fmla="*/ 111262 h 699899"/>
                <a:gd name="connsiteX2" fmla="*/ 189090 w 643588"/>
                <a:gd name="connsiteY2" fmla="*/ 43259 h 699899"/>
                <a:gd name="connsiteX3" fmla="*/ 314981 w 643588"/>
                <a:gd name="connsiteY3" fmla="*/ 8340 h 699899"/>
                <a:gd name="connsiteX4" fmla="*/ 464002 w 643588"/>
                <a:gd name="connsiteY4" fmla="*/ 203509 h 699899"/>
                <a:gd name="connsiteX5" fmla="*/ 629306 w 643588"/>
                <a:gd name="connsiteY5" fmla="*/ 351241 h 699899"/>
                <a:gd name="connsiteX6" fmla="*/ 632506 w 643588"/>
                <a:gd name="connsiteY6" fmla="*/ 441041 h 699899"/>
                <a:gd name="connsiteX7" fmla="*/ 608333 w 643588"/>
                <a:gd name="connsiteY7" fmla="*/ 552439 h 699899"/>
                <a:gd name="connsiteX8" fmla="*/ 435527 w 643588"/>
                <a:gd name="connsiteY8" fmla="*/ 658426 h 699899"/>
                <a:gd name="connsiteX9" fmla="*/ 314981 w 643588"/>
                <a:gd name="connsiteY9" fmla="*/ 694142 h 699899"/>
                <a:gd name="connsiteX10" fmla="*/ 142387 w 643588"/>
                <a:gd name="connsiteY10" fmla="*/ 558407 h 699899"/>
                <a:gd name="connsiteX11" fmla="*/ 656 w 643588"/>
                <a:gd name="connsiteY11" fmla="*/ 351241 h 699899"/>
                <a:gd name="connsiteX0" fmla="*/ 656 w 643588"/>
                <a:gd name="connsiteY0" fmla="*/ 351241 h 698530"/>
                <a:gd name="connsiteX1" fmla="*/ 99191 w 643588"/>
                <a:gd name="connsiteY1" fmla="*/ 111262 h 698530"/>
                <a:gd name="connsiteX2" fmla="*/ 189090 w 643588"/>
                <a:gd name="connsiteY2" fmla="*/ 43259 h 698530"/>
                <a:gd name="connsiteX3" fmla="*/ 314981 w 643588"/>
                <a:gd name="connsiteY3" fmla="*/ 8340 h 698530"/>
                <a:gd name="connsiteX4" fmla="*/ 464002 w 643588"/>
                <a:gd name="connsiteY4" fmla="*/ 203509 h 698530"/>
                <a:gd name="connsiteX5" fmla="*/ 629306 w 643588"/>
                <a:gd name="connsiteY5" fmla="*/ 351241 h 698530"/>
                <a:gd name="connsiteX6" fmla="*/ 632506 w 643588"/>
                <a:gd name="connsiteY6" fmla="*/ 441041 h 698530"/>
                <a:gd name="connsiteX7" fmla="*/ 608333 w 643588"/>
                <a:gd name="connsiteY7" fmla="*/ 552439 h 698530"/>
                <a:gd name="connsiteX8" fmla="*/ 542328 w 643588"/>
                <a:gd name="connsiteY8" fmla="*/ 589587 h 698530"/>
                <a:gd name="connsiteX9" fmla="*/ 435527 w 643588"/>
                <a:gd name="connsiteY9" fmla="*/ 658426 h 698530"/>
                <a:gd name="connsiteX10" fmla="*/ 314981 w 643588"/>
                <a:gd name="connsiteY10" fmla="*/ 694142 h 698530"/>
                <a:gd name="connsiteX11" fmla="*/ 142387 w 643588"/>
                <a:gd name="connsiteY11" fmla="*/ 558407 h 698530"/>
                <a:gd name="connsiteX12" fmla="*/ 656 w 643588"/>
                <a:gd name="connsiteY12" fmla="*/ 351241 h 698530"/>
                <a:gd name="connsiteX0" fmla="*/ 656 w 643588"/>
                <a:gd name="connsiteY0" fmla="*/ 351241 h 698530"/>
                <a:gd name="connsiteX1" fmla="*/ 99191 w 643588"/>
                <a:gd name="connsiteY1" fmla="*/ 111262 h 698530"/>
                <a:gd name="connsiteX2" fmla="*/ 189090 w 643588"/>
                <a:gd name="connsiteY2" fmla="*/ 43259 h 698530"/>
                <a:gd name="connsiteX3" fmla="*/ 314981 w 643588"/>
                <a:gd name="connsiteY3" fmla="*/ 8340 h 698530"/>
                <a:gd name="connsiteX4" fmla="*/ 464002 w 643588"/>
                <a:gd name="connsiteY4" fmla="*/ 203509 h 698530"/>
                <a:gd name="connsiteX5" fmla="*/ 629306 w 643588"/>
                <a:gd name="connsiteY5" fmla="*/ 351241 h 698530"/>
                <a:gd name="connsiteX6" fmla="*/ 632506 w 643588"/>
                <a:gd name="connsiteY6" fmla="*/ 441041 h 698530"/>
                <a:gd name="connsiteX7" fmla="*/ 608333 w 643588"/>
                <a:gd name="connsiteY7" fmla="*/ 552439 h 698530"/>
                <a:gd name="connsiteX8" fmla="*/ 548014 w 643588"/>
                <a:gd name="connsiteY8" fmla="*/ 618976 h 698530"/>
                <a:gd name="connsiteX9" fmla="*/ 435527 w 643588"/>
                <a:gd name="connsiteY9" fmla="*/ 658426 h 698530"/>
                <a:gd name="connsiteX10" fmla="*/ 314981 w 643588"/>
                <a:gd name="connsiteY10" fmla="*/ 694142 h 698530"/>
                <a:gd name="connsiteX11" fmla="*/ 142387 w 643588"/>
                <a:gd name="connsiteY11" fmla="*/ 558407 h 698530"/>
                <a:gd name="connsiteX12" fmla="*/ 656 w 643588"/>
                <a:gd name="connsiteY12" fmla="*/ 351241 h 698530"/>
                <a:gd name="connsiteX0" fmla="*/ 656 w 642979"/>
                <a:gd name="connsiteY0" fmla="*/ 351241 h 698530"/>
                <a:gd name="connsiteX1" fmla="*/ 99191 w 642979"/>
                <a:gd name="connsiteY1" fmla="*/ 111262 h 698530"/>
                <a:gd name="connsiteX2" fmla="*/ 189090 w 642979"/>
                <a:gd name="connsiteY2" fmla="*/ 43259 h 698530"/>
                <a:gd name="connsiteX3" fmla="*/ 314981 w 642979"/>
                <a:gd name="connsiteY3" fmla="*/ 8340 h 698530"/>
                <a:gd name="connsiteX4" fmla="*/ 464002 w 642979"/>
                <a:gd name="connsiteY4" fmla="*/ 203509 h 698530"/>
                <a:gd name="connsiteX5" fmla="*/ 629306 w 642979"/>
                <a:gd name="connsiteY5" fmla="*/ 351241 h 698530"/>
                <a:gd name="connsiteX6" fmla="*/ 632506 w 642979"/>
                <a:gd name="connsiteY6" fmla="*/ 441041 h 698530"/>
                <a:gd name="connsiteX7" fmla="*/ 622107 w 642979"/>
                <a:gd name="connsiteY7" fmla="*/ 488177 h 698530"/>
                <a:gd name="connsiteX8" fmla="*/ 608333 w 642979"/>
                <a:gd name="connsiteY8" fmla="*/ 552439 h 698530"/>
                <a:gd name="connsiteX9" fmla="*/ 548014 w 642979"/>
                <a:gd name="connsiteY9" fmla="*/ 618976 h 698530"/>
                <a:gd name="connsiteX10" fmla="*/ 435527 w 642979"/>
                <a:gd name="connsiteY10" fmla="*/ 658426 h 698530"/>
                <a:gd name="connsiteX11" fmla="*/ 314981 w 642979"/>
                <a:gd name="connsiteY11" fmla="*/ 694142 h 698530"/>
                <a:gd name="connsiteX12" fmla="*/ 142387 w 642979"/>
                <a:gd name="connsiteY12" fmla="*/ 558407 h 698530"/>
                <a:gd name="connsiteX13" fmla="*/ 656 w 642979"/>
                <a:gd name="connsiteY13" fmla="*/ 351241 h 698530"/>
                <a:gd name="connsiteX0" fmla="*/ 656 w 664488"/>
                <a:gd name="connsiteY0" fmla="*/ 351241 h 698530"/>
                <a:gd name="connsiteX1" fmla="*/ 99191 w 664488"/>
                <a:gd name="connsiteY1" fmla="*/ 111262 h 698530"/>
                <a:gd name="connsiteX2" fmla="*/ 189090 w 664488"/>
                <a:gd name="connsiteY2" fmla="*/ 43259 h 698530"/>
                <a:gd name="connsiteX3" fmla="*/ 314981 w 664488"/>
                <a:gd name="connsiteY3" fmla="*/ 8340 h 698530"/>
                <a:gd name="connsiteX4" fmla="*/ 464002 w 664488"/>
                <a:gd name="connsiteY4" fmla="*/ 203509 h 698530"/>
                <a:gd name="connsiteX5" fmla="*/ 629306 w 664488"/>
                <a:gd name="connsiteY5" fmla="*/ 351241 h 698530"/>
                <a:gd name="connsiteX6" fmla="*/ 632506 w 664488"/>
                <a:gd name="connsiteY6" fmla="*/ 441041 h 698530"/>
                <a:gd name="connsiteX7" fmla="*/ 664181 w 664488"/>
                <a:gd name="connsiteY7" fmla="*/ 481868 h 698530"/>
                <a:gd name="connsiteX8" fmla="*/ 608333 w 664488"/>
                <a:gd name="connsiteY8" fmla="*/ 552439 h 698530"/>
                <a:gd name="connsiteX9" fmla="*/ 548014 w 664488"/>
                <a:gd name="connsiteY9" fmla="*/ 618976 h 698530"/>
                <a:gd name="connsiteX10" fmla="*/ 435527 w 664488"/>
                <a:gd name="connsiteY10" fmla="*/ 658426 h 698530"/>
                <a:gd name="connsiteX11" fmla="*/ 314981 w 664488"/>
                <a:gd name="connsiteY11" fmla="*/ 694142 h 698530"/>
                <a:gd name="connsiteX12" fmla="*/ 142387 w 664488"/>
                <a:gd name="connsiteY12" fmla="*/ 558407 h 698530"/>
                <a:gd name="connsiteX13" fmla="*/ 656 w 664488"/>
                <a:gd name="connsiteY13" fmla="*/ 351241 h 698530"/>
                <a:gd name="connsiteX0" fmla="*/ 656 w 642979"/>
                <a:gd name="connsiteY0" fmla="*/ 351241 h 698530"/>
                <a:gd name="connsiteX1" fmla="*/ 99191 w 642979"/>
                <a:gd name="connsiteY1" fmla="*/ 111262 h 698530"/>
                <a:gd name="connsiteX2" fmla="*/ 189090 w 642979"/>
                <a:gd name="connsiteY2" fmla="*/ 43259 h 698530"/>
                <a:gd name="connsiteX3" fmla="*/ 314981 w 642979"/>
                <a:gd name="connsiteY3" fmla="*/ 8340 h 698530"/>
                <a:gd name="connsiteX4" fmla="*/ 464002 w 642979"/>
                <a:gd name="connsiteY4" fmla="*/ 203509 h 698530"/>
                <a:gd name="connsiteX5" fmla="*/ 629306 w 642979"/>
                <a:gd name="connsiteY5" fmla="*/ 351241 h 698530"/>
                <a:gd name="connsiteX6" fmla="*/ 632506 w 642979"/>
                <a:gd name="connsiteY6" fmla="*/ 441041 h 698530"/>
                <a:gd name="connsiteX7" fmla="*/ 514114 w 642979"/>
                <a:gd name="connsiteY7" fmla="*/ 446866 h 698530"/>
                <a:gd name="connsiteX8" fmla="*/ 608333 w 642979"/>
                <a:gd name="connsiteY8" fmla="*/ 552439 h 698530"/>
                <a:gd name="connsiteX9" fmla="*/ 548014 w 642979"/>
                <a:gd name="connsiteY9" fmla="*/ 618976 h 698530"/>
                <a:gd name="connsiteX10" fmla="*/ 435527 w 642979"/>
                <a:gd name="connsiteY10" fmla="*/ 658426 h 698530"/>
                <a:gd name="connsiteX11" fmla="*/ 314981 w 642979"/>
                <a:gd name="connsiteY11" fmla="*/ 694142 h 698530"/>
                <a:gd name="connsiteX12" fmla="*/ 142387 w 642979"/>
                <a:gd name="connsiteY12" fmla="*/ 558407 h 698530"/>
                <a:gd name="connsiteX13" fmla="*/ 656 w 642979"/>
                <a:gd name="connsiteY13" fmla="*/ 351241 h 698530"/>
                <a:gd name="connsiteX0" fmla="*/ 656 w 642979"/>
                <a:gd name="connsiteY0" fmla="*/ 351241 h 698530"/>
                <a:gd name="connsiteX1" fmla="*/ 99191 w 642979"/>
                <a:gd name="connsiteY1" fmla="*/ 111262 h 698530"/>
                <a:gd name="connsiteX2" fmla="*/ 189090 w 642979"/>
                <a:gd name="connsiteY2" fmla="*/ 43259 h 698530"/>
                <a:gd name="connsiteX3" fmla="*/ 314981 w 642979"/>
                <a:gd name="connsiteY3" fmla="*/ 8340 h 698530"/>
                <a:gd name="connsiteX4" fmla="*/ 464002 w 642979"/>
                <a:gd name="connsiteY4" fmla="*/ 203509 h 698530"/>
                <a:gd name="connsiteX5" fmla="*/ 629306 w 642979"/>
                <a:gd name="connsiteY5" fmla="*/ 351241 h 698530"/>
                <a:gd name="connsiteX6" fmla="*/ 632506 w 642979"/>
                <a:gd name="connsiteY6" fmla="*/ 441041 h 698530"/>
                <a:gd name="connsiteX7" fmla="*/ 514114 w 642979"/>
                <a:gd name="connsiteY7" fmla="*/ 446866 h 698530"/>
                <a:gd name="connsiteX8" fmla="*/ 608333 w 642979"/>
                <a:gd name="connsiteY8" fmla="*/ 552439 h 698530"/>
                <a:gd name="connsiteX9" fmla="*/ 429692 w 642979"/>
                <a:gd name="connsiteY9" fmla="*/ 540027 h 698530"/>
                <a:gd name="connsiteX10" fmla="*/ 435527 w 642979"/>
                <a:gd name="connsiteY10" fmla="*/ 658426 h 698530"/>
                <a:gd name="connsiteX11" fmla="*/ 314981 w 642979"/>
                <a:gd name="connsiteY11" fmla="*/ 694142 h 698530"/>
                <a:gd name="connsiteX12" fmla="*/ 142387 w 642979"/>
                <a:gd name="connsiteY12" fmla="*/ 558407 h 698530"/>
                <a:gd name="connsiteX13" fmla="*/ 656 w 642979"/>
                <a:gd name="connsiteY13" fmla="*/ 351241 h 698530"/>
                <a:gd name="connsiteX0" fmla="*/ 656 w 642979"/>
                <a:gd name="connsiteY0" fmla="*/ 351241 h 698530"/>
                <a:gd name="connsiteX1" fmla="*/ 99191 w 642979"/>
                <a:gd name="connsiteY1" fmla="*/ 111262 h 698530"/>
                <a:gd name="connsiteX2" fmla="*/ 189090 w 642979"/>
                <a:gd name="connsiteY2" fmla="*/ 43259 h 698530"/>
                <a:gd name="connsiteX3" fmla="*/ 314981 w 642979"/>
                <a:gd name="connsiteY3" fmla="*/ 8340 h 698530"/>
                <a:gd name="connsiteX4" fmla="*/ 464002 w 642979"/>
                <a:gd name="connsiteY4" fmla="*/ 203509 h 698530"/>
                <a:gd name="connsiteX5" fmla="*/ 629306 w 642979"/>
                <a:gd name="connsiteY5" fmla="*/ 351241 h 698530"/>
                <a:gd name="connsiteX6" fmla="*/ 632506 w 642979"/>
                <a:gd name="connsiteY6" fmla="*/ 441041 h 698530"/>
                <a:gd name="connsiteX7" fmla="*/ 514114 w 642979"/>
                <a:gd name="connsiteY7" fmla="*/ 446866 h 698530"/>
                <a:gd name="connsiteX8" fmla="*/ 608333 w 642979"/>
                <a:gd name="connsiteY8" fmla="*/ 552439 h 698530"/>
                <a:gd name="connsiteX9" fmla="*/ 465245 w 642979"/>
                <a:gd name="connsiteY9" fmla="*/ 487421 h 698530"/>
                <a:gd name="connsiteX10" fmla="*/ 429692 w 642979"/>
                <a:gd name="connsiteY10" fmla="*/ 540027 h 698530"/>
                <a:gd name="connsiteX11" fmla="*/ 435527 w 642979"/>
                <a:gd name="connsiteY11" fmla="*/ 658426 h 698530"/>
                <a:gd name="connsiteX12" fmla="*/ 314981 w 642979"/>
                <a:gd name="connsiteY12" fmla="*/ 694142 h 698530"/>
                <a:gd name="connsiteX13" fmla="*/ 142387 w 642979"/>
                <a:gd name="connsiteY13" fmla="*/ 558407 h 698530"/>
                <a:gd name="connsiteX14" fmla="*/ 656 w 642979"/>
                <a:gd name="connsiteY14" fmla="*/ 351241 h 698530"/>
                <a:gd name="connsiteX0" fmla="*/ 656 w 642979"/>
                <a:gd name="connsiteY0" fmla="*/ 351241 h 694351"/>
                <a:gd name="connsiteX1" fmla="*/ 99191 w 642979"/>
                <a:gd name="connsiteY1" fmla="*/ 111262 h 694351"/>
                <a:gd name="connsiteX2" fmla="*/ 189090 w 642979"/>
                <a:gd name="connsiteY2" fmla="*/ 43259 h 694351"/>
                <a:gd name="connsiteX3" fmla="*/ 314981 w 642979"/>
                <a:gd name="connsiteY3" fmla="*/ 8340 h 694351"/>
                <a:gd name="connsiteX4" fmla="*/ 464002 w 642979"/>
                <a:gd name="connsiteY4" fmla="*/ 203509 h 694351"/>
                <a:gd name="connsiteX5" fmla="*/ 629306 w 642979"/>
                <a:gd name="connsiteY5" fmla="*/ 351241 h 694351"/>
                <a:gd name="connsiteX6" fmla="*/ 632506 w 642979"/>
                <a:gd name="connsiteY6" fmla="*/ 441041 h 694351"/>
                <a:gd name="connsiteX7" fmla="*/ 514114 w 642979"/>
                <a:gd name="connsiteY7" fmla="*/ 446866 h 694351"/>
                <a:gd name="connsiteX8" fmla="*/ 608333 w 642979"/>
                <a:gd name="connsiteY8" fmla="*/ 552439 h 694351"/>
                <a:gd name="connsiteX9" fmla="*/ 465245 w 642979"/>
                <a:gd name="connsiteY9" fmla="*/ 487421 h 694351"/>
                <a:gd name="connsiteX10" fmla="*/ 429692 w 642979"/>
                <a:gd name="connsiteY10" fmla="*/ 540027 h 694351"/>
                <a:gd name="connsiteX11" fmla="*/ 372795 w 642979"/>
                <a:gd name="connsiteY11" fmla="*/ 589459 h 694351"/>
                <a:gd name="connsiteX12" fmla="*/ 314981 w 642979"/>
                <a:gd name="connsiteY12" fmla="*/ 694142 h 694351"/>
                <a:gd name="connsiteX13" fmla="*/ 142387 w 642979"/>
                <a:gd name="connsiteY13" fmla="*/ 558407 h 694351"/>
                <a:gd name="connsiteX14" fmla="*/ 656 w 642979"/>
                <a:gd name="connsiteY14" fmla="*/ 351241 h 694351"/>
                <a:gd name="connsiteX0" fmla="*/ 656 w 642979"/>
                <a:gd name="connsiteY0" fmla="*/ 351241 h 596438"/>
                <a:gd name="connsiteX1" fmla="*/ 99191 w 642979"/>
                <a:gd name="connsiteY1" fmla="*/ 111262 h 596438"/>
                <a:gd name="connsiteX2" fmla="*/ 189090 w 642979"/>
                <a:gd name="connsiteY2" fmla="*/ 43259 h 596438"/>
                <a:gd name="connsiteX3" fmla="*/ 314981 w 642979"/>
                <a:gd name="connsiteY3" fmla="*/ 8340 h 596438"/>
                <a:gd name="connsiteX4" fmla="*/ 464002 w 642979"/>
                <a:gd name="connsiteY4" fmla="*/ 203509 h 596438"/>
                <a:gd name="connsiteX5" fmla="*/ 629306 w 642979"/>
                <a:gd name="connsiteY5" fmla="*/ 351241 h 596438"/>
                <a:gd name="connsiteX6" fmla="*/ 632506 w 642979"/>
                <a:gd name="connsiteY6" fmla="*/ 441041 h 596438"/>
                <a:gd name="connsiteX7" fmla="*/ 514114 w 642979"/>
                <a:gd name="connsiteY7" fmla="*/ 446866 h 596438"/>
                <a:gd name="connsiteX8" fmla="*/ 608333 w 642979"/>
                <a:gd name="connsiteY8" fmla="*/ 552439 h 596438"/>
                <a:gd name="connsiteX9" fmla="*/ 465245 w 642979"/>
                <a:gd name="connsiteY9" fmla="*/ 487421 h 596438"/>
                <a:gd name="connsiteX10" fmla="*/ 429692 w 642979"/>
                <a:gd name="connsiteY10" fmla="*/ 540027 h 596438"/>
                <a:gd name="connsiteX11" fmla="*/ 372795 w 642979"/>
                <a:gd name="connsiteY11" fmla="*/ 589459 h 596438"/>
                <a:gd name="connsiteX12" fmla="*/ 275539 w 642979"/>
                <a:gd name="connsiteY12" fmla="*/ 581644 h 596438"/>
                <a:gd name="connsiteX13" fmla="*/ 142387 w 642979"/>
                <a:gd name="connsiteY13" fmla="*/ 558407 h 596438"/>
                <a:gd name="connsiteX14" fmla="*/ 656 w 642979"/>
                <a:gd name="connsiteY14" fmla="*/ 351241 h 596438"/>
                <a:gd name="connsiteX0" fmla="*/ 7365 w 582037"/>
                <a:gd name="connsiteY0" fmla="*/ 347911 h 596438"/>
                <a:gd name="connsiteX1" fmla="*/ 38249 w 582037"/>
                <a:gd name="connsiteY1" fmla="*/ 111262 h 596438"/>
                <a:gd name="connsiteX2" fmla="*/ 128148 w 582037"/>
                <a:gd name="connsiteY2" fmla="*/ 43259 h 596438"/>
                <a:gd name="connsiteX3" fmla="*/ 254039 w 582037"/>
                <a:gd name="connsiteY3" fmla="*/ 8340 h 596438"/>
                <a:gd name="connsiteX4" fmla="*/ 403060 w 582037"/>
                <a:gd name="connsiteY4" fmla="*/ 203509 h 596438"/>
                <a:gd name="connsiteX5" fmla="*/ 568364 w 582037"/>
                <a:gd name="connsiteY5" fmla="*/ 351241 h 596438"/>
                <a:gd name="connsiteX6" fmla="*/ 571564 w 582037"/>
                <a:gd name="connsiteY6" fmla="*/ 441041 h 596438"/>
                <a:gd name="connsiteX7" fmla="*/ 453172 w 582037"/>
                <a:gd name="connsiteY7" fmla="*/ 446866 h 596438"/>
                <a:gd name="connsiteX8" fmla="*/ 547391 w 582037"/>
                <a:gd name="connsiteY8" fmla="*/ 552439 h 596438"/>
                <a:gd name="connsiteX9" fmla="*/ 404303 w 582037"/>
                <a:gd name="connsiteY9" fmla="*/ 487421 h 596438"/>
                <a:gd name="connsiteX10" fmla="*/ 368750 w 582037"/>
                <a:gd name="connsiteY10" fmla="*/ 540027 h 596438"/>
                <a:gd name="connsiteX11" fmla="*/ 311853 w 582037"/>
                <a:gd name="connsiteY11" fmla="*/ 589459 h 596438"/>
                <a:gd name="connsiteX12" fmla="*/ 214597 w 582037"/>
                <a:gd name="connsiteY12" fmla="*/ 581644 h 596438"/>
                <a:gd name="connsiteX13" fmla="*/ 81445 w 582037"/>
                <a:gd name="connsiteY13" fmla="*/ 558407 h 596438"/>
                <a:gd name="connsiteX14" fmla="*/ 7365 w 582037"/>
                <a:gd name="connsiteY14" fmla="*/ 347911 h 596438"/>
                <a:gd name="connsiteX0" fmla="*/ 531 w 575203"/>
                <a:gd name="connsiteY0" fmla="*/ 347911 h 596438"/>
                <a:gd name="connsiteX1" fmla="*/ 57409 w 575203"/>
                <a:gd name="connsiteY1" fmla="*/ 122698 h 596438"/>
                <a:gd name="connsiteX2" fmla="*/ 121314 w 575203"/>
                <a:gd name="connsiteY2" fmla="*/ 43259 h 596438"/>
                <a:gd name="connsiteX3" fmla="*/ 247205 w 575203"/>
                <a:gd name="connsiteY3" fmla="*/ 8340 h 596438"/>
                <a:gd name="connsiteX4" fmla="*/ 396226 w 575203"/>
                <a:gd name="connsiteY4" fmla="*/ 203509 h 596438"/>
                <a:gd name="connsiteX5" fmla="*/ 561530 w 575203"/>
                <a:gd name="connsiteY5" fmla="*/ 351241 h 596438"/>
                <a:gd name="connsiteX6" fmla="*/ 564730 w 575203"/>
                <a:gd name="connsiteY6" fmla="*/ 441041 h 596438"/>
                <a:gd name="connsiteX7" fmla="*/ 446338 w 575203"/>
                <a:gd name="connsiteY7" fmla="*/ 446866 h 596438"/>
                <a:gd name="connsiteX8" fmla="*/ 540557 w 575203"/>
                <a:gd name="connsiteY8" fmla="*/ 552439 h 596438"/>
                <a:gd name="connsiteX9" fmla="*/ 397469 w 575203"/>
                <a:gd name="connsiteY9" fmla="*/ 487421 h 596438"/>
                <a:gd name="connsiteX10" fmla="*/ 361916 w 575203"/>
                <a:gd name="connsiteY10" fmla="*/ 540027 h 596438"/>
                <a:gd name="connsiteX11" fmla="*/ 305019 w 575203"/>
                <a:gd name="connsiteY11" fmla="*/ 589459 h 596438"/>
                <a:gd name="connsiteX12" fmla="*/ 207763 w 575203"/>
                <a:gd name="connsiteY12" fmla="*/ 581644 h 596438"/>
                <a:gd name="connsiteX13" fmla="*/ 74611 w 575203"/>
                <a:gd name="connsiteY13" fmla="*/ 558407 h 596438"/>
                <a:gd name="connsiteX14" fmla="*/ 531 w 575203"/>
                <a:gd name="connsiteY14" fmla="*/ 347911 h 596438"/>
                <a:gd name="connsiteX0" fmla="*/ 531 w 575203"/>
                <a:gd name="connsiteY0" fmla="*/ 314228 h 562755"/>
                <a:gd name="connsiteX1" fmla="*/ 57409 w 575203"/>
                <a:gd name="connsiteY1" fmla="*/ 89015 h 562755"/>
                <a:gd name="connsiteX2" fmla="*/ 121314 w 575203"/>
                <a:gd name="connsiteY2" fmla="*/ 9576 h 562755"/>
                <a:gd name="connsiteX3" fmla="*/ 249702 w 575203"/>
                <a:gd name="connsiteY3" fmla="*/ 25395 h 562755"/>
                <a:gd name="connsiteX4" fmla="*/ 396226 w 575203"/>
                <a:gd name="connsiteY4" fmla="*/ 169826 h 562755"/>
                <a:gd name="connsiteX5" fmla="*/ 561530 w 575203"/>
                <a:gd name="connsiteY5" fmla="*/ 317558 h 562755"/>
                <a:gd name="connsiteX6" fmla="*/ 564730 w 575203"/>
                <a:gd name="connsiteY6" fmla="*/ 407358 h 562755"/>
                <a:gd name="connsiteX7" fmla="*/ 446338 w 575203"/>
                <a:gd name="connsiteY7" fmla="*/ 413183 h 562755"/>
                <a:gd name="connsiteX8" fmla="*/ 540557 w 575203"/>
                <a:gd name="connsiteY8" fmla="*/ 518756 h 562755"/>
                <a:gd name="connsiteX9" fmla="*/ 397469 w 575203"/>
                <a:gd name="connsiteY9" fmla="*/ 453738 h 562755"/>
                <a:gd name="connsiteX10" fmla="*/ 361916 w 575203"/>
                <a:gd name="connsiteY10" fmla="*/ 506344 h 562755"/>
                <a:gd name="connsiteX11" fmla="*/ 305019 w 575203"/>
                <a:gd name="connsiteY11" fmla="*/ 555776 h 562755"/>
                <a:gd name="connsiteX12" fmla="*/ 207763 w 575203"/>
                <a:gd name="connsiteY12" fmla="*/ 547961 h 562755"/>
                <a:gd name="connsiteX13" fmla="*/ 74611 w 575203"/>
                <a:gd name="connsiteY13" fmla="*/ 524724 h 562755"/>
                <a:gd name="connsiteX14" fmla="*/ 531 w 575203"/>
                <a:gd name="connsiteY14" fmla="*/ 314228 h 562755"/>
                <a:gd name="connsiteX0" fmla="*/ 531 w 575203"/>
                <a:gd name="connsiteY0" fmla="*/ 312695 h 561222"/>
                <a:gd name="connsiteX1" fmla="*/ 57409 w 575203"/>
                <a:gd name="connsiteY1" fmla="*/ 87482 h 561222"/>
                <a:gd name="connsiteX2" fmla="*/ 121314 w 575203"/>
                <a:gd name="connsiteY2" fmla="*/ 8043 h 561222"/>
                <a:gd name="connsiteX3" fmla="*/ 249702 w 575203"/>
                <a:gd name="connsiteY3" fmla="*/ 23862 h 561222"/>
                <a:gd name="connsiteX4" fmla="*/ 398584 w 575203"/>
                <a:gd name="connsiteY4" fmla="*/ 130031 h 561222"/>
                <a:gd name="connsiteX5" fmla="*/ 561530 w 575203"/>
                <a:gd name="connsiteY5" fmla="*/ 316025 h 561222"/>
                <a:gd name="connsiteX6" fmla="*/ 564730 w 575203"/>
                <a:gd name="connsiteY6" fmla="*/ 405825 h 561222"/>
                <a:gd name="connsiteX7" fmla="*/ 446338 w 575203"/>
                <a:gd name="connsiteY7" fmla="*/ 411650 h 561222"/>
                <a:gd name="connsiteX8" fmla="*/ 540557 w 575203"/>
                <a:gd name="connsiteY8" fmla="*/ 517223 h 561222"/>
                <a:gd name="connsiteX9" fmla="*/ 397469 w 575203"/>
                <a:gd name="connsiteY9" fmla="*/ 452205 h 561222"/>
                <a:gd name="connsiteX10" fmla="*/ 361916 w 575203"/>
                <a:gd name="connsiteY10" fmla="*/ 504811 h 561222"/>
                <a:gd name="connsiteX11" fmla="*/ 305019 w 575203"/>
                <a:gd name="connsiteY11" fmla="*/ 554243 h 561222"/>
                <a:gd name="connsiteX12" fmla="*/ 207763 w 575203"/>
                <a:gd name="connsiteY12" fmla="*/ 546428 h 561222"/>
                <a:gd name="connsiteX13" fmla="*/ 74611 w 575203"/>
                <a:gd name="connsiteY13" fmla="*/ 523191 h 561222"/>
                <a:gd name="connsiteX14" fmla="*/ 531 w 575203"/>
                <a:gd name="connsiteY14" fmla="*/ 312695 h 561222"/>
                <a:gd name="connsiteX0" fmla="*/ 531 w 575203"/>
                <a:gd name="connsiteY0" fmla="*/ 312695 h 561222"/>
                <a:gd name="connsiteX1" fmla="*/ 57409 w 575203"/>
                <a:gd name="connsiteY1" fmla="*/ 87482 h 561222"/>
                <a:gd name="connsiteX2" fmla="*/ 121314 w 575203"/>
                <a:gd name="connsiteY2" fmla="*/ 8043 h 561222"/>
                <a:gd name="connsiteX3" fmla="*/ 249702 w 575203"/>
                <a:gd name="connsiteY3" fmla="*/ 23862 h 561222"/>
                <a:gd name="connsiteX4" fmla="*/ 398584 w 575203"/>
                <a:gd name="connsiteY4" fmla="*/ 130031 h 561222"/>
                <a:gd name="connsiteX5" fmla="*/ 561530 w 575203"/>
                <a:gd name="connsiteY5" fmla="*/ 316025 h 561222"/>
                <a:gd name="connsiteX6" fmla="*/ 564730 w 575203"/>
                <a:gd name="connsiteY6" fmla="*/ 405825 h 561222"/>
                <a:gd name="connsiteX7" fmla="*/ 446338 w 575203"/>
                <a:gd name="connsiteY7" fmla="*/ 411650 h 561222"/>
                <a:gd name="connsiteX8" fmla="*/ 366596 w 575203"/>
                <a:gd name="connsiteY8" fmla="*/ 525783 h 561222"/>
                <a:gd name="connsiteX9" fmla="*/ 397469 w 575203"/>
                <a:gd name="connsiteY9" fmla="*/ 452205 h 561222"/>
                <a:gd name="connsiteX10" fmla="*/ 361916 w 575203"/>
                <a:gd name="connsiteY10" fmla="*/ 504811 h 561222"/>
                <a:gd name="connsiteX11" fmla="*/ 305019 w 575203"/>
                <a:gd name="connsiteY11" fmla="*/ 554243 h 561222"/>
                <a:gd name="connsiteX12" fmla="*/ 207763 w 575203"/>
                <a:gd name="connsiteY12" fmla="*/ 546428 h 561222"/>
                <a:gd name="connsiteX13" fmla="*/ 74611 w 575203"/>
                <a:gd name="connsiteY13" fmla="*/ 523191 h 561222"/>
                <a:gd name="connsiteX14" fmla="*/ 531 w 575203"/>
                <a:gd name="connsiteY14" fmla="*/ 312695 h 5612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</a:cxnLst>
              <a:rect l="l" t="t" r="r" b="b"/>
              <a:pathLst>
                <a:path w="575203" h="561222">
                  <a:moveTo>
                    <a:pt x="531" y="312695"/>
                  </a:moveTo>
                  <a:cubicBezTo>
                    <a:pt x="-2336" y="240077"/>
                    <a:pt x="5022" y="144632"/>
                    <a:pt x="57409" y="87482"/>
                  </a:cubicBezTo>
                  <a:cubicBezTo>
                    <a:pt x="88815" y="36152"/>
                    <a:pt x="85349" y="25197"/>
                    <a:pt x="121314" y="8043"/>
                  </a:cubicBezTo>
                  <a:cubicBezTo>
                    <a:pt x="157279" y="-9111"/>
                    <a:pt x="203490" y="3531"/>
                    <a:pt x="249702" y="23862"/>
                  </a:cubicBezTo>
                  <a:cubicBezTo>
                    <a:pt x="295914" y="44193"/>
                    <a:pt x="346197" y="72881"/>
                    <a:pt x="398584" y="130031"/>
                  </a:cubicBezTo>
                  <a:cubicBezTo>
                    <a:pt x="450971" y="187181"/>
                    <a:pt x="533446" y="276436"/>
                    <a:pt x="561530" y="316025"/>
                  </a:cubicBezTo>
                  <a:cubicBezTo>
                    <a:pt x="589614" y="355614"/>
                    <a:pt x="565930" y="383002"/>
                    <a:pt x="564730" y="405825"/>
                  </a:cubicBezTo>
                  <a:cubicBezTo>
                    <a:pt x="563530" y="428648"/>
                    <a:pt x="479360" y="391657"/>
                    <a:pt x="446338" y="411650"/>
                  </a:cubicBezTo>
                  <a:cubicBezTo>
                    <a:pt x="413316" y="431643"/>
                    <a:pt x="355899" y="509355"/>
                    <a:pt x="366596" y="525783"/>
                  </a:cubicBezTo>
                  <a:cubicBezTo>
                    <a:pt x="377293" y="542211"/>
                    <a:pt x="398249" y="455700"/>
                    <a:pt x="397469" y="452205"/>
                  </a:cubicBezTo>
                  <a:cubicBezTo>
                    <a:pt x="396689" y="448710"/>
                    <a:pt x="385711" y="485979"/>
                    <a:pt x="361916" y="504811"/>
                  </a:cubicBezTo>
                  <a:cubicBezTo>
                    <a:pt x="338121" y="523643"/>
                    <a:pt x="342910" y="536817"/>
                    <a:pt x="305019" y="554243"/>
                  </a:cubicBezTo>
                  <a:cubicBezTo>
                    <a:pt x="267128" y="571669"/>
                    <a:pt x="246164" y="551603"/>
                    <a:pt x="207763" y="546428"/>
                  </a:cubicBezTo>
                  <a:cubicBezTo>
                    <a:pt x="169362" y="541253"/>
                    <a:pt x="126998" y="580341"/>
                    <a:pt x="74611" y="523191"/>
                  </a:cubicBezTo>
                  <a:cubicBezTo>
                    <a:pt x="22224" y="466041"/>
                    <a:pt x="3398" y="385313"/>
                    <a:pt x="531" y="312695"/>
                  </a:cubicBezTo>
                  <a:close/>
                </a:path>
              </a:pathLst>
            </a:cu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b="1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6" name="Rectangle 25"/>
            <p:cNvSpPr/>
            <p:nvPr/>
          </p:nvSpPr>
          <p:spPr>
            <a:xfrm>
              <a:off x="4631386" y="7035370"/>
              <a:ext cx="740908" cy="38869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HIF1</a:t>
              </a:r>
              <a:r>
                <a:rPr lang="el-GR" kern="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α</a:t>
              </a:r>
              <a:endParaRPr lang="en-IN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10" name="Curved Connector 309"/>
            <p:cNvCxnSpPr>
              <a:stCxn id="55" idx="4"/>
            </p:cNvCxnSpPr>
            <p:nvPr/>
          </p:nvCxnSpPr>
          <p:spPr>
            <a:xfrm rot="5400000">
              <a:off x="4852984" y="7881567"/>
              <a:ext cx="692143" cy="287761"/>
            </a:xfrm>
            <a:prstGeom prst="curvedConnector3">
              <a:avLst>
                <a:gd name="adj1" fmla="val 39515"/>
              </a:avLst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2" name="TextBox 168"/>
            <p:cNvSpPr txBox="1">
              <a:spLocks noChangeArrowheads="1"/>
            </p:cNvSpPr>
            <p:nvPr/>
          </p:nvSpPr>
          <p:spPr bwMode="auto">
            <a:xfrm rot="802727">
              <a:off x="4838457" y="7743835"/>
              <a:ext cx="2159057" cy="9233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IN" sz="5400" b="1" dirty="0">
                  <a:solidFill>
                    <a:srgbClr val="FF0000"/>
                  </a:solidFill>
                  <a:latin typeface="+mn-lt"/>
                </a:rPr>
                <a:t>+</a:t>
              </a:r>
            </a:p>
          </p:txBody>
        </p:sp>
        <p:sp>
          <p:nvSpPr>
            <p:cNvPr id="313" name="Rectangle 312"/>
            <p:cNvSpPr/>
            <p:nvPr/>
          </p:nvSpPr>
          <p:spPr>
            <a:xfrm>
              <a:off x="4623752" y="1532495"/>
              <a:ext cx="565539" cy="38869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solidFill>
                    <a:schemeClr val="bg1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ROS</a:t>
              </a:r>
              <a:endParaRPr lang="en-IN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14" name="Rectangle 313"/>
            <p:cNvSpPr/>
            <p:nvPr/>
          </p:nvSpPr>
          <p:spPr>
            <a:xfrm>
              <a:off x="4937387" y="552158"/>
              <a:ext cx="565539" cy="38869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solidFill>
                    <a:schemeClr val="bg1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ROS</a:t>
              </a:r>
              <a:endParaRPr lang="en-IN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16" name="Group 315"/>
            <p:cNvGrpSpPr/>
            <p:nvPr/>
          </p:nvGrpSpPr>
          <p:grpSpPr>
            <a:xfrm>
              <a:off x="3418510" y="4532823"/>
              <a:ext cx="565539" cy="473851"/>
              <a:chOff x="4053269" y="454835"/>
              <a:chExt cx="565539" cy="473851"/>
            </a:xfrm>
          </p:grpSpPr>
          <p:sp>
            <p:nvSpPr>
              <p:cNvPr id="315" name="Cloud 314"/>
              <p:cNvSpPr/>
              <p:nvPr/>
            </p:nvSpPr>
            <p:spPr>
              <a:xfrm>
                <a:off x="4121562" y="454835"/>
                <a:ext cx="440125" cy="473851"/>
              </a:xfrm>
              <a:prstGeom prst="cloud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IN" b="1">
                  <a:solidFill>
                    <a:schemeClr val="tx1"/>
                  </a:solidFill>
                  <a:cs typeface="Times New Roman" pitchFamily="18" charset="0"/>
                </a:endParaRPr>
              </a:p>
            </p:txBody>
          </p:sp>
          <p:sp>
            <p:nvSpPr>
              <p:cNvPr id="7" name="Rectangle 6"/>
              <p:cNvSpPr/>
              <p:nvPr/>
            </p:nvSpPr>
            <p:spPr>
              <a:xfrm>
                <a:off x="4053269" y="511931"/>
                <a:ext cx="565539" cy="37555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N" kern="100" dirty="0">
                    <a:solidFill>
                      <a:schemeClr val="bg1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ROS</a:t>
                </a:r>
                <a:endParaRPr lang="en-IN" kern="100" dirty="0">
                  <a:solidFill>
                    <a:schemeClr val="bg1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17" name="Rounded Rectangle 316"/>
            <p:cNvSpPr/>
            <p:nvPr/>
          </p:nvSpPr>
          <p:spPr>
            <a:xfrm>
              <a:off x="1767528" y="5579936"/>
              <a:ext cx="518559" cy="299899"/>
            </a:xfrm>
            <a:prstGeom prst="roundRect">
              <a:avLst/>
            </a:prstGeom>
            <a:noFill/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319" name="Oval 454"/>
            <p:cNvSpPr/>
            <p:nvPr/>
          </p:nvSpPr>
          <p:spPr bwMode="auto">
            <a:xfrm rot="16369013">
              <a:off x="2925100" y="6289875"/>
              <a:ext cx="575201" cy="561223"/>
            </a:xfrm>
            <a:custGeom>
              <a:avLst/>
              <a:gdLst>
                <a:gd name="connsiteX0" fmla="*/ 0 w 628650"/>
                <a:gd name="connsiteY0" fmla="*/ 342901 h 685801"/>
                <a:gd name="connsiteX1" fmla="*/ 314325 w 628650"/>
                <a:gd name="connsiteY1" fmla="*/ 0 h 685801"/>
                <a:gd name="connsiteX2" fmla="*/ 628650 w 628650"/>
                <a:gd name="connsiteY2" fmla="*/ 342901 h 685801"/>
                <a:gd name="connsiteX3" fmla="*/ 314325 w 628650"/>
                <a:gd name="connsiteY3" fmla="*/ 685802 h 685801"/>
                <a:gd name="connsiteX4" fmla="*/ 0 w 628650"/>
                <a:gd name="connsiteY4" fmla="*/ 342901 h 685801"/>
                <a:gd name="connsiteX0" fmla="*/ 0 w 650253"/>
                <a:gd name="connsiteY0" fmla="*/ 342901 h 688891"/>
                <a:gd name="connsiteX1" fmla="*/ 314325 w 650253"/>
                <a:gd name="connsiteY1" fmla="*/ 0 h 688891"/>
                <a:gd name="connsiteX2" fmla="*/ 628650 w 650253"/>
                <a:gd name="connsiteY2" fmla="*/ 342901 h 688891"/>
                <a:gd name="connsiteX3" fmla="*/ 588683 w 650253"/>
                <a:gd name="connsiteY3" fmla="*/ 502649 h 688891"/>
                <a:gd name="connsiteX4" fmla="*/ 314325 w 650253"/>
                <a:gd name="connsiteY4" fmla="*/ 685802 h 688891"/>
                <a:gd name="connsiteX5" fmla="*/ 0 w 650253"/>
                <a:gd name="connsiteY5" fmla="*/ 342901 h 688891"/>
                <a:gd name="connsiteX0" fmla="*/ 0 w 646386"/>
                <a:gd name="connsiteY0" fmla="*/ 342901 h 706454"/>
                <a:gd name="connsiteX1" fmla="*/ 314325 w 646386"/>
                <a:gd name="connsiteY1" fmla="*/ 0 h 706454"/>
                <a:gd name="connsiteX2" fmla="*/ 628650 w 646386"/>
                <a:gd name="connsiteY2" fmla="*/ 342901 h 706454"/>
                <a:gd name="connsiteX3" fmla="*/ 588683 w 646386"/>
                <a:gd name="connsiteY3" fmla="*/ 502649 h 706454"/>
                <a:gd name="connsiteX4" fmla="*/ 434871 w 646386"/>
                <a:gd name="connsiteY4" fmla="*/ 650086 h 706454"/>
                <a:gd name="connsiteX5" fmla="*/ 314325 w 646386"/>
                <a:gd name="connsiteY5" fmla="*/ 685802 h 706454"/>
                <a:gd name="connsiteX6" fmla="*/ 0 w 646386"/>
                <a:gd name="connsiteY6" fmla="*/ 342901 h 706454"/>
                <a:gd name="connsiteX0" fmla="*/ 4180 w 650566"/>
                <a:gd name="connsiteY0" fmla="*/ 342901 h 686680"/>
                <a:gd name="connsiteX1" fmla="*/ 318505 w 650566"/>
                <a:gd name="connsiteY1" fmla="*/ 0 h 686680"/>
                <a:gd name="connsiteX2" fmla="*/ 632830 w 650566"/>
                <a:gd name="connsiteY2" fmla="*/ 342901 h 686680"/>
                <a:gd name="connsiteX3" fmla="*/ 592863 w 650566"/>
                <a:gd name="connsiteY3" fmla="*/ 502649 h 686680"/>
                <a:gd name="connsiteX4" fmla="*/ 439051 w 650566"/>
                <a:gd name="connsiteY4" fmla="*/ 650086 h 686680"/>
                <a:gd name="connsiteX5" fmla="*/ 318505 w 650566"/>
                <a:gd name="connsiteY5" fmla="*/ 685802 h 686680"/>
                <a:gd name="connsiteX6" fmla="*/ 149656 w 650566"/>
                <a:gd name="connsiteY6" fmla="*/ 626177 h 686680"/>
                <a:gd name="connsiteX7" fmla="*/ 4180 w 650566"/>
                <a:gd name="connsiteY7" fmla="*/ 342901 h 686680"/>
                <a:gd name="connsiteX0" fmla="*/ 4180 w 650566"/>
                <a:gd name="connsiteY0" fmla="*/ 353175 h 696954"/>
                <a:gd name="connsiteX1" fmla="*/ 102715 w 650566"/>
                <a:gd name="connsiteY1" fmla="*/ 113196 h 696954"/>
                <a:gd name="connsiteX2" fmla="*/ 318505 w 650566"/>
                <a:gd name="connsiteY2" fmla="*/ 10274 h 696954"/>
                <a:gd name="connsiteX3" fmla="*/ 632830 w 650566"/>
                <a:gd name="connsiteY3" fmla="*/ 353175 h 696954"/>
                <a:gd name="connsiteX4" fmla="*/ 592863 w 650566"/>
                <a:gd name="connsiteY4" fmla="*/ 512923 h 696954"/>
                <a:gd name="connsiteX5" fmla="*/ 439051 w 650566"/>
                <a:gd name="connsiteY5" fmla="*/ 660360 h 696954"/>
                <a:gd name="connsiteX6" fmla="*/ 318505 w 650566"/>
                <a:gd name="connsiteY6" fmla="*/ 696076 h 696954"/>
                <a:gd name="connsiteX7" fmla="*/ 149656 w 650566"/>
                <a:gd name="connsiteY7" fmla="*/ 636451 h 696954"/>
                <a:gd name="connsiteX8" fmla="*/ 4180 w 650566"/>
                <a:gd name="connsiteY8" fmla="*/ 353175 h 696954"/>
                <a:gd name="connsiteX0" fmla="*/ 4180 w 639547"/>
                <a:gd name="connsiteY0" fmla="*/ 343504 h 687283"/>
                <a:gd name="connsiteX1" fmla="*/ 102715 w 639547"/>
                <a:gd name="connsiteY1" fmla="*/ 103525 h 687283"/>
                <a:gd name="connsiteX2" fmla="*/ 318505 w 639547"/>
                <a:gd name="connsiteY2" fmla="*/ 603 h 687283"/>
                <a:gd name="connsiteX3" fmla="*/ 473484 w 639547"/>
                <a:gd name="connsiteY3" fmla="*/ 144619 h 687283"/>
                <a:gd name="connsiteX4" fmla="*/ 632830 w 639547"/>
                <a:gd name="connsiteY4" fmla="*/ 343504 h 687283"/>
                <a:gd name="connsiteX5" fmla="*/ 592863 w 639547"/>
                <a:gd name="connsiteY5" fmla="*/ 503252 h 687283"/>
                <a:gd name="connsiteX6" fmla="*/ 439051 w 639547"/>
                <a:gd name="connsiteY6" fmla="*/ 650689 h 687283"/>
                <a:gd name="connsiteX7" fmla="*/ 318505 w 639547"/>
                <a:gd name="connsiteY7" fmla="*/ 686405 h 687283"/>
                <a:gd name="connsiteX8" fmla="*/ 149656 w 639547"/>
                <a:gd name="connsiteY8" fmla="*/ 626780 h 687283"/>
                <a:gd name="connsiteX9" fmla="*/ 4180 w 639547"/>
                <a:gd name="connsiteY9" fmla="*/ 343504 h 687283"/>
                <a:gd name="connsiteX0" fmla="*/ 4180 w 639547"/>
                <a:gd name="connsiteY0" fmla="*/ 347904 h 691683"/>
                <a:gd name="connsiteX1" fmla="*/ 102715 w 639547"/>
                <a:gd name="connsiteY1" fmla="*/ 107925 h 691683"/>
                <a:gd name="connsiteX2" fmla="*/ 192614 w 639547"/>
                <a:gd name="connsiteY2" fmla="*/ 39922 h 691683"/>
                <a:gd name="connsiteX3" fmla="*/ 318505 w 639547"/>
                <a:gd name="connsiteY3" fmla="*/ 5003 h 691683"/>
                <a:gd name="connsiteX4" fmla="*/ 473484 w 639547"/>
                <a:gd name="connsiteY4" fmla="*/ 149019 h 691683"/>
                <a:gd name="connsiteX5" fmla="*/ 632830 w 639547"/>
                <a:gd name="connsiteY5" fmla="*/ 347904 h 691683"/>
                <a:gd name="connsiteX6" fmla="*/ 592863 w 639547"/>
                <a:gd name="connsiteY6" fmla="*/ 507652 h 691683"/>
                <a:gd name="connsiteX7" fmla="*/ 439051 w 639547"/>
                <a:gd name="connsiteY7" fmla="*/ 655089 h 691683"/>
                <a:gd name="connsiteX8" fmla="*/ 318505 w 639547"/>
                <a:gd name="connsiteY8" fmla="*/ 690805 h 691683"/>
                <a:gd name="connsiteX9" fmla="*/ 149656 w 639547"/>
                <a:gd name="connsiteY9" fmla="*/ 631180 h 691683"/>
                <a:gd name="connsiteX10" fmla="*/ 4180 w 639547"/>
                <a:gd name="connsiteY10" fmla="*/ 347904 h 691683"/>
                <a:gd name="connsiteX0" fmla="*/ 4180 w 643470"/>
                <a:gd name="connsiteY0" fmla="*/ 347904 h 691683"/>
                <a:gd name="connsiteX1" fmla="*/ 102715 w 643470"/>
                <a:gd name="connsiteY1" fmla="*/ 107925 h 691683"/>
                <a:gd name="connsiteX2" fmla="*/ 192614 w 643470"/>
                <a:gd name="connsiteY2" fmla="*/ 39922 h 691683"/>
                <a:gd name="connsiteX3" fmla="*/ 318505 w 643470"/>
                <a:gd name="connsiteY3" fmla="*/ 5003 h 691683"/>
                <a:gd name="connsiteX4" fmla="*/ 473484 w 643470"/>
                <a:gd name="connsiteY4" fmla="*/ 149019 h 691683"/>
                <a:gd name="connsiteX5" fmla="*/ 632830 w 643470"/>
                <a:gd name="connsiteY5" fmla="*/ 347904 h 691683"/>
                <a:gd name="connsiteX6" fmla="*/ 611857 w 643470"/>
                <a:gd name="connsiteY6" fmla="*/ 549102 h 691683"/>
                <a:gd name="connsiteX7" fmla="*/ 439051 w 643470"/>
                <a:gd name="connsiteY7" fmla="*/ 655089 h 691683"/>
                <a:gd name="connsiteX8" fmla="*/ 318505 w 643470"/>
                <a:gd name="connsiteY8" fmla="*/ 690805 h 691683"/>
                <a:gd name="connsiteX9" fmla="*/ 149656 w 643470"/>
                <a:gd name="connsiteY9" fmla="*/ 631180 h 691683"/>
                <a:gd name="connsiteX10" fmla="*/ 4180 w 643470"/>
                <a:gd name="connsiteY10" fmla="*/ 347904 h 691683"/>
                <a:gd name="connsiteX0" fmla="*/ 4180 w 643470"/>
                <a:gd name="connsiteY0" fmla="*/ 351241 h 695020"/>
                <a:gd name="connsiteX1" fmla="*/ 102715 w 643470"/>
                <a:gd name="connsiteY1" fmla="*/ 111262 h 695020"/>
                <a:gd name="connsiteX2" fmla="*/ 192614 w 643470"/>
                <a:gd name="connsiteY2" fmla="*/ 43259 h 695020"/>
                <a:gd name="connsiteX3" fmla="*/ 318505 w 643470"/>
                <a:gd name="connsiteY3" fmla="*/ 8340 h 695020"/>
                <a:gd name="connsiteX4" fmla="*/ 467526 w 643470"/>
                <a:gd name="connsiteY4" fmla="*/ 203509 h 695020"/>
                <a:gd name="connsiteX5" fmla="*/ 632830 w 643470"/>
                <a:gd name="connsiteY5" fmla="*/ 351241 h 695020"/>
                <a:gd name="connsiteX6" fmla="*/ 611857 w 643470"/>
                <a:gd name="connsiteY6" fmla="*/ 552439 h 695020"/>
                <a:gd name="connsiteX7" fmla="*/ 439051 w 643470"/>
                <a:gd name="connsiteY7" fmla="*/ 658426 h 695020"/>
                <a:gd name="connsiteX8" fmla="*/ 318505 w 643470"/>
                <a:gd name="connsiteY8" fmla="*/ 694142 h 695020"/>
                <a:gd name="connsiteX9" fmla="*/ 149656 w 643470"/>
                <a:gd name="connsiteY9" fmla="*/ 634517 h 695020"/>
                <a:gd name="connsiteX10" fmla="*/ 4180 w 643470"/>
                <a:gd name="connsiteY10" fmla="*/ 351241 h 695020"/>
                <a:gd name="connsiteX0" fmla="*/ 1874 w 641164"/>
                <a:gd name="connsiteY0" fmla="*/ 351241 h 702699"/>
                <a:gd name="connsiteX1" fmla="*/ 100409 w 641164"/>
                <a:gd name="connsiteY1" fmla="*/ 111262 h 702699"/>
                <a:gd name="connsiteX2" fmla="*/ 190308 w 641164"/>
                <a:gd name="connsiteY2" fmla="*/ 43259 h 702699"/>
                <a:gd name="connsiteX3" fmla="*/ 316199 w 641164"/>
                <a:gd name="connsiteY3" fmla="*/ 8340 h 702699"/>
                <a:gd name="connsiteX4" fmla="*/ 465220 w 641164"/>
                <a:gd name="connsiteY4" fmla="*/ 203509 h 702699"/>
                <a:gd name="connsiteX5" fmla="*/ 630524 w 641164"/>
                <a:gd name="connsiteY5" fmla="*/ 351241 h 702699"/>
                <a:gd name="connsiteX6" fmla="*/ 609551 w 641164"/>
                <a:gd name="connsiteY6" fmla="*/ 552439 h 702699"/>
                <a:gd name="connsiteX7" fmla="*/ 436745 w 641164"/>
                <a:gd name="connsiteY7" fmla="*/ 658426 h 702699"/>
                <a:gd name="connsiteX8" fmla="*/ 316199 w 641164"/>
                <a:gd name="connsiteY8" fmla="*/ 694142 h 702699"/>
                <a:gd name="connsiteX9" fmla="*/ 179786 w 641164"/>
                <a:gd name="connsiteY9" fmla="*/ 518482 h 702699"/>
                <a:gd name="connsiteX10" fmla="*/ 1874 w 641164"/>
                <a:gd name="connsiteY10" fmla="*/ 351241 h 702699"/>
                <a:gd name="connsiteX0" fmla="*/ 656 w 639946"/>
                <a:gd name="connsiteY0" fmla="*/ 351241 h 699899"/>
                <a:gd name="connsiteX1" fmla="*/ 99191 w 639946"/>
                <a:gd name="connsiteY1" fmla="*/ 111262 h 699899"/>
                <a:gd name="connsiteX2" fmla="*/ 189090 w 639946"/>
                <a:gd name="connsiteY2" fmla="*/ 43259 h 699899"/>
                <a:gd name="connsiteX3" fmla="*/ 314981 w 639946"/>
                <a:gd name="connsiteY3" fmla="*/ 8340 h 699899"/>
                <a:gd name="connsiteX4" fmla="*/ 464002 w 639946"/>
                <a:gd name="connsiteY4" fmla="*/ 203509 h 699899"/>
                <a:gd name="connsiteX5" fmla="*/ 629306 w 639946"/>
                <a:gd name="connsiteY5" fmla="*/ 351241 h 699899"/>
                <a:gd name="connsiteX6" fmla="*/ 608333 w 639946"/>
                <a:gd name="connsiteY6" fmla="*/ 552439 h 699899"/>
                <a:gd name="connsiteX7" fmla="*/ 435527 w 639946"/>
                <a:gd name="connsiteY7" fmla="*/ 658426 h 699899"/>
                <a:gd name="connsiteX8" fmla="*/ 314981 w 639946"/>
                <a:gd name="connsiteY8" fmla="*/ 694142 h 699899"/>
                <a:gd name="connsiteX9" fmla="*/ 142387 w 639946"/>
                <a:gd name="connsiteY9" fmla="*/ 558407 h 699899"/>
                <a:gd name="connsiteX10" fmla="*/ 656 w 639946"/>
                <a:gd name="connsiteY10" fmla="*/ 351241 h 699899"/>
                <a:gd name="connsiteX0" fmla="*/ 656 w 643588"/>
                <a:gd name="connsiteY0" fmla="*/ 351241 h 699899"/>
                <a:gd name="connsiteX1" fmla="*/ 99191 w 643588"/>
                <a:gd name="connsiteY1" fmla="*/ 111262 h 699899"/>
                <a:gd name="connsiteX2" fmla="*/ 189090 w 643588"/>
                <a:gd name="connsiteY2" fmla="*/ 43259 h 699899"/>
                <a:gd name="connsiteX3" fmla="*/ 314981 w 643588"/>
                <a:gd name="connsiteY3" fmla="*/ 8340 h 699899"/>
                <a:gd name="connsiteX4" fmla="*/ 464002 w 643588"/>
                <a:gd name="connsiteY4" fmla="*/ 203509 h 699899"/>
                <a:gd name="connsiteX5" fmla="*/ 629306 w 643588"/>
                <a:gd name="connsiteY5" fmla="*/ 351241 h 699899"/>
                <a:gd name="connsiteX6" fmla="*/ 632506 w 643588"/>
                <a:gd name="connsiteY6" fmla="*/ 441041 h 699899"/>
                <a:gd name="connsiteX7" fmla="*/ 608333 w 643588"/>
                <a:gd name="connsiteY7" fmla="*/ 552439 h 699899"/>
                <a:gd name="connsiteX8" fmla="*/ 435527 w 643588"/>
                <a:gd name="connsiteY8" fmla="*/ 658426 h 699899"/>
                <a:gd name="connsiteX9" fmla="*/ 314981 w 643588"/>
                <a:gd name="connsiteY9" fmla="*/ 694142 h 699899"/>
                <a:gd name="connsiteX10" fmla="*/ 142387 w 643588"/>
                <a:gd name="connsiteY10" fmla="*/ 558407 h 699899"/>
                <a:gd name="connsiteX11" fmla="*/ 656 w 643588"/>
                <a:gd name="connsiteY11" fmla="*/ 351241 h 699899"/>
                <a:gd name="connsiteX0" fmla="*/ 656 w 643588"/>
                <a:gd name="connsiteY0" fmla="*/ 351241 h 698530"/>
                <a:gd name="connsiteX1" fmla="*/ 99191 w 643588"/>
                <a:gd name="connsiteY1" fmla="*/ 111262 h 698530"/>
                <a:gd name="connsiteX2" fmla="*/ 189090 w 643588"/>
                <a:gd name="connsiteY2" fmla="*/ 43259 h 698530"/>
                <a:gd name="connsiteX3" fmla="*/ 314981 w 643588"/>
                <a:gd name="connsiteY3" fmla="*/ 8340 h 698530"/>
                <a:gd name="connsiteX4" fmla="*/ 464002 w 643588"/>
                <a:gd name="connsiteY4" fmla="*/ 203509 h 698530"/>
                <a:gd name="connsiteX5" fmla="*/ 629306 w 643588"/>
                <a:gd name="connsiteY5" fmla="*/ 351241 h 698530"/>
                <a:gd name="connsiteX6" fmla="*/ 632506 w 643588"/>
                <a:gd name="connsiteY6" fmla="*/ 441041 h 698530"/>
                <a:gd name="connsiteX7" fmla="*/ 608333 w 643588"/>
                <a:gd name="connsiteY7" fmla="*/ 552439 h 698530"/>
                <a:gd name="connsiteX8" fmla="*/ 542328 w 643588"/>
                <a:gd name="connsiteY8" fmla="*/ 589587 h 698530"/>
                <a:gd name="connsiteX9" fmla="*/ 435527 w 643588"/>
                <a:gd name="connsiteY9" fmla="*/ 658426 h 698530"/>
                <a:gd name="connsiteX10" fmla="*/ 314981 w 643588"/>
                <a:gd name="connsiteY10" fmla="*/ 694142 h 698530"/>
                <a:gd name="connsiteX11" fmla="*/ 142387 w 643588"/>
                <a:gd name="connsiteY11" fmla="*/ 558407 h 698530"/>
                <a:gd name="connsiteX12" fmla="*/ 656 w 643588"/>
                <a:gd name="connsiteY12" fmla="*/ 351241 h 698530"/>
                <a:gd name="connsiteX0" fmla="*/ 656 w 643588"/>
                <a:gd name="connsiteY0" fmla="*/ 351241 h 698530"/>
                <a:gd name="connsiteX1" fmla="*/ 99191 w 643588"/>
                <a:gd name="connsiteY1" fmla="*/ 111262 h 698530"/>
                <a:gd name="connsiteX2" fmla="*/ 189090 w 643588"/>
                <a:gd name="connsiteY2" fmla="*/ 43259 h 698530"/>
                <a:gd name="connsiteX3" fmla="*/ 314981 w 643588"/>
                <a:gd name="connsiteY3" fmla="*/ 8340 h 698530"/>
                <a:gd name="connsiteX4" fmla="*/ 464002 w 643588"/>
                <a:gd name="connsiteY4" fmla="*/ 203509 h 698530"/>
                <a:gd name="connsiteX5" fmla="*/ 629306 w 643588"/>
                <a:gd name="connsiteY5" fmla="*/ 351241 h 698530"/>
                <a:gd name="connsiteX6" fmla="*/ 632506 w 643588"/>
                <a:gd name="connsiteY6" fmla="*/ 441041 h 698530"/>
                <a:gd name="connsiteX7" fmla="*/ 608333 w 643588"/>
                <a:gd name="connsiteY7" fmla="*/ 552439 h 698530"/>
                <a:gd name="connsiteX8" fmla="*/ 548014 w 643588"/>
                <a:gd name="connsiteY8" fmla="*/ 618976 h 698530"/>
                <a:gd name="connsiteX9" fmla="*/ 435527 w 643588"/>
                <a:gd name="connsiteY9" fmla="*/ 658426 h 698530"/>
                <a:gd name="connsiteX10" fmla="*/ 314981 w 643588"/>
                <a:gd name="connsiteY10" fmla="*/ 694142 h 698530"/>
                <a:gd name="connsiteX11" fmla="*/ 142387 w 643588"/>
                <a:gd name="connsiteY11" fmla="*/ 558407 h 698530"/>
                <a:gd name="connsiteX12" fmla="*/ 656 w 643588"/>
                <a:gd name="connsiteY12" fmla="*/ 351241 h 698530"/>
                <a:gd name="connsiteX0" fmla="*/ 656 w 642979"/>
                <a:gd name="connsiteY0" fmla="*/ 351241 h 698530"/>
                <a:gd name="connsiteX1" fmla="*/ 99191 w 642979"/>
                <a:gd name="connsiteY1" fmla="*/ 111262 h 698530"/>
                <a:gd name="connsiteX2" fmla="*/ 189090 w 642979"/>
                <a:gd name="connsiteY2" fmla="*/ 43259 h 698530"/>
                <a:gd name="connsiteX3" fmla="*/ 314981 w 642979"/>
                <a:gd name="connsiteY3" fmla="*/ 8340 h 698530"/>
                <a:gd name="connsiteX4" fmla="*/ 464002 w 642979"/>
                <a:gd name="connsiteY4" fmla="*/ 203509 h 698530"/>
                <a:gd name="connsiteX5" fmla="*/ 629306 w 642979"/>
                <a:gd name="connsiteY5" fmla="*/ 351241 h 698530"/>
                <a:gd name="connsiteX6" fmla="*/ 632506 w 642979"/>
                <a:gd name="connsiteY6" fmla="*/ 441041 h 698530"/>
                <a:gd name="connsiteX7" fmla="*/ 622107 w 642979"/>
                <a:gd name="connsiteY7" fmla="*/ 488177 h 698530"/>
                <a:gd name="connsiteX8" fmla="*/ 608333 w 642979"/>
                <a:gd name="connsiteY8" fmla="*/ 552439 h 698530"/>
                <a:gd name="connsiteX9" fmla="*/ 548014 w 642979"/>
                <a:gd name="connsiteY9" fmla="*/ 618976 h 698530"/>
                <a:gd name="connsiteX10" fmla="*/ 435527 w 642979"/>
                <a:gd name="connsiteY10" fmla="*/ 658426 h 698530"/>
                <a:gd name="connsiteX11" fmla="*/ 314981 w 642979"/>
                <a:gd name="connsiteY11" fmla="*/ 694142 h 698530"/>
                <a:gd name="connsiteX12" fmla="*/ 142387 w 642979"/>
                <a:gd name="connsiteY12" fmla="*/ 558407 h 698530"/>
                <a:gd name="connsiteX13" fmla="*/ 656 w 642979"/>
                <a:gd name="connsiteY13" fmla="*/ 351241 h 698530"/>
                <a:gd name="connsiteX0" fmla="*/ 656 w 664488"/>
                <a:gd name="connsiteY0" fmla="*/ 351241 h 698530"/>
                <a:gd name="connsiteX1" fmla="*/ 99191 w 664488"/>
                <a:gd name="connsiteY1" fmla="*/ 111262 h 698530"/>
                <a:gd name="connsiteX2" fmla="*/ 189090 w 664488"/>
                <a:gd name="connsiteY2" fmla="*/ 43259 h 698530"/>
                <a:gd name="connsiteX3" fmla="*/ 314981 w 664488"/>
                <a:gd name="connsiteY3" fmla="*/ 8340 h 698530"/>
                <a:gd name="connsiteX4" fmla="*/ 464002 w 664488"/>
                <a:gd name="connsiteY4" fmla="*/ 203509 h 698530"/>
                <a:gd name="connsiteX5" fmla="*/ 629306 w 664488"/>
                <a:gd name="connsiteY5" fmla="*/ 351241 h 698530"/>
                <a:gd name="connsiteX6" fmla="*/ 632506 w 664488"/>
                <a:gd name="connsiteY6" fmla="*/ 441041 h 698530"/>
                <a:gd name="connsiteX7" fmla="*/ 664181 w 664488"/>
                <a:gd name="connsiteY7" fmla="*/ 481868 h 698530"/>
                <a:gd name="connsiteX8" fmla="*/ 608333 w 664488"/>
                <a:gd name="connsiteY8" fmla="*/ 552439 h 698530"/>
                <a:gd name="connsiteX9" fmla="*/ 548014 w 664488"/>
                <a:gd name="connsiteY9" fmla="*/ 618976 h 698530"/>
                <a:gd name="connsiteX10" fmla="*/ 435527 w 664488"/>
                <a:gd name="connsiteY10" fmla="*/ 658426 h 698530"/>
                <a:gd name="connsiteX11" fmla="*/ 314981 w 664488"/>
                <a:gd name="connsiteY11" fmla="*/ 694142 h 698530"/>
                <a:gd name="connsiteX12" fmla="*/ 142387 w 664488"/>
                <a:gd name="connsiteY12" fmla="*/ 558407 h 698530"/>
                <a:gd name="connsiteX13" fmla="*/ 656 w 664488"/>
                <a:gd name="connsiteY13" fmla="*/ 351241 h 698530"/>
                <a:gd name="connsiteX0" fmla="*/ 656 w 642979"/>
                <a:gd name="connsiteY0" fmla="*/ 351241 h 698530"/>
                <a:gd name="connsiteX1" fmla="*/ 99191 w 642979"/>
                <a:gd name="connsiteY1" fmla="*/ 111262 h 698530"/>
                <a:gd name="connsiteX2" fmla="*/ 189090 w 642979"/>
                <a:gd name="connsiteY2" fmla="*/ 43259 h 698530"/>
                <a:gd name="connsiteX3" fmla="*/ 314981 w 642979"/>
                <a:gd name="connsiteY3" fmla="*/ 8340 h 698530"/>
                <a:gd name="connsiteX4" fmla="*/ 464002 w 642979"/>
                <a:gd name="connsiteY4" fmla="*/ 203509 h 698530"/>
                <a:gd name="connsiteX5" fmla="*/ 629306 w 642979"/>
                <a:gd name="connsiteY5" fmla="*/ 351241 h 698530"/>
                <a:gd name="connsiteX6" fmla="*/ 632506 w 642979"/>
                <a:gd name="connsiteY6" fmla="*/ 441041 h 698530"/>
                <a:gd name="connsiteX7" fmla="*/ 514114 w 642979"/>
                <a:gd name="connsiteY7" fmla="*/ 446866 h 698530"/>
                <a:gd name="connsiteX8" fmla="*/ 608333 w 642979"/>
                <a:gd name="connsiteY8" fmla="*/ 552439 h 698530"/>
                <a:gd name="connsiteX9" fmla="*/ 548014 w 642979"/>
                <a:gd name="connsiteY9" fmla="*/ 618976 h 698530"/>
                <a:gd name="connsiteX10" fmla="*/ 435527 w 642979"/>
                <a:gd name="connsiteY10" fmla="*/ 658426 h 698530"/>
                <a:gd name="connsiteX11" fmla="*/ 314981 w 642979"/>
                <a:gd name="connsiteY11" fmla="*/ 694142 h 698530"/>
                <a:gd name="connsiteX12" fmla="*/ 142387 w 642979"/>
                <a:gd name="connsiteY12" fmla="*/ 558407 h 698530"/>
                <a:gd name="connsiteX13" fmla="*/ 656 w 642979"/>
                <a:gd name="connsiteY13" fmla="*/ 351241 h 698530"/>
                <a:gd name="connsiteX0" fmla="*/ 656 w 642979"/>
                <a:gd name="connsiteY0" fmla="*/ 351241 h 698530"/>
                <a:gd name="connsiteX1" fmla="*/ 99191 w 642979"/>
                <a:gd name="connsiteY1" fmla="*/ 111262 h 698530"/>
                <a:gd name="connsiteX2" fmla="*/ 189090 w 642979"/>
                <a:gd name="connsiteY2" fmla="*/ 43259 h 698530"/>
                <a:gd name="connsiteX3" fmla="*/ 314981 w 642979"/>
                <a:gd name="connsiteY3" fmla="*/ 8340 h 698530"/>
                <a:gd name="connsiteX4" fmla="*/ 464002 w 642979"/>
                <a:gd name="connsiteY4" fmla="*/ 203509 h 698530"/>
                <a:gd name="connsiteX5" fmla="*/ 629306 w 642979"/>
                <a:gd name="connsiteY5" fmla="*/ 351241 h 698530"/>
                <a:gd name="connsiteX6" fmla="*/ 632506 w 642979"/>
                <a:gd name="connsiteY6" fmla="*/ 441041 h 698530"/>
                <a:gd name="connsiteX7" fmla="*/ 514114 w 642979"/>
                <a:gd name="connsiteY7" fmla="*/ 446866 h 698530"/>
                <a:gd name="connsiteX8" fmla="*/ 608333 w 642979"/>
                <a:gd name="connsiteY8" fmla="*/ 552439 h 698530"/>
                <a:gd name="connsiteX9" fmla="*/ 429692 w 642979"/>
                <a:gd name="connsiteY9" fmla="*/ 540027 h 698530"/>
                <a:gd name="connsiteX10" fmla="*/ 435527 w 642979"/>
                <a:gd name="connsiteY10" fmla="*/ 658426 h 698530"/>
                <a:gd name="connsiteX11" fmla="*/ 314981 w 642979"/>
                <a:gd name="connsiteY11" fmla="*/ 694142 h 698530"/>
                <a:gd name="connsiteX12" fmla="*/ 142387 w 642979"/>
                <a:gd name="connsiteY12" fmla="*/ 558407 h 698530"/>
                <a:gd name="connsiteX13" fmla="*/ 656 w 642979"/>
                <a:gd name="connsiteY13" fmla="*/ 351241 h 698530"/>
                <a:gd name="connsiteX0" fmla="*/ 656 w 642979"/>
                <a:gd name="connsiteY0" fmla="*/ 351241 h 698530"/>
                <a:gd name="connsiteX1" fmla="*/ 99191 w 642979"/>
                <a:gd name="connsiteY1" fmla="*/ 111262 h 698530"/>
                <a:gd name="connsiteX2" fmla="*/ 189090 w 642979"/>
                <a:gd name="connsiteY2" fmla="*/ 43259 h 698530"/>
                <a:gd name="connsiteX3" fmla="*/ 314981 w 642979"/>
                <a:gd name="connsiteY3" fmla="*/ 8340 h 698530"/>
                <a:gd name="connsiteX4" fmla="*/ 464002 w 642979"/>
                <a:gd name="connsiteY4" fmla="*/ 203509 h 698530"/>
                <a:gd name="connsiteX5" fmla="*/ 629306 w 642979"/>
                <a:gd name="connsiteY5" fmla="*/ 351241 h 698530"/>
                <a:gd name="connsiteX6" fmla="*/ 632506 w 642979"/>
                <a:gd name="connsiteY6" fmla="*/ 441041 h 698530"/>
                <a:gd name="connsiteX7" fmla="*/ 514114 w 642979"/>
                <a:gd name="connsiteY7" fmla="*/ 446866 h 698530"/>
                <a:gd name="connsiteX8" fmla="*/ 608333 w 642979"/>
                <a:gd name="connsiteY8" fmla="*/ 552439 h 698530"/>
                <a:gd name="connsiteX9" fmla="*/ 465245 w 642979"/>
                <a:gd name="connsiteY9" fmla="*/ 487421 h 698530"/>
                <a:gd name="connsiteX10" fmla="*/ 429692 w 642979"/>
                <a:gd name="connsiteY10" fmla="*/ 540027 h 698530"/>
                <a:gd name="connsiteX11" fmla="*/ 435527 w 642979"/>
                <a:gd name="connsiteY11" fmla="*/ 658426 h 698530"/>
                <a:gd name="connsiteX12" fmla="*/ 314981 w 642979"/>
                <a:gd name="connsiteY12" fmla="*/ 694142 h 698530"/>
                <a:gd name="connsiteX13" fmla="*/ 142387 w 642979"/>
                <a:gd name="connsiteY13" fmla="*/ 558407 h 698530"/>
                <a:gd name="connsiteX14" fmla="*/ 656 w 642979"/>
                <a:gd name="connsiteY14" fmla="*/ 351241 h 698530"/>
                <a:gd name="connsiteX0" fmla="*/ 656 w 642979"/>
                <a:gd name="connsiteY0" fmla="*/ 351241 h 694351"/>
                <a:gd name="connsiteX1" fmla="*/ 99191 w 642979"/>
                <a:gd name="connsiteY1" fmla="*/ 111262 h 694351"/>
                <a:gd name="connsiteX2" fmla="*/ 189090 w 642979"/>
                <a:gd name="connsiteY2" fmla="*/ 43259 h 694351"/>
                <a:gd name="connsiteX3" fmla="*/ 314981 w 642979"/>
                <a:gd name="connsiteY3" fmla="*/ 8340 h 694351"/>
                <a:gd name="connsiteX4" fmla="*/ 464002 w 642979"/>
                <a:gd name="connsiteY4" fmla="*/ 203509 h 694351"/>
                <a:gd name="connsiteX5" fmla="*/ 629306 w 642979"/>
                <a:gd name="connsiteY5" fmla="*/ 351241 h 694351"/>
                <a:gd name="connsiteX6" fmla="*/ 632506 w 642979"/>
                <a:gd name="connsiteY6" fmla="*/ 441041 h 694351"/>
                <a:gd name="connsiteX7" fmla="*/ 514114 w 642979"/>
                <a:gd name="connsiteY7" fmla="*/ 446866 h 694351"/>
                <a:gd name="connsiteX8" fmla="*/ 608333 w 642979"/>
                <a:gd name="connsiteY8" fmla="*/ 552439 h 694351"/>
                <a:gd name="connsiteX9" fmla="*/ 465245 w 642979"/>
                <a:gd name="connsiteY9" fmla="*/ 487421 h 694351"/>
                <a:gd name="connsiteX10" fmla="*/ 429692 w 642979"/>
                <a:gd name="connsiteY10" fmla="*/ 540027 h 694351"/>
                <a:gd name="connsiteX11" fmla="*/ 372795 w 642979"/>
                <a:gd name="connsiteY11" fmla="*/ 589459 h 694351"/>
                <a:gd name="connsiteX12" fmla="*/ 314981 w 642979"/>
                <a:gd name="connsiteY12" fmla="*/ 694142 h 694351"/>
                <a:gd name="connsiteX13" fmla="*/ 142387 w 642979"/>
                <a:gd name="connsiteY13" fmla="*/ 558407 h 694351"/>
                <a:gd name="connsiteX14" fmla="*/ 656 w 642979"/>
                <a:gd name="connsiteY14" fmla="*/ 351241 h 694351"/>
                <a:gd name="connsiteX0" fmla="*/ 656 w 642979"/>
                <a:gd name="connsiteY0" fmla="*/ 351241 h 596438"/>
                <a:gd name="connsiteX1" fmla="*/ 99191 w 642979"/>
                <a:gd name="connsiteY1" fmla="*/ 111262 h 596438"/>
                <a:gd name="connsiteX2" fmla="*/ 189090 w 642979"/>
                <a:gd name="connsiteY2" fmla="*/ 43259 h 596438"/>
                <a:gd name="connsiteX3" fmla="*/ 314981 w 642979"/>
                <a:gd name="connsiteY3" fmla="*/ 8340 h 596438"/>
                <a:gd name="connsiteX4" fmla="*/ 464002 w 642979"/>
                <a:gd name="connsiteY4" fmla="*/ 203509 h 596438"/>
                <a:gd name="connsiteX5" fmla="*/ 629306 w 642979"/>
                <a:gd name="connsiteY5" fmla="*/ 351241 h 596438"/>
                <a:gd name="connsiteX6" fmla="*/ 632506 w 642979"/>
                <a:gd name="connsiteY6" fmla="*/ 441041 h 596438"/>
                <a:gd name="connsiteX7" fmla="*/ 514114 w 642979"/>
                <a:gd name="connsiteY7" fmla="*/ 446866 h 596438"/>
                <a:gd name="connsiteX8" fmla="*/ 608333 w 642979"/>
                <a:gd name="connsiteY8" fmla="*/ 552439 h 596438"/>
                <a:gd name="connsiteX9" fmla="*/ 465245 w 642979"/>
                <a:gd name="connsiteY9" fmla="*/ 487421 h 596438"/>
                <a:gd name="connsiteX10" fmla="*/ 429692 w 642979"/>
                <a:gd name="connsiteY10" fmla="*/ 540027 h 596438"/>
                <a:gd name="connsiteX11" fmla="*/ 372795 w 642979"/>
                <a:gd name="connsiteY11" fmla="*/ 589459 h 596438"/>
                <a:gd name="connsiteX12" fmla="*/ 275539 w 642979"/>
                <a:gd name="connsiteY12" fmla="*/ 581644 h 596438"/>
                <a:gd name="connsiteX13" fmla="*/ 142387 w 642979"/>
                <a:gd name="connsiteY13" fmla="*/ 558407 h 596438"/>
                <a:gd name="connsiteX14" fmla="*/ 656 w 642979"/>
                <a:gd name="connsiteY14" fmla="*/ 351241 h 596438"/>
                <a:gd name="connsiteX0" fmla="*/ 7365 w 582037"/>
                <a:gd name="connsiteY0" fmla="*/ 347911 h 596438"/>
                <a:gd name="connsiteX1" fmla="*/ 38249 w 582037"/>
                <a:gd name="connsiteY1" fmla="*/ 111262 h 596438"/>
                <a:gd name="connsiteX2" fmla="*/ 128148 w 582037"/>
                <a:gd name="connsiteY2" fmla="*/ 43259 h 596438"/>
                <a:gd name="connsiteX3" fmla="*/ 254039 w 582037"/>
                <a:gd name="connsiteY3" fmla="*/ 8340 h 596438"/>
                <a:gd name="connsiteX4" fmla="*/ 403060 w 582037"/>
                <a:gd name="connsiteY4" fmla="*/ 203509 h 596438"/>
                <a:gd name="connsiteX5" fmla="*/ 568364 w 582037"/>
                <a:gd name="connsiteY5" fmla="*/ 351241 h 596438"/>
                <a:gd name="connsiteX6" fmla="*/ 571564 w 582037"/>
                <a:gd name="connsiteY6" fmla="*/ 441041 h 596438"/>
                <a:gd name="connsiteX7" fmla="*/ 453172 w 582037"/>
                <a:gd name="connsiteY7" fmla="*/ 446866 h 596438"/>
                <a:gd name="connsiteX8" fmla="*/ 547391 w 582037"/>
                <a:gd name="connsiteY8" fmla="*/ 552439 h 596438"/>
                <a:gd name="connsiteX9" fmla="*/ 404303 w 582037"/>
                <a:gd name="connsiteY9" fmla="*/ 487421 h 596438"/>
                <a:gd name="connsiteX10" fmla="*/ 368750 w 582037"/>
                <a:gd name="connsiteY10" fmla="*/ 540027 h 596438"/>
                <a:gd name="connsiteX11" fmla="*/ 311853 w 582037"/>
                <a:gd name="connsiteY11" fmla="*/ 589459 h 596438"/>
                <a:gd name="connsiteX12" fmla="*/ 214597 w 582037"/>
                <a:gd name="connsiteY12" fmla="*/ 581644 h 596438"/>
                <a:gd name="connsiteX13" fmla="*/ 81445 w 582037"/>
                <a:gd name="connsiteY13" fmla="*/ 558407 h 596438"/>
                <a:gd name="connsiteX14" fmla="*/ 7365 w 582037"/>
                <a:gd name="connsiteY14" fmla="*/ 347911 h 596438"/>
                <a:gd name="connsiteX0" fmla="*/ 531 w 575203"/>
                <a:gd name="connsiteY0" fmla="*/ 347911 h 596438"/>
                <a:gd name="connsiteX1" fmla="*/ 57409 w 575203"/>
                <a:gd name="connsiteY1" fmla="*/ 122698 h 596438"/>
                <a:gd name="connsiteX2" fmla="*/ 121314 w 575203"/>
                <a:gd name="connsiteY2" fmla="*/ 43259 h 596438"/>
                <a:gd name="connsiteX3" fmla="*/ 247205 w 575203"/>
                <a:gd name="connsiteY3" fmla="*/ 8340 h 596438"/>
                <a:gd name="connsiteX4" fmla="*/ 396226 w 575203"/>
                <a:gd name="connsiteY4" fmla="*/ 203509 h 596438"/>
                <a:gd name="connsiteX5" fmla="*/ 561530 w 575203"/>
                <a:gd name="connsiteY5" fmla="*/ 351241 h 596438"/>
                <a:gd name="connsiteX6" fmla="*/ 564730 w 575203"/>
                <a:gd name="connsiteY6" fmla="*/ 441041 h 596438"/>
                <a:gd name="connsiteX7" fmla="*/ 446338 w 575203"/>
                <a:gd name="connsiteY7" fmla="*/ 446866 h 596438"/>
                <a:gd name="connsiteX8" fmla="*/ 540557 w 575203"/>
                <a:gd name="connsiteY8" fmla="*/ 552439 h 596438"/>
                <a:gd name="connsiteX9" fmla="*/ 397469 w 575203"/>
                <a:gd name="connsiteY9" fmla="*/ 487421 h 596438"/>
                <a:gd name="connsiteX10" fmla="*/ 361916 w 575203"/>
                <a:gd name="connsiteY10" fmla="*/ 540027 h 596438"/>
                <a:gd name="connsiteX11" fmla="*/ 305019 w 575203"/>
                <a:gd name="connsiteY11" fmla="*/ 589459 h 596438"/>
                <a:gd name="connsiteX12" fmla="*/ 207763 w 575203"/>
                <a:gd name="connsiteY12" fmla="*/ 581644 h 596438"/>
                <a:gd name="connsiteX13" fmla="*/ 74611 w 575203"/>
                <a:gd name="connsiteY13" fmla="*/ 558407 h 596438"/>
                <a:gd name="connsiteX14" fmla="*/ 531 w 575203"/>
                <a:gd name="connsiteY14" fmla="*/ 347911 h 596438"/>
                <a:gd name="connsiteX0" fmla="*/ 531 w 575203"/>
                <a:gd name="connsiteY0" fmla="*/ 314228 h 562755"/>
                <a:gd name="connsiteX1" fmla="*/ 57409 w 575203"/>
                <a:gd name="connsiteY1" fmla="*/ 89015 h 562755"/>
                <a:gd name="connsiteX2" fmla="*/ 121314 w 575203"/>
                <a:gd name="connsiteY2" fmla="*/ 9576 h 562755"/>
                <a:gd name="connsiteX3" fmla="*/ 249702 w 575203"/>
                <a:gd name="connsiteY3" fmla="*/ 25395 h 562755"/>
                <a:gd name="connsiteX4" fmla="*/ 396226 w 575203"/>
                <a:gd name="connsiteY4" fmla="*/ 169826 h 562755"/>
                <a:gd name="connsiteX5" fmla="*/ 561530 w 575203"/>
                <a:gd name="connsiteY5" fmla="*/ 317558 h 562755"/>
                <a:gd name="connsiteX6" fmla="*/ 564730 w 575203"/>
                <a:gd name="connsiteY6" fmla="*/ 407358 h 562755"/>
                <a:gd name="connsiteX7" fmla="*/ 446338 w 575203"/>
                <a:gd name="connsiteY7" fmla="*/ 413183 h 562755"/>
                <a:gd name="connsiteX8" fmla="*/ 540557 w 575203"/>
                <a:gd name="connsiteY8" fmla="*/ 518756 h 562755"/>
                <a:gd name="connsiteX9" fmla="*/ 397469 w 575203"/>
                <a:gd name="connsiteY9" fmla="*/ 453738 h 562755"/>
                <a:gd name="connsiteX10" fmla="*/ 361916 w 575203"/>
                <a:gd name="connsiteY10" fmla="*/ 506344 h 562755"/>
                <a:gd name="connsiteX11" fmla="*/ 305019 w 575203"/>
                <a:gd name="connsiteY11" fmla="*/ 555776 h 562755"/>
                <a:gd name="connsiteX12" fmla="*/ 207763 w 575203"/>
                <a:gd name="connsiteY12" fmla="*/ 547961 h 562755"/>
                <a:gd name="connsiteX13" fmla="*/ 74611 w 575203"/>
                <a:gd name="connsiteY13" fmla="*/ 524724 h 562755"/>
                <a:gd name="connsiteX14" fmla="*/ 531 w 575203"/>
                <a:gd name="connsiteY14" fmla="*/ 314228 h 562755"/>
                <a:gd name="connsiteX0" fmla="*/ 531 w 575203"/>
                <a:gd name="connsiteY0" fmla="*/ 312695 h 561222"/>
                <a:gd name="connsiteX1" fmla="*/ 57409 w 575203"/>
                <a:gd name="connsiteY1" fmla="*/ 87482 h 561222"/>
                <a:gd name="connsiteX2" fmla="*/ 121314 w 575203"/>
                <a:gd name="connsiteY2" fmla="*/ 8043 h 561222"/>
                <a:gd name="connsiteX3" fmla="*/ 249702 w 575203"/>
                <a:gd name="connsiteY3" fmla="*/ 23862 h 561222"/>
                <a:gd name="connsiteX4" fmla="*/ 398584 w 575203"/>
                <a:gd name="connsiteY4" fmla="*/ 130031 h 561222"/>
                <a:gd name="connsiteX5" fmla="*/ 561530 w 575203"/>
                <a:gd name="connsiteY5" fmla="*/ 316025 h 561222"/>
                <a:gd name="connsiteX6" fmla="*/ 564730 w 575203"/>
                <a:gd name="connsiteY6" fmla="*/ 405825 h 561222"/>
                <a:gd name="connsiteX7" fmla="*/ 446338 w 575203"/>
                <a:gd name="connsiteY7" fmla="*/ 411650 h 561222"/>
                <a:gd name="connsiteX8" fmla="*/ 540557 w 575203"/>
                <a:gd name="connsiteY8" fmla="*/ 517223 h 561222"/>
                <a:gd name="connsiteX9" fmla="*/ 397469 w 575203"/>
                <a:gd name="connsiteY9" fmla="*/ 452205 h 561222"/>
                <a:gd name="connsiteX10" fmla="*/ 361916 w 575203"/>
                <a:gd name="connsiteY10" fmla="*/ 504811 h 561222"/>
                <a:gd name="connsiteX11" fmla="*/ 305019 w 575203"/>
                <a:gd name="connsiteY11" fmla="*/ 554243 h 561222"/>
                <a:gd name="connsiteX12" fmla="*/ 207763 w 575203"/>
                <a:gd name="connsiteY12" fmla="*/ 546428 h 561222"/>
                <a:gd name="connsiteX13" fmla="*/ 74611 w 575203"/>
                <a:gd name="connsiteY13" fmla="*/ 523191 h 561222"/>
                <a:gd name="connsiteX14" fmla="*/ 531 w 575203"/>
                <a:gd name="connsiteY14" fmla="*/ 312695 h 561222"/>
                <a:gd name="connsiteX0" fmla="*/ 531 w 575203"/>
                <a:gd name="connsiteY0" fmla="*/ 312695 h 561222"/>
                <a:gd name="connsiteX1" fmla="*/ 57409 w 575203"/>
                <a:gd name="connsiteY1" fmla="*/ 87482 h 561222"/>
                <a:gd name="connsiteX2" fmla="*/ 121314 w 575203"/>
                <a:gd name="connsiteY2" fmla="*/ 8043 h 561222"/>
                <a:gd name="connsiteX3" fmla="*/ 249702 w 575203"/>
                <a:gd name="connsiteY3" fmla="*/ 23862 h 561222"/>
                <a:gd name="connsiteX4" fmla="*/ 398584 w 575203"/>
                <a:gd name="connsiteY4" fmla="*/ 130031 h 561222"/>
                <a:gd name="connsiteX5" fmla="*/ 561530 w 575203"/>
                <a:gd name="connsiteY5" fmla="*/ 316025 h 561222"/>
                <a:gd name="connsiteX6" fmla="*/ 564730 w 575203"/>
                <a:gd name="connsiteY6" fmla="*/ 405825 h 561222"/>
                <a:gd name="connsiteX7" fmla="*/ 446338 w 575203"/>
                <a:gd name="connsiteY7" fmla="*/ 411650 h 561222"/>
                <a:gd name="connsiteX8" fmla="*/ 366596 w 575203"/>
                <a:gd name="connsiteY8" fmla="*/ 525783 h 561222"/>
                <a:gd name="connsiteX9" fmla="*/ 397469 w 575203"/>
                <a:gd name="connsiteY9" fmla="*/ 452205 h 561222"/>
                <a:gd name="connsiteX10" fmla="*/ 361916 w 575203"/>
                <a:gd name="connsiteY10" fmla="*/ 504811 h 561222"/>
                <a:gd name="connsiteX11" fmla="*/ 305019 w 575203"/>
                <a:gd name="connsiteY11" fmla="*/ 554243 h 561222"/>
                <a:gd name="connsiteX12" fmla="*/ 207763 w 575203"/>
                <a:gd name="connsiteY12" fmla="*/ 546428 h 561222"/>
                <a:gd name="connsiteX13" fmla="*/ 74611 w 575203"/>
                <a:gd name="connsiteY13" fmla="*/ 523191 h 561222"/>
                <a:gd name="connsiteX14" fmla="*/ 531 w 575203"/>
                <a:gd name="connsiteY14" fmla="*/ 312695 h 5612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</a:cxnLst>
              <a:rect l="l" t="t" r="r" b="b"/>
              <a:pathLst>
                <a:path w="575203" h="561222">
                  <a:moveTo>
                    <a:pt x="531" y="312695"/>
                  </a:moveTo>
                  <a:cubicBezTo>
                    <a:pt x="-2336" y="240077"/>
                    <a:pt x="5022" y="144632"/>
                    <a:pt x="57409" y="87482"/>
                  </a:cubicBezTo>
                  <a:cubicBezTo>
                    <a:pt x="88815" y="36152"/>
                    <a:pt x="85349" y="25197"/>
                    <a:pt x="121314" y="8043"/>
                  </a:cubicBezTo>
                  <a:cubicBezTo>
                    <a:pt x="157279" y="-9111"/>
                    <a:pt x="203490" y="3531"/>
                    <a:pt x="249702" y="23862"/>
                  </a:cubicBezTo>
                  <a:cubicBezTo>
                    <a:pt x="295914" y="44193"/>
                    <a:pt x="346197" y="72881"/>
                    <a:pt x="398584" y="130031"/>
                  </a:cubicBezTo>
                  <a:cubicBezTo>
                    <a:pt x="450971" y="187181"/>
                    <a:pt x="533446" y="276436"/>
                    <a:pt x="561530" y="316025"/>
                  </a:cubicBezTo>
                  <a:cubicBezTo>
                    <a:pt x="589614" y="355614"/>
                    <a:pt x="565930" y="383002"/>
                    <a:pt x="564730" y="405825"/>
                  </a:cubicBezTo>
                  <a:cubicBezTo>
                    <a:pt x="563530" y="428648"/>
                    <a:pt x="479360" y="391657"/>
                    <a:pt x="446338" y="411650"/>
                  </a:cubicBezTo>
                  <a:cubicBezTo>
                    <a:pt x="413316" y="431643"/>
                    <a:pt x="355899" y="509355"/>
                    <a:pt x="366596" y="525783"/>
                  </a:cubicBezTo>
                  <a:cubicBezTo>
                    <a:pt x="377293" y="542211"/>
                    <a:pt x="398249" y="455700"/>
                    <a:pt x="397469" y="452205"/>
                  </a:cubicBezTo>
                  <a:cubicBezTo>
                    <a:pt x="396689" y="448710"/>
                    <a:pt x="385711" y="485979"/>
                    <a:pt x="361916" y="504811"/>
                  </a:cubicBezTo>
                  <a:cubicBezTo>
                    <a:pt x="338121" y="523643"/>
                    <a:pt x="342910" y="536817"/>
                    <a:pt x="305019" y="554243"/>
                  </a:cubicBezTo>
                  <a:cubicBezTo>
                    <a:pt x="267128" y="571669"/>
                    <a:pt x="246164" y="551603"/>
                    <a:pt x="207763" y="546428"/>
                  </a:cubicBezTo>
                  <a:cubicBezTo>
                    <a:pt x="169362" y="541253"/>
                    <a:pt x="126998" y="580341"/>
                    <a:pt x="74611" y="523191"/>
                  </a:cubicBezTo>
                  <a:cubicBezTo>
                    <a:pt x="22224" y="466041"/>
                    <a:pt x="3398" y="385313"/>
                    <a:pt x="531" y="312695"/>
                  </a:cubicBezTo>
                  <a:close/>
                </a:path>
              </a:pathLst>
            </a:cu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b="1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20" name="Rectangle 319"/>
            <p:cNvSpPr/>
            <p:nvPr/>
          </p:nvSpPr>
          <p:spPr>
            <a:xfrm>
              <a:off x="2867478" y="6472169"/>
              <a:ext cx="740908" cy="38869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IN" kern="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HIF1</a:t>
              </a:r>
              <a:r>
                <a:rPr lang="el-GR" kern="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α</a:t>
              </a:r>
              <a:endParaRPr lang="en-IN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21" name="Straight Arrow Connector 320"/>
            <p:cNvCxnSpPr/>
            <p:nvPr/>
          </p:nvCxnSpPr>
          <p:spPr>
            <a:xfrm>
              <a:off x="2141564" y="5935966"/>
              <a:ext cx="751322" cy="530872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3" name="Straight Arrow Connector 322"/>
            <p:cNvCxnSpPr/>
            <p:nvPr/>
          </p:nvCxnSpPr>
          <p:spPr>
            <a:xfrm>
              <a:off x="3572372" y="6697125"/>
              <a:ext cx="1034047" cy="48628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6" name="Straight Arrow Connector 325"/>
            <p:cNvCxnSpPr/>
            <p:nvPr/>
          </p:nvCxnSpPr>
          <p:spPr>
            <a:xfrm flipH="1">
              <a:off x="3391413" y="5039783"/>
              <a:ext cx="84943" cy="485932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7" name="Straight Arrow Connector 326"/>
            <p:cNvCxnSpPr/>
            <p:nvPr/>
          </p:nvCxnSpPr>
          <p:spPr>
            <a:xfrm>
              <a:off x="3844313" y="5019446"/>
              <a:ext cx="292981" cy="381712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29" name="Group 328"/>
            <p:cNvGrpSpPr/>
            <p:nvPr/>
          </p:nvGrpSpPr>
          <p:grpSpPr>
            <a:xfrm rot="16690555" flipV="1">
              <a:off x="5486313" y="3878171"/>
              <a:ext cx="2212706" cy="449562"/>
              <a:chOff x="1328362" y="5659156"/>
              <a:chExt cx="382992" cy="255083"/>
            </a:xfrm>
          </p:grpSpPr>
          <p:cxnSp>
            <p:nvCxnSpPr>
              <p:cNvPr id="330" name="Straight Connector 329"/>
              <p:cNvCxnSpPr/>
              <p:nvPr/>
            </p:nvCxnSpPr>
            <p:spPr>
              <a:xfrm>
                <a:off x="1328362" y="5659156"/>
                <a:ext cx="0" cy="255083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1" name="Straight Connector 330"/>
              <p:cNvCxnSpPr/>
              <p:nvPr/>
            </p:nvCxnSpPr>
            <p:spPr>
              <a:xfrm flipH="1" flipV="1">
                <a:off x="1328362" y="5786697"/>
                <a:ext cx="382992" cy="903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34" name="Straight Arrow Connector 333"/>
            <p:cNvCxnSpPr>
              <a:endCxn id="32" idx="1"/>
            </p:cNvCxnSpPr>
            <p:nvPr/>
          </p:nvCxnSpPr>
          <p:spPr>
            <a:xfrm>
              <a:off x="7451321" y="4999988"/>
              <a:ext cx="386076" cy="481423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58" name="Group 357"/>
            <p:cNvGrpSpPr/>
            <p:nvPr/>
          </p:nvGrpSpPr>
          <p:grpSpPr>
            <a:xfrm rot="12155562" flipV="1">
              <a:off x="6963673" y="5466255"/>
              <a:ext cx="745675" cy="449562"/>
              <a:chOff x="1328362" y="5659156"/>
              <a:chExt cx="382992" cy="255083"/>
            </a:xfrm>
          </p:grpSpPr>
          <p:cxnSp>
            <p:nvCxnSpPr>
              <p:cNvPr id="359" name="Straight Connector 358"/>
              <p:cNvCxnSpPr/>
              <p:nvPr/>
            </p:nvCxnSpPr>
            <p:spPr>
              <a:xfrm>
                <a:off x="1328362" y="5659156"/>
                <a:ext cx="0" cy="255083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0" name="Straight Connector 359"/>
              <p:cNvCxnSpPr/>
              <p:nvPr/>
            </p:nvCxnSpPr>
            <p:spPr>
              <a:xfrm flipH="1" flipV="1">
                <a:off x="1328362" y="5786697"/>
                <a:ext cx="382992" cy="903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61" name="Straight Arrow Connector 360"/>
            <p:cNvCxnSpPr/>
            <p:nvPr/>
          </p:nvCxnSpPr>
          <p:spPr>
            <a:xfrm flipH="1">
              <a:off x="3978859" y="4036434"/>
              <a:ext cx="732289" cy="568327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64" name="Group 363"/>
            <p:cNvGrpSpPr/>
            <p:nvPr/>
          </p:nvGrpSpPr>
          <p:grpSpPr>
            <a:xfrm rot="15636404">
              <a:off x="5384677" y="1833480"/>
              <a:ext cx="353073" cy="266558"/>
              <a:chOff x="1328362" y="5659156"/>
              <a:chExt cx="382992" cy="255083"/>
            </a:xfrm>
          </p:grpSpPr>
          <p:cxnSp>
            <p:nvCxnSpPr>
              <p:cNvPr id="365" name="Straight Connector 364"/>
              <p:cNvCxnSpPr/>
              <p:nvPr/>
            </p:nvCxnSpPr>
            <p:spPr>
              <a:xfrm>
                <a:off x="1328362" y="5659156"/>
                <a:ext cx="0" cy="255083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6" name="Straight Connector 365"/>
              <p:cNvCxnSpPr/>
              <p:nvPr/>
            </p:nvCxnSpPr>
            <p:spPr>
              <a:xfrm flipH="1" flipV="1">
                <a:off x="1328362" y="5786697"/>
                <a:ext cx="382992" cy="903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68" name="Curved Connector 367"/>
            <p:cNvCxnSpPr/>
            <p:nvPr/>
          </p:nvCxnSpPr>
          <p:spPr>
            <a:xfrm rot="5400000" flipH="1" flipV="1">
              <a:off x="5458702" y="1007730"/>
              <a:ext cx="1089171" cy="823004"/>
            </a:xfrm>
            <a:prstGeom prst="curvedConnector2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AC796D0-6372-C8E5-B19E-A63EDBA27E84}"/>
                </a:ext>
              </a:extLst>
            </p:cNvPr>
            <p:cNvSpPr txBox="1"/>
            <p:nvPr/>
          </p:nvSpPr>
          <p:spPr>
            <a:xfrm>
              <a:off x="4595823" y="-2154620"/>
              <a:ext cx="3369139" cy="1200329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IN" b="0" i="0" dirty="0">
                  <a:solidFill>
                    <a:srgbClr val="222222"/>
                  </a:solidFill>
                  <a:effectLst/>
                  <a:latin typeface="-apple-system"/>
                </a:rPr>
                <a:t>Novel molecules are required to block mitochondrial transcription, inhibiting mitochondrial OXPHOS in </a:t>
              </a:r>
              <a:r>
                <a:rPr lang="en-IN" b="0" i="0" dirty="0" err="1">
                  <a:solidFill>
                    <a:srgbClr val="222222"/>
                  </a:solidFill>
                  <a:effectLst/>
                  <a:latin typeface="-apple-system"/>
                </a:rPr>
                <a:t>chemoresistant</a:t>
              </a:r>
              <a:r>
                <a:rPr lang="en-IN" b="0" i="0" dirty="0">
                  <a:solidFill>
                    <a:srgbClr val="222222"/>
                  </a:solidFill>
                  <a:effectLst/>
                  <a:latin typeface="-apple-system"/>
                </a:rPr>
                <a:t> CRC cells</a:t>
              </a:r>
              <a:endParaRPr lang="en-IN" dirty="0"/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E8EED5D6-4F61-6C96-05A7-3EB2C8C2089C}"/>
                </a:ext>
              </a:extLst>
            </p:cNvPr>
            <p:cNvSpPr/>
            <p:nvPr/>
          </p:nvSpPr>
          <p:spPr>
            <a:xfrm>
              <a:off x="6118953" y="1479524"/>
              <a:ext cx="904415" cy="37555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IN" b="1" kern="100" dirty="0" err="1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tDNA</a:t>
              </a:r>
              <a:endParaRPr lang="en-IN" b="1" kern="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409478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7</TotalTime>
  <Words>175</Words>
  <Application>Microsoft Office PowerPoint</Application>
  <PresentationFormat>Widescreen</PresentationFormat>
  <Paragraphs>10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-apple-system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Narasimha Beeraka</cp:lastModifiedBy>
  <cp:revision>18</cp:revision>
  <dcterms:created xsi:type="dcterms:W3CDTF">2024-08-28T09:35:28Z</dcterms:created>
  <dcterms:modified xsi:type="dcterms:W3CDTF">2025-10-30T10:57:17Z</dcterms:modified>
</cp:coreProperties>
</file>